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9" r:id="rId3"/>
    <p:sldId id="268" r:id="rId4"/>
    <p:sldId id="262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Guilbaud, Axel Xavier Christophe {MMDU~SOUTH SAN FRANCISCO}" initials="GAXC{SF" lastIdx="7" clrIdx="0">
    <p:extLst>
      <p:ext uri="{19B8F6BF-5375-455C-9EA6-DF929625EA0E}">
        <p15:presenceInfo xmlns:p15="http://schemas.microsoft.com/office/powerpoint/2012/main" userId="S-1-5-21-2116170847-193796598-433219294-183716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4040"/>
    <a:srgbClr val="4040FF"/>
    <a:srgbClr val="FFCA95"/>
    <a:srgbClr val="FFE0C0"/>
    <a:srgbClr val="789344"/>
    <a:srgbClr val="9D3F3C"/>
    <a:srgbClr val="3C669A"/>
    <a:srgbClr val="83B9E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377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126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8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1B6F2-A756-4EF4-8F97-52BCF1DDD9F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77F56F-3B20-49F4-8DAC-57B2CDF1D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0557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1B6F2-A756-4EF4-8F97-52BCF1DDD9F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77F56F-3B20-49F4-8DAC-57B2CDF1D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332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1B6F2-A756-4EF4-8F97-52BCF1DDD9F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77F56F-3B20-49F4-8DAC-57B2CDF1D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509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1B6F2-A756-4EF4-8F97-52BCF1DDD9F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77F56F-3B20-49F4-8DAC-57B2CDF1D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267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1B6F2-A756-4EF4-8F97-52BCF1DDD9F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77F56F-3B20-49F4-8DAC-57B2CDF1D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9869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1B6F2-A756-4EF4-8F97-52BCF1DDD9F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77F56F-3B20-49F4-8DAC-57B2CDF1D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358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1B6F2-A756-4EF4-8F97-52BCF1DDD9F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77F56F-3B20-49F4-8DAC-57B2CDF1D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132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1B6F2-A756-4EF4-8F97-52BCF1DDD9F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77F56F-3B20-49F4-8DAC-57B2CDF1D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9580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1B6F2-A756-4EF4-8F97-52BCF1DDD9F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77F56F-3B20-49F4-8DAC-57B2CDF1D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1323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1B6F2-A756-4EF4-8F97-52BCF1DDD9F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77F56F-3B20-49F4-8DAC-57B2CDF1D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479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1B6F2-A756-4EF4-8F97-52BCF1DDD9F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77F56F-3B20-49F4-8DAC-57B2CDF1D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769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B1B6F2-A756-4EF4-8F97-52BCF1DDD9F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77F56F-3B20-49F4-8DAC-57B2CDF1DD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699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21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0.png"/><Relationship Id="rId11" Type="http://schemas.openxmlformats.org/officeDocument/2006/relationships/image" Target="../media/image25.png"/><Relationship Id="rId5" Type="http://schemas.openxmlformats.org/officeDocument/2006/relationships/image" Target="../media/image19.png"/><Relationship Id="rId10" Type="http://schemas.openxmlformats.org/officeDocument/2006/relationships/image" Target="../media/image24.png"/><Relationship Id="rId4" Type="http://schemas.openxmlformats.org/officeDocument/2006/relationships/image" Target="../media/image18.emf"/><Relationship Id="rId9" Type="http://schemas.openxmlformats.org/officeDocument/2006/relationships/image" Target="../media/image23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3058985" y="518956"/>
            <a:ext cx="5510936" cy="5370584"/>
            <a:chOff x="2506228" y="892644"/>
            <a:chExt cx="5510936" cy="5370584"/>
          </a:xfrm>
        </p:grpSpPr>
        <p:grpSp>
          <p:nvGrpSpPr>
            <p:cNvPr id="12" name="Group 11"/>
            <p:cNvGrpSpPr/>
            <p:nvPr/>
          </p:nvGrpSpPr>
          <p:grpSpPr>
            <a:xfrm>
              <a:off x="2506228" y="892644"/>
              <a:ext cx="5510936" cy="5370584"/>
              <a:chOff x="529646" y="1095844"/>
              <a:chExt cx="5510936" cy="5370584"/>
            </a:xfrm>
          </p:grpSpPr>
          <p:pic>
            <p:nvPicPr>
              <p:cNvPr id="2057" name="Picture 9" descr="https://lh6.googleusercontent.com/B_zLQjU3eyDuLOOuYJFmcUobtZgqcaPgZsV3FatPoy4sy13id_to12J8P1WhQ8ZNb05jnS-SIXa8l3AgHljVHHY3M7swftEdWFLSULBOK8xuA8o_24dly4113E-HeNT8MqgGLW6UNa2gWCbEtOH4IBdfNQ=s2048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740" b="9176"/>
              <a:stretch/>
            </p:blipFill>
            <p:spPr bwMode="auto">
              <a:xfrm>
                <a:off x="541914" y="1267691"/>
                <a:ext cx="2187431" cy="121227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59" name="Picture 11" descr="https://lh6.googleusercontent.com/Z1qnfrdJ8wpN38d3iGNEf9PmeYaswlxqollx88zTLD797d8nvSkdCwZOkh8RGYfw4Jb-JpCrf3RnEUCrzyNks1MDqRow9XdhUZ0OsRAycPlDeDUj9SRDH4mtYVGtovD35KbDKO0qIxDq1n61xWESKfgGZA=s2048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945" b="8980"/>
              <a:stretch/>
            </p:blipFill>
            <p:spPr bwMode="auto">
              <a:xfrm>
                <a:off x="541914" y="2658524"/>
                <a:ext cx="2182813" cy="106618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61" name="Picture 13" descr="https://lh5.googleusercontent.com/vQUs0vrO2aipgxk2oa2qhohM3q8eQHUtgJSZO_SintV2eY4pw_M703cbtPZ_CTyca5g901Wci6OgfxSE7n8DKuCCouLSApf8DM1DjdZrXoN7oEV4Q9YWDBtvAB1Kyom9RDziBaB-oKzzcGuvFWjeujV0Bg=s2048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740" b="7550"/>
              <a:stretch/>
            </p:blipFill>
            <p:spPr bwMode="auto">
              <a:xfrm>
                <a:off x="541914" y="3884373"/>
                <a:ext cx="2187431" cy="108294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63" name="Picture 15" descr="https://lh3.googleusercontent.com/bjhYwXed89VTgSzqXaAjGYgnVMlrwqhPJ4aMQEZFDR6gt1OVsauRQOmP-n-y0r7WMECYoMY0Q7HZkOcZCHXJNdmRr1GYVwMNjaVn_b2mawf7MxtUpyjCNRVEnHGGpVEsilK4L5q_1erHqig9F6Ps6J6ISg=s2048"/>
              <p:cNvPicPr>
                <a:picLocks noChangeAspect="1" noChangeArrowheads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151" b="8440"/>
              <a:stretch/>
            </p:blipFill>
            <p:spPr bwMode="auto">
              <a:xfrm>
                <a:off x="541914" y="5245162"/>
                <a:ext cx="2178195" cy="107251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65" name="Picture 17" descr="https://lh5.googleusercontent.com/8ac7q-wnUtzw4PGdqOEQwY1MN0_qCVq8ifAHnFSf1zXFS1B5LLySEsadTIbmNH2DoPNruWhi-cIV9ZCdAzyT2GPmUbQ6ZTjpEaTU-xtAO9Sv7VxD1BEdX18oAEWN9P48TRsd2Dcrohh4E2jxKRp0taAm8Q=s2048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58" t="2564" r="2157" b="11088"/>
              <a:stretch/>
            </p:blipFill>
            <p:spPr bwMode="auto">
              <a:xfrm>
                <a:off x="3343563" y="1319259"/>
                <a:ext cx="2697019" cy="158865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9" name="TextBox 8"/>
              <p:cNvSpPr txBox="1"/>
              <p:nvPr/>
            </p:nvSpPr>
            <p:spPr>
              <a:xfrm>
                <a:off x="4692072" y="2894892"/>
                <a:ext cx="544945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5130800" y="1437042"/>
                <a:ext cx="835892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</a:t>
                </a:r>
                <a:r>
                  <a:rPr lang="en-US" sz="11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= </a:t>
                </a:r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9328</a:t>
                </a: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 rot="16200000">
                <a:off x="2272801" y="1902225"/>
                <a:ext cx="182820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intensity of pHrodo dye (%)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541914" y="2258126"/>
                <a:ext cx="170873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541914" y="3599338"/>
                <a:ext cx="170873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529646" y="4850187"/>
                <a:ext cx="170873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529646" y="6097096"/>
                <a:ext cx="170873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</p:grpSp>
        <p:sp>
          <p:nvSpPr>
            <p:cNvPr id="13" name="TextBox 12"/>
            <p:cNvSpPr txBox="1"/>
            <p:nvPr/>
          </p:nvSpPr>
          <p:spPr>
            <a:xfrm>
              <a:off x="3431309" y="892646"/>
              <a:ext cx="76200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403600" y="2448797"/>
              <a:ext cx="76200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275878" y="3690050"/>
              <a:ext cx="76200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407496" y="4844474"/>
              <a:ext cx="76200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3" name="Rectangle 2"/>
            <p:cNvSpPr/>
            <p:nvPr/>
          </p:nvSpPr>
          <p:spPr>
            <a:xfrm>
              <a:off x="4245212" y="1261978"/>
              <a:ext cx="47801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 9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ectangle 4"/>
            <p:cNvSpPr/>
            <p:nvPr/>
          </p:nvSpPr>
          <p:spPr>
            <a:xfrm>
              <a:off x="4117496" y="2500092"/>
              <a:ext cx="58381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 6.5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ectangle 5"/>
            <p:cNvSpPr/>
            <p:nvPr/>
          </p:nvSpPr>
          <p:spPr>
            <a:xfrm>
              <a:off x="4104812" y="4868459"/>
              <a:ext cx="58381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 4.5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>
              <a:off x="4104812" y="3770603"/>
              <a:ext cx="58381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 5.5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7" name="TextBox 26"/>
          <p:cNvSpPr txBox="1"/>
          <p:nvPr/>
        </p:nvSpPr>
        <p:spPr>
          <a:xfrm>
            <a:off x="5608520" y="2645522"/>
            <a:ext cx="5227119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essment of the pHrodo dye conjugation according to the pH using flow cytometry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Hrodo dye is a pH-sensitive fluorescent dye. Histograms are representing the relative intensity of pHrodo at pH 9 (a), 6.5 (b), 5.5 (c) and 4.5 (d). The red line called “P4” is the gate used for the ROS population. A negative correlation is observed between relative intensity of pHrodo dye and the pH (R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9328).</a:t>
            </a:r>
            <a:endParaRPr lang="en-US" sz="11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977198" y="542048"/>
            <a:ext cx="4758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2970340" y="1868794"/>
            <a:ext cx="4758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2981067" y="3190516"/>
            <a:ext cx="4044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2970340" y="4468778"/>
            <a:ext cx="4044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5311809" y="542048"/>
            <a:ext cx="4044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</a:p>
        </p:txBody>
      </p:sp>
      <p:sp>
        <p:nvSpPr>
          <p:cNvPr id="14" name="Rectangle 13"/>
          <p:cNvSpPr/>
          <p:nvPr/>
        </p:nvSpPr>
        <p:spPr>
          <a:xfrm>
            <a:off x="3039541" y="5740785"/>
            <a:ext cx="265852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rodo Green dye – fluorescence intensity </a:t>
            </a:r>
            <a:endParaRPr lang="en-US" sz="1000" b="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23295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27"/>
          <p:cNvSpPr/>
          <p:nvPr/>
        </p:nvSpPr>
        <p:spPr>
          <a:xfrm>
            <a:off x="1294895" y="3971162"/>
            <a:ext cx="1124959" cy="24177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TextBox 70"/>
          <p:cNvSpPr txBox="1"/>
          <p:nvPr/>
        </p:nvSpPr>
        <p:spPr>
          <a:xfrm>
            <a:off x="398581" y="4331773"/>
            <a:ext cx="699790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: Analysis of homemade retinal extraction preparation using flow cytometry-based method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cytometry-based method isolation of POS population based on (a) SSC-A (side scatter area, standing for the granularity) vs. FSC-A (forward scatter area, standing for the size) parameters. (b) Hoechst 33342-A (b) or (c) ATPase a3 AF750-A were used to determine nucleated cells or impurities such as other retina cellular debris or inner segments. The number of events recorded for the flow cytometry panels was 100,000. </a:t>
            </a:r>
          </a:p>
        </p:txBody>
      </p:sp>
      <p:pic>
        <p:nvPicPr>
          <p:cNvPr id="3074" name="Picture 2">
            <a:extLst>
              <a:ext uri="{FF2B5EF4-FFF2-40B4-BE49-F238E27FC236}">
                <a16:creationId xmlns:a16="http://schemas.microsoft.com/office/drawing/2014/main" id="{CB9B3861-2120-8E85-2E8A-718C26AB2D2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07" t="4056" r="3277" b="6993"/>
          <a:stretch/>
        </p:blipFill>
        <p:spPr bwMode="auto">
          <a:xfrm>
            <a:off x="701591" y="295635"/>
            <a:ext cx="1850059" cy="16788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F2213A4-DD27-5E74-741B-EECD16FB4814}"/>
              </a:ext>
            </a:extLst>
          </p:cNvPr>
          <p:cNvSpPr txBox="1"/>
          <p:nvPr/>
        </p:nvSpPr>
        <p:spPr>
          <a:xfrm rot="16200000">
            <a:off x="195325" y="793297"/>
            <a:ext cx="752376" cy="26015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C-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D94C36E-8149-BE63-A1FD-2B8B5D2DDD6A}"/>
              </a:ext>
            </a:extLst>
          </p:cNvPr>
          <p:cNvSpPr txBox="1"/>
          <p:nvPr/>
        </p:nvSpPr>
        <p:spPr>
          <a:xfrm>
            <a:off x="1488705" y="1878222"/>
            <a:ext cx="752376" cy="26015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17C63590-CE8B-50FC-9D6D-EF3201301F3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8806" y="1842044"/>
            <a:ext cx="325570" cy="21437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8915DF4-12A6-DDD8-5A75-83396972E53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1030" y="127497"/>
            <a:ext cx="1138824" cy="214370"/>
          </a:xfrm>
          <a:prstGeom prst="rect">
            <a:avLst/>
          </a:prstGeom>
        </p:spPr>
      </p:pic>
      <p:grpSp>
        <p:nvGrpSpPr>
          <p:cNvPr id="11" name="Group 10">
            <a:extLst>
              <a:ext uri="{FF2B5EF4-FFF2-40B4-BE49-F238E27FC236}">
                <a16:creationId xmlns:a16="http://schemas.microsoft.com/office/drawing/2014/main" id="{D4D28517-8B6E-75EC-D0D5-6C145497D63D}"/>
              </a:ext>
            </a:extLst>
          </p:cNvPr>
          <p:cNvGrpSpPr/>
          <p:nvPr/>
        </p:nvGrpSpPr>
        <p:grpSpPr>
          <a:xfrm>
            <a:off x="3011089" y="341867"/>
            <a:ext cx="1544806" cy="1696520"/>
            <a:chOff x="6681086" y="3100101"/>
            <a:chExt cx="1544806" cy="1696520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D5312526-1F30-5E63-219F-B89C1C29795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90166" y="3100101"/>
              <a:ext cx="1135726" cy="126546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2D7FEA81-037C-847B-484E-82873447824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81086" y="4490857"/>
              <a:ext cx="258095" cy="305764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4E848626-CBED-45F0-E298-DF6DD1B4580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33486" y="4648482"/>
              <a:ext cx="258095" cy="84487"/>
            </a:xfrm>
            <a:prstGeom prst="rect">
              <a:avLst/>
            </a:prstGeom>
          </p:spPr>
        </p:pic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4574188C-DEE7-7972-8E64-369D9B0B5085}"/>
              </a:ext>
            </a:extLst>
          </p:cNvPr>
          <p:cNvSpPr txBox="1"/>
          <p:nvPr/>
        </p:nvSpPr>
        <p:spPr>
          <a:xfrm>
            <a:off x="3114670" y="1872830"/>
            <a:ext cx="182533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hodopsin 1D4 Alexa 488-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70CA696-55EC-995F-515B-00499279D841}"/>
              </a:ext>
            </a:extLst>
          </p:cNvPr>
          <p:cNvSpPr txBox="1"/>
          <p:nvPr/>
        </p:nvSpPr>
        <p:spPr>
          <a:xfrm rot="16200000">
            <a:off x="2296116" y="953300"/>
            <a:ext cx="1255496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echst 33342-A</a:t>
            </a:r>
          </a:p>
        </p:txBody>
      </p:sp>
      <p:pic>
        <p:nvPicPr>
          <p:cNvPr id="3076" name="Picture 4">
            <a:extLst>
              <a:ext uri="{FF2B5EF4-FFF2-40B4-BE49-F238E27FC236}">
                <a16:creationId xmlns:a16="http://schemas.microsoft.com/office/drawing/2014/main" id="{4E9CD832-B9D6-DA39-487E-5F19418DF9C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75" t="6574" r="2157" b="5523"/>
          <a:stretch/>
        </p:blipFill>
        <p:spPr bwMode="auto">
          <a:xfrm>
            <a:off x="2996911" y="339448"/>
            <a:ext cx="1801240" cy="1587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866CB8BC-5B82-0C9B-EEC9-D93BEA82DD5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9110" y="1824017"/>
            <a:ext cx="325570" cy="214370"/>
          </a:xfrm>
          <a:prstGeom prst="rect">
            <a:avLst/>
          </a:prstGeom>
        </p:spPr>
      </p:pic>
      <p:pic>
        <p:nvPicPr>
          <p:cNvPr id="3078" name="Picture 6">
            <a:extLst>
              <a:ext uri="{FF2B5EF4-FFF2-40B4-BE49-F238E27FC236}">
                <a16:creationId xmlns:a16="http://schemas.microsoft.com/office/drawing/2014/main" id="{B96743AE-CE61-34A9-6A12-FDE7370818E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66" t="6390" r="2782" b="6031"/>
          <a:stretch/>
        </p:blipFill>
        <p:spPr bwMode="auto">
          <a:xfrm>
            <a:off x="5305500" y="326137"/>
            <a:ext cx="1774511" cy="15856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BE548A90-8F2E-DACA-A3C5-C12E671B3A3E}"/>
              </a:ext>
            </a:extLst>
          </p:cNvPr>
          <p:cNvSpPr txBox="1"/>
          <p:nvPr/>
        </p:nvSpPr>
        <p:spPr>
          <a:xfrm rot="16200000">
            <a:off x="4424324" y="988151"/>
            <a:ext cx="147865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ase a3 AF750-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6BFA348-F4AB-BB6A-0F59-42FB3E13F623}"/>
              </a:ext>
            </a:extLst>
          </p:cNvPr>
          <p:cNvSpPr txBox="1"/>
          <p:nvPr/>
        </p:nvSpPr>
        <p:spPr>
          <a:xfrm>
            <a:off x="5426672" y="1872830"/>
            <a:ext cx="182533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hodopsin 1D4 Alexa 488-A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8A21C6CD-FA88-468D-F19B-DD0BF65EB68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1900" y="1780331"/>
            <a:ext cx="325570" cy="214370"/>
          </a:xfrm>
          <a:prstGeom prst="rect">
            <a:avLst/>
          </a:prstGeom>
        </p:spPr>
      </p:pic>
      <p:pic>
        <p:nvPicPr>
          <p:cNvPr id="3080" name="Picture 8">
            <a:extLst>
              <a:ext uri="{FF2B5EF4-FFF2-40B4-BE49-F238E27FC236}">
                <a16:creationId xmlns:a16="http://schemas.microsoft.com/office/drawing/2014/main" id="{F80E2232-86B8-FE3A-DC7E-91C58921F1C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83" t="7448" r="2678" b="7227"/>
          <a:stretch/>
        </p:blipFill>
        <p:spPr bwMode="auto">
          <a:xfrm>
            <a:off x="738800" y="2210055"/>
            <a:ext cx="1775639" cy="16274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70E7FE13-1855-34E6-FACB-2FCD0100B1B3}"/>
              </a:ext>
            </a:extLst>
          </p:cNvPr>
          <p:cNvSpPr txBox="1"/>
          <p:nvPr/>
        </p:nvSpPr>
        <p:spPr>
          <a:xfrm rot="16200000">
            <a:off x="-304147" y="2971583"/>
            <a:ext cx="173738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hodopsin 4D2 Alexa 647-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26F597C-6F0A-67BD-521D-97CEEA830F2D}"/>
              </a:ext>
            </a:extLst>
          </p:cNvPr>
          <p:cNvSpPr txBox="1"/>
          <p:nvPr/>
        </p:nvSpPr>
        <p:spPr>
          <a:xfrm>
            <a:off x="817777" y="3927705"/>
            <a:ext cx="182533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hodopsin 1D4 Alexa 488-A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9D89A3F0-D361-5F2B-5EBE-7D743FA794F8}"/>
              </a:ext>
            </a:extLst>
          </p:cNvPr>
          <p:cNvSpPr/>
          <p:nvPr/>
        </p:nvSpPr>
        <p:spPr>
          <a:xfrm>
            <a:off x="1234650" y="3361012"/>
            <a:ext cx="1279788" cy="354674"/>
          </a:xfrm>
          <a:prstGeom prst="rect">
            <a:avLst/>
          </a:prstGeom>
          <a:noFill/>
          <a:ln w="6350">
            <a:solidFill>
              <a:srgbClr val="0432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E7530DDC-C7CB-BC81-B87B-CF930F5F563D}"/>
              </a:ext>
            </a:extLst>
          </p:cNvPr>
          <p:cNvSpPr/>
          <p:nvPr/>
        </p:nvSpPr>
        <p:spPr>
          <a:xfrm>
            <a:off x="866248" y="3361012"/>
            <a:ext cx="368404" cy="354674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463E2AF5-969A-5598-D0FA-9B7E47015472}"/>
              </a:ext>
            </a:extLst>
          </p:cNvPr>
          <p:cNvSpPr/>
          <p:nvPr/>
        </p:nvSpPr>
        <p:spPr>
          <a:xfrm>
            <a:off x="864376" y="2210055"/>
            <a:ext cx="370276" cy="1150957"/>
          </a:xfrm>
          <a:prstGeom prst="rect">
            <a:avLst/>
          </a:prstGeom>
          <a:noFill/>
          <a:ln w="635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E3423BFE-A689-43EB-ECB9-CB57620A573A}"/>
              </a:ext>
            </a:extLst>
          </p:cNvPr>
          <p:cNvSpPr/>
          <p:nvPr/>
        </p:nvSpPr>
        <p:spPr>
          <a:xfrm>
            <a:off x="1246524" y="2210055"/>
            <a:ext cx="1267915" cy="1158823"/>
          </a:xfrm>
          <a:prstGeom prst="rect">
            <a:avLst/>
          </a:prstGeom>
          <a:noFill/>
          <a:ln w="635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EFC9CC3-CE01-543D-7723-095F07E797B6}"/>
              </a:ext>
            </a:extLst>
          </p:cNvPr>
          <p:cNvSpPr txBox="1"/>
          <p:nvPr/>
        </p:nvSpPr>
        <p:spPr>
          <a:xfrm>
            <a:off x="2169353" y="3434560"/>
            <a:ext cx="5633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S</a:t>
            </a:r>
          </a:p>
        </p:txBody>
      </p:sp>
      <p:pic>
        <p:nvPicPr>
          <p:cNvPr id="3082" name="Picture 10">
            <a:extLst>
              <a:ext uri="{FF2B5EF4-FFF2-40B4-BE49-F238E27FC236}">
                <a16:creationId xmlns:a16="http://schemas.microsoft.com/office/drawing/2014/main" id="{08219522-4C79-5ABA-43BC-3658ED6E9A7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21" t="7147" r="2596" b="6884"/>
          <a:stretch/>
        </p:blipFill>
        <p:spPr bwMode="auto">
          <a:xfrm>
            <a:off x="3203890" y="2243045"/>
            <a:ext cx="1801240" cy="16005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FFBDF3A5-DDD9-3D8B-DE21-73C4F4606CF8}"/>
              </a:ext>
            </a:extLst>
          </p:cNvPr>
          <p:cNvSpPr txBox="1"/>
          <p:nvPr/>
        </p:nvSpPr>
        <p:spPr>
          <a:xfrm rot="16200000">
            <a:off x="2198925" y="2993159"/>
            <a:ext cx="1671291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en, Red Anti Opsin PE-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3446E76-5294-9388-FACB-A387F9C94CBF}"/>
              </a:ext>
            </a:extLst>
          </p:cNvPr>
          <p:cNvSpPr txBox="1"/>
          <p:nvPr/>
        </p:nvSpPr>
        <p:spPr>
          <a:xfrm>
            <a:off x="3108887" y="3930260"/>
            <a:ext cx="182533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hodopsin 1D4 Alexa 488-A</a:t>
            </a: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062AA7D4-4D64-D814-3348-B3AE81FCC17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651" y="3712843"/>
            <a:ext cx="197725" cy="214370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B3688EE5-6BE3-78DB-E75A-518A322EE09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42819" y="3707415"/>
            <a:ext cx="197725" cy="214370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332BD39F-46BF-8466-26D1-92AC9F35A2D9}"/>
              </a:ext>
            </a:extLst>
          </p:cNvPr>
          <p:cNvSpPr txBox="1"/>
          <p:nvPr/>
        </p:nvSpPr>
        <p:spPr>
          <a:xfrm>
            <a:off x="3258492" y="2305700"/>
            <a:ext cx="4704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S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9D836A9-6492-26DD-1ADB-9CA54D00490A}"/>
              </a:ext>
            </a:extLst>
          </p:cNvPr>
          <p:cNvSpPr txBox="1"/>
          <p:nvPr/>
        </p:nvSpPr>
        <p:spPr>
          <a:xfrm>
            <a:off x="5142535" y="164830"/>
            <a:ext cx="4758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855AB69-E3BF-277C-6315-D40A866F7105}"/>
              </a:ext>
            </a:extLst>
          </p:cNvPr>
          <p:cNvSpPr txBox="1"/>
          <p:nvPr/>
        </p:nvSpPr>
        <p:spPr>
          <a:xfrm>
            <a:off x="424828" y="178634"/>
            <a:ext cx="457654" cy="2625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5C7886F-D117-580E-99A1-CDA9399CE7F7}"/>
              </a:ext>
            </a:extLst>
          </p:cNvPr>
          <p:cNvSpPr txBox="1"/>
          <p:nvPr/>
        </p:nvSpPr>
        <p:spPr>
          <a:xfrm>
            <a:off x="402287" y="2064671"/>
            <a:ext cx="4758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295E00A-81F3-52B3-0152-A9BA5FD41759}"/>
              </a:ext>
            </a:extLst>
          </p:cNvPr>
          <p:cNvSpPr txBox="1"/>
          <p:nvPr/>
        </p:nvSpPr>
        <p:spPr>
          <a:xfrm>
            <a:off x="2846599" y="2050832"/>
            <a:ext cx="4758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C4D4CFB-9325-B2BF-A915-6E6D1472D765}"/>
              </a:ext>
            </a:extLst>
          </p:cNvPr>
          <p:cNvSpPr txBox="1"/>
          <p:nvPr/>
        </p:nvSpPr>
        <p:spPr>
          <a:xfrm>
            <a:off x="2802484" y="181261"/>
            <a:ext cx="4758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2329EA5-FE7B-CB3C-493B-73B1982D5088}"/>
              </a:ext>
            </a:extLst>
          </p:cNvPr>
          <p:cNvSpPr txBox="1"/>
          <p:nvPr/>
        </p:nvSpPr>
        <p:spPr>
          <a:xfrm>
            <a:off x="3082762" y="324547"/>
            <a:ext cx="53994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48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026B4D9-6F98-F547-2578-786FE8AED545}"/>
              </a:ext>
            </a:extLst>
          </p:cNvPr>
          <p:cNvSpPr txBox="1"/>
          <p:nvPr/>
        </p:nvSpPr>
        <p:spPr>
          <a:xfrm>
            <a:off x="5404146" y="318399"/>
            <a:ext cx="53994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.81</a:t>
            </a:r>
          </a:p>
        </p:txBody>
      </p:sp>
    </p:spTree>
    <p:extLst>
      <p:ext uri="{BB962C8B-B14F-4D97-AF65-F5344CB8AC3E}">
        <p14:creationId xmlns:p14="http://schemas.microsoft.com/office/powerpoint/2010/main" val="29401827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extBox 70"/>
          <p:cNvSpPr txBox="1"/>
          <p:nvPr/>
        </p:nvSpPr>
        <p:spPr>
          <a:xfrm>
            <a:off x="1260701" y="3389774"/>
            <a:ext cx="799115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: Characterization of POS population using flow cytometry-based method in different batches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S and COS populations, as well as total purity observed in Figure 2 have been shown to be consistent through three POS batches.</a:t>
            </a:r>
          </a:p>
        </p:txBody>
      </p:sp>
      <p:pic>
        <p:nvPicPr>
          <p:cNvPr id="5123" name="Picture 3">
            <a:extLst>
              <a:ext uri="{FF2B5EF4-FFF2-40B4-BE49-F238E27FC236}">
                <a16:creationId xmlns:a16="http://schemas.microsoft.com/office/drawing/2014/main" id="{38BDC0C1-6F7E-B7F7-A2B9-B4D1A582E99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70" t="6283" r="4163" b="6956"/>
          <a:stretch/>
        </p:blipFill>
        <p:spPr bwMode="auto">
          <a:xfrm>
            <a:off x="1389480" y="924276"/>
            <a:ext cx="2062928" cy="20655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4" name="Picture 4">
            <a:extLst>
              <a:ext uri="{FF2B5EF4-FFF2-40B4-BE49-F238E27FC236}">
                <a16:creationId xmlns:a16="http://schemas.microsoft.com/office/drawing/2014/main" id="{97BE03FE-EAEA-9EBC-002E-3D438F1B38D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94" t="6245" r="4340" b="6955"/>
          <a:stretch/>
        </p:blipFill>
        <p:spPr bwMode="auto">
          <a:xfrm>
            <a:off x="4036334" y="917462"/>
            <a:ext cx="2062927" cy="20664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2" name="Rectangle 121">
            <a:extLst>
              <a:ext uri="{FF2B5EF4-FFF2-40B4-BE49-F238E27FC236}">
                <a16:creationId xmlns:a16="http://schemas.microsoft.com/office/drawing/2014/main" id="{1F290CCA-4F23-43D2-9D57-ADE59A5782AF}"/>
              </a:ext>
            </a:extLst>
          </p:cNvPr>
          <p:cNvSpPr/>
          <p:nvPr/>
        </p:nvSpPr>
        <p:spPr>
          <a:xfrm>
            <a:off x="255640" y="4826466"/>
            <a:ext cx="523546" cy="4375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7" name="Rectangle 126">
            <a:extLst>
              <a:ext uri="{FF2B5EF4-FFF2-40B4-BE49-F238E27FC236}">
                <a16:creationId xmlns:a16="http://schemas.microsoft.com/office/drawing/2014/main" id="{5E987C98-A25D-98D0-8C66-0399C76FF95A}"/>
              </a:ext>
            </a:extLst>
          </p:cNvPr>
          <p:cNvSpPr/>
          <p:nvPr/>
        </p:nvSpPr>
        <p:spPr>
          <a:xfrm>
            <a:off x="970934" y="2782479"/>
            <a:ext cx="523546" cy="4375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20" name="Rectangle 5119">
            <a:extLst>
              <a:ext uri="{FF2B5EF4-FFF2-40B4-BE49-F238E27FC236}">
                <a16:creationId xmlns:a16="http://schemas.microsoft.com/office/drawing/2014/main" id="{FEE48C05-FCEC-EADA-1F87-73B5FEEA8A0B}"/>
              </a:ext>
            </a:extLst>
          </p:cNvPr>
          <p:cNvSpPr/>
          <p:nvPr/>
        </p:nvSpPr>
        <p:spPr>
          <a:xfrm>
            <a:off x="3581508" y="2775665"/>
            <a:ext cx="523546" cy="4375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29" name="Rectangle 5128">
            <a:extLst>
              <a:ext uri="{FF2B5EF4-FFF2-40B4-BE49-F238E27FC236}">
                <a16:creationId xmlns:a16="http://schemas.microsoft.com/office/drawing/2014/main" id="{456CFDFC-9805-5BD6-AA89-837A8DFB0B23}"/>
              </a:ext>
            </a:extLst>
          </p:cNvPr>
          <p:cNvSpPr/>
          <p:nvPr/>
        </p:nvSpPr>
        <p:spPr>
          <a:xfrm>
            <a:off x="1992267" y="2385303"/>
            <a:ext cx="1443388" cy="454945"/>
          </a:xfrm>
          <a:prstGeom prst="rect">
            <a:avLst/>
          </a:prstGeom>
          <a:noFill/>
          <a:ln w="6350">
            <a:solidFill>
              <a:srgbClr val="0432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30" name="Rectangle 5129">
            <a:extLst>
              <a:ext uri="{FF2B5EF4-FFF2-40B4-BE49-F238E27FC236}">
                <a16:creationId xmlns:a16="http://schemas.microsoft.com/office/drawing/2014/main" id="{9AA71C28-6239-9AD7-AED2-CCDFBF9B2AB0}"/>
              </a:ext>
            </a:extLst>
          </p:cNvPr>
          <p:cNvSpPr/>
          <p:nvPr/>
        </p:nvSpPr>
        <p:spPr>
          <a:xfrm>
            <a:off x="1537261" y="2384074"/>
            <a:ext cx="463195" cy="456173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31" name="Rectangle 5130">
            <a:extLst>
              <a:ext uri="{FF2B5EF4-FFF2-40B4-BE49-F238E27FC236}">
                <a16:creationId xmlns:a16="http://schemas.microsoft.com/office/drawing/2014/main" id="{D72F8D91-72B5-ED61-9ECE-77262AFE3E0F}"/>
              </a:ext>
            </a:extLst>
          </p:cNvPr>
          <p:cNvSpPr/>
          <p:nvPr/>
        </p:nvSpPr>
        <p:spPr>
          <a:xfrm>
            <a:off x="1541540" y="936976"/>
            <a:ext cx="450727" cy="1447099"/>
          </a:xfrm>
          <a:prstGeom prst="rect">
            <a:avLst/>
          </a:prstGeom>
          <a:noFill/>
          <a:ln w="635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32" name="Rectangle 5131">
            <a:extLst>
              <a:ext uri="{FF2B5EF4-FFF2-40B4-BE49-F238E27FC236}">
                <a16:creationId xmlns:a16="http://schemas.microsoft.com/office/drawing/2014/main" id="{5E26AA33-CB4C-6F8F-F322-AEF50E79CDA3}"/>
              </a:ext>
            </a:extLst>
          </p:cNvPr>
          <p:cNvSpPr/>
          <p:nvPr/>
        </p:nvSpPr>
        <p:spPr>
          <a:xfrm>
            <a:off x="2000456" y="938205"/>
            <a:ext cx="1435199" cy="1447099"/>
          </a:xfrm>
          <a:prstGeom prst="rect">
            <a:avLst/>
          </a:prstGeom>
          <a:noFill/>
          <a:ln w="635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33" name="Rectangle 5132">
            <a:extLst>
              <a:ext uri="{FF2B5EF4-FFF2-40B4-BE49-F238E27FC236}">
                <a16:creationId xmlns:a16="http://schemas.microsoft.com/office/drawing/2014/main" id="{10EFB555-E135-E916-0929-2195C2D60D59}"/>
              </a:ext>
            </a:extLst>
          </p:cNvPr>
          <p:cNvSpPr/>
          <p:nvPr/>
        </p:nvSpPr>
        <p:spPr>
          <a:xfrm>
            <a:off x="4637512" y="2379415"/>
            <a:ext cx="1469937" cy="454945"/>
          </a:xfrm>
          <a:prstGeom prst="rect">
            <a:avLst/>
          </a:prstGeom>
          <a:noFill/>
          <a:ln w="6350">
            <a:solidFill>
              <a:srgbClr val="0432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34" name="Rectangle 5133">
            <a:extLst>
              <a:ext uri="{FF2B5EF4-FFF2-40B4-BE49-F238E27FC236}">
                <a16:creationId xmlns:a16="http://schemas.microsoft.com/office/drawing/2014/main" id="{6822A6E1-50C4-7C2C-21A5-FF7F436EC05A}"/>
              </a:ext>
            </a:extLst>
          </p:cNvPr>
          <p:cNvSpPr/>
          <p:nvPr/>
        </p:nvSpPr>
        <p:spPr>
          <a:xfrm>
            <a:off x="4186787" y="2378186"/>
            <a:ext cx="458916" cy="456173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35" name="Rectangle 5134">
            <a:extLst>
              <a:ext uri="{FF2B5EF4-FFF2-40B4-BE49-F238E27FC236}">
                <a16:creationId xmlns:a16="http://schemas.microsoft.com/office/drawing/2014/main" id="{F08395E2-E59C-4CE8-4FA1-E4969BA39853}"/>
              </a:ext>
            </a:extLst>
          </p:cNvPr>
          <p:cNvSpPr/>
          <p:nvPr/>
        </p:nvSpPr>
        <p:spPr>
          <a:xfrm>
            <a:off x="4186786" y="931088"/>
            <a:ext cx="450727" cy="1447099"/>
          </a:xfrm>
          <a:prstGeom prst="rect">
            <a:avLst/>
          </a:prstGeom>
          <a:noFill/>
          <a:ln w="635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36" name="Rectangle 5135">
            <a:extLst>
              <a:ext uri="{FF2B5EF4-FFF2-40B4-BE49-F238E27FC236}">
                <a16:creationId xmlns:a16="http://schemas.microsoft.com/office/drawing/2014/main" id="{1F36DD70-8FD5-EACF-096A-114E010AC718}"/>
              </a:ext>
            </a:extLst>
          </p:cNvPr>
          <p:cNvSpPr/>
          <p:nvPr/>
        </p:nvSpPr>
        <p:spPr>
          <a:xfrm>
            <a:off x="4645702" y="932317"/>
            <a:ext cx="1461747" cy="1447099"/>
          </a:xfrm>
          <a:prstGeom prst="rect">
            <a:avLst/>
          </a:prstGeom>
          <a:noFill/>
          <a:ln w="635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37" name="TextBox 5136">
            <a:extLst>
              <a:ext uri="{FF2B5EF4-FFF2-40B4-BE49-F238E27FC236}">
                <a16:creationId xmlns:a16="http://schemas.microsoft.com/office/drawing/2014/main" id="{7077A737-F425-F581-1C35-34FDEACEE7DE}"/>
              </a:ext>
            </a:extLst>
          </p:cNvPr>
          <p:cNvSpPr txBox="1"/>
          <p:nvPr/>
        </p:nvSpPr>
        <p:spPr>
          <a:xfrm>
            <a:off x="3124288" y="2541882"/>
            <a:ext cx="4932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S</a:t>
            </a:r>
          </a:p>
        </p:txBody>
      </p:sp>
      <p:sp>
        <p:nvSpPr>
          <p:cNvPr id="5138" name="TextBox 5137">
            <a:extLst>
              <a:ext uri="{FF2B5EF4-FFF2-40B4-BE49-F238E27FC236}">
                <a16:creationId xmlns:a16="http://schemas.microsoft.com/office/drawing/2014/main" id="{36DB5BE1-5E5A-69F1-7423-DEE979DBCEA3}"/>
              </a:ext>
            </a:extLst>
          </p:cNvPr>
          <p:cNvSpPr txBox="1"/>
          <p:nvPr/>
        </p:nvSpPr>
        <p:spPr>
          <a:xfrm>
            <a:off x="5756435" y="2537225"/>
            <a:ext cx="4932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S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6357321" y="940136"/>
            <a:ext cx="3613922" cy="2311470"/>
            <a:chOff x="1260702" y="898501"/>
            <a:chExt cx="3613922" cy="2311470"/>
          </a:xfrm>
        </p:grpSpPr>
        <p:sp>
          <p:nvSpPr>
            <p:cNvPr id="63" name="TextBox 62"/>
            <p:cNvSpPr txBox="1"/>
            <p:nvPr/>
          </p:nvSpPr>
          <p:spPr>
            <a:xfrm rot="16200000">
              <a:off x="452399" y="1706804"/>
              <a:ext cx="18628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hodopsin 4D2 Alexa 647-A</a:t>
              </a:r>
            </a:p>
          </p:txBody>
        </p:sp>
        <p:pic>
          <p:nvPicPr>
            <p:cNvPr id="5122" name="Picture 2">
              <a:extLst>
                <a:ext uri="{FF2B5EF4-FFF2-40B4-BE49-F238E27FC236}">
                  <a16:creationId xmlns:a16="http://schemas.microsoft.com/office/drawing/2014/main" id="{3225FF2F-512E-C0E5-3527-3CADD45C43B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70" t="6933" r="4163" b="7733"/>
            <a:stretch/>
          </p:blipFill>
          <p:spPr bwMode="auto">
            <a:xfrm>
              <a:off x="1511712" y="905973"/>
              <a:ext cx="2032745" cy="203158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121" name="Rectangle 5120">
              <a:extLst>
                <a:ext uri="{FF2B5EF4-FFF2-40B4-BE49-F238E27FC236}">
                  <a16:creationId xmlns:a16="http://schemas.microsoft.com/office/drawing/2014/main" id="{053F7717-5EB9-ABE6-713A-F3F5ADA0B0CF}"/>
                </a:ext>
              </a:extLst>
            </p:cNvPr>
            <p:cNvSpPr/>
            <p:nvPr/>
          </p:nvSpPr>
          <p:spPr>
            <a:xfrm>
              <a:off x="2101069" y="2354299"/>
              <a:ext cx="1443388" cy="454945"/>
            </a:xfrm>
            <a:prstGeom prst="rect">
              <a:avLst/>
            </a:prstGeom>
            <a:noFill/>
            <a:ln w="6350">
              <a:solidFill>
                <a:srgbClr val="0432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5" name="Rectangle 5124">
              <a:extLst>
                <a:ext uri="{FF2B5EF4-FFF2-40B4-BE49-F238E27FC236}">
                  <a16:creationId xmlns:a16="http://schemas.microsoft.com/office/drawing/2014/main" id="{EE0868D2-5199-E2BD-56AD-B80275CBF931}"/>
                </a:ext>
              </a:extLst>
            </p:cNvPr>
            <p:cNvSpPr/>
            <p:nvPr/>
          </p:nvSpPr>
          <p:spPr>
            <a:xfrm>
              <a:off x="1658531" y="2353070"/>
              <a:ext cx="450727" cy="456173"/>
            </a:xfrm>
            <a:prstGeom prst="rect">
              <a:avLst/>
            </a:prstGeom>
            <a:noFill/>
            <a:ln w="63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6" name="TextBox 5125">
              <a:extLst>
                <a:ext uri="{FF2B5EF4-FFF2-40B4-BE49-F238E27FC236}">
                  <a16:creationId xmlns:a16="http://schemas.microsoft.com/office/drawing/2014/main" id="{A205EC47-3C8D-D07D-B76A-06A429FCBF5D}"/>
                </a:ext>
              </a:extLst>
            </p:cNvPr>
            <p:cNvSpPr txBox="1"/>
            <p:nvPr/>
          </p:nvSpPr>
          <p:spPr>
            <a:xfrm>
              <a:off x="3225402" y="2497090"/>
              <a:ext cx="4932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OS</a:t>
              </a:r>
            </a:p>
          </p:txBody>
        </p:sp>
        <p:sp>
          <p:nvSpPr>
            <p:cNvPr id="5127" name="Rectangle 5126">
              <a:extLst>
                <a:ext uri="{FF2B5EF4-FFF2-40B4-BE49-F238E27FC236}">
                  <a16:creationId xmlns:a16="http://schemas.microsoft.com/office/drawing/2014/main" id="{9932A59D-A1FC-EC62-11EE-D92E6FDF3D27}"/>
                </a:ext>
              </a:extLst>
            </p:cNvPr>
            <p:cNvSpPr/>
            <p:nvPr/>
          </p:nvSpPr>
          <p:spPr>
            <a:xfrm>
              <a:off x="1666720" y="905972"/>
              <a:ext cx="434349" cy="1447099"/>
            </a:xfrm>
            <a:prstGeom prst="rect">
              <a:avLst/>
            </a:prstGeom>
            <a:noFill/>
            <a:ln w="6350"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8" name="Rectangle 5127">
              <a:extLst>
                <a:ext uri="{FF2B5EF4-FFF2-40B4-BE49-F238E27FC236}">
                  <a16:creationId xmlns:a16="http://schemas.microsoft.com/office/drawing/2014/main" id="{1685C145-6C6E-0789-E45E-23EE032EFD9B}"/>
                </a:ext>
              </a:extLst>
            </p:cNvPr>
            <p:cNvSpPr/>
            <p:nvPr/>
          </p:nvSpPr>
          <p:spPr>
            <a:xfrm>
              <a:off x="2109258" y="907201"/>
              <a:ext cx="1435199" cy="1447099"/>
            </a:xfrm>
            <a:prstGeom prst="rect">
              <a:avLst/>
            </a:prstGeom>
            <a:noFill/>
            <a:ln w="635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39" name="TextBox 5138">
              <a:extLst>
                <a:ext uri="{FF2B5EF4-FFF2-40B4-BE49-F238E27FC236}">
                  <a16:creationId xmlns:a16="http://schemas.microsoft.com/office/drawing/2014/main" id="{EF7BEC97-7030-466D-8387-81A7554A72BD}"/>
                </a:ext>
              </a:extLst>
            </p:cNvPr>
            <p:cNvSpPr txBox="1"/>
            <p:nvPr/>
          </p:nvSpPr>
          <p:spPr>
            <a:xfrm>
              <a:off x="1789678" y="2963750"/>
              <a:ext cx="30849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hodopsin 1D4 Alexa 488-A</a:t>
              </a:r>
            </a:p>
          </p:txBody>
        </p:sp>
      </p:grpSp>
      <p:sp>
        <p:nvSpPr>
          <p:cNvPr id="5140" name="TextBox 5139">
            <a:extLst>
              <a:ext uri="{FF2B5EF4-FFF2-40B4-BE49-F238E27FC236}">
                <a16:creationId xmlns:a16="http://schemas.microsoft.com/office/drawing/2014/main" id="{95B035A5-FC06-9B31-548C-005F94F94597}"/>
              </a:ext>
            </a:extLst>
          </p:cNvPr>
          <p:cNvSpPr txBox="1"/>
          <p:nvPr/>
        </p:nvSpPr>
        <p:spPr>
          <a:xfrm rot="16200000">
            <a:off x="287792" y="1748439"/>
            <a:ext cx="18628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hodopsin 4D2 Alexa 647-A</a:t>
            </a:r>
          </a:p>
        </p:txBody>
      </p:sp>
      <p:sp>
        <p:nvSpPr>
          <p:cNvPr id="5141" name="TextBox 5140">
            <a:extLst>
              <a:ext uri="{FF2B5EF4-FFF2-40B4-BE49-F238E27FC236}">
                <a16:creationId xmlns:a16="http://schemas.microsoft.com/office/drawing/2014/main" id="{6058F363-D5FC-2E6B-F212-A90EF60A0333}"/>
              </a:ext>
            </a:extLst>
          </p:cNvPr>
          <p:cNvSpPr txBox="1"/>
          <p:nvPr/>
        </p:nvSpPr>
        <p:spPr>
          <a:xfrm>
            <a:off x="1625071" y="3005385"/>
            <a:ext cx="30849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hodopsin 1D4 Alexa 488-A</a:t>
            </a:r>
          </a:p>
        </p:txBody>
      </p:sp>
      <p:sp>
        <p:nvSpPr>
          <p:cNvPr id="5142" name="TextBox 5141">
            <a:extLst>
              <a:ext uri="{FF2B5EF4-FFF2-40B4-BE49-F238E27FC236}">
                <a16:creationId xmlns:a16="http://schemas.microsoft.com/office/drawing/2014/main" id="{24AC46B1-1A46-0CF1-DD9B-11684FED0ABE}"/>
              </a:ext>
            </a:extLst>
          </p:cNvPr>
          <p:cNvSpPr txBox="1"/>
          <p:nvPr/>
        </p:nvSpPr>
        <p:spPr>
          <a:xfrm rot="16200000">
            <a:off x="2934331" y="1741625"/>
            <a:ext cx="18628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hodopsin 4D2 Alexa 647-A</a:t>
            </a:r>
          </a:p>
        </p:txBody>
      </p:sp>
      <p:sp>
        <p:nvSpPr>
          <p:cNvPr id="5143" name="TextBox 5142">
            <a:extLst>
              <a:ext uri="{FF2B5EF4-FFF2-40B4-BE49-F238E27FC236}">
                <a16:creationId xmlns:a16="http://schemas.microsoft.com/office/drawing/2014/main" id="{520A10E1-D858-FFE1-8F4B-819548C8281F}"/>
              </a:ext>
            </a:extLst>
          </p:cNvPr>
          <p:cNvSpPr txBox="1"/>
          <p:nvPr/>
        </p:nvSpPr>
        <p:spPr>
          <a:xfrm>
            <a:off x="4364825" y="2998571"/>
            <a:ext cx="30849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hodopsin 1D4 Alexa 488-A</a:t>
            </a:r>
          </a:p>
        </p:txBody>
      </p:sp>
    </p:spTree>
    <p:extLst>
      <p:ext uri="{BB962C8B-B14F-4D97-AF65-F5344CB8AC3E}">
        <p14:creationId xmlns:p14="http://schemas.microsoft.com/office/powerpoint/2010/main" val="11026660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4300933" y="752110"/>
            <a:ext cx="466944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: Degradation of POS after heat exposure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ile Figure 4 provided an overview of the heat degradation process, this Supplementary offers a more detailed analysis of the degradation process. POS samples were exposed to (a) 25°C, (b) 37°C, (c) 45°C, (d) 50 °C, and (e) 55°C for 30 min. (f) The histogram shows the relative distribution of the ROS population across the different heat conditions.</a:t>
            </a:r>
            <a:endParaRPr lang="en-US" sz="1100" dirty="0">
              <a:latin typeface="Times New Roman" panose="02020603050405020304" pitchFamily="18" charset="0"/>
              <a:ea typeface="Gene Sans"/>
              <a:cs typeface="Times New Roman" panose="02020603050405020304" pitchFamily="18" charset="0"/>
              <a:sym typeface="Gene Sans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173812" y="184697"/>
            <a:ext cx="4094493" cy="6044184"/>
            <a:chOff x="173812" y="184697"/>
            <a:chExt cx="4094493" cy="6044184"/>
          </a:xfrm>
        </p:grpSpPr>
        <p:grpSp>
          <p:nvGrpSpPr>
            <p:cNvPr id="2" name="Group 1"/>
            <p:cNvGrpSpPr/>
            <p:nvPr/>
          </p:nvGrpSpPr>
          <p:grpSpPr>
            <a:xfrm>
              <a:off x="320912" y="184697"/>
              <a:ext cx="3947393" cy="6044184"/>
              <a:chOff x="320912" y="184697"/>
              <a:chExt cx="3947393" cy="6044184"/>
            </a:xfrm>
          </p:grpSpPr>
          <p:graphicFrame>
            <p:nvGraphicFramePr>
              <p:cNvPr id="23" name="Object 2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963547180"/>
                  </p:ext>
                </p:extLst>
              </p:nvPr>
            </p:nvGraphicFramePr>
            <p:xfrm>
              <a:off x="2221602" y="4177566"/>
              <a:ext cx="2046703" cy="205131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78" name="Prism 9" r:id="rId3" imgW="2817362" imgH="2823539" progId="Prism9.Document">
                      <p:embed/>
                    </p:oleObj>
                  </mc:Choice>
                  <mc:Fallback>
                    <p:oleObj name="Prism 9" r:id="rId3" imgW="2817362" imgH="2823539" progId="Prism9.Document">
                      <p:embed/>
                      <p:pic>
                        <p:nvPicPr>
                          <p:cNvPr id="2" name="Object 1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2221602" y="4177566"/>
                            <a:ext cx="2046703" cy="205131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7" name="Rectangle 16"/>
              <p:cNvSpPr/>
              <p:nvPr/>
            </p:nvSpPr>
            <p:spPr>
              <a:xfrm>
                <a:off x="844550" y="6086194"/>
                <a:ext cx="1032309" cy="13045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Rectangle 20"/>
              <p:cNvSpPr/>
              <p:nvPr/>
            </p:nvSpPr>
            <p:spPr>
              <a:xfrm>
                <a:off x="843418" y="4465096"/>
                <a:ext cx="920750" cy="1127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2784580" y="2553415"/>
                <a:ext cx="920750" cy="1127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336410" y="2909376"/>
                <a:ext cx="152271" cy="121131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336410" y="4589307"/>
                <a:ext cx="152271" cy="121131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2228481" y="2811164"/>
                <a:ext cx="152271" cy="121131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" name="Rectangle 32"/>
              <p:cNvSpPr/>
              <p:nvPr/>
            </p:nvSpPr>
            <p:spPr>
              <a:xfrm>
                <a:off x="841651" y="4221934"/>
                <a:ext cx="1032309" cy="13045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" name="Rectangle 33"/>
              <p:cNvSpPr/>
              <p:nvPr/>
            </p:nvSpPr>
            <p:spPr>
              <a:xfrm>
                <a:off x="2728800" y="4185039"/>
                <a:ext cx="1032309" cy="13045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904833" y="2593844"/>
                <a:ext cx="1032309" cy="13045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841650" y="2379992"/>
                <a:ext cx="1032309" cy="13045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2785988" y="2392121"/>
                <a:ext cx="1032309" cy="13045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" name="Rectangle 37"/>
              <p:cNvSpPr/>
              <p:nvPr/>
            </p:nvSpPr>
            <p:spPr>
              <a:xfrm>
                <a:off x="2811131" y="717256"/>
                <a:ext cx="1032309" cy="13045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9" name="Rectangle 38"/>
              <p:cNvSpPr/>
              <p:nvPr/>
            </p:nvSpPr>
            <p:spPr>
              <a:xfrm>
                <a:off x="740305" y="752110"/>
                <a:ext cx="1032309" cy="13045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0" name="Rectangle 39"/>
              <p:cNvSpPr/>
              <p:nvPr/>
            </p:nvSpPr>
            <p:spPr>
              <a:xfrm>
                <a:off x="2228480" y="924422"/>
                <a:ext cx="152271" cy="121131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1" name="Rectangle 40"/>
              <p:cNvSpPr/>
              <p:nvPr/>
            </p:nvSpPr>
            <p:spPr>
              <a:xfrm>
                <a:off x="320912" y="1048609"/>
                <a:ext cx="152271" cy="121131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2" name="Rectangle 41"/>
              <p:cNvSpPr/>
              <p:nvPr/>
            </p:nvSpPr>
            <p:spPr>
              <a:xfrm>
                <a:off x="370348" y="2250769"/>
                <a:ext cx="163730" cy="152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3" name="Rectangle 42"/>
              <p:cNvSpPr/>
              <p:nvPr/>
            </p:nvSpPr>
            <p:spPr>
              <a:xfrm>
                <a:off x="2266180" y="2261339"/>
                <a:ext cx="186800" cy="13078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4" name="Rectangle 43"/>
              <p:cNvSpPr/>
              <p:nvPr/>
            </p:nvSpPr>
            <p:spPr>
              <a:xfrm>
                <a:off x="370348" y="4110553"/>
                <a:ext cx="173890" cy="1458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5" name="Rectangle 44"/>
              <p:cNvSpPr/>
              <p:nvPr/>
            </p:nvSpPr>
            <p:spPr>
              <a:xfrm>
                <a:off x="2261100" y="4075403"/>
                <a:ext cx="186800" cy="13078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6" name="Rectangle 45"/>
              <p:cNvSpPr/>
              <p:nvPr/>
            </p:nvSpPr>
            <p:spPr>
              <a:xfrm>
                <a:off x="370348" y="5973988"/>
                <a:ext cx="173890" cy="1458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 rot="16200000">
                <a:off x="-466104" y="1016083"/>
                <a:ext cx="186282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odopsin 4D2 Alexa 647-A</a:t>
                </a: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 rot="16200000">
                <a:off x="-494682" y="2884617"/>
                <a:ext cx="186282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odopsin 4D2 Alexa 647-A</a:t>
                </a: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 rot="16200000">
                <a:off x="-505815" y="4556813"/>
                <a:ext cx="186282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odopsin 4D2 Alexa 647-A</a:t>
                </a: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593163" y="5837948"/>
                <a:ext cx="308494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odopsin 1D4 Alexa 488-A</a:t>
                </a: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2795224" y="5832968"/>
                <a:ext cx="1395540" cy="20005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emperature (</a:t>
                </a:r>
                <a:r>
                  <a:rPr lang="en-US" sz="700" dirty="0">
                    <a:latin typeface="Times New Roman" panose="02020603050405020304" pitchFamily="18" charset="0"/>
                    <a:ea typeface="Gene Sans"/>
                    <a:cs typeface="Times New Roman" panose="02020603050405020304" pitchFamily="18" charset="0"/>
                    <a:sym typeface="Gene Sans"/>
                  </a:rPr>
                  <a:t>°C</a:t>
                </a:r>
                <a:r>
                  <a:rPr lang="en-US" sz="700" dirty="0">
                    <a:latin typeface="Times New Roman" panose="02020603050405020304" pitchFamily="18" charset="0"/>
                    <a:cs typeface="Times New Roman" panose="02020603050405020304" pitchFamily="18" charset="0"/>
                    <a:sym typeface="Gene Sans"/>
                  </a:rPr>
                  <a:t>)</a:t>
                </a:r>
                <a:endParaRPr lang="en-US" sz="700" dirty="0">
                  <a:latin typeface="Times New Roman" panose="02020603050405020304" pitchFamily="18" charset="0"/>
                  <a:ea typeface="Gene Sans"/>
                  <a:cs typeface="Times New Roman" panose="02020603050405020304" pitchFamily="18" charset="0"/>
                  <a:sym typeface="Gene Sans"/>
                </a:endParaRPr>
              </a:p>
            </p:txBody>
          </p:sp>
        </p:grpSp>
        <p:sp>
          <p:nvSpPr>
            <p:cNvPr id="53" name="TextBox 52"/>
            <p:cNvSpPr txBox="1"/>
            <p:nvPr/>
          </p:nvSpPr>
          <p:spPr>
            <a:xfrm>
              <a:off x="176802" y="614930"/>
              <a:ext cx="4758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78481" y="2512268"/>
              <a:ext cx="4758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73812" y="4195486"/>
              <a:ext cx="4758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)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155263" y="4215767"/>
              <a:ext cx="4758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f)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2048113" y="2457447"/>
              <a:ext cx="4758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e)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2101851" y="627169"/>
              <a:ext cx="4758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d)</a:t>
              </a:r>
            </a:p>
          </p:txBody>
        </p:sp>
      </p:grpSp>
      <p:sp>
        <p:nvSpPr>
          <p:cNvPr id="51" name="TextBox 50"/>
          <p:cNvSpPr txBox="1"/>
          <p:nvPr/>
        </p:nvSpPr>
        <p:spPr>
          <a:xfrm>
            <a:off x="2509529" y="4105758"/>
            <a:ext cx="30849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hodopsin 1D4 Alexa 488-A</a:t>
            </a:r>
          </a:p>
        </p:txBody>
      </p:sp>
      <p:pic>
        <p:nvPicPr>
          <p:cNvPr id="6173" name="Picture 9">
            <a:extLst>
              <a:ext uri="{FF2B5EF4-FFF2-40B4-BE49-F238E27FC236}">
                <a16:creationId xmlns:a16="http://schemas.microsoft.com/office/drawing/2014/main" id="{6A6FE713-5B5E-E415-E9A9-89B75723D21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98" t="6388" r="4184" b="6257"/>
          <a:stretch/>
        </p:blipFill>
        <p:spPr bwMode="auto">
          <a:xfrm>
            <a:off x="2296016" y="842513"/>
            <a:ext cx="1579331" cy="15249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174" name="Google Shape;1564;g23c6e7809d4_0_831">
            <a:extLst>
              <a:ext uri="{FF2B5EF4-FFF2-40B4-BE49-F238E27FC236}">
                <a16:creationId xmlns:a16="http://schemas.microsoft.com/office/drawing/2014/main" id="{CB2B944A-2AE0-3682-04AA-C06A4770534A}"/>
              </a:ext>
            </a:extLst>
          </p:cNvPr>
          <p:cNvSpPr txBox="1"/>
          <p:nvPr/>
        </p:nvSpPr>
        <p:spPr>
          <a:xfrm>
            <a:off x="2922729" y="757852"/>
            <a:ext cx="565200" cy="4616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sz="1200" b="1" dirty="0">
                <a:solidFill>
                  <a:srgbClr val="980000"/>
                </a:solidFill>
                <a:latin typeface="Gene Sans"/>
                <a:ea typeface="Gene Sans"/>
                <a:cs typeface="Gene Sans"/>
                <a:sym typeface="Gene Sans"/>
              </a:rPr>
              <a:t>50°C</a:t>
            </a:r>
            <a:endParaRPr lang="en-US" sz="1200" dirty="0">
              <a:solidFill>
                <a:srgbClr val="980000"/>
              </a:solidFill>
              <a:latin typeface="Gene Sans"/>
              <a:ea typeface="Gene Sans"/>
              <a:cs typeface="Gene Sans"/>
              <a:sym typeface="Gene Sans"/>
            </a:endParaRPr>
          </a:p>
        </p:txBody>
      </p:sp>
      <p:grpSp>
        <p:nvGrpSpPr>
          <p:cNvPr id="6175" name="Group 6174">
            <a:extLst>
              <a:ext uri="{FF2B5EF4-FFF2-40B4-BE49-F238E27FC236}">
                <a16:creationId xmlns:a16="http://schemas.microsoft.com/office/drawing/2014/main" id="{F9B5A610-8171-5C50-05EA-7AEBEBF2B118}"/>
              </a:ext>
            </a:extLst>
          </p:cNvPr>
          <p:cNvGrpSpPr/>
          <p:nvPr/>
        </p:nvGrpSpPr>
        <p:grpSpPr>
          <a:xfrm>
            <a:off x="328620" y="846266"/>
            <a:ext cx="1753147" cy="1719169"/>
            <a:chOff x="1004518" y="2210302"/>
            <a:chExt cx="1698925" cy="1719169"/>
          </a:xfrm>
        </p:grpSpPr>
        <p:pic>
          <p:nvPicPr>
            <p:cNvPr id="6176" name="Picture 6">
              <a:extLst>
                <a:ext uri="{FF2B5EF4-FFF2-40B4-BE49-F238E27FC236}">
                  <a16:creationId xmlns:a16="http://schemas.microsoft.com/office/drawing/2014/main" id="{5109F168-5BC1-C5E6-AACC-C2F009E928D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79" t="6738" r="4498" b="6334"/>
            <a:stretch/>
          </p:blipFill>
          <p:spPr bwMode="auto">
            <a:xfrm>
              <a:off x="1172958" y="2213712"/>
              <a:ext cx="1530485" cy="152215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177" name="Picture 6176">
              <a:extLst>
                <a:ext uri="{FF2B5EF4-FFF2-40B4-BE49-F238E27FC236}">
                  <a16:creationId xmlns:a16="http://schemas.microsoft.com/office/drawing/2014/main" id="{270D3C62-D9EC-E206-0906-7656C60B303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4518" y="3592989"/>
              <a:ext cx="239177" cy="234372"/>
            </a:xfrm>
            <a:prstGeom prst="rect">
              <a:avLst/>
            </a:prstGeom>
          </p:spPr>
        </p:pic>
        <p:pic>
          <p:nvPicPr>
            <p:cNvPr id="6178" name="Picture 6177">
              <a:extLst>
                <a:ext uri="{FF2B5EF4-FFF2-40B4-BE49-F238E27FC236}">
                  <a16:creationId xmlns:a16="http://schemas.microsoft.com/office/drawing/2014/main" id="{8E4E480D-521B-89F2-0788-3C00C9DA692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1291" y="3756607"/>
              <a:ext cx="239177" cy="172864"/>
            </a:xfrm>
            <a:prstGeom prst="rect">
              <a:avLst/>
            </a:prstGeom>
          </p:spPr>
        </p:pic>
        <p:sp>
          <p:nvSpPr>
            <p:cNvPr id="6179" name="Rectangle 6178">
              <a:extLst>
                <a:ext uri="{FF2B5EF4-FFF2-40B4-BE49-F238E27FC236}">
                  <a16:creationId xmlns:a16="http://schemas.microsoft.com/office/drawing/2014/main" id="{954B9000-9E33-9EFC-9BED-425ED5751E71}"/>
                </a:ext>
              </a:extLst>
            </p:cNvPr>
            <p:cNvSpPr/>
            <p:nvPr/>
          </p:nvSpPr>
          <p:spPr>
            <a:xfrm>
              <a:off x="1676467" y="3262259"/>
              <a:ext cx="1026976" cy="355469"/>
            </a:xfrm>
            <a:prstGeom prst="rect">
              <a:avLst/>
            </a:prstGeom>
            <a:noFill/>
            <a:ln w="6350">
              <a:solidFill>
                <a:srgbClr val="0432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80" name="Rectangle 6179">
              <a:extLst>
                <a:ext uri="{FF2B5EF4-FFF2-40B4-BE49-F238E27FC236}">
                  <a16:creationId xmlns:a16="http://schemas.microsoft.com/office/drawing/2014/main" id="{22B9EAA3-E158-557B-5D37-72159085D4D7}"/>
                </a:ext>
              </a:extLst>
            </p:cNvPr>
            <p:cNvSpPr/>
            <p:nvPr/>
          </p:nvSpPr>
          <p:spPr>
            <a:xfrm>
              <a:off x="1288846" y="3262259"/>
              <a:ext cx="389493" cy="349070"/>
            </a:xfrm>
            <a:prstGeom prst="rect">
              <a:avLst/>
            </a:prstGeom>
            <a:noFill/>
            <a:ln w="63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81" name="Rectangle 6180">
              <a:extLst>
                <a:ext uri="{FF2B5EF4-FFF2-40B4-BE49-F238E27FC236}">
                  <a16:creationId xmlns:a16="http://schemas.microsoft.com/office/drawing/2014/main" id="{40D63054-DD5F-FAC4-78D5-E038A99A8669}"/>
                </a:ext>
              </a:extLst>
            </p:cNvPr>
            <p:cNvSpPr/>
            <p:nvPr/>
          </p:nvSpPr>
          <p:spPr>
            <a:xfrm>
              <a:off x="1286974" y="2210302"/>
              <a:ext cx="389493" cy="1051958"/>
            </a:xfrm>
            <a:prstGeom prst="rect">
              <a:avLst/>
            </a:prstGeom>
            <a:noFill/>
            <a:ln w="6350"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82" name="Rectangle 6181">
              <a:extLst>
                <a:ext uri="{FF2B5EF4-FFF2-40B4-BE49-F238E27FC236}">
                  <a16:creationId xmlns:a16="http://schemas.microsoft.com/office/drawing/2014/main" id="{288BBC9F-28B3-5A87-CB5B-195E2082A403}"/>
                </a:ext>
              </a:extLst>
            </p:cNvPr>
            <p:cNvSpPr/>
            <p:nvPr/>
          </p:nvSpPr>
          <p:spPr>
            <a:xfrm>
              <a:off x="1678339" y="2212134"/>
              <a:ext cx="1025104" cy="1051355"/>
            </a:xfrm>
            <a:prstGeom prst="rect">
              <a:avLst/>
            </a:prstGeom>
            <a:noFill/>
            <a:ln w="635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183" name="TextBox 6182">
            <a:extLst>
              <a:ext uri="{FF2B5EF4-FFF2-40B4-BE49-F238E27FC236}">
                <a16:creationId xmlns:a16="http://schemas.microsoft.com/office/drawing/2014/main" id="{AB900927-4705-71D6-D456-CCB8BAAE46F5}"/>
              </a:ext>
            </a:extLst>
          </p:cNvPr>
          <p:cNvSpPr txBox="1"/>
          <p:nvPr/>
        </p:nvSpPr>
        <p:spPr>
          <a:xfrm>
            <a:off x="1772900" y="1989699"/>
            <a:ext cx="4932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S</a:t>
            </a:r>
          </a:p>
        </p:txBody>
      </p:sp>
      <p:sp>
        <p:nvSpPr>
          <p:cNvPr id="6184" name="Google Shape;1564;g23c6e7809d4_0_831">
            <a:extLst>
              <a:ext uri="{FF2B5EF4-FFF2-40B4-BE49-F238E27FC236}">
                <a16:creationId xmlns:a16="http://schemas.microsoft.com/office/drawing/2014/main" id="{B78BA1A0-4136-9DF4-C1BD-23FF9E509CA0}"/>
              </a:ext>
            </a:extLst>
          </p:cNvPr>
          <p:cNvSpPr txBox="1"/>
          <p:nvPr/>
        </p:nvSpPr>
        <p:spPr>
          <a:xfrm>
            <a:off x="1267580" y="757852"/>
            <a:ext cx="565200" cy="4616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sz="1200" b="1" dirty="0">
                <a:solidFill>
                  <a:srgbClr val="980000"/>
                </a:solidFill>
                <a:latin typeface="Gene Sans"/>
                <a:ea typeface="Gene Sans"/>
                <a:cs typeface="Gene Sans"/>
                <a:sym typeface="Gene Sans"/>
              </a:rPr>
              <a:t>25°C</a:t>
            </a:r>
            <a:endParaRPr lang="en-US" sz="1200" dirty="0">
              <a:solidFill>
                <a:srgbClr val="980000"/>
              </a:solidFill>
              <a:latin typeface="Gene Sans"/>
              <a:ea typeface="Gene Sans"/>
              <a:cs typeface="Gene Sans"/>
              <a:sym typeface="Gene Sans"/>
            </a:endParaRPr>
          </a:p>
        </p:txBody>
      </p:sp>
      <p:pic>
        <p:nvPicPr>
          <p:cNvPr id="6185" name="Picture 5">
            <a:extLst>
              <a:ext uri="{FF2B5EF4-FFF2-40B4-BE49-F238E27FC236}">
                <a16:creationId xmlns:a16="http://schemas.microsoft.com/office/drawing/2014/main" id="{139A3820-2998-6055-7AE0-9F22623631C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36" t="6658" r="3596" b="6410"/>
          <a:stretch/>
        </p:blipFill>
        <p:spPr bwMode="auto">
          <a:xfrm>
            <a:off x="502436" y="2615803"/>
            <a:ext cx="1579331" cy="15196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186" name="Rectangle 6185">
            <a:extLst>
              <a:ext uri="{FF2B5EF4-FFF2-40B4-BE49-F238E27FC236}">
                <a16:creationId xmlns:a16="http://schemas.microsoft.com/office/drawing/2014/main" id="{F18572FB-75CD-7EA2-4A47-1D59FB7C9494}"/>
              </a:ext>
            </a:extLst>
          </p:cNvPr>
          <p:cNvSpPr/>
          <p:nvPr/>
        </p:nvSpPr>
        <p:spPr>
          <a:xfrm>
            <a:off x="1009473" y="3671812"/>
            <a:ext cx="1072294" cy="337657"/>
          </a:xfrm>
          <a:prstGeom prst="rect">
            <a:avLst/>
          </a:prstGeom>
          <a:noFill/>
          <a:ln w="6350">
            <a:solidFill>
              <a:srgbClr val="0432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87" name="Rectangle 6186">
            <a:extLst>
              <a:ext uri="{FF2B5EF4-FFF2-40B4-BE49-F238E27FC236}">
                <a16:creationId xmlns:a16="http://schemas.microsoft.com/office/drawing/2014/main" id="{89799F17-08CB-F8C5-E09B-A9A689A86E3D}"/>
              </a:ext>
            </a:extLst>
          </p:cNvPr>
          <p:cNvSpPr/>
          <p:nvPr/>
        </p:nvSpPr>
        <p:spPr>
          <a:xfrm>
            <a:off x="620092" y="3671812"/>
            <a:ext cx="389382" cy="337657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88" name="TextBox 6187">
            <a:extLst>
              <a:ext uri="{FF2B5EF4-FFF2-40B4-BE49-F238E27FC236}">
                <a16:creationId xmlns:a16="http://schemas.microsoft.com/office/drawing/2014/main" id="{C06B0323-BE74-C1F9-3BED-93C0429F2675}"/>
              </a:ext>
            </a:extLst>
          </p:cNvPr>
          <p:cNvSpPr txBox="1"/>
          <p:nvPr/>
        </p:nvSpPr>
        <p:spPr>
          <a:xfrm>
            <a:off x="1773253" y="3763280"/>
            <a:ext cx="5633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S</a:t>
            </a:r>
          </a:p>
        </p:txBody>
      </p:sp>
      <p:sp>
        <p:nvSpPr>
          <p:cNvPr id="6189" name="Rectangle 6188">
            <a:extLst>
              <a:ext uri="{FF2B5EF4-FFF2-40B4-BE49-F238E27FC236}">
                <a16:creationId xmlns:a16="http://schemas.microsoft.com/office/drawing/2014/main" id="{A0B36600-D96D-AD67-03DA-7D4041FBABDD}"/>
              </a:ext>
            </a:extLst>
          </p:cNvPr>
          <p:cNvSpPr/>
          <p:nvPr/>
        </p:nvSpPr>
        <p:spPr>
          <a:xfrm>
            <a:off x="620092" y="2626943"/>
            <a:ext cx="389381" cy="1044869"/>
          </a:xfrm>
          <a:prstGeom prst="rect">
            <a:avLst/>
          </a:prstGeom>
          <a:noFill/>
          <a:ln w="635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90" name="Rectangle 6189">
            <a:extLst>
              <a:ext uri="{FF2B5EF4-FFF2-40B4-BE49-F238E27FC236}">
                <a16:creationId xmlns:a16="http://schemas.microsoft.com/office/drawing/2014/main" id="{0223FE31-3E48-739C-165D-C830DA9E73F2}"/>
              </a:ext>
            </a:extLst>
          </p:cNvPr>
          <p:cNvSpPr/>
          <p:nvPr/>
        </p:nvSpPr>
        <p:spPr>
          <a:xfrm>
            <a:off x="1009473" y="2626943"/>
            <a:ext cx="1072294" cy="1044869"/>
          </a:xfrm>
          <a:prstGeom prst="rect">
            <a:avLst/>
          </a:prstGeom>
          <a:noFill/>
          <a:ln w="635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191" name="Picture 7">
            <a:extLst>
              <a:ext uri="{FF2B5EF4-FFF2-40B4-BE49-F238E27FC236}">
                <a16:creationId xmlns:a16="http://schemas.microsoft.com/office/drawing/2014/main" id="{1DA4F659-914B-65CF-DADF-AFBE2D0FDE3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41" t="6883" r="3530" b="6247"/>
          <a:stretch/>
        </p:blipFill>
        <p:spPr bwMode="auto">
          <a:xfrm>
            <a:off x="502435" y="4322988"/>
            <a:ext cx="1579331" cy="15196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92" name="Picture 6191">
            <a:extLst>
              <a:ext uri="{FF2B5EF4-FFF2-40B4-BE49-F238E27FC236}">
                <a16:creationId xmlns:a16="http://schemas.microsoft.com/office/drawing/2014/main" id="{5B430B6F-2366-2A9F-AAAB-11DB25258DCA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484" y="4007583"/>
            <a:ext cx="246810" cy="234372"/>
          </a:xfrm>
          <a:prstGeom prst="rect">
            <a:avLst/>
          </a:prstGeom>
        </p:spPr>
      </p:pic>
      <p:pic>
        <p:nvPicPr>
          <p:cNvPr id="6193" name="Picture 6192">
            <a:extLst>
              <a:ext uri="{FF2B5EF4-FFF2-40B4-BE49-F238E27FC236}">
                <a16:creationId xmlns:a16="http://schemas.microsoft.com/office/drawing/2014/main" id="{BB7ACA49-8701-65F7-C361-3E2F0D01B41F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22" y="4171201"/>
            <a:ext cx="246810" cy="172864"/>
          </a:xfrm>
          <a:prstGeom prst="rect">
            <a:avLst/>
          </a:prstGeom>
        </p:spPr>
      </p:pic>
      <p:sp>
        <p:nvSpPr>
          <p:cNvPr id="6194" name="Google Shape;1564;g23c6e7809d4_0_831">
            <a:extLst>
              <a:ext uri="{FF2B5EF4-FFF2-40B4-BE49-F238E27FC236}">
                <a16:creationId xmlns:a16="http://schemas.microsoft.com/office/drawing/2014/main" id="{06FB5DDF-8816-9DD1-E84C-9D9EDE8D1417}"/>
              </a:ext>
            </a:extLst>
          </p:cNvPr>
          <p:cNvSpPr txBox="1"/>
          <p:nvPr/>
        </p:nvSpPr>
        <p:spPr>
          <a:xfrm>
            <a:off x="1292533" y="2571125"/>
            <a:ext cx="565200" cy="4616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sz="1200" b="1" dirty="0">
                <a:solidFill>
                  <a:srgbClr val="980000"/>
                </a:solidFill>
                <a:latin typeface="Gene Sans"/>
                <a:ea typeface="Gene Sans"/>
                <a:cs typeface="Gene Sans"/>
                <a:sym typeface="Gene Sans"/>
              </a:rPr>
              <a:t>37°C</a:t>
            </a:r>
            <a:endParaRPr lang="en-US" sz="1200" dirty="0">
              <a:solidFill>
                <a:srgbClr val="980000"/>
              </a:solidFill>
              <a:latin typeface="Gene Sans"/>
              <a:ea typeface="Gene Sans"/>
              <a:cs typeface="Gene Sans"/>
              <a:sym typeface="Gene Sans"/>
            </a:endParaRPr>
          </a:p>
        </p:txBody>
      </p:sp>
      <p:sp>
        <p:nvSpPr>
          <p:cNvPr id="6195" name="Rectangle 6194">
            <a:extLst>
              <a:ext uri="{FF2B5EF4-FFF2-40B4-BE49-F238E27FC236}">
                <a16:creationId xmlns:a16="http://schemas.microsoft.com/office/drawing/2014/main" id="{D17DC9FE-F674-6DD7-FF8D-F2BD0AA9D254}"/>
              </a:ext>
            </a:extLst>
          </p:cNvPr>
          <p:cNvSpPr/>
          <p:nvPr/>
        </p:nvSpPr>
        <p:spPr>
          <a:xfrm>
            <a:off x="1007600" y="5367329"/>
            <a:ext cx="1074165" cy="348453"/>
          </a:xfrm>
          <a:prstGeom prst="rect">
            <a:avLst/>
          </a:prstGeom>
          <a:noFill/>
          <a:ln w="6350">
            <a:solidFill>
              <a:srgbClr val="0432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96" name="Rectangle 6195">
            <a:extLst>
              <a:ext uri="{FF2B5EF4-FFF2-40B4-BE49-F238E27FC236}">
                <a16:creationId xmlns:a16="http://schemas.microsoft.com/office/drawing/2014/main" id="{BDD1E184-491E-F147-2889-C96EE080964F}"/>
              </a:ext>
            </a:extLst>
          </p:cNvPr>
          <p:cNvSpPr/>
          <p:nvPr/>
        </p:nvSpPr>
        <p:spPr>
          <a:xfrm>
            <a:off x="609929" y="5367329"/>
            <a:ext cx="399544" cy="348453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97" name="TextBox 6196">
            <a:extLst>
              <a:ext uri="{FF2B5EF4-FFF2-40B4-BE49-F238E27FC236}">
                <a16:creationId xmlns:a16="http://schemas.microsoft.com/office/drawing/2014/main" id="{555B2948-D384-627F-AE23-0149E32B4022}"/>
              </a:ext>
            </a:extLst>
          </p:cNvPr>
          <p:cNvSpPr txBox="1"/>
          <p:nvPr/>
        </p:nvSpPr>
        <p:spPr>
          <a:xfrm>
            <a:off x="1772899" y="5464566"/>
            <a:ext cx="4932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S</a:t>
            </a:r>
          </a:p>
        </p:txBody>
      </p:sp>
      <p:sp>
        <p:nvSpPr>
          <p:cNvPr id="6198" name="Rectangle 6197">
            <a:extLst>
              <a:ext uri="{FF2B5EF4-FFF2-40B4-BE49-F238E27FC236}">
                <a16:creationId xmlns:a16="http://schemas.microsoft.com/office/drawing/2014/main" id="{ADE6BA71-F31C-1E0A-171A-D1E03ACE5A1E}"/>
              </a:ext>
            </a:extLst>
          </p:cNvPr>
          <p:cNvSpPr/>
          <p:nvPr/>
        </p:nvSpPr>
        <p:spPr>
          <a:xfrm>
            <a:off x="608057" y="4331486"/>
            <a:ext cx="399544" cy="1035843"/>
          </a:xfrm>
          <a:prstGeom prst="rect">
            <a:avLst/>
          </a:prstGeom>
          <a:noFill/>
          <a:ln w="635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99" name="Rectangle 6198">
            <a:extLst>
              <a:ext uri="{FF2B5EF4-FFF2-40B4-BE49-F238E27FC236}">
                <a16:creationId xmlns:a16="http://schemas.microsoft.com/office/drawing/2014/main" id="{FE6FFCEE-E893-AEA9-3B6C-4D8980E98A61}"/>
              </a:ext>
            </a:extLst>
          </p:cNvPr>
          <p:cNvSpPr/>
          <p:nvPr/>
        </p:nvSpPr>
        <p:spPr>
          <a:xfrm>
            <a:off x="1009472" y="4332715"/>
            <a:ext cx="1072293" cy="1034614"/>
          </a:xfrm>
          <a:prstGeom prst="rect">
            <a:avLst/>
          </a:prstGeom>
          <a:noFill/>
          <a:ln w="635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00" name="Google Shape;1564;g23c6e7809d4_0_831">
            <a:extLst>
              <a:ext uri="{FF2B5EF4-FFF2-40B4-BE49-F238E27FC236}">
                <a16:creationId xmlns:a16="http://schemas.microsoft.com/office/drawing/2014/main" id="{2CE13DBA-84C1-35BE-CE1A-990FDC9CC5AF}"/>
              </a:ext>
            </a:extLst>
          </p:cNvPr>
          <p:cNvSpPr txBox="1"/>
          <p:nvPr/>
        </p:nvSpPr>
        <p:spPr>
          <a:xfrm>
            <a:off x="1262082" y="4303964"/>
            <a:ext cx="565200" cy="4616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sz="1200" b="1" dirty="0">
                <a:solidFill>
                  <a:srgbClr val="980000"/>
                </a:solidFill>
                <a:latin typeface="Gene Sans"/>
                <a:ea typeface="Gene Sans"/>
                <a:cs typeface="Gene Sans"/>
                <a:sym typeface="Gene Sans"/>
              </a:rPr>
              <a:t>45°C</a:t>
            </a:r>
            <a:endParaRPr lang="en-US" sz="1200" dirty="0">
              <a:solidFill>
                <a:srgbClr val="980000"/>
              </a:solidFill>
              <a:latin typeface="Gene Sans"/>
              <a:ea typeface="Gene Sans"/>
              <a:cs typeface="Gene Sans"/>
              <a:sym typeface="Gene Sans"/>
            </a:endParaRPr>
          </a:p>
        </p:txBody>
      </p:sp>
      <p:pic>
        <p:nvPicPr>
          <p:cNvPr id="6201" name="Picture 6200">
            <a:extLst>
              <a:ext uri="{FF2B5EF4-FFF2-40B4-BE49-F238E27FC236}">
                <a16:creationId xmlns:a16="http://schemas.microsoft.com/office/drawing/2014/main" id="{38A17481-24A9-8DF8-139A-639B1BECCA0B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353" y="5715782"/>
            <a:ext cx="246810" cy="234372"/>
          </a:xfrm>
          <a:prstGeom prst="rect">
            <a:avLst/>
          </a:prstGeom>
        </p:spPr>
      </p:pic>
      <p:pic>
        <p:nvPicPr>
          <p:cNvPr id="6203" name="Picture 6202">
            <a:extLst>
              <a:ext uri="{FF2B5EF4-FFF2-40B4-BE49-F238E27FC236}">
                <a16:creationId xmlns:a16="http://schemas.microsoft.com/office/drawing/2014/main" id="{FB7FEF33-C02E-DE81-0B7E-01D03E9F66D7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8638" y="2242232"/>
            <a:ext cx="246810" cy="234372"/>
          </a:xfrm>
          <a:prstGeom prst="rect">
            <a:avLst/>
          </a:prstGeom>
        </p:spPr>
      </p:pic>
      <p:pic>
        <p:nvPicPr>
          <p:cNvPr id="6204" name="Picture 6203">
            <a:extLst>
              <a:ext uri="{FF2B5EF4-FFF2-40B4-BE49-F238E27FC236}">
                <a16:creationId xmlns:a16="http://schemas.microsoft.com/office/drawing/2014/main" id="{1D5A5C4D-C19D-61A0-7A47-4550241A505E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6720" y="2405850"/>
            <a:ext cx="246810" cy="172864"/>
          </a:xfrm>
          <a:prstGeom prst="rect">
            <a:avLst/>
          </a:prstGeom>
        </p:spPr>
      </p:pic>
      <p:sp>
        <p:nvSpPr>
          <p:cNvPr id="6205" name="Rectangle 6204">
            <a:extLst>
              <a:ext uri="{FF2B5EF4-FFF2-40B4-BE49-F238E27FC236}">
                <a16:creationId xmlns:a16="http://schemas.microsoft.com/office/drawing/2014/main" id="{5C3F7D12-898C-BBD5-0E9A-E074E0003FB4}"/>
              </a:ext>
            </a:extLst>
          </p:cNvPr>
          <p:cNvSpPr/>
          <p:nvPr/>
        </p:nvSpPr>
        <p:spPr>
          <a:xfrm>
            <a:off x="2801958" y="1894569"/>
            <a:ext cx="1073390" cy="347661"/>
          </a:xfrm>
          <a:prstGeom prst="rect">
            <a:avLst/>
          </a:prstGeom>
          <a:noFill/>
          <a:ln w="6350">
            <a:solidFill>
              <a:srgbClr val="0432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06" name="Rectangle 6205">
            <a:extLst>
              <a:ext uri="{FF2B5EF4-FFF2-40B4-BE49-F238E27FC236}">
                <a16:creationId xmlns:a16="http://schemas.microsoft.com/office/drawing/2014/main" id="{2FB6645F-2B96-2C8B-A057-2BA5275EB461}"/>
              </a:ext>
            </a:extLst>
          </p:cNvPr>
          <p:cNvSpPr/>
          <p:nvPr/>
        </p:nvSpPr>
        <p:spPr>
          <a:xfrm>
            <a:off x="2403511" y="1894570"/>
            <a:ext cx="400909" cy="34766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07" name="TextBox 6206">
            <a:extLst>
              <a:ext uri="{FF2B5EF4-FFF2-40B4-BE49-F238E27FC236}">
                <a16:creationId xmlns:a16="http://schemas.microsoft.com/office/drawing/2014/main" id="{51D3F25C-1F5F-B822-D13A-23AC5ABCF8BA}"/>
              </a:ext>
            </a:extLst>
          </p:cNvPr>
          <p:cNvSpPr txBox="1"/>
          <p:nvPr/>
        </p:nvSpPr>
        <p:spPr>
          <a:xfrm>
            <a:off x="3538928" y="1984957"/>
            <a:ext cx="4932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S</a:t>
            </a:r>
          </a:p>
        </p:txBody>
      </p:sp>
      <p:sp>
        <p:nvSpPr>
          <p:cNvPr id="6208" name="Rectangle 6207">
            <a:extLst>
              <a:ext uri="{FF2B5EF4-FFF2-40B4-BE49-F238E27FC236}">
                <a16:creationId xmlns:a16="http://schemas.microsoft.com/office/drawing/2014/main" id="{727A4098-6FBC-3291-38FE-4449BADAEABE}"/>
              </a:ext>
            </a:extLst>
          </p:cNvPr>
          <p:cNvSpPr/>
          <p:nvPr/>
        </p:nvSpPr>
        <p:spPr>
          <a:xfrm>
            <a:off x="2401639" y="845066"/>
            <a:ext cx="402781" cy="1049504"/>
          </a:xfrm>
          <a:prstGeom prst="rect">
            <a:avLst/>
          </a:prstGeom>
          <a:noFill/>
          <a:ln w="635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09" name="Rectangle 6208">
            <a:extLst>
              <a:ext uri="{FF2B5EF4-FFF2-40B4-BE49-F238E27FC236}">
                <a16:creationId xmlns:a16="http://schemas.microsoft.com/office/drawing/2014/main" id="{63D5ED35-93BE-1EEB-6A99-F8FE0E7A5BFF}"/>
              </a:ext>
            </a:extLst>
          </p:cNvPr>
          <p:cNvSpPr/>
          <p:nvPr/>
        </p:nvSpPr>
        <p:spPr>
          <a:xfrm>
            <a:off x="2804420" y="846266"/>
            <a:ext cx="1070928" cy="1048301"/>
          </a:xfrm>
          <a:prstGeom prst="rect">
            <a:avLst/>
          </a:prstGeom>
          <a:noFill/>
          <a:ln w="635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210" name="Picture 11">
            <a:extLst>
              <a:ext uri="{FF2B5EF4-FFF2-40B4-BE49-F238E27FC236}">
                <a16:creationId xmlns:a16="http://schemas.microsoft.com/office/drawing/2014/main" id="{6D380CBA-9EB3-5D72-83A5-F964BBA5F9E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19" t="6800" r="3006" b="6471"/>
          <a:stretch/>
        </p:blipFill>
        <p:spPr bwMode="auto">
          <a:xfrm>
            <a:off x="2299663" y="2615293"/>
            <a:ext cx="1587314" cy="15196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211" name="Rectangle 6210">
            <a:extLst>
              <a:ext uri="{FF2B5EF4-FFF2-40B4-BE49-F238E27FC236}">
                <a16:creationId xmlns:a16="http://schemas.microsoft.com/office/drawing/2014/main" id="{52DEB978-4848-AD74-A468-F4B3BB375F05}"/>
              </a:ext>
            </a:extLst>
          </p:cNvPr>
          <p:cNvSpPr/>
          <p:nvPr/>
        </p:nvSpPr>
        <p:spPr>
          <a:xfrm>
            <a:off x="2806381" y="3671812"/>
            <a:ext cx="1080596" cy="335770"/>
          </a:xfrm>
          <a:prstGeom prst="rect">
            <a:avLst/>
          </a:prstGeom>
          <a:noFill/>
          <a:ln w="6350">
            <a:solidFill>
              <a:srgbClr val="0432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12" name="Rectangle 6211">
            <a:extLst>
              <a:ext uri="{FF2B5EF4-FFF2-40B4-BE49-F238E27FC236}">
                <a16:creationId xmlns:a16="http://schemas.microsoft.com/office/drawing/2014/main" id="{BE96186D-EA19-6689-B59B-E7CAA1B07E49}"/>
              </a:ext>
            </a:extLst>
          </p:cNvPr>
          <p:cNvSpPr/>
          <p:nvPr/>
        </p:nvSpPr>
        <p:spPr>
          <a:xfrm>
            <a:off x="2402052" y="3668006"/>
            <a:ext cx="404328" cy="339576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13" name="TextBox 6212">
            <a:extLst>
              <a:ext uri="{FF2B5EF4-FFF2-40B4-BE49-F238E27FC236}">
                <a16:creationId xmlns:a16="http://schemas.microsoft.com/office/drawing/2014/main" id="{51D88A93-AE84-930E-8947-5691FC20C989}"/>
              </a:ext>
            </a:extLst>
          </p:cNvPr>
          <p:cNvSpPr txBox="1"/>
          <p:nvPr/>
        </p:nvSpPr>
        <p:spPr>
          <a:xfrm>
            <a:off x="3559790" y="3754175"/>
            <a:ext cx="5787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S</a:t>
            </a:r>
          </a:p>
        </p:txBody>
      </p:sp>
      <p:sp>
        <p:nvSpPr>
          <p:cNvPr id="6214" name="Rectangle 6213">
            <a:extLst>
              <a:ext uri="{FF2B5EF4-FFF2-40B4-BE49-F238E27FC236}">
                <a16:creationId xmlns:a16="http://schemas.microsoft.com/office/drawing/2014/main" id="{7EECDB28-B4CE-EAD5-D697-A7D141053A3C}"/>
              </a:ext>
            </a:extLst>
          </p:cNvPr>
          <p:cNvSpPr/>
          <p:nvPr/>
        </p:nvSpPr>
        <p:spPr>
          <a:xfrm>
            <a:off x="2400180" y="2614064"/>
            <a:ext cx="406527" cy="1053942"/>
          </a:xfrm>
          <a:prstGeom prst="rect">
            <a:avLst/>
          </a:prstGeom>
          <a:noFill/>
          <a:ln w="635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15" name="Rectangle 6214">
            <a:extLst>
              <a:ext uri="{FF2B5EF4-FFF2-40B4-BE49-F238E27FC236}">
                <a16:creationId xmlns:a16="http://schemas.microsoft.com/office/drawing/2014/main" id="{9FFE201F-E82F-D428-B855-634181EDD488}"/>
              </a:ext>
            </a:extLst>
          </p:cNvPr>
          <p:cNvSpPr/>
          <p:nvPr/>
        </p:nvSpPr>
        <p:spPr>
          <a:xfrm>
            <a:off x="2806382" y="2615293"/>
            <a:ext cx="1080596" cy="1048907"/>
          </a:xfrm>
          <a:prstGeom prst="rect">
            <a:avLst/>
          </a:prstGeom>
          <a:noFill/>
          <a:ln w="635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16" name="Google Shape;1564;g23c6e7809d4_0_831">
            <a:extLst>
              <a:ext uri="{FF2B5EF4-FFF2-40B4-BE49-F238E27FC236}">
                <a16:creationId xmlns:a16="http://schemas.microsoft.com/office/drawing/2014/main" id="{0685ADE2-F3CB-0961-3F2F-C22281D0DEF3}"/>
              </a:ext>
            </a:extLst>
          </p:cNvPr>
          <p:cNvSpPr txBox="1"/>
          <p:nvPr/>
        </p:nvSpPr>
        <p:spPr>
          <a:xfrm>
            <a:off x="3010672" y="2565435"/>
            <a:ext cx="565200" cy="4616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sz="1200" b="1" dirty="0">
                <a:solidFill>
                  <a:srgbClr val="980000"/>
                </a:solidFill>
                <a:latin typeface="Gene Sans"/>
                <a:ea typeface="Gene Sans"/>
                <a:cs typeface="Gene Sans"/>
                <a:sym typeface="Gene Sans"/>
              </a:rPr>
              <a:t>55°C</a:t>
            </a:r>
            <a:endParaRPr lang="en-US" sz="1200" dirty="0">
              <a:solidFill>
                <a:srgbClr val="980000"/>
              </a:solidFill>
              <a:latin typeface="Gene Sans"/>
              <a:ea typeface="Gene Sans"/>
              <a:cs typeface="Gene Sans"/>
              <a:sym typeface="Gene Sans"/>
            </a:endParaRPr>
          </a:p>
        </p:txBody>
      </p:sp>
      <p:pic>
        <p:nvPicPr>
          <p:cNvPr id="6217" name="Picture 6216">
            <a:extLst>
              <a:ext uri="{FF2B5EF4-FFF2-40B4-BE49-F238E27FC236}">
                <a16:creationId xmlns:a16="http://schemas.microsoft.com/office/drawing/2014/main" id="{32AAC522-2BEE-9E8E-0813-A61FBE4D1B79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4132" y="4025250"/>
            <a:ext cx="246810" cy="2343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51310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2446157" y="4153723"/>
            <a:ext cx="6522352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ra- and extracellular insoluble proteins detected using HPLC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or flow cytometry analysis, POS sample was resuspended in DPBS, vortexed, centrifuged and then the supernatant was collected for intra- and extracellular soluble proteins analysis. (Red) HPLC chromatogram for soluble proteins present in the POS supernatant sample with retention times ranging from 8 to 23 minutes. (Black) HPLC chromatograms for the same sample after an additional wash with DPBS. The area under each peak is proportional to the amount of protein.</a:t>
            </a:r>
            <a:endParaRPr lang="en-US" sz="11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2528967" y="902279"/>
            <a:ext cx="7228337" cy="2960389"/>
            <a:chOff x="2602858" y="1188606"/>
            <a:chExt cx="7228337" cy="2960389"/>
          </a:xfrm>
        </p:grpSpPr>
        <p:sp>
          <p:nvSpPr>
            <p:cNvPr id="55" name="Line 254"/>
            <p:cNvSpPr>
              <a:spLocks noChangeShapeType="1"/>
            </p:cNvSpPr>
            <p:nvPr/>
          </p:nvSpPr>
          <p:spPr bwMode="auto">
            <a:xfrm flipV="1">
              <a:off x="2767533" y="1349417"/>
              <a:ext cx="0" cy="2547634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56" name="Rectangle 255"/>
            <p:cNvSpPr>
              <a:spLocks noChangeArrowheads="1"/>
            </p:cNvSpPr>
            <p:nvPr/>
          </p:nvSpPr>
          <p:spPr bwMode="auto">
            <a:xfrm>
              <a:off x="2710812" y="1241181"/>
              <a:ext cx="14638" cy="309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256"/>
            <p:cNvSpPr>
              <a:spLocks noChangeArrowheads="1"/>
            </p:cNvSpPr>
            <p:nvPr/>
          </p:nvSpPr>
          <p:spPr bwMode="auto">
            <a:xfrm>
              <a:off x="2602858" y="1256644"/>
              <a:ext cx="83253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x10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Line 257"/>
            <p:cNvSpPr>
              <a:spLocks noChangeShapeType="1"/>
            </p:cNvSpPr>
            <p:nvPr/>
          </p:nvSpPr>
          <p:spPr bwMode="auto">
            <a:xfrm flipH="1">
              <a:off x="2747406" y="3877041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59" name="Rectangle 258"/>
            <p:cNvSpPr>
              <a:spLocks noChangeArrowheads="1"/>
            </p:cNvSpPr>
            <p:nvPr/>
          </p:nvSpPr>
          <p:spPr bwMode="auto">
            <a:xfrm>
              <a:off x="2639453" y="3841569"/>
              <a:ext cx="89657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-0.1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Line 259"/>
            <p:cNvSpPr>
              <a:spLocks noChangeShapeType="1"/>
            </p:cNvSpPr>
            <p:nvPr/>
          </p:nvSpPr>
          <p:spPr bwMode="auto">
            <a:xfrm flipH="1">
              <a:off x="2747406" y="3769715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61" name="Rectangle 260"/>
            <p:cNvSpPr>
              <a:spLocks noChangeArrowheads="1"/>
            </p:cNvSpPr>
            <p:nvPr/>
          </p:nvSpPr>
          <p:spPr bwMode="auto">
            <a:xfrm>
              <a:off x="2608347" y="3733333"/>
              <a:ext cx="118932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-0.0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Line 261"/>
            <p:cNvSpPr>
              <a:spLocks noChangeShapeType="1"/>
            </p:cNvSpPr>
            <p:nvPr/>
          </p:nvSpPr>
          <p:spPr bwMode="auto">
            <a:xfrm flipH="1">
              <a:off x="2747406" y="3666936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63" name="Rectangle 262"/>
            <p:cNvSpPr>
              <a:spLocks noChangeArrowheads="1"/>
            </p:cNvSpPr>
            <p:nvPr/>
          </p:nvSpPr>
          <p:spPr bwMode="auto">
            <a:xfrm>
              <a:off x="2706238" y="3631464"/>
              <a:ext cx="29276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Line 263"/>
            <p:cNvSpPr>
              <a:spLocks noChangeShapeType="1"/>
            </p:cNvSpPr>
            <p:nvPr/>
          </p:nvSpPr>
          <p:spPr bwMode="auto">
            <a:xfrm flipH="1">
              <a:off x="2747406" y="3558701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65" name="Rectangle 264"/>
            <p:cNvSpPr>
              <a:spLocks noChangeArrowheads="1"/>
            </p:cNvSpPr>
            <p:nvPr/>
          </p:nvSpPr>
          <p:spPr bwMode="auto">
            <a:xfrm>
              <a:off x="2628474" y="3523228"/>
              <a:ext cx="100635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0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Line 265"/>
            <p:cNvSpPr>
              <a:spLocks noChangeShapeType="1"/>
            </p:cNvSpPr>
            <p:nvPr/>
          </p:nvSpPr>
          <p:spPr bwMode="auto">
            <a:xfrm flipH="1">
              <a:off x="2747406" y="3456832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67" name="Rectangle 266"/>
            <p:cNvSpPr>
              <a:spLocks noChangeArrowheads="1"/>
            </p:cNvSpPr>
            <p:nvPr/>
          </p:nvSpPr>
          <p:spPr bwMode="auto">
            <a:xfrm>
              <a:off x="2659580" y="3421359"/>
              <a:ext cx="72274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1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Line 267"/>
            <p:cNvSpPr>
              <a:spLocks noChangeShapeType="1"/>
            </p:cNvSpPr>
            <p:nvPr/>
          </p:nvSpPr>
          <p:spPr bwMode="auto">
            <a:xfrm flipH="1">
              <a:off x="2747406" y="3348596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69" name="Rectangle 268"/>
            <p:cNvSpPr>
              <a:spLocks noChangeArrowheads="1"/>
            </p:cNvSpPr>
            <p:nvPr/>
          </p:nvSpPr>
          <p:spPr bwMode="auto">
            <a:xfrm>
              <a:off x="2628474" y="3313124"/>
              <a:ext cx="100635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1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Line 269"/>
            <p:cNvSpPr>
              <a:spLocks noChangeShapeType="1"/>
            </p:cNvSpPr>
            <p:nvPr/>
          </p:nvSpPr>
          <p:spPr bwMode="auto">
            <a:xfrm flipH="1">
              <a:off x="2747406" y="3245817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71" name="Rectangle 270"/>
            <p:cNvSpPr>
              <a:spLocks noChangeArrowheads="1"/>
            </p:cNvSpPr>
            <p:nvPr/>
          </p:nvSpPr>
          <p:spPr bwMode="auto">
            <a:xfrm>
              <a:off x="2659580" y="3210345"/>
              <a:ext cx="72274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2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Line 271"/>
            <p:cNvSpPr>
              <a:spLocks noChangeShapeType="1"/>
            </p:cNvSpPr>
            <p:nvPr/>
          </p:nvSpPr>
          <p:spPr bwMode="auto">
            <a:xfrm flipH="1">
              <a:off x="2747406" y="3138491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73" name="Rectangle 272"/>
            <p:cNvSpPr>
              <a:spLocks noChangeArrowheads="1"/>
            </p:cNvSpPr>
            <p:nvPr/>
          </p:nvSpPr>
          <p:spPr bwMode="auto">
            <a:xfrm>
              <a:off x="2628474" y="3103019"/>
              <a:ext cx="100635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2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Line 273"/>
            <p:cNvSpPr>
              <a:spLocks noChangeShapeType="1"/>
            </p:cNvSpPr>
            <p:nvPr/>
          </p:nvSpPr>
          <p:spPr bwMode="auto">
            <a:xfrm flipH="1">
              <a:off x="2747406" y="3035713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75" name="Rectangle 274"/>
            <p:cNvSpPr>
              <a:spLocks noChangeArrowheads="1"/>
            </p:cNvSpPr>
            <p:nvPr/>
          </p:nvSpPr>
          <p:spPr bwMode="auto">
            <a:xfrm>
              <a:off x="2659580" y="3000240"/>
              <a:ext cx="72274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3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Line 275"/>
            <p:cNvSpPr>
              <a:spLocks noChangeShapeType="1"/>
            </p:cNvSpPr>
            <p:nvPr/>
          </p:nvSpPr>
          <p:spPr bwMode="auto">
            <a:xfrm flipH="1">
              <a:off x="2747406" y="2928386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77" name="Rectangle 276"/>
            <p:cNvSpPr>
              <a:spLocks noChangeArrowheads="1"/>
            </p:cNvSpPr>
            <p:nvPr/>
          </p:nvSpPr>
          <p:spPr bwMode="auto">
            <a:xfrm>
              <a:off x="2628474" y="2892914"/>
              <a:ext cx="100635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3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Line 277"/>
            <p:cNvSpPr>
              <a:spLocks noChangeShapeType="1"/>
            </p:cNvSpPr>
            <p:nvPr/>
          </p:nvSpPr>
          <p:spPr bwMode="auto">
            <a:xfrm flipH="1">
              <a:off x="2747406" y="2825608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79" name="Rectangle 278"/>
            <p:cNvSpPr>
              <a:spLocks noChangeArrowheads="1"/>
            </p:cNvSpPr>
            <p:nvPr/>
          </p:nvSpPr>
          <p:spPr bwMode="auto">
            <a:xfrm>
              <a:off x="2659580" y="2790136"/>
              <a:ext cx="72274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4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Line 279"/>
            <p:cNvSpPr>
              <a:spLocks noChangeShapeType="1"/>
            </p:cNvSpPr>
            <p:nvPr/>
          </p:nvSpPr>
          <p:spPr bwMode="auto">
            <a:xfrm flipH="1">
              <a:off x="2747406" y="2718282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81" name="Rectangle 280"/>
            <p:cNvSpPr>
              <a:spLocks noChangeArrowheads="1"/>
            </p:cNvSpPr>
            <p:nvPr/>
          </p:nvSpPr>
          <p:spPr bwMode="auto">
            <a:xfrm>
              <a:off x="2628474" y="2682809"/>
              <a:ext cx="100635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4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Line 281"/>
            <p:cNvSpPr>
              <a:spLocks noChangeShapeType="1"/>
            </p:cNvSpPr>
            <p:nvPr/>
          </p:nvSpPr>
          <p:spPr bwMode="auto">
            <a:xfrm flipH="1">
              <a:off x="2747406" y="2610046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83" name="Rectangle 282"/>
            <p:cNvSpPr>
              <a:spLocks noChangeArrowheads="1"/>
            </p:cNvSpPr>
            <p:nvPr/>
          </p:nvSpPr>
          <p:spPr bwMode="auto">
            <a:xfrm>
              <a:off x="2659580" y="2574573"/>
              <a:ext cx="72274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Line 283"/>
            <p:cNvSpPr>
              <a:spLocks noChangeShapeType="1"/>
            </p:cNvSpPr>
            <p:nvPr/>
          </p:nvSpPr>
          <p:spPr bwMode="auto">
            <a:xfrm flipH="1">
              <a:off x="2747406" y="2508177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85" name="Rectangle 284"/>
            <p:cNvSpPr>
              <a:spLocks noChangeArrowheads="1"/>
            </p:cNvSpPr>
            <p:nvPr/>
          </p:nvSpPr>
          <p:spPr bwMode="auto">
            <a:xfrm>
              <a:off x="2628474" y="2472704"/>
              <a:ext cx="100635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5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Line 285"/>
            <p:cNvSpPr>
              <a:spLocks noChangeShapeType="1"/>
            </p:cNvSpPr>
            <p:nvPr/>
          </p:nvSpPr>
          <p:spPr bwMode="auto">
            <a:xfrm flipH="1">
              <a:off x="2747406" y="2399941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87" name="Rectangle 286"/>
            <p:cNvSpPr>
              <a:spLocks noChangeArrowheads="1"/>
            </p:cNvSpPr>
            <p:nvPr/>
          </p:nvSpPr>
          <p:spPr bwMode="auto">
            <a:xfrm>
              <a:off x="2659580" y="2364469"/>
              <a:ext cx="72274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6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Line 287"/>
            <p:cNvSpPr>
              <a:spLocks noChangeShapeType="1"/>
            </p:cNvSpPr>
            <p:nvPr/>
          </p:nvSpPr>
          <p:spPr bwMode="auto">
            <a:xfrm flipH="1">
              <a:off x="2747406" y="2298072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89" name="Rectangle 288"/>
            <p:cNvSpPr>
              <a:spLocks noChangeArrowheads="1"/>
            </p:cNvSpPr>
            <p:nvPr/>
          </p:nvSpPr>
          <p:spPr bwMode="auto">
            <a:xfrm>
              <a:off x="2628474" y="2261690"/>
              <a:ext cx="100635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6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Line 289"/>
            <p:cNvSpPr>
              <a:spLocks noChangeShapeType="1"/>
            </p:cNvSpPr>
            <p:nvPr/>
          </p:nvSpPr>
          <p:spPr bwMode="auto">
            <a:xfrm flipH="1">
              <a:off x="2747406" y="2189836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91" name="Rectangle 290"/>
            <p:cNvSpPr>
              <a:spLocks noChangeArrowheads="1"/>
            </p:cNvSpPr>
            <p:nvPr/>
          </p:nvSpPr>
          <p:spPr bwMode="auto">
            <a:xfrm>
              <a:off x="2659580" y="2154364"/>
              <a:ext cx="72274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7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Line 291"/>
            <p:cNvSpPr>
              <a:spLocks noChangeShapeType="1"/>
            </p:cNvSpPr>
            <p:nvPr/>
          </p:nvSpPr>
          <p:spPr bwMode="auto">
            <a:xfrm flipH="1">
              <a:off x="2747406" y="2087058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93" name="Rectangle 292"/>
            <p:cNvSpPr>
              <a:spLocks noChangeArrowheads="1"/>
            </p:cNvSpPr>
            <p:nvPr/>
          </p:nvSpPr>
          <p:spPr bwMode="auto">
            <a:xfrm>
              <a:off x="2628474" y="2051585"/>
              <a:ext cx="100635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7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Line 293"/>
            <p:cNvSpPr>
              <a:spLocks noChangeShapeType="1"/>
            </p:cNvSpPr>
            <p:nvPr/>
          </p:nvSpPr>
          <p:spPr bwMode="auto">
            <a:xfrm flipH="1">
              <a:off x="2747406" y="1979731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95" name="Rectangle 294"/>
            <p:cNvSpPr>
              <a:spLocks noChangeArrowheads="1"/>
            </p:cNvSpPr>
            <p:nvPr/>
          </p:nvSpPr>
          <p:spPr bwMode="auto">
            <a:xfrm>
              <a:off x="2659580" y="1944259"/>
              <a:ext cx="72274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8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Line 295"/>
            <p:cNvSpPr>
              <a:spLocks noChangeShapeType="1"/>
            </p:cNvSpPr>
            <p:nvPr/>
          </p:nvSpPr>
          <p:spPr bwMode="auto">
            <a:xfrm flipH="1">
              <a:off x="2747406" y="1876953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97" name="Rectangle 296"/>
            <p:cNvSpPr>
              <a:spLocks noChangeArrowheads="1"/>
            </p:cNvSpPr>
            <p:nvPr/>
          </p:nvSpPr>
          <p:spPr bwMode="auto">
            <a:xfrm>
              <a:off x="2628474" y="1841481"/>
              <a:ext cx="100635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8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Line 297"/>
            <p:cNvSpPr>
              <a:spLocks noChangeShapeType="1"/>
            </p:cNvSpPr>
            <p:nvPr/>
          </p:nvSpPr>
          <p:spPr bwMode="auto">
            <a:xfrm flipH="1">
              <a:off x="2747406" y="1769627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99" name="Rectangle 298"/>
            <p:cNvSpPr>
              <a:spLocks noChangeArrowheads="1"/>
            </p:cNvSpPr>
            <p:nvPr/>
          </p:nvSpPr>
          <p:spPr bwMode="auto">
            <a:xfrm>
              <a:off x="2659580" y="1734154"/>
              <a:ext cx="72274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9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Line 299"/>
            <p:cNvSpPr>
              <a:spLocks noChangeShapeType="1"/>
            </p:cNvSpPr>
            <p:nvPr/>
          </p:nvSpPr>
          <p:spPr bwMode="auto">
            <a:xfrm flipH="1">
              <a:off x="2747406" y="1666848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101" name="Rectangle 300"/>
            <p:cNvSpPr>
              <a:spLocks noChangeArrowheads="1"/>
            </p:cNvSpPr>
            <p:nvPr/>
          </p:nvSpPr>
          <p:spPr bwMode="auto">
            <a:xfrm>
              <a:off x="2628474" y="1631376"/>
              <a:ext cx="100635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0.9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Line 301"/>
            <p:cNvSpPr>
              <a:spLocks noChangeShapeType="1"/>
            </p:cNvSpPr>
            <p:nvPr/>
          </p:nvSpPr>
          <p:spPr bwMode="auto">
            <a:xfrm flipH="1">
              <a:off x="2747406" y="1559522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103" name="Rectangle 302"/>
            <p:cNvSpPr>
              <a:spLocks noChangeArrowheads="1"/>
            </p:cNvSpPr>
            <p:nvPr/>
          </p:nvSpPr>
          <p:spPr bwMode="auto">
            <a:xfrm>
              <a:off x="2706238" y="1524050"/>
              <a:ext cx="29276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Line 303"/>
            <p:cNvSpPr>
              <a:spLocks noChangeShapeType="1"/>
            </p:cNvSpPr>
            <p:nvPr/>
          </p:nvSpPr>
          <p:spPr bwMode="auto">
            <a:xfrm flipH="1">
              <a:off x="2747406" y="1456743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105" name="Rectangle 304"/>
            <p:cNvSpPr>
              <a:spLocks noChangeArrowheads="1"/>
            </p:cNvSpPr>
            <p:nvPr/>
          </p:nvSpPr>
          <p:spPr bwMode="auto">
            <a:xfrm>
              <a:off x="2628474" y="1421271"/>
              <a:ext cx="100635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0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Line 305"/>
            <p:cNvSpPr>
              <a:spLocks noChangeShapeType="1"/>
            </p:cNvSpPr>
            <p:nvPr/>
          </p:nvSpPr>
          <p:spPr bwMode="auto">
            <a:xfrm flipH="1">
              <a:off x="2747406" y="1349417"/>
              <a:ext cx="20127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107" name="Rectangle 306"/>
            <p:cNvSpPr>
              <a:spLocks noChangeArrowheads="1"/>
            </p:cNvSpPr>
            <p:nvPr/>
          </p:nvSpPr>
          <p:spPr bwMode="auto">
            <a:xfrm>
              <a:off x="2659580" y="1313035"/>
              <a:ext cx="72274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1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Rectangle 307"/>
            <p:cNvSpPr>
              <a:spLocks noChangeArrowheads="1"/>
            </p:cNvSpPr>
            <p:nvPr/>
          </p:nvSpPr>
          <p:spPr bwMode="auto">
            <a:xfrm>
              <a:off x="2773023" y="1215714"/>
              <a:ext cx="6932837" cy="271226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109" name="Rectangle 308"/>
            <p:cNvSpPr>
              <a:spLocks noChangeArrowheads="1"/>
            </p:cNvSpPr>
            <p:nvPr/>
          </p:nvSpPr>
          <p:spPr bwMode="auto">
            <a:xfrm>
              <a:off x="2783086" y="1349417"/>
              <a:ext cx="6908136" cy="2547634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185" name="Freeform 385"/>
            <p:cNvSpPr>
              <a:spLocks/>
            </p:cNvSpPr>
            <p:nvPr/>
          </p:nvSpPr>
          <p:spPr bwMode="auto">
            <a:xfrm>
              <a:off x="3170074" y="1559522"/>
              <a:ext cx="4496555" cy="2106505"/>
            </a:xfrm>
            <a:custGeom>
              <a:avLst/>
              <a:gdLst>
                <a:gd name="T0" fmla="*/ 77 w 4915"/>
                <a:gd name="T1" fmla="*/ 2124 h 2316"/>
                <a:gd name="T2" fmla="*/ 159 w 4915"/>
                <a:gd name="T3" fmla="*/ 2126 h 2316"/>
                <a:gd name="T4" fmla="*/ 241 w 4915"/>
                <a:gd name="T5" fmla="*/ 2128 h 2316"/>
                <a:gd name="T6" fmla="*/ 322 w 4915"/>
                <a:gd name="T7" fmla="*/ 2124 h 2316"/>
                <a:gd name="T8" fmla="*/ 404 w 4915"/>
                <a:gd name="T9" fmla="*/ 2126 h 2316"/>
                <a:gd name="T10" fmla="*/ 486 w 4915"/>
                <a:gd name="T11" fmla="*/ 2123 h 2316"/>
                <a:gd name="T12" fmla="*/ 567 w 4915"/>
                <a:gd name="T13" fmla="*/ 2126 h 2316"/>
                <a:gd name="T14" fmla="*/ 649 w 4915"/>
                <a:gd name="T15" fmla="*/ 2124 h 2316"/>
                <a:gd name="T16" fmla="*/ 730 w 4915"/>
                <a:gd name="T17" fmla="*/ 2123 h 2316"/>
                <a:gd name="T18" fmla="*/ 812 w 4915"/>
                <a:gd name="T19" fmla="*/ 2120 h 2316"/>
                <a:gd name="T20" fmla="*/ 894 w 4915"/>
                <a:gd name="T21" fmla="*/ 2116 h 2316"/>
                <a:gd name="T22" fmla="*/ 975 w 4915"/>
                <a:gd name="T23" fmla="*/ 2116 h 2316"/>
                <a:gd name="T24" fmla="*/ 1057 w 4915"/>
                <a:gd name="T25" fmla="*/ 2116 h 2316"/>
                <a:gd name="T26" fmla="*/ 1139 w 4915"/>
                <a:gd name="T27" fmla="*/ 2113 h 2316"/>
                <a:gd name="T28" fmla="*/ 1221 w 4915"/>
                <a:gd name="T29" fmla="*/ 2098 h 2316"/>
                <a:gd name="T30" fmla="*/ 1302 w 4915"/>
                <a:gd name="T31" fmla="*/ 2091 h 2316"/>
                <a:gd name="T32" fmla="*/ 1384 w 4915"/>
                <a:gd name="T33" fmla="*/ 2076 h 2316"/>
                <a:gd name="T34" fmla="*/ 1466 w 4915"/>
                <a:gd name="T35" fmla="*/ 2085 h 2316"/>
                <a:gd name="T36" fmla="*/ 1547 w 4915"/>
                <a:gd name="T37" fmla="*/ 2067 h 2316"/>
                <a:gd name="T38" fmla="*/ 1629 w 4915"/>
                <a:gd name="T39" fmla="*/ 2089 h 2316"/>
                <a:gd name="T40" fmla="*/ 1711 w 4915"/>
                <a:gd name="T41" fmla="*/ 2048 h 2316"/>
                <a:gd name="T42" fmla="*/ 1792 w 4915"/>
                <a:gd name="T43" fmla="*/ 2060 h 2316"/>
                <a:gd name="T44" fmla="*/ 1874 w 4915"/>
                <a:gd name="T45" fmla="*/ 1971 h 2316"/>
                <a:gd name="T46" fmla="*/ 1955 w 4915"/>
                <a:gd name="T47" fmla="*/ 1193 h 2316"/>
                <a:gd name="T48" fmla="*/ 2037 w 4915"/>
                <a:gd name="T49" fmla="*/ 1644 h 2316"/>
                <a:gd name="T50" fmla="*/ 2119 w 4915"/>
                <a:gd name="T51" fmla="*/ 1944 h 2316"/>
                <a:gd name="T52" fmla="*/ 2200 w 4915"/>
                <a:gd name="T53" fmla="*/ 1428 h 2316"/>
                <a:gd name="T54" fmla="*/ 2282 w 4915"/>
                <a:gd name="T55" fmla="*/ 1647 h 2316"/>
                <a:gd name="T56" fmla="*/ 2364 w 4915"/>
                <a:gd name="T57" fmla="*/ 1976 h 2316"/>
                <a:gd name="T58" fmla="*/ 2446 w 4915"/>
                <a:gd name="T59" fmla="*/ 1454 h 2316"/>
                <a:gd name="T60" fmla="*/ 2527 w 4915"/>
                <a:gd name="T61" fmla="*/ 1950 h 2316"/>
                <a:gd name="T62" fmla="*/ 2609 w 4915"/>
                <a:gd name="T63" fmla="*/ 1978 h 2316"/>
                <a:gd name="T64" fmla="*/ 2691 w 4915"/>
                <a:gd name="T65" fmla="*/ 1921 h 2316"/>
                <a:gd name="T66" fmla="*/ 2772 w 4915"/>
                <a:gd name="T67" fmla="*/ 1586 h 2316"/>
                <a:gd name="T68" fmla="*/ 2854 w 4915"/>
                <a:gd name="T69" fmla="*/ 1935 h 2316"/>
                <a:gd name="T70" fmla="*/ 2936 w 4915"/>
                <a:gd name="T71" fmla="*/ 1881 h 2316"/>
                <a:gd name="T72" fmla="*/ 3017 w 4915"/>
                <a:gd name="T73" fmla="*/ 478 h 2316"/>
                <a:gd name="T74" fmla="*/ 3099 w 4915"/>
                <a:gd name="T75" fmla="*/ 1773 h 2316"/>
                <a:gd name="T76" fmla="*/ 3180 w 4915"/>
                <a:gd name="T77" fmla="*/ 1797 h 2316"/>
                <a:gd name="T78" fmla="*/ 3262 w 4915"/>
                <a:gd name="T79" fmla="*/ 1680 h 2316"/>
                <a:gd name="T80" fmla="*/ 3344 w 4915"/>
                <a:gd name="T81" fmla="*/ 1936 h 2316"/>
                <a:gd name="T82" fmla="*/ 3426 w 4915"/>
                <a:gd name="T83" fmla="*/ 376 h 2316"/>
                <a:gd name="T84" fmla="*/ 3507 w 4915"/>
                <a:gd name="T85" fmla="*/ 1958 h 2316"/>
                <a:gd name="T86" fmla="*/ 3589 w 4915"/>
                <a:gd name="T87" fmla="*/ 1989 h 2316"/>
                <a:gd name="T88" fmla="*/ 3671 w 4915"/>
                <a:gd name="T89" fmla="*/ 2026 h 2316"/>
                <a:gd name="T90" fmla="*/ 3752 w 4915"/>
                <a:gd name="T91" fmla="*/ 2045 h 2316"/>
                <a:gd name="T92" fmla="*/ 3834 w 4915"/>
                <a:gd name="T93" fmla="*/ 1982 h 2316"/>
                <a:gd name="T94" fmla="*/ 3916 w 4915"/>
                <a:gd name="T95" fmla="*/ 2078 h 2316"/>
                <a:gd name="T96" fmla="*/ 3997 w 4915"/>
                <a:gd name="T97" fmla="*/ 2032 h 2316"/>
                <a:gd name="T98" fmla="*/ 4079 w 4915"/>
                <a:gd name="T99" fmla="*/ 2020 h 2316"/>
                <a:gd name="T100" fmla="*/ 4161 w 4915"/>
                <a:gd name="T101" fmla="*/ 1942 h 2316"/>
                <a:gd name="T102" fmla="*/ 4242 w 4915"/>
                <a:gd name="T103" fmla="*/ 1567 h 2316"/>
                <a:gd name="T104" fmla="*/ 4324 w 4915"/>
                <a:gd name="T105" fmla="*/ 2067 h 2316"/>
                <a:gd name="T106" fmla="*/ 4406 w 4915"/>
                <a:gd name="T107" fmla="*/ 1837 h 2316"/>
                <a:gd name="T108" fmla="*/ 4487 w 4915"/>
                <a:gd name="T109" fmla="*/ 1969 h 2316"/>
                <a:gd name="T110" fmla="*/ 4569 w 4915"/>
                <a:gd name="T111" fmla="*/ 777 h 2316"/>
                <a:gd name="T112" fmla="*/ 4651 w 4915"/>
                <a:gd name="T113" fmla="*/ 1952 h 2316"/>
                <a:gd name="T114" fmla="*/ 4733 w 4915"/>
                <a:gd name="T115" fmla="*/ 1942 h 2316"/>
                <a:gd name="T116" fmla="*/ 4814 w 4915"/>
                <a:gd name="T117" fmla="*/ 2116 h 2316"/>
                <a:gd name="T118" fmla="*/ 4896 w 4915"/>
                <a:gd name="T119" fmla="*/ 2157 h 23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4915" h="2316">
                  <a:moveTo>
                    <a:pt x="0" y="2316"/>
                  </a:moveTo>
                  <a:lnTo>
                    <a:pt x="5" y="2242"/>
                  </a:lnTo>
                  <a:lnTo>
                    <a:pt x="10" y="2136"/>
                  </a:lnTo>
                  <a:lnTo>
                    <a:pt x="15" y="2128"/>
                  </a:lnTo>
                  <a:lnTo>
                    <a:pt x="20" y="2125"/>
                  </a:lnTo>
                  <a:lnTo>
                    <a:pt x="24" y="2123"/>
                  </a:lnTo>
                  <a:lnTo>
                    <a:pt x="29" y="2123"/>
                  </a:lnTo>
                  <a:lnTo>
                    <a:pt x="34" y="2122"/>
                  </a:lnTo>
                  <a:lnTo>
                    <a:pt x="39" y="2124"/>
                  </a:lnTo>
                  <a:lnTo>
                    <a:pt x="44" y="2124"/>
                  </a:lnTo>
                  <a:lnTo>
                    <a:pt x="48" y="2122"/>
                  </a:lnTo>
                  <a:lnTo>
                    <a:pt x="53" y="2122"/>
                  </a:lnTo>
                  <a:lnTo>
                    <a:pt x="58" y="2122"/>
                  </a:lnTo>
                  <a:lnTo>
                    <a:pt x="63" y="2123"/>
                  </a:lnTo>
                  <a:lnTo>
                    <a:pt x="68" y="2123"/>
                  </a:lnTo>
                  <a:lnTo>
                    <a:pt x="73" y="2126"/>
                  </a:lnTo>
                  <a:lnTo>
                    <a:pt x="77" y="2124"/>
                  </a:lnTo>
                  <a:lnTo>
                    <a:pt x="82" y="2123"/>
                  </a:lnTo>
                  <a:lnTo>
                    <a:pt x="87" y="2122"/>
                  </a:lnTo>
                  <a:lnTo>
                    <a:pt x="92" y="2123"/>
                  </a:lnTo>
                  <a:lnTo>
                    <a:pt x="97" y="2125"/>
                  </a:lnTo>
                  <a:lnTo>
                    <a:pt x="101" y="2126"/>
                  </a:lnTo>
                  <a:lnTo>
                    <a:pt x="106" y="2123"/>
                  </a:lnTo>
                  <a:lnTo>
                    <a:pt x="111" y="2123"/>
                  </a:lnTo>
                  <a:lnTo>
                    <a:pt x="116" y="2123"/>
                  </a:lnTo>
                  <a:lnTo>
                    <a:pt x="120" y="2124"/>
                  </a:lnTo>
                  <a:lnTo>
                    <a:pt x="125" y="2123"/>
                  </a:lnTo>
                  <a:lnTo>
                    <a:pt x="130" y="2124"/>
                  </a:lnTo>
                  <a:lnTo>
                    <a:pt x="135" y="2126"/>
                  </a:lnTo>
                  <a:lnTo>
                    <a:pt x="140" y="2128"/>
                  </a:lnTo>
                  <a:lnTo>
                    <a:pt x="144" y="2126"/>
                  </a:lnTo>
                  <a:lnTo>
                    <a:pt x="149" y="2126"/>
                  </a:lnTo>
                  <a:lnTo>
                    <a:pt x="154" y="2125"/>
                  </a:lnTo>
                  <a:lnTo>
                    <a:pt x="159" y="2126"/>
                  </a:lnTo>
                  <a:lnTo>
                    <a:pt x="164" y="2124"/>
                  </a:lnTo>
                  <a:lnTo>
                    <a:pt x="168" y="2126"/>
                  </a:lnTo>
                  <a:lnTo>
                    <a:pt x="173" y="2126"/>
                  </a:lnTo>
                  <a:lnTo>
                    <a:pt x="178" y="2128"/>
                  </a:lnTo>
                  <a:lnTo>
                    <a:pt x="183" y="2128"/>
                  </a:lnTo>
                  <a:lnTo>
                    <a:pt x="188" y="2132"/>
                  </a:lnTo>
                  <a:lnTo>
                    <a:pt x="192" y="2136"/>
                  </a:lnTo>
                  <a:lnTo>
                    <a:pt x="197" y="2138"/>
                  </a:lnTo>
                  <a:lnTo>
                    <a:pt x="202" y="2138"/>
                  </a:lnTo>
                  <a:lnTo>
                    <a:pt x="207" y="2136"/>
                  </a:lnTo>
                  <a:lnTo>
                    <a:pt x="212" y="2130"/>
                  </a:lnTo>
                  <a:lnTo>
                    <a:pt x="216" y="2131"/>
                  </a:lnTo>
                  <a:lnTo>
                    <a:pt x="221" y="2132"/>
                  </a:lnTo>
                  <a:lnTo>
                    <a:pt x="226" y="2129"/>
                  </a:lnTo>
                  <a:lnTo>
                    <a:pt x="231" y="2129"/>
                  </a:lnTo>
                  <a:lnTo>
                    <a:pt x="236" y="2128"/>
                  </a:lnTo>
                  <a:lnTo>
                    <a:pt x="241" y="2128"/>
                  </a:lnTo>
                  <a:lnTo>
                    <a:pt x="245" y="2130"/>
                  </a:lnTo>
                  <a:lnTo>
                    <a:pt x="250" y="2126"/>
                  </a:lnTo>
                  <a:lnTo>
                    <a:pt x="255" y="2129"/>
                  </a:lnTo>
                  <a:lnTo>
                    <a:pt x="260" y="2125"/>
                  </a:lnTo>
                  <a:lnTo>
                    <a:pt x="265" y="2127"/>
                  </a:lnTo>
                  <a:lnTo>
                    <a:pt x="269" y="2121"/>
                  </a:lnTo>
                  <a:lnTo>
                    <a:pt x="274" y="2122"/>
                  </a:lnTo>
                  <a:lnTo>
                    <a:pt x="279" y="2122"/>
                  </a:lnTo>
                  <a:lnTo>
                    <a:pt x="284" y="2120"/>
                  </a:lnTo>
                  <a:lnTo>
                    <a:pt x="289" y="2125"/>
                  </a:lnTo>
                  <a:lnTo>
                    <a:pt x="294" y="2126"/>
                  </a:lnTo>
                  <a:lnTo>
                    <a:pt x="298" y="2122"/>
                  </a:lnTo>
                  <a:lnTo>
                    <a:pt x="303" y="2123"/>
                  </a:lnTo>
                  <a:lnTo>
                    <a:pt x="308" y="2121"/>
                  </a:lnTo>
                  <a:lnTo>
                    <a:pt x="313" y="2123"/>
                  </a:lnTo>
                  <a:lnTo>
                    <a:pt x="317" y="2124"/>
                  </a:lnTo>
                  <a:lnTo>
                    <a:pt x="322" y="2124"/>
                  </a:lnTo>
                  <a:lnTo>
                    <a:pt x="327" y="2121"/>
                  </a:lnTo>
                  <a:lnTo>
                    <a:pt x="332" y="2125"/>
                  </a:lnTo>
                  <a:lnTo>
                    <a:pt x="336" y="2123"/>
                  </a:lnTo>
                  <a:lnTo>
                    <a:pt x="341" y="2126"/>
                  </a:lnTo>
                  <a:lnTo>
                    <a:pt x="346" y="2127"/>
                  </a:lnTo>
                  <a:lnTo>
                    <a:pt x="351" y="2124"/>
                  </a:lnTo>
                  <a:lnTo>
                    <a:pt x="356" y="2124"/>
                  </a:lnTo>
                  <a:lnTo>
                    <a:pt x="360" y="2125"/>
                  </a:lnTo>
                  <a:lnTo>
                    <a:pt x="365" y="2125"/>
                  </a:lnTo>
                  <a:lnTo>
                    <a:pt x="370" y="2124"/>
                  </a:lnTo>
                  <a:lnTo>
                    <a:pt x="375" y="2127"/>
                  </a:lnTo>
                  <a:lnTo>
                    <a:pt x="380" y="2123"/>
                  </a:lnTo>
                  <a:lnTo>
                    <a:pt x="385" y="2127"/>
                  </a:lnTo>
                  <a:lnTo>
                    <a:pt x="389" y="2126"/>
                  </a:lnTo>
                  <a:lnTo>
                    <a:pt x="394" y="2129"/>
                  </a:lnTo>
                  <a:lnTo>
                    <a:pt x="399" y="2128"/>
                  </a:lnTo>
                  <a:lnTo>
                    <a:pt x="404" y="2126"/>
                  </a:lnTo>
                  <a:lnTo>
                    <a:pt x="409" y="2126"/>
                  </a:lnTo>
                  <a:lnTo>
                    <a:pt x="413" y="2128"/>
                  </a:lnTo>
                  <a:lnTo>
                    <a:pt x="418" y="2127"/>
                  </a:lnTo>
                  <a:lnTo>
                    <a:pt x="423" y="2126"/>
                  </a:lnTo>
                  <a:lnTo>
                    <a:pt x="428" y="2126"/>
                  </a:lnTo>
                  <a:lnTo>
                    <a:pt x="433" y="2126"/>
                  </a:lnTo>
                  <a:lnTo>
                    <a:pt x="438" y="2124"/>
                  </a:lnTo>
                  <a:lnTo>
                    <a:pt x="442" y="2127"/>
                  </a:lnTo>
                  <a:lnTo>
                    <a:pt x="447" y="2125"/>
                  </a:lnTo>
                  <a:lnTo>
                    <a:pt x="452" y="2127"/>
                  </a:lnTo>
                  <a:lnTo>
                    <a:pt x="457" y="2126"/>
                  </a:lnTo>
                  <a:lnTo>
                    <a:pt x="462" y="2125"/>
                  </a:lnTo>
                  <a:lnTo>
                    <a:pt x="466" y="2125"/>
                  </a:lnTo>
                  <a:lnTo>
                    <a:pt x="471" y="2126"/>
                  </a:lnTo>
                  <a:lnTo>
                    <a:pt x="476" y="2124"/>
                  </a:lnTo>
                  <a:lnTo>
                    <a:pt x="481" y="2129"/>
                  </a:lnTo>
                  <a:lnTo>
                    <a:pt x="486" y="2123"/>
                  </a:lnTo>
                  <a:lnTo>
                    <a:pt x="491" y="2128"/>
                  </a:lnTo>
                  <a:lnTo>
                    <a:pt x="495" y="2123"/>
                  </a:lnTo>
                  <a:lnTo>
                    <a:pt x="500" y="2125"/>
                  </a:lnTo>
                  <a:lnTo>
                    <a:pt x="505" y="2125"/>
                  </a:lnTo>
                  <a:lnTo>
                    <a:pt x="510" y="2123"/>
                  </a:lnTo>
                  <a:lnTo>
                    <a:pt x="514" y="2123"/>
                  </a:lnTo>
                  <a:lnTo>
                    <a:pt x="519" y="2125"/>
                  </a:lnTo>
                  <a:lnTo>
                    <a:pt x="524" y="2126"/>
                  </a:lnTo>
                  <a:lnTo>
                    <a:pt x="529" y="2124"/>
                  </a:lnTo>
                  <a:lnTo>
                    <a:pt x="533" y="2124"/>
                  </a:lnTo>
                  <a:lnTo>
                    <a:pt x="538" y="2126"/>
                  </a:lnTo>
                  <a:lnTo>
                    <a:pt x="543" y="2125"/>
                  </a:lnTo>
                  <a:lnTo>
                    <a:pt x="548" y="2126"/>
                  </a:lnTo>
                  <a:lnTo>
                    <a:pt x="553" y="2126"/>
                  </a:lnTo>
                  <a:lnTo>
                    <a:pt x="557" y="2128"/>
                  </a:lnTo>
                  <a:lnTo>
                    <a:pt x="562" y="2128"/>
                  </a:lnTo>
                  <a:lnTo>
                    <a:pt x="567" y="2126"/>
                  </a:lnTo>
                  <a:lnTo>
                    <a:pt x="572" y="2127"/>
                  </a:lnTo>
                  <a:lnTo>
                    <a:pt x="577" y="2127"/>
                  </a:lnTo>
                  <a:lnTo>
                    <a:pt x="582" y="2126"/>
                  </a:lnTo>
                  <a:lnTo>
                    <a:pt x="586" y="2123"/>
                  </a:lnTo>
                  <a:lnTo>
                    <a:pt x="591" y="2122"/>
                  </a:lnTo>
                  <a:lnTo>
                    <a:pt x="596" y="2127"/>
                  </a:lnTo>
                  <a:lnTo>
                    <a:pt x="601" y="2127"/>
                  </a:lnTo>
                  <a:lnTo>
                    <a:pt x="606" y="2124"/>
                  </a:lnTo>
                  <a:lnTo>
                    <a:pt x="610" y="2123"/>
                  </a:lnTo>
                  <a:lnTo>
                    <a:pt x="615" y="2122"/>
                  </a:lnTo>
                  <a:lnTo>
                    <a:pt x="620" y="2125"/>
                  </a:lnTo>
                  <a:lnTo>
                    <a:pt x="625" y="2123"/>
                  </a:lnTo>
                  <a:lnTo>
                    <a:pt x="630" y="2123"/>
                  </a:lnTo>
                  <a:lnTo>
                    <a:pt x="634" y="2129"/>
                  </a:lnTo>
                  <a:lnTo>
                    <a:pt x="639" y="2125"/>
                  </a:lnTo>
                  <a:lnTo>
                    <a:pt x="644" y="2125"/>
                  </a:lnTo>
                  <a:lnTo>
                    <a:pt x="649" y="2124"/>
                  </a:lnTo>
                  <a:lnTo>
                    <a:pt x="654" y="2123"/>
                  </a:lnTo>
                  <a:lnTo>
                    <a:pt x="659" y="2122"/>
                  </a:lnTo>
                  <a:lnTo>
                    <a:pt x="663" y="2123"/>
                  </a:lnTo>
                  <a:lnTo>
                    <a:pt x="668" y="2123"/>
                  </a:lnTo>
                  <a:lnTo>
                    <a:pt x="673" y="2121"/>
                  </a:lnTo>
                  <a:lnTo>
                    <a:pt x="678" y="2125"/>
                  </a:lnTo>
                  <a:lnTo>
                    <a:pt x="683" y="2122"/>
                  </a:lnTo>
                  <a:lnTo>
                    <a:pt x="687" y="2122"/>
                  </a:lnTo>
                  <a:lnTo>
                    <a:pt x="692" y="2122"/>
                  </a:lnTo>
                  <a:lnTo>
                    <a:pt x="697" y="2121"/>
                  </a:lnTo>
                  <a:lnTo>
                    <a:pt x="702" y="2123"/>
                  </a:lnTo>
                  <a:lnTo>
                    <a:pt x="707" y="2122"/>
                  </a:lnTo>
                  <a:lnTo>
                    <a:pt x="711" y="2124"/>
                  </a:lnTo>
                  <a:lnTo>
                    <a:pt x="716" y="2122"/>
                  </a:lnTo>
                  <a:lnTo>
                    <a:pt x="721" y="2124"/>
                  </a:lnTo>
                  <a:lnTo>
                    <a:pt x="726" y="2121"/>
                  </a:lnTo>
                  <a:lnTo>
                    <a:pt x="730" y="2123"/>
                  </a:lnTo>
                  <a:lnTo>
                    <a:pt x="735" y="2122"/>
                  </a:lnTo>
                  <a:lnTo>
                    <a:pt x="740" y="2123"/>
                  </a:lnTo>
                  <a:lnTo>
                    <a:pt x="745" y="2122"/>
                  </a:lnTo>
                  <a:lnTo>
                    <a:pt x="750" y="2122"/>
                  </a:lnTo>
                  <a:lnTo>
                    <a:pt x="754" y="2119"/>
                  </a:lnTo>
                  <a:lnTo>
                    <a:pt x="759" y="2124"/>
                  </a:lnTo>
                  <a:lnTo>
                    <a:pt x="764" y="2119"/>
                  </a:lnTo>
                  <a:lnTo>
                    <a:pt x="769" y="2123"/>
                  </a:lnTo>
                  <a:lnTo>
                    <a:pt x="774" y="2120"/>
                  </a:lnTo>
                  <a:lnTo>
                    <a:pt x="778" y="2121"/>
                  </a:lnTo>
                  <a:lnTo>
                    <a:pt x="783" y="2120"/>
                  </a:lnTo>
                  <a:lnTo>
                    <a:pt x="788" y="2123"/>
                  </a:lnTo>
                  <a:lnTo>
                    <a:pt x="793" y="2117"/>
                  </a:lnTo>
                  <a:lnTo>
                    <a:pt x="798" y="2117"/>
                  </a:lnTo>
                  <a:lnTo>
                    <a:pt x="803" y="2119"/>
                  </a:lnTo>
                  <a:lnTo>
                    <a:pt x="807" y="2120"/>
                  </a:lnTo>
                  <a:lnTo>
                    <a:pt x="812" y="2120"/>
                  </a:lnTo>
                  <a:lnTo>
                    <a:pt x="817" y="2121"/>
                  </a:lnTo>
                  <a:lnTo>
                    <a:pt x="822" y="2119"/>
                  </a:lnTo>
                  <a:lnTo>
                    <a:pt x="827" y="2119"/>
                  </a:lnTo>
                  <a:lnTo>
                    <a:pt x="831" y="2119"/>
                  </a:lnTo>
                  <a:lnTo>
                    <a:pt x="836" y="2121"/>
                  </a:lnTo>
                  <a:lnTo>
                    <a:pt x="841" y="2119"/>
                  </a:lnTo>
                  <a:lnTo>
                    <a:pt x="846" y="2119"/>
                  </a:lnTo>
                  <a:lnTo>
                    <a:pt x="851" y="2120"/>
                  </a:lnTo>
                  <a:lnTo>
                    <a:pt x="856" y="2118"/>
                  </a:lnTo>
                  <a:lnTo>
                    <a:pt x="860" y="2117"/>
                  </a:lnTo>
                  <a:lnTo>
                    <a:pt x="865" y="2116"/>
                  </a:lnTo>
                  <a:lnTo>
                    <a:pt x="870" y="2117"/>
                  </a:lnTo>
                  <a:lnTo>
                    <a:pt x="875" y="2120"/>
                  </a:lnTo>
                  <a:lnTo>
                    <a:pt x="880" y="2118"/>
                  </a:lnTo>
                  <a:lnTo>
                    <a:pt x="884" y="2116"/>
                  </a:lnTo>
                  <a:lnTo>
                    <a:pt x="889" y="2113"/>
                  </a:lnTo>
                  <a:lnTo>
                    <a:pt x="894" y="2116"/>
                  </a:lnTo>
                  <a:lnTo>
                    <a:pt x="899" y="2119"/>
                  </a:lnTo>
                  <a:lnTo>
                    <a:pt x="904" y="2115"/>
                  </a:lnTo>
                  <a:lnTo>
                    <a:pt x="908" y="2119"/>
                  </a:lnTo>
                  <a:lnTo>
                    <a:pt x="913" y="2117"/>
                  </a:lnTo>
                  <a:lnTo>
                    <a:pt x="918" y="2116"/>
                  </a:lnTo>
                  <a:lnTo>
                    <a:pt x="923" y="2116"/>
                  </a:lnTo>
                  <a:lnTo>
                    <a:pt x="927" y="2118"/>
                  </a:lnTo>
                  <a:lnTo>
                    <a:pt x="932" y="2115"/>
                  </a:lnTo>
                  <a:lnTo>
                    <a:pt x="937" y="2115"/>
                  </a:lnTo>
                  <a:lnTo>
                    <a:pt x="942" y="2116"/>
                  </a:lnTo>
                  <a:lnTo>
                    <a:pt x="947" y="2112"/>
                  </a:lnTo>
                  <a:lnTo>
                    <a:pt x="951" y="2114"/>
                  </a:lnTo>
                  <a:lnTo>
                    <a:pt x="956" y="2112"/>
                  </a:lnTo>
                  <a:lnTo>
                    <a:pt x="961" y="2112"/>
                  </a:lnTo>
                  <a:lnTo>
                    <a:pt x="966" y="2117"/>
                  </a:lnTo>
                  <a:lnTo>
                    <a:pt x="971" y="2116"/>
                  </a:lnTo>
                  <a:lnTo>
                    <a:pt x="975" y="2116"/>
                  </a:lnTo>
                  <a:lnTo>
                    <a:pt x="980" y="2113"/>
                  </a:lnTo>
                  <a:lnTo>
                    <a:pt x="985" y="2112"/>
                  </a:lnTo>
                  <a:lnTo>
                    <a:pt x="990" y="2113"/>
                  </a:lnTo>
                  <a:lnTo>
                    <a:pt x="995" y="2117"/>
                  </a:lnTo>
                  <a:lnTo>
                    <a:pt x="1000" y="2112"/>
                  </a:lnTo>
                  <a:lnTo>
                    <a:pt x="1004" y="2117"/>
                  </a:lnTo>
                  <a:lnTo>
                    <a:pt x="1009" y="2116"/>
                  </a:lnTo>
                  <a:lnTo>
                    <a:pt x="1014" y="2118"/>
                  </a:lnTo>
                  <a:lnTo>
                    <a:pt x="1019" y="2115"/>
                  </a:lnTo>
                  <a:lnTo>
                    <a:pt x="1024" y="2116"/>
                  </a:lnTo>
                  <a:lnTo>
                    <a:pt x="1028" y="2115"/>
                  </a:lnTo>
                  <a:lnTo>
                    <a:pt x="1033" y="2113"/>
                  </a:lnTo>
                  <a:lnTo>
                    <a:pt x="1038" y="2112"/>
                  </a:lnTo>
                  <a:lnTo>
                    <a:pt x="1043" y="2114"/>
                  </a:lnTo>
                  <a:lnTo>
                    <a:pt x="1048" y="2111"/>
                  </a:lnTo>
                  <a:lnTo>
                    <a:pt x="1052" y="2113"/>
                  </a:lnTo>
                  <a:lnTo>
                    <a:pt x="1057" y="2116"/>
                  </a:lnTo>
                  <a:lnTo>
                    <a:pt x="1062" y="2111"/>
                  </a:lnTo>
                  <a:lnTo>
                    <a:pt x="1067" y="2111"/>
                  </a:lnTo>
                  <a:lnTo>
                    <a:pt x="1072" y="2112"/>
                  </a:lnTo>
                  <a:lnTo>
                    <a:pt x="1077" y="2114"/>
                  </a:lnTo>
                  <a:lnTo>
                    <a:pt x="1081" y="2112"/>
                  </a:lnTo>
                  <a:lnTo>
                    <a:pt x="1086" y="2114"/>
                  </a:lnTo>
                  <a:lnTo>
                    <a:pt x="1091" y="2117"/>
                  </a:lnTo>
                  <a:lnTo>
                    <a:pt x="1096" y="2112"/>
                  </a:lnTo>
                  <a:lnTo>
                    <a:pt x="1101" y="2113"/>
                  </a:lnTo>
                  <a:lnTo>
                    <a:pt x="1105" y="2114"/>
                  </a:lnTo>
                  <a:lnTo>
                    <a:pt x="1110" y="2110"/>
                  </a:lnTo>
                  <a:lnTo>
                    <a:pt x="1115" y="2112"/>
                  </a:lnTo>
                  <a:lnTo>
                    <a:pt x="1120" y="2110"/>
                  </a:lnTo>
                  <a:lnTo>
                    <a:pt x="1124" y="2106"/>
                  </a:lnTo>
                  <a:lnTo>
                    <a:pt x="1129" y="2111"/>
                  </a:lnTo>
                  <a:lnTo>
                    <a:pt x="1134" y="2111"/>
                  </a:lnTo>
                  <a:lnTo>
                    <a:pt x="1139" y="2113"/>
                  </a:lnTo>
                  <a:lnTo>
                    <a:pt x="1144" y="2111"/>
                  </a:lnTo>
                  <a:lnTo>
                    <a:pt x="1148" y="2113"/>
                  </a:lnTo>
                  <a:lnTo>
                    <a:pt x="1153" y="2109"/>
                  </a:lnTo>
                  <a:lnTo>
                    <a:pt x="1158" y="2109"/>
                  </a:lnTo>
                  <a:lnTo>
                    <a:pt x="1163" y="2108"/>
                  </a:lnTo>
                  <a:lnTo>
                    <a:pt x="1168" y="2110"/>
                  </a:lnTo>
                  <a:lnTo>
                    <a:pt x="1172" y="2109"/>
                  </a:lnTo>
                  <a:lnTo>
                    <a:pt x="1177" y="2107"/>
                  </a:lnTo>
                  <a:lnTo>
                    <a:pt x="1182" y="2111"/>
                  </a:lnTo>
                  <a:lnTo>
                    <a:pt x="1187" y="2105"/>
                  </a:lnTo>
                  <a:lnTo>
                    <a:pt x="1192" y="2108"/>
                  </a:lnTo>
                  <a:lnTo>
                    <a:pt x="1196" y="2109"/>
                  </a:lnTo>
                  <a:lnTo>
                    <a:pt x="1201" y="2104"/>
                  </a:lnTo>
                  <a:lnTo>
                    <a:pt x="1206" y="2104"/>
                  </a:lnTo>
                  <a:lnTo>
                    <a:pt x="1211" y="2101"/>
                  </a:lnTo>
                  <a:lnTo>
                    <a:pt x="1216" y="2099"/>
                  </a:lnTo>
                  <a:lnTo>
                    <a:pt x="1221" y="2098"/>
                  </a:lnTo>
                  <a:lnTo>
                    <a:pt x="1225" y="2093"/>
                  </a:lnTo>
                  <a:lnTo>
                    <a:pt x="1230" y="2094"/>
                  </a:lnTo>
                  <a:lnTo>
                    <a:pt x="1235" y="2093"/>
                  </a:lnTo>
                  <a:lnTo>
                    <a:pt x="1240" y="2095"/>
                  </a:lnTo>
                  <a:lnTo>
                    <a:pt x="1245" y="2094"/>
                  </a:lnTo>
                  <a:lnTo>
                    <a:pt x="1249" y="2101"/>
                  </a:lnTo>
                  <a:lnTo>
                    <a:pt x="1254" y="2100"/>
                  </a:lnTo>
                  <a:lnTo>
                    <a:pt x="1259" y="2100"/>
                  </a:lnTo>
                  <a:lnTo>
                    <a:pt x="1264" y="2103"/>
                  </a:lnTo>
                  <a:lnTo>
                    <a:pt x="1269" y="2100"/>
                  </a:lnTo>
                  <a:lnTo>
                    <a:pt x="1274" y="2096"/>
                  </a:lnTo>
                  <a:lnTo>
                    <a:pt x="1278" y="2097"/>
                  </a:lnTo>
                  <a:lnTo>
                    <a:pt x="1283" y="2100"/>
                  </a:lnTo>
                  <a:lnTo>
                    <a:pt x="1288" y="2098"/>
                  </a:lnTo>
                  <a:lnTo>
                    <a:pt x="1293" y="2092"/>
                  </a:lnTo>
                  <a:lnTo>
                    <a:pt x="1298" y="2090"/>
                  </a:lnTo>
                  <a:lnTo>
                    <a:pt x="1302" y="2091"/>
                  </a:lnTo>
                  <a:lnTo>
                    <a:pt x="1307" y="2099"/>
                  </a:lnTo>
                  <a:lnTo>
                    <a:pt x="1312" y="2098"/>
                  </a:lnTo>
                  <a:lnTo>
                    <a:pt x="1317" y="2101"/>
                  </a:lnTo>
                  <a:lnTo>
                    <a:pt x="1321" y="2105"/>
                  </a:lnTo>
                  <a:lnTo>
                    <a:pt x="1326" y="2103"/>
                  </a:lnTo>
                  <a:lnTo>
                    <a:pt x="1331" y="2105"/>
                  </a:lnTo>
                  <a:lnTo>
                    <a:pt x="1336" y="2102"/>
                  </a:lnTo>
                  <a:lnTo>
                    <a:pt x="1341" y="2098"/>
                  </a:lnTo>
                  <a:lnTo>
                    <a:pt x="1345" y="2101"/>
                  </a:lnTo>
                  <a:lnTo>
                    <a:pt x="1350" y="2098"/>
                  </a:lnTo>
                  <a:lnTo>
                    <a:pt x="1355" y="2099"/>
                  </a:lnTo>
                  <a:lnTo>
                    <a:pt x="1360" y="2097"/>
                  </a:lnTo>
                  <a:lnTo>
                    <a:pt x="1365" y="2099"/>
                  </a:lnTo>
                  <a:lnTo>
                    <a:pt x="1369" y="2091"/>
                  </a:lnTo>
                  <a:lnTo>
                    <a:pt x="1374" y="2086"/>
                  </a:lnTo>
                  <a:lnTo>
                    <a:pt x="1379" y="2085"/>
                  </a:lnTo>
                  <a:lnTo>
                    <a:pt x="1384" y="2076"/>
                  </a:lnTo>
                  <a:lnTo>
                    <a:pt x="1389" y="2074"/>
                  </a:lnTo>
                  <a:lnTo>
                    <a:pt x="1393" y="2065"/>
                  </a:lnTo>
                  <a:lnTo>
                    <a:pt x="1398" y="2054"/>
                  </a:lnTo>
                  <a:lnTo>
                    <a:pt x="1403" y="2056"/>
                  </a:lnTo>
                  <a:lnTo>
                    <a:pt x="1408" y="2054"/>
                  </a:lnTo>
                  <a:lnTo>
                    <a:pt x="1413" y="2055"/>
                  </a:lnTo>
                  <a:lnTo>
                    <a:pt x="1417" y="2059"/>
                  </a:lnTo>
                  <a:lnTo>
                    <a:pt x="1422" y="2063"/>
                  </a:lnTo>
                  <a:lnTo>
                    <a:pt x="1427" y="2069"/>
                  </a:lnTo>
                  <a:lnTo>
                    <a:pt x="1432" y="2073"/>
                  </a:lnTo>
                  <a:lnTo>
                    <a:pt x="1437" y="2085"/>
                  </a:lnTo>
                  <a:lnTo>
                    <a:pt x="1442" y="2092"/>
                  </a:lnTo>
                  <a:lnTo>
                    <a:pt x="1446" y="2089"/>
                  </a:lnTo>
                  <a:lnTo>
                    <a:pt x="1451" y="2092"/>
                  </a:lnTo>
                  <a:lnTo>
                    <a:pt x="1456" y="2092"/>
                  </a:lnTo>
                  <a:lnTo>
                    <a:pt x="1461" y="2091"/>
                  </a:lnTo>
                  <a:lnTo>
                    <a:pt x="1466" y="2085"/>
                  </a:lnTo>
                  <a:lnTo>
                    <a:pt x="1470" y="2080"/>
                  </a:lnTo>
                  <a:lnTo>
                    <a:pt x="1475" y="2081"/>
                  </a:lnTo>
                  <a:lnTo>
                    <a:pt x="1480" y="2084"/>
                  </a:lnTo>
                  <a:lnTo>
                    <a:pt x="1485" y="2090"/>
                  </a:lnTo>
                  <a:lnTo>
                    <a:pt x="1490" y="2091"/>
                  </a:lnTo>
                  <a:lnTo>
                    <a:pt x="1495" y="2091"/>
                  </a:lnTo>
                  <a:lnTo>
                    <a:pt x="1499" y="2089"/>
                  </a:lnTo>
                  <a:lnTo>
                    <a:pt x="1504" y="2089"/>
                  </a:lnTo>
                  <a:lnTo>
                    <a:pt x="1509" y="2090"/>
                  </a:lnTo>
                  <a:lnTo>
                    <a:pt x="1514" y="2089"/>
                  </a:lnTo>
                  <a:lnTo>
                    <a:pt x="1518" y="2087"/>
                  </a:lnTo>
                  <a:lnTo>
                    <a:pt x="1523" y="2086"/>
                  </a:lnTo>
                  <a:lnTo>
                    <a:pt x="1528" y="2079"/>
                  </a:lnTo>
                  <a:lnTo>
                    <a:pt x="1533" y="2073"/>
                  </a:lnTo>
                  <a:lnTo>
                    <a:pt x="1538" y="2075"/>
                  </a:lnTo>
                  <a:lnTo>
                    <a:pt x="1542" y="2076"/>
                  </a:lnTo>
                  <a:lnTo>
                    <a:pt x="1547" y="2067"/>
                  </a:lnTo>
                  <a:lnTo>
                    <a:pt x="1552" y="2064"/>
                  </a:lnTo>
                  <a:lnTo>
                    <a:pt x="1557" y="2057"/>
                  </a:lnTo>
                  <a:lnTo>
                    <a:pt x="1561" y="2059"/>
                  </a:lnTo>
                  <a:lnTo>
                    <a:pt x="1566" y="2063"/>
                  </a:lnTo>
                  <a:lnTo>
                    <a:pt x="1571" y="2073"/>
                  </a:lnTo>
                  <a:lnTo>
                    <a:pt x="1576" y="2079"/>
                  </a:lnTo>
                  <a:lnTo>
                    <a:pt x="1581" y="2080"/>
                  </a:lnTo>
                  <a:lnTo>
                    <a:pt x="1586" y="2084"/>
                  </a:lnTo>
                  <a:lnTo>
                    <a:pt x="1590" y="2086"/>
                  </a:lnTo>
                  <a:lnTo>
                    <a:pt x="1595" y="2088"/>
                  </a:lnTo>
                  <a:lnTo>
                    <a:pt x="1600" y="2090"/>
                  </a:lnTo>
                  <a:lnTo>
                    <a:pt x="1605" y="2094"/>
                  </a:lnTo>
                  <a:lnTo>
                    <a:pt x="1610" y="2089"/>
                  </a:lnTo>
                  <a:lnTo>
                    <a:pt x="1614" y="2090"/>
                  </a:lnTo>
                  <a:lnTo>
                    <a:pt x="1619" y="2094"/>
                  </a:lnTo>
                  <a:lnTo>
                    <a:pt x="1624" y="2088"/>
                  </a:lnTo>
                  <a:lnTo>
                    <a:pt x="1629" y="2089"/>
                  </a:lnTo>
                  <a:lnTo>
                    <a:pt x="1634" y="2086"/>
                  </a:lnTo>
                  <a:lnTo>
                    <a:pt x="1639" y="2092"/>
                  </a:lnTo>
                  <a:lnTo>
                    <a:pt x="1643" y="2086"/>
                  </a:lnTo>
                  <a:lnTo>
                    <a:pt x="1648" y="2083"/>
                  </a:lnTo>
                  <a:lnTo>
                    <a:pt x="1653" y="2083"/>
                  </a:lnTo>
                  <a:lnTo>
                    <a:pt x="1658" y="2083"/>
                  </a:lnTo>
                  <a:lnTo>
                    <a:pt x="1663" y="2081"/>
                  </a:lnTo>
                  <a:lnTo>
                    <a:pt x="1667" y="2087"/>
                  </a:lnTo>
                  <a:lnTo>
                    <a:pt x="1672" y="2085"/>
                  </a:lnTo>
                  <a:lnTo>
                    <a:pt x="1677" y="2076"/>
                  </a:lnTo>
                  <a:lnTo>
                    <a:pt x="1682" y="2075"/>
                  </a:lnTo>
                  <a:lnTo>
                    <a:pt x="1687" y="2070"/>
                  </a:lnTo>
                  <a:lnTo>
                    <a:pt x="1692" y="2071"/>
                  </a:lnTo>
                  <a:lnTo>
                    <a:pt x="1696" y="2069"/>
                  </a:lnTo>
                  <a:lnTo>
                    <a:pt x="1701" y="2064"/>
                  </a:lnTo>
                  <a:lnTo>
                    <a:pt x="1706" y="2050"/>
                  </a:lnTo>
                  <a:lnTo>
                    <a:pt x="1711" y="2048"/>
                  </a:lnTo>
                  <a:lnTo>
                    <a:pt x="1715" y="2034"/>
                  </a:lnTo>
                  <a:lnTo>
                    <a:pt x="1720" y="2026"/>
                  </a:lnTo>
                  <a:lnTo>
                    <a:pt x="1725" y="2037"/>
                  </a:lnTo>
                  <a:lnTo>
                    <a:pt x="1730" y="2047"/>
                  </a:lnTo>
                  <a:lnTo>
                    <a:pt x="1735" y="2054"/>
                  </a:lnTo>
                  <a:lnTo>
                    <a:pt x="1739" y="2056"/>
                  </a:lnTo>
                  <a:lnTo>
                    <a:pt x="1744" y="2062"/>
                  </a:lnTo>
                  <a:lnTo>
                    <a:pt x="1749" y="2059"/>
                  </a:lnTo>
                  <a:lnTo>
                    <a:pt x="1754" y="2060"/>
                  </a:lnTo>
                  <a:lnTo>
                    <a:pt x="1758" y="2059"/>
                  </a:lnTo>
                  <a:lnTo>
                    <a:pt x="1763" y="2049"/>
                  </a:lnTo>
                  <a:lnTo>
                    <a:pt x="1768" y="2049"/>
                  </a:lnTo>
                  <a:lnTo>
                    <a:pt x="1773" y="2047"/>
                  </a:lnTo>
                  <a:lnTo>
                    <a:pt x="1778" y="2047"/>
                  </a:lnTo>
                  <a:lnTo>
                    <a:pt x="1783" y="2052"/>
                  </a:lnTo>
                  <a:lnTo>
                    <a:pt x="1787" y="2055"/>
                  </a:lnTo>
                  <a:lnTo>
                    <a:pt x="1792" y="2060"/>
                  </a:lnTo>
                  <a:lnTo>
                    <a:pt x="1797" y="2056"/>
                  </a:lnTo>
                  <a:lnTo>
                    <a:pt x="1802" y="2057"/>
                  </a:lnTo>
                  <a:lnTo>
                    <a:pt x="1807" y="2055"/>
                  </a:lnTo>
                  <a:lnTo>
                    <a:pt x="1811" y="2052"/>
                  </a:lnTo>
                  <a:lnTo>
                    <a:pt x="1816" y="2049"/>
                  </a:lnTo>
                  <a:lnTo>
                    <a:pt x="1821" y="2052"/>
                  </a:lnTo>
                  <a:lnTo>
                    <a:pt x="1826" y="2049"/>
                  </a:lnTo>
                  <a:lnTo>
                    <a:pt x="1831" y="2050"/>
                  </a:lnTo>
                  <a:lnTo>
                    <a:pt x="1835" y="2054"/>
                  </a:lnTo>
                  <a:lnTo>
                    <a:pt x="1840" y="2055"/>
                  </a:lnTo>
                  <a:lnTo>
                    <a:pt x="1845" y="2045"/>
                  </a:lnTo>
                  <a:lnTo>
                    <a:pt x="1850" y="2040"/>
                  </a:lnTo>
                  <a:lnTo>
                    <a:pt x="1855" y="2032"/>
                  </a:lnTo>
                  <a:lnTo>
                    <a:pt x="1860" y="2022"/>
                  </a:lnTo>
                  <a:lnTo>
                    <a:pt x="1864" y="2010"/>
                  </a:lnTo>
                  <a:lnTo>
                    <a:pt x="1869" y="2001"/>
                  </a:lnTo>
                  <a:lnTo>
                    <a:pt x="1874" y="1971"/>
                  </a:lnTo>
                  <a:lnTo>
                    <a:pt x="1879" y="1931"/>
                  </a:lnTo>
                  <a:lnTo>
                    <a:pt x="1884" y="1889"/>
                  </a:lnTo>
                  <a:lnTo>
                    <a:pt x="1888" y="1876"/>
                  </a:lnTo>
                  <a:lnTo>
                    <a:pt x="1893" y="1887"/>
                  </a:lnTo>
                  <a:lnTo>
                    <a:pt x="1898" y="1913"/>
                  </a:lnTo>
                  <a:lnTo>
                    <a:pt x="1903" y="1935"/>
                  </a:lnTo>
                  <a:lnTo>
                    <a:pt x="1908" y="1937"/>
                  </a:lnTo>
                  <a:lnTo>
                    <a:pt x="1912" y="1917"/>
                  </a:lnTo>
                  <a:lnTo>
                    <a:pt x="1917" y="1882"/>
                  </a:lnTo>
                  <a:lnTo>
                    <a:pt x="1922" y="1845"/>
                  </a:lnTo>
                  <a:lnTo>
                    <a:pt x="1927" y="1794"/>
                  </a:lnTo>
                  <a:lnTo>
                    <a:pt x="1932" y="1709"/>
                  </a:lnTo>
                  <a:lnTo>
                    <a:pt x="1936" y="1592"/>
                  </a:lnTo>
                  <a:lnTo>
                    <a:pt x="1941" y="1454"/>
                  </a:lnTo>
                  <a:lnTo>
                    <a:pt x="1946" y="1414"/>
                  </a:lnTo>
                  <a:lnTo>
                    <a:pt x="1951" y="1330"/>
                  </a:lnTo>
                  <a:lnTo>
                    <a:pt x="1955" y="1193"/>
                  </a:lnTo>
                  <a:lnTo>
                    <a:pt x="1960" y="878"/>
                  </a:lnTo>
                  <a:lnTo>
                    <a:pt x="1965" y="723"/>
                  </a:lnTo>
                  <a:lnTo>
                    <a:pt x="1970" y="809"/>
                  </a:lnTo>
                  <a:lnTo>
                    <a:pt x="1975" y="967"/>
                  </a:lnTo>
                  <a:lnTo>
                    <a:pt x="1979" y="1130"/>
                  </a:lnTo>
                  <a:lnTo>
                    <a:pt x="1984" y="1276"/>
                  </a:lnTo>
                  <a:lnTo>
                    <a:pt x="1989" y="1278"/>
                  </a:lnTo>
                  <a:lnTo>
                    <a:pt x="1994" y="1210"/>
                  </a:lnTo>
                  <a:lnTo>
                    <a:pt x="1999" y="1157"/>
                  </a:lnTo>
                  <a:lnTo>
                    <a:pt x="2004" y="991"/>
                  </a:lnTo>
                  <a:lnTo>
                    <a:pt x="2008" y="470"/>
                  </a:lnTo>
                  <a:lnTo>
                    <a:pt x="2013" y="259"/>
                  </a:lnTo>
                  <a:lnTo>
                    <a:pt x="2018" y="479"/>
                  </a:lnTo>
                  <a:lnTo>
                    <a:pt x="2023" y="868"/>
                  </a:lnTo>
                  <a:lnTo>
                    <a:pt x="2028" y="1302"/>
                  </a:lnTo>
                  <a:lnTo>
                    <a:pt x="2032" y="1546"/>
                  </a:lnTo>
                  <a:lnTo>
                    <a:pt x="2037" y="1644"/>
                  </a:lnTo>
                  <a:lnTo>
                    <a:pt x="2042" y="1703"/>
                  </a:lnTo>
                  <a:lnTo>
                    <a:pt x="2047" y="1750"/>
                  </a:lnTo>
                  <a:lnTo>
                    <a:pt x="2052" y="1787"/>
                  </a:lnTo>
                  <a:lnTo>
                    <a:pt x="2057" y="1811"/>
                  </a:lnTo>
                  <a:lnTo>
                    <a:pt x="2061" y="1842"/>
                  </a:lnTo>
                  <a:lnTo>
                    <a:pt x="2066" y="1837"/>
                  </a:lnTo>
                  <a:lnTo>
                    <a:pt x="2071" y="1838"/>
                  </a:lnTo>
                  <a:lnTo>
                    <a:pt x="2076" y="1812"/>
                  </a:lnTo>
                  <a:lnTo>
                    <a:pt x="2081" y="1811"/>
                  </a:lnTo>
                  <a:lnTo>
                    <a:pt x="2085" y="1801"/>
                  </a:lnTo>
                  <a:lnTo>
                    <a:pt x="2090" y="1794"/>
                  </a:lnTo>
                  <a:lnTo>
                    <a:pt x="2095" y="1819"/>
                  </a:lnTo>
                  <a:lnTo>
                    <a:pt x="2100" y="1858"/>
                  </a:lnTo>
                  <a:lnTo>
                    <a:pt x="2105" y="1882"/>
                  </a:lnTo>
                  <a:lnTo>
                    <a:pt x="2109" y="1925"/>
                  </a:lnTo>
                  <a:lnTo>
                    <a:pt x="2114" y="1933"/>
                  </a:lnTo>
                  <a:lnTo>
                    <a:pt x="2119" y="1944"/>
                  </a:lnTo>
                  <a:lnTo>
                    <a:pt x="2124" y="1949"/>
                  </a:lnTo>
                  <a:lnTo>
                    <a:pt x="2129" y="1940"/>
                  </a:lnTo>
                  <a:lnTo>
                    <a:pt x="2133" y="1934"/>
                  </a:lnTo>
                  <a:lnTo>
                    <a:pt x="2138" y="1934"/>
                  </a:lnTo>
                  <a:lnTo>
                    <a:pt x="2143" y="1903"/>
                  </a:lnTo>
                  <a:lnTo>
                    <a:pt x="2148" y="1893"/>
                  </a:lnTo>
                  <a:lnTo>
                    <a:pt x="2152" y="1890"/>
                  </a:lnTo>
                  <a:lnTo>
                    <a:pt x="2157" y="1885"/>
                  </a:lnTo>
                  <a:lnTo>
                    <a:pt x="2162" y="1869"/>
                  </a:lnTo>
                  <a:lnTo>
                    <a:pt x="2167" y="1860"/>
                  </a:lnTo>
                  <a:lnTo>
                    <a:pt x="2172" y="1834"/>
                  </a:lnTo>
                  <a:lnTo>
                    <a:pt x="2176" y="1743"/>
                  </a:lnTo>
                  <a:lnTo>
                    <a:pt x="2181" y="1647"/>
                  </a:lnTo>
                  <a:lnTo>
                    <a:pt x="2186" y="1587"/>
                  </a:lnTo>
                  <a:lnTo>
                    <a:pt x="2191" y="1555"/>
                  </a:lnTo>
                  <a:lnTo>
                    <a:pt x="2196" y="1496"/>
                  </a:lnTo>
                  <a:lnTo>
                    <a:pt x="2200" y="1428"/>
                  </a:lnTo>
                  <a:lnTo>
                    <a:pt x="2205" y="1316"/>
                  </a:lnTo>
                  <a:lnTo>
                    <a:pt x="2210" y="1063"/>
                  </a:lnTo>
                  <a:lnTo>
                    <a:pt x="2215" y="446"/>
                  </a:lnTo>
                  <a:lnTo>
                    <a:pt x="2220" y="0"/>
                  </a:lnTo>
                  <a:lnTo>
                    <a:pt x="2225" y="120"/>
                  </a:lnTo>
                  <a:lnTo>
                    <a:pt x="2229" y="570"/>
                  </a:lnTo>
                  <a:lnTo>
                    <a:pt x="2234" y="1076"/>
                  </a:lnTo>
                  <a:lnTo>
                    <a:pt x="2239" y="1398"/>
                  </a:lnTo>
                  <a:lnTo>
                    <a:pt x="2244" y="1572"/>
                  </a:lnTo>
                  <a:lnTo>
                    <a:pt x="2249" y="1669"/>
                  </a:lnTo>
                  <a:lnTo>
                    <a:pt x="2253" y="1718"/>
                  </a:lnTo>
                  <a:lnTo>
                    <a:pt x="2258" y="1727"/>
                  </a:lnTo>
                  <a:lnTo>
                    <a:pt x="2263" y="1703"/>
                  </a:lnTo>
                  <a:lnTo>
                    <a:pt x="2268" y="1634"/>
                  </a:lnTo>
                  <a:lnTo>
                    <a:pt x="2273" y="1586"/>
                  </a:lnTo>
                  <a:lnTo>
                    <a:pt x="2278" y="1621"/>
                  </a:lnTo>
                  <a:lnTo>
                    <a:pt x="2282" y="1647"/>
                  </a:lnTo>
                  <a:lnTo>
                    <a:pt x="2287" y="1661"/>
                  </a:lnTo>
                  <a:lnTo>
                    <a:pt x="2292" y="1612"/>
                  </a:lnTo>
                  <a:lnTo>
                    <a:pt x="2297" y="1590"/>
                  </a:lnTo>
                  <a:lnTo>
                    <a:pt x="2302" y="1521"/>
                  </a:lnTo>
                  <a:lnTo>
                    <a:pt x="2306" y="1345"/>
                  </a:lnTo>
                  <a:lnTo>
                    <a:pt x="2311" y="1218"/>
                  </a:lnTo>
                  <a:lnTo>
                    <a:pt x="2316" y="1319"/>
                  </a:lnTo>
                  <a:lnTo>
                    <a:pt x="2321" y="1513"/>
                  </a:lnTo>
                  <a:lnTo>
                    <a:pt x="2326" y="1702"/>
                  </a:lnTo>
                  <a:lnTo>
                    <a:pt x="2330" y="1834"/>
                  </a:lnTo>
                  <a:lnTo>
                    <a:pt x="2335" y="1910"/>
                  </a:lnTo>
                  <a:lnTo>
                    <a:pt x="2340" y="1954"/>
                  </a:lnTo>
                  <a:lnTo>
                    <a:pt x="2345" y="1980"/>
                  </a:lnTo>
                  <a:lnTo>
                    <a:pt x="2349" y="1985"/>
                  </a:lnTo>
                  <a:lnTo>
                    <a:pt x="2354" y="1984"/>
                  </a:lnTo>
                  <a:lnTo>
                    <a:pt x="2359" y="1983"/>
                  </a:lnTo>
                  <a:lnTo>
                    <a:pt x="2364" y="1976"/>
                  </a:lnTo>
                  <a:lnTo>
                    <a:pt x="2369" y="1963"/>
                  </a:lnTo>
                  <a:lnTo>
                    <a:pt x="2373" y="1950"/>
                  </a:lnTo>
                  <a:lnTo>
                    <a:pt x="2378" y="1938"/>
                  </a:lnTo>
                  <a:lnTo>
                    <a:pt x="2383" y="1945"/>
                  </a:lnTo>
                  <a:lnTo>
                    <a:pt x="2388" y="1947"/>
                  </a:lnTo>
                  <a:lnTo>
                    <a:pt x="2393" y="1953"/>
                  </a:lnTo>
                  <a:lnTo>
                    <a:pt x="2397" y="1966"/>
                  </a:lnTo>
                  <a:lnTo>
                    <a:pt x="2402" y="1963"/>
                  </a:lnTo>
                  <a:lnTo>
                    <a:pt x="2407" y="1956"/>
                  </a:lnTo>
                  <a:lnTo>
                    <a:pt x="2412" y="1950"/>
                  </a:lnTo>
                  <a:lnTo>
                    <a:pt x="2417" y="1940"/>
                  </a:lnTo>
                  <a:lnTo>
                    <a:pt x="2422" y="1920"/>
                  </a:lnTo>
                  <a:lnTo>
                    <a:pt x="2426" y="1895"/>
                  </a:lnTo>
                  <a:lnTo>
                    <a:pt x="2431" y="1842"/>
                  </a:lnTo>
                  <a:lnTo>
                    <a:pt x="2436" y="1781"/>
                  </a:lnTo>
                  <a:lnTo>
                    <a:pt x="2441" y="1602"/>
                  </a:lnTo>
                  <a:lnTo>
                    <a:pt x="2446" y="1454"/>
                  </a:lnTo>
                  <a:lnTo>
                    <a:pt x="2450" y="1436"/>
                  </a:lnTo>
                  <a:lnTo>
                    <a:pt x="2455" y="1566"/>
                  </a:lnTo>
                  <a:lnTo>
                    <a:pt x="2460" y="1721"/>
                  </a:lnTo>
                  <a:lnTo>
                    <a:pt x="2465" y="1832"/>
                  </a:lnTo>
                  <a:lnTo>
                    <a:pt x="2470" y="1908"/>
                  </a:lnTo>
                  <a:lnTo>
                    <a:pt x="2475" y="1955"/>
                  </a:lnTo>
                  <a:lnTo>
                    <a:pt x="2479" y="1990"/>
                  </a:lnTo>
                  <a:lnTo>
                    <a:pt x="2484" y="1973"/>
                  </a:lnTo>
                  <a:lnTo>
                    <a:pt x="2489" y="1982"/>
                  </a:lnTo>
                  <a:lnTo>
                    <a:pt x="2494" y="1969"/>
                  </a:lnTo>
                  <a:lnTo>
                    <a:pt x="2499" y="1964"/>
                  </a:lnTo>
                  <a:lnTo>
                    <a:pt x="2503" y="1962"/>
                  </a:lnTo>
                  <a:lnTo>
                    <a:pt x="2508" y="1947"/>
                  </a:lnTo>
                  <a:lnTo>
                    <a:pt x="2513" y="1962"/>
                  </a:lnTo>
                  <a:lnTo>
                    <a:pt x="2518" y="1961"/>
                  </a:lnTo>
                  <a:lnTo>
                    <a:pt x="2523" y="1965"/>
                  </a:lnTo>
                  <a:lnTo>
                    <a:pt x="2527" y="1950"/>
                  </a:lnTo>
                  <a:lnTo>
                    <a:pt x="2532" y="1941"/>
                  </a:lnTo>
                  <a:lnTo>
                    <a:pt x="2537" y="1895"/>
                  </a:lnTo>
                  <a:lnTo>
                    <a:pt x="2542" y="1784"/>
                  </a:lnTo>
                  <a:lnTo>
                    <a:pt x="2546" y="1664"/>
                  </a:lnTo>
                  <a:lnTo>
                    <a:pt x="2551" y="1605"/>
                  </a:lnTo>
                  <a:lnTo>
                    <a:pt x="2556" y="1682"/>
                  </a:lnTo>
                  <a:lnTo>
                    <a:pt x="2561" y="1779"/>
                  </a:lnTo>
                  <a:lnTo>
                    <a:pt x="2566" y="1849"/>
                  </a:lnTo>
                  <a:lnTo>
                    <a:pt x="2570" y="1894"/>
                  </a:lnTo>
                  <a:lnTo>
                    <a:pt x="2575" y="1925"/>
                  </a:lnTo>
                  <a:lnTo>
                    <a:pt x="2580" y="1951"/>
                  </a:lnTo>
                  <a:lnTo>
                    <a:pt x="2585" y="1946"/>
                  </a:lnTo>
                  <a:lnTo>
                    <a:pt x="2590" y="1946"/>
                  </a:lnTo>
                  <a:lnTo>
                    <a:pt x="2594" y="1945"/>
                  </a:lnTo>
                  <a:lnTo>
                    <a:pt x="2599" y="1965"/>
                  </a:lnTo>
                  <a:lnTo>
                    <a:pt x="2604" y="1976"/>
                  </a:lnTo>
                  <a:lnTo>
                    <a:pt x="2609" y="1978"/>
                  </a:lnTo>
                  <a:lnTo>
                    <a:pt x="2614" y="1974"/>
                  </a:lnTo>
                  <a:lnTo>
                    <a:pt x="2618" y="1968"/>
                  </a:lnTo>
                  <a:lnTo>
                    <a:pt x="2623" y="1955"/>
                  </a:lnTo>
                  <a:lnTo>
                    <a:pt x="2628" y="1940"/>
                  </a:lnTo>
                  <a:lnTo>
                    <a:pt x="2633" y="1934"/>
                  </a:lnTo>
                  <a:lnTo>
                    <a:pt x="2638" y="1924"/>
                  </a:lnTo>
                  <a:lnTo>
                    <a:pt x="2643" y="1891"/>
                  </a:lnTo>
                  <a:lnTo>
                    <a:pt x="2647" y="1846"/>
                  </a:lnTo>
                  <a:lnTo>
                    <a:pt x="2652" y="1813"/>
                  </a:lnTo>
                  <a:lnTo>
                    <a:pt x="2657" y="1848"/>
                  </a:lnTo>
                  <a:lnTo>
                    <a:pt x="2662" y="1897"/>
                  </a:lnTo>
                  <a:lnTo>
                    <a:pt x="2667" y="1936"/>
                  </a:lnTo>
                  <a:lnTo>
                    <a:pt x="2671" y="1955"/>
                  </a:lnTo>
                  <a:lnTo>
                    <a:pt x="2676" y="1978"/>
                  </a:lnTo>
                  <a:lnTo>
                    <a:pt x="2681" y="1961"/>
                  </a:lnTo>
                  <a:lnTo>
                    <a:pt x="2686" y="1957"/>
                  </a:lnTo>
                  <a:lnTo>
                    <a:pt x="2691" y="1921"/>
                  </a:lnTo>
                  <a:lnTo>
                    <a:pt x="2696" y="1905"/>
                  </a:lnTo>
                  <a:lnTo>
                    <a:pt x="2700" y="1909"/>
                  </a:lnTo>
                  <a:lnTo>
                    <a:pt x="2705" y="1911"/>
                  </a:lnTo>
                  <a:lnTo>
                    <a:pt x="2710" y="1886"/>
                  </a:lnTo>
                  <a:lnTo>
                    <a:pt x="2715" y="1798"/>
                  </a:lnTo>
                  <a:lnTo>
                    <a:pt x="2720" y="1697"/>
                  </a:lnTo>
                  <a:lnTo>
                    <a:pt x="2724" y="1695"/>
                  </a:lnTo>
                  <a:lnTo>
                    <a:pt x="2729" y="1748"/>
                  </a:lnTo>
                  <a:lnTo>
                    <a:pt x="2734" y="1813"/>
                  </a:lnTo>
                  <a:lnTo>
                    <a:pt x="2739" y="1826"/>
                  </a:lnTo>
                  <a:lnTo>
                    <a:pt x="2743" y="1825"/>
                  </a:lnTo>
                  <a:lnTo>
                    <a:pt x="2748" y="1808"/>
                  </a:lnTo>
                  <a:lnTo>
                    <a:pt x="2753" y="1767"/>
                  </a:lnTo>
                  <a:lnTo>
                    <a:pt x="2758" y="1666"/>
                  </a:lnTo>
                  <a:lnTo>
                    <a:pt x="2763" y="1548"/>
                  </a:lnTo>
                  <a:lnTo>
                    <a:pt x="2767" y="1515"/>
                  </a:lnTo>
                  <a:lnTo>
                    <a:pt x="2772" y="1586"/>
                  </a:lnTo>
                  <a:lnTo>
                    <a:pt x="2777" y="1693"/>
                  </a:lnTo>
                  <a:lnTo>
                    <a:pt x="2782" y="1815"/>
                  </a:lnTo>
                  <a:lnTo>
                    <a:pt x="2787" y="1896"/>
                  </a:lnTo>
                  <a:lnTo>
                    <a:pt x="2791" y="1942"/>
                  </a:lnTo>
                  <a:lnTo>
                    <a:pt x="2796" y="1951"/>
                  </a:lnTo>
                  <a:lnTo>
                    <a:pt x="2801" y="1961"/>
                  </a:lnTo>
                  <a:lnTo>
                    <a:pt x="2806" y="1969"/>
                  </a:lnTo>
                  <a:lnTo>
                    <a:pt x="2811" y="1934"/>
                  </a:lnTo>
                  <a:lnTo>
                    <a:pt x="2815" y="1893"/>
                  </a:lnTo>
                  <a:lnTo>
                    <a:pt x="2820" y="1887"/>
                  </a:lnTo>
                  <a:lnTo>
                    <a:pt x="2825" y="1899"/>
                  </a:lnTo>
                  <a:lnTo>
                    <a:pt x="2830" y="1936"/>
                  </a:lnTo>
                  <a:lnTo>
                    <a:pt x="2835" y="1955"/>
                  </a:lnTo>
                  <a:lnTo>
                    <a:pt x="2840" y="1963"/>
                  </a:lnTo>
                  <a:lnTo>
                    <a:pt x="2844" y="1954"/>
                  </a:lnTo>
                  <a:lnTo>
                    <a:pt x="2849" y="1953"/>
                  </a:lnTo>
                  <a:lnTo>
                    <a:pt x="2854" y="1935"/>
                  </a:lnTo>
                  <a:lnTo>
                    <a:pt x="2859" y="1930"/>
                  </a:lnTo>
                  <a:lnTo>
                    <a:pt x="2864" y="1919"/>
                  </a:lnTo>
                  <a:lnTo>
                    <a:pt x="2868" y="1935"/>
                  </a:lnTo>
                  <a:lnTo>
                    <a:pt x="2873" y="1934"/>
                  </a:lnTo>
                  <a:lnTo>
                    <a:pt x="2878" y="1938"/>
                  </a:lnTo>
                  <a:lnTo>
                    <a:pt x="2883" y="1924"/>
                  </a:lnTo>
                  <a:lnTo>
                    <a:pt x="2888" y="1910"/>
                  </a:lnTo>
                  <a:lnTo>
                    <a:pt x="2893" y="1914"/>
                  </a:lnTo>
                  <a:lnTo>
                    <a:pt x="2897" y="1933"/>
                  </a:lnTo>
                  <a:lnTo>
                    <a:pt x="2902" y="1929"/>
                  </a:lnTo>
                  <a:lnTo>
                    <a:pt x="2907" y="1938"/>
                  </a:lnTo>
                  <a:lnTo>
                    <a:pt x="2912" y="1930"/>
                  </a:lnTo>
                  <a:lnTo>
                    <a:pt x="2917" y="1916"/>
                  </a:lnTo>
                  <a:lnTo>
                    <a:pt x="2921" y="1915"/>
                  </a:lnTo>
                  <a:lnTo>
                    <a:pt x="2926" y="1909"/>
                  </a:lnTo>
                  <a:lnTo>
                    <a:pt x="2931" y="1893"/>
                  </a:lnTo>
                  <a:lnTo>
                    <a:pt x="2936" y="1881"/>
                  </a:lnTo>
                  <a:lnTo>
                    <a:pt x="2940" y="1849"/>
                  </a:lnTo>
                  <a:lnTo>
                    <a:pt x="2945" y="1831"/>
                  </a:lnTo>
                  <a:lnTo>
                    <a:pt x="2950" y="1810"/>
                  </a:lnTo>
                  <a:lnTo>
                    <a:pt x="2955" y="1777"/>
                  </a:lnTo>
                  <a:lnTo>
                    <a:pt x="2960" y="1719"/>
                  </a:lnTo>
                  <a:lnTo>
                    <a:pt x="2964" y="1669"/>
                  </a:lnTo>
                  <a:lnTo>
                    <a:pt x="2969" y="1543"/>
                  </a:lnTo>
                  <a:lnTo>
                    <a:pt x="2974" y="1402"/>
                  </a:lnTo>
                  <a:lnTo>
                    <a:pt x="2979" y="1330"/>
                  </a:lnTo>
                  <a:lnTo>
                    <a:pt x="2984" y="1294"/>
                  </a:lnTo>
                  <a:lnTo>
                    <a:pt x="2988" y="1241"/>
                  </a:lnTo>
                  <a:lnTo>
                    <a:pt x="2993" y="1112"/>
                  </a:lnTo>
                  <a:lnTo>
                    <a:pt x="2998" y="931"/>
                  </a:lnTo>
                  <a:lnTo>
                    <a:pt x="3003" y="635"/>
                  </a:lnTo>
                  <a:lnTo>
                    <a:pt x="3008" y="408"/>
                  </a:lnTo>
                  <a:lnTo>
                    <a:pt x="3012" y="332"/>
                  </a:lnTo>
                  <a:lnTo>
                    <a:pt x="3017" y="478"/>
                  </a:lnTo>
                  <a:lnTo>
                    <a:pt x="3022" y="757"/>
                  </a:lnTo>
                  <a:lnTo>
                    <a:pt x="3027" y="1090"/>
                  </a:lnTo>
                  <a:lnTo>
                    <a:pt x="3032" y="1375"/>
                  </a:lnTo>
                  <a:lnTo>
                    <a:pt x="3036" y="1585"/>
                  </a:lnTo>
                  <a:lnTo>
                    <a:pt x="3041" y="1699"/>
                  </a:lnTo>
                  <a:lnTo>
                    <a:pt x="3046" y="1748"/>
                  </a:lnTo>
                  <a:lnTo>
                    <a:pt x="3051" y="1775"/>
                  </a:lnTo>
                  <a:lnTo>
                    <a:pt x="3056" y="1809"/>
                  </a:lnTo>
                  <a:lnTo>
                    <a:pt x="3061" y="1820"/>
                  </a:lnTo>
                  <a:lnTo>
                    <a:pt x="3065" y="1828"/>
                  </a:lnTo>
                  <a:lnTo>
                    <a:pt x="3070" y="1808"/>
                  </a:lnTo>
                  <a:lnTo>
                    <a:pt x="3075" y="1822"/>
                  </a:lnTo>
                  <a:lnTo>
                    <a:pt x="3080" y="1817"/>
                  </a:lnTo>
                  <a:lnTo>
                    <a:pt x="3085" y="1805"/>
                  </a:lnTo>
                  <a:lnTo>
                    <a:pt x="3089" y="1801"/>
                  </a:lnTo>
                  <a:lnTo>
                    <a:pt x="3094" y="1789"/>
                  </a:lnTo>
                  <a:lnTo>
                    <a:pt x="3099" y="1773"/>
                  </a:lnTo>
                  <a:lnTo>
                    <a:pt x="3104" y="1756"/>
                  </a:lnTo>
                  <a:lnTo>
                    <a:pt x="3109" y="1724"/>
                  </a:lnTo>
                  <a:lnTo>
                    <a:pt x="3114" y="1669"/>
                  </a:lnTo>
                  <a:lnTo>
                    <a:pt x="3118" y="1553"/>
                  </a:lnTo>
                  <a:lnTo>
                    <a:pt x="3123" y="1496"/>
                  </a:lnTo>
                  <a:lnTo>
                    <a:pt x="3128" y="1550"/>
                  </a:lnTo>
                  <a:lnTo>
                    <a:pt x="3133" y="1623"/>
                  </a:lnTo>
                  <a:lnTo>
                    <a:pt x="3137" y="1692"/>
                  </a:lnTo>
                  <a:lnTo>
                    <a:pt x="3142" y="1757"/>
                  </a:lnTo>
                  <a:lnTo>
                    <a:pt x="3147" y="1777"/>
                  </a:lnTo>
                  <a:lnTo>
                    <a:pt x="3152" y="1796"/>
                  </a:lnTo>
                  <a:lnTo>
                    <a:pt x="3157" y="1816"/>
                  </a:lnTo>
                  <a:lnTo>
                    <a:pt x="3161" y="1830"/>
                  </a:lnTo>
                  <a:lnTo>
                    <a:pt x="3166" y="1848"/>
                  </a:lnTo>
                  <a:lnTo>
                    <a:pt x="3171" y="1849"/>
                  </a:lnTo>
                  <a:lnTo>
                    <a:pt x="3176" y="1825"/>
                  </a:lnTo>
                  <a:lnTo>
                    <a:pt x="3180" y="1797"/>
                  </a:lnTo>
                  <a:lnTo>
                    <a:pt x="3185" y="1771"/>
                  </a:lnTo>
                  <a:lnTo>
                    <a:pt x="3190" y="1763"/>
                  </a:lnTo>
                  <a:lnTo>
                    <a:pt x="3195" y="1795"/>
                  </a:lnTo>
                  <a:lnTo>
                    <a:pt x="3200" y="1816"/>
                  </a:lnTo>
                  <a:lnTo>
                    <a:pt x="3205" y="1843"/>
                  </a:lnTo>
                  <a:lnTo>
                    <a:pt x="3209" y="1847"/>
                  </a:lnTo>
                  <a:lnTo>
                    <a:pt x="3214" y="1827"/>
                  </a:lnTo>
                  <a:lnTo>
                    <a:pt x="3219" y="1812"/>
                  </a:lnTo>
                  <a:lnTo>
                    <a:pt x="3224" y="1780"/>
                  </a:lnTo>
                  <a:lnTo>
                    <a:pt x="3229" y="1719"/>
                  </a:lnTo>
                  <a:lnTo>
                    <a:pt x="3233" y="1572"/>
                  </a:lnTo>
                  <a:lnTo>
                    <a:pt x="3238" y="1341"/>
                  </a:lnTo>
                  <a:lnTo>
                    <a:pt x="3243" y="1194"/>
                  </a:lnTo>
                  <a:lnTo>
                    <a:pt x="3248" y="1203"/>
                  </a:lnTo>
                  <a:lnTo>
                    <a:pt x="3253" y="1346"/>
                  </a:lnTo>
                  <a:lnTo>
                    <a:pt x="3258" y="1520"/>
                  </a:lnTo>
                  <a:lnTo>
                    <a:pt x="3262" y="1680"/>
                  </a:lnTo>
                  <a:lnTo>
                    <a:pt x="3267" y="1794"/>
                  </a:lnTo>
                  <a:lnTo>
                    <a:pt x="3272" y="1837"/>
                  </a:lnTo>
                  <a:lnTo>
                    <a:pt x="3277" y="1888"/>
                  </a:lnTo>
                  <a:lnTo>
                    <a:pt x="3282" y="1908"/>
                  </a:lnTo>
                  <a:lnTo>
                    <a:pt x="3286" y="1922"/>
                  </a:lnTo>
                  <a:lnTo>
                    <a:pt x="3291" y="1923"/>
                  </a:lnTo>
                  <a:lnTo>
                    <a:pt x="3296" y="1925"/>
                  </a:lnTo>
                  <a:lnTo>
                    <a:pt x="3301" y="1919"/>
                  </a:lnTo>
                  <a:lnTo>
                    <a:pt x="3306" y="1937"/>
                  </a:lnTo>
                  <a:lnTo>
                    <a:pt x="3310" y="1938"/>
                  </a:lnTo>
                  <a:lnTo>
                    <a:pt x="3315" y="1936"/>
                  </a:lnTo>
                  <a:lnTo>
                    <a:pt x="3320" y="1920"/>
                  </a:lnTo>
                  <a:lnTo>
                    <a:pt x="3325" y="1935"/>
                  </a:lnTo>
                  <a:lnTo>
                    <a:pt x="3330" y="1927"/>
                  </a:lnTo>
                  <a:lnTo>
                    <a:pt x="3334" y="1916"/>
                  </a:lnTo>
                  <a:lnTo>
                    <a:pt x="3339" y="1932"/>
                  </a:lnTo>
                  <a:lnTo>
                    <a:pt x="3344" y="1936"/>
                  </a:lnTo>
                  <a:lnTo>
                    <a:pt x="3349" y="1935"/>
                  </a:lnTo>
                  <a:lnTo>
                    <a:pt x="3354" y="1952"/>
                  </a:lnTo>
                  <a:lnTo>
                    <a:pt x="3358" y="1946"/>
                  </a:lnTo>
                  <a:lnTo>
                    <a:pt x="3363" y="1944"/>
                  </a:lnTo>
                  <a:lnTo>
                    <a:pt x="3368" y="1935"/>
                  </a:lnTo>
                  <a:lnTo>
                    <a:pt x="3373" y="1922"/>
                  </a:lnTo>
                  <a:lnTo>
                    <a:pt x="3377" y="1921"/>
                  </a:lnTo>
                  <a:lnTo>
                    <a:pt x="3382" y="1912"/>
                  </a:lnTo>
                  <a:lnTo>
                    <a:pt x="3387" y="1910"/>
                  </a:lnTo>
                  <a:lnTo>
                    <a:pt x="3392" y="1881"/>
                  </a:lnTo>
                  <a:lnTo>
                    <a:pt x="3397" y="1852"/>
                  </a:lnTo>
                  <a:lnTo>
                    <a:pt x="3401" y="1715"/>
                  </a:lnTo>
                  <a:lnTo>
                    <a:pt x="3406" y="1533"/>
                  </a:lnTo>
                  <a:lnTo>
                    <a:pt x="3411" y="1273"/>
                  </a:lnTo>
                  <a:lnTo>
                    <a:pt x="3416" y="923"/>
                  </a:lnTo>
                  <a:lnTo>
                    <a:pt x="3421" y="591"/>
                  </a:lnTo>
                  <a:lnTo>
                    <a:pt x="3426" y="376"/>
                  </a:lnTo>
                  <a:lnTo>
                    <a:pt x="3430" y="370"/>
                  </a:lnTo>
                  <a:lnTo>
                    <a:pt x="3435" y="585"/>
                  </a:lnTo>
                  <a:lnTo>
                    <a:pt x="3440" y="844"/>
                  </a:lnTo>
                  <a:lnTo>
                    <a:pt x="3445" y="956"/>
                  </a:lnTo>
                  <a:lnTo>
                    <a:pt x="3450" y="1128"/>
                  </a:lnTo>
                  <a:lnTo>
                    <a:pt x="3454" y="1364"/>
                  </a:lnTo>
                  <a:lnTo>
                    <a:pt x="3459" y="1526"/>
                  </a:lnTo>
                  <a:lnTo>
                    <a:pt x="3464" y="1648"/>
                  </a:lnTo>
                  <a:lnTo>
                    <a:pt x="3469" y="1758"/>
                  </a:lnTo>
                  <a:lnTo>
                    <a:pt x="3474" y="1809"/>
                  </a:lnTo>
                  <a:lnTo>
                    <a:pt x="3479" y="1854"/>
                  </a:lnTo>
                  <a:lnTo>
                    <a:pt x="3483" y="1889"/>
                  </a:lnTo>
                  <a:lnTo>
                    <a:pt x="3488" y="1906"/>
                  </a:lnTo>
                  <a:lnTo>
                    <a:pt x="3493" y="1917"/>
                  </a:lnTo>
                  <a:lnTo>
                    <a:pt x="3498" y="1942"/>
                  </a:lnTo>
                  <a:lnTo>
                    <a:pt x="3503" y="1942"/>
                  </a:lnTo>
                  <a:lnTo>
                    <a:pt x="3507" y="1958"/>
                  </a:lnTo>
                  <a:lnTo>
                    <a:pt x="3512" y="1971"/>
                  </a:lnTo>
                  <a:lnTo>
                    <a:pt x="3517" y="1979"/>
                  </a:lnTo>
                  <a:lnTo>
                    <a:pt x="3522" y="1984"/>
                  </a:lnTo>
                  <a:lnTo>
                    <a:pt x="3527" y="1997"/>
                  </a:lnTo>
                  <a:lnTo>
                    <a:pt x="3531" y="2012"/>
                  </a:lnTo>
                  <a:lnTo>
                    <a:pt x="3536" y="2008"/>
                  </a:lnTo>
                  <a:lnTo>
                    <a:pt x="3541" y="2011"/>
                  </a:lnTo>
                  <a:lnTo>
                    <a:pt x="3546" y="2001"/>
                  </a:lnTo>
                  <a:lnTo>
                    <a:pt x="3551" y="1990"/>
                  </a:lnTo>
                  <a:lnTo>
                    <a:pt x="3555" y="1989"/>
                  </a:lnTo>
                  <a:lnTo>
                    <a:pt x="3560" y="1990"/>
                  </a:lnTo>
                  <a:lnTo>
                    <a:pt x="3565" y="2000"/>
                  </a:lnTo>
                  <a:lnTo>
                    <a:pt x="3570" y="2005"/>
                  </a:lnTo>
                  <a:lnTo>
                    <a:pt x="3574" y="2004"/>
                  </a:lnTo>
                  <a:lnTo>
                    <a:pt x="3579" y="1999"/>
                  </a:lnTo>
                  <a:lnTo>
                    <a:pt x="3584" y="2003"/>
                  </a:lnTo>
                  <a:lnTo>
                    <a:pt x="3589" y="1989"/>
                  </a:lnTo>
                  <a:lnTo>
                    <a:pt x="3594" y="1968"/>
                  </a:lnTo>
                  <a:lnTo>
                    <a:pt x="3598" y="1957"/>
                  </a:lnTo>
                  <a:lnTo>
                    <a:pt x="3603" y="1966"/>
                  </a:lnTo>
                  <a:lnTo>
                    <a:pt x="3608" y="1974"/>
                  </a:lnTo>
                  <a:lnTo>
                    <a:pt x="3613" y="1995"/>
                  </a:lnTo>
                  <a:lnTo>
                    <a:pt x="3618" y="1980"/>
                  </a:lnTo>
                  <a:lnTo>
                    <a:pt x="3623" y="1982"/>
                  </a:lnTo>
                  <a:lnTo>
                    <a:pt x="3627" y="1984"/>
                  </a:lnTo>
                  <a:lnTo>
                    <a:pt x="3632" y="1994"/>
                  </a:lnTo>
                  <a:lnTo>
                    <a:pt x="3637" y="1987"/>
                  </a:lnTo>
                  <a:lnTo>
                    <a:pt x="3642" y="2001"/>
                  </a:lnTo>
                  <a:lnTo>
                    <a:pt x="3647" y="2011"/>
                  </a:lnTo>
                  <a:lnTo>
                    <a:pt x="3651" y="2019"/>
                  </a:lnTo>
                  <a:lnTo>
                    <a:pt x="3656" y="2022"/>
                  </a:lnTo>
                  <a:lnTo>
                    <a:pt x="3661" y="2027"/>
                  </a:lnTo>
                  <a:lnTo>
                    <a:pt x="3666" y="2026"/>
                  </a:lnTo>
                  <a:lnTo>
                    <a:pt x="3671" y="2026"/>
                  </a:lnTo>
                  <a:lnTo>
                    <a:pt x="3676" y="2045"/>
                  </a:lnTo>
                  <a:lnTo>
                    <a:pt x="3680" y="2044"/>
                  </a:lnTo>
                  <a:lnTo>
                    <a:pt x="3685" y="2048"/>
                  </a:lnTo>
                  <a:lnTo>
                    <a:pt x="3690" y="2051"/>
                  </a:lnTo>
                  <a:lnTo>
                    <a:pt x="3695" y="2054"/>
                  </a:lnTo>
                  <a:lnTo>
                    <a:pt x="3700" y="2053"/>
                  </a:lnTo>
                  <a:lnTo>
                    <a:pt x="3704" y="2039"/>
                  </a:lnTo>
                  <a:lnTo>
                    <a:pt x="3709" y="2049"/>
                  </a:lnTo>
                  <a:lnTo>
                    <a:pt x="3714" y="2049"/>
                  </a:lnTo>
                  <a:lnTo>
                    <a:pt x="3719" y="2050"/>
                  </a:lnTo>
                  <a:lnTo>
                    <a:pt x="3724" y="2044"/>
                  </a:lnTo>
                  <a:lnTo>
                    <a:pt x="3728" y="2041"/>
                  </a:lnTo>
                  <a:lnTo>
                    <a:pt x="3733" y="2034"/>
                  </a:lnTo>
                  <a:lnTo>
                    <a:pt x="3738" y="2032"/>
                  </a:lnTo>
                  <a:lnTo>
                    <a:pt x="3743" y="2031"/>
                  </a:lnTo>
                  <a:lnTo>
                    <a:pt x="3748" y="2038"/>
                  </a:lnTo>
                  <a:lnTo>
                    <a:pt x="3752" y="2045"/>
                  </a:lnTo>
                  <a:lnTo>
                    <a:pt x="3757" y="2057"/>
                  </a:lnTo>
                  <a:lnTo>
                    <a:pt x="3762" y="2054"/>
                  </a:lnTo>
                  <a:lnTo>
                    <a:pt x="3767" y="2065"/>
                  </a:lnTo>
                  <a:lnTo>
                    <a:pt x="3771" y="2075"/>
                  </a:lnTo>
                  <a:lnTo>
                    <a:pt x="3776" y="2064"/>
                  </a:lnTo>
                  <a:lnTo>
                    <a:pt x="3781" y="2070"/>
                  </a:lnTo>
                  <a:lnTo>
                    <a:pt x="3786" y="2072"/>
                  </a:lnTo>
                  <a:lnTo>
                    <a:pt x="3791" y="2063"/>
                  </a:lnTo>
                  <a:lnTo>
                    <a:pt x="3795" y="2064"/>
                  </a:lnTo>
                  <a:lnTo>
                    <a:pt x="3800" y="2060"/>
                  </a:lnTo>
                  <a:lnTo>
                    <a:pt x="3805" y="2050"/>
                  </a:lnTo>
                  <a:lnTo>
                    <a:pt x="3810" y="2037"/>
                  </a:lnTo>
                  <a:lnTo>
                    <a:pt x="3815" y="2031"/>
                  </a:lnTo>
                  <a:lnTo>
                    <a:pt x="3819" y="2013"/>
                  </a:lnTo>
                  <a:lnTo>
                    <a:pt x="3824" y="1995"/>
                  </a:lnTo>
                  <a:lnTo>
                    <a:pt x="3829" y="1986"/>
                  </a:lnTo>
                  <a:lnTo>
                    <a:pt x="3834" y="1982"/>
                  </a:lnTo>
                  <a:lnTo>
                    <a:pt x="3839" y="1981"/>
                  </a:lnTo>
                  <a:lnTo>
                    <a:pt x="3844" y="1992"/>
                  </a:lnTo>
                  <a:lnTo>
                    <a:pt x="3848" y="1996"/>
                  </a:lnTo>
                  <a:lnTo>
                    <a:pt x="3853" y="2020"/>
                  </a:lnTo>
                  <a:lnTo>
                    <a:pt x="3858" y="2023"/>
                  </a:lnTo>
                  <a:lnTo>
                    <a:pt x="3863" y="2037"/>
                  </a:lnTo>
                  <a:lnTo>
                    <a:pt x="3868" y="2031"/>
                  </a:lnTo>
                  <a:lnTo>
                    <a:pt x="3872" y="2032"/>
                  </a:lnTo>
                  <a:lnTo>
                    <a:pt x="3877" y="2042"/>
                  </a:lnTo>
                  <a:lnTo>
                    <a:pt x="3882" y="2047"/>
                  </a:lnTo>
                  <a:lnTo>
                    <a:pt x="3887" y="2050"/>
                  </a:lnTo>
                  <a:lnTo>
                    <a:pt x="3892" y="2054"/>
                  </a:lnTo>
                  <a:lnTo>
                    <a:pt x="3897" y="2064"/>
                  </a:lnTo>
                  <a:lnTo>
                    <a:pt x="3901" y="2067"/>
                  </a:lnTo>
                  <a:lnTo>
                    <a:pt x="3906" y="2077"/>
                  </a:lnTo>
                  <a:lnTo>
                    <a:pt x="3911" y="2072"/>
                  </a:lnTo>
                  <a:lnTo>
                    <a:pt x="3916" y="2078"/>
                  </a:lnTo>
                  <a:lnTo>
                    <a:pt x="3921" y="2078"/>
                  </a:lnTo>
                  <a:lnTo>
                    <a:pt x="3925" y="2059"/>
                  </a:lnTo>
                  <a:lnTo>
                    <a:pt x="3930" y="2048"/>
                  </a:lnTo>
                  <a:lnTo>
                    <a:pt x="3935" y="2020"/>
                  </a:lnTo>
                  <a:lnTo>
                    <a:pt x="3940" y="2001"/>
                  </a:lnTo>
                  <a:lnTo>
                    <a:pt x="3945" y="1997"/>
                  </a:lnTo>
                  <a:lnTo>
                    <a:pt x="3949" y="2004"/>
                  </a:lnTo>
                  <a:lnTo>
                    <a:pt x="3954" y="2015"/>
                  </a:lnTo>
                  <a:lnTo>
                    <a:pt x="3959" y="2018"/>
                  </a:lnTo>
                  <a:lnTo>
                    <a:pt x="3964" y="2025"/>
                  </a:lnTo>
                  <a:lnTo>
                    <a:pt x="3968" y="2030"/>
                  </a:lnTo>
                  <a:lnTo>
                    <a:pt x="3973" y="2029"/>
                  </a:lnTo>
                  <a:lnTo>
                    <a:pt x="3978" y="2030"/>
                  </a:lnTo>
                  <a:lnTo>
                    <a:pt x="3983" y="2028"/>
                  </a:lnTo>
                  <a:lnTo>
                    <a:pt x="3988" y="2032"/>
                  </a:lnTo>
                  <a:lnTo>
                    <a:pt x="3992" y="2029"/>
                  </a:lnTo>
                  <a:lnTo>
                    <a:pt x="3997" y="2032"/>
                  </a:lnTo>
                  <a:lnTo>
                    <a:pt x="4002" y="2039"/>
                  </a:lnTo>
                  <a:lnTo>
                    <a:pt x="4007" y="2032"/>
                  </a:lnTo>
                  <a:lnTo>
                    <a:pt x="4012" y="2031"/>
                  </a:lnTo>
                  <a:lnTo>
                    <a:pt x="4016" y="2023"/>
                  </a:lnTo>
                  <a:lnTo>
                    <a:pt x="4021" y="2029"/>
                  </a:lnTo>
                  <a:lnTo>
                    <a:pt x="4026" y="2025"/>
                  </a:lnTo>
                  <a:lnTo>
                    <a:pt x="4031" y="2032"/>
                  </a:lnTo>
                  <a:lnTo>
                    <a:pt x="4036" y="2027"/>
                  </a:lnTo>
                  <a:lnTo>
                    <a:pt x="4041" y="2028"/>
                  </a:lnTo>
                  <a:lnTo>
                    <a:pt x="4045" y="2015"/>
                  </a:lnTo>
                  <a:lnTo>
                    <a:pt x="4050" y="1998"/>
                  </a:lnTo>
                  <a:lnTo>
                    <a:pt x="4055" y="2004"/>
                  </a:lnTo>
                  <a:lnTo>
                    <a:pt x="4060" y="2011"/>
                  </a:lnTo>
                  <a:lnTo>
                    <a:pt x="4065" y="2017"/>
                  </a:lnTo>
                  <a:lnTo>
                    <a:pt x="4069" y="2029"/>
                  </a:lnTo>
                  <a:lnTo>
                    <a:pt x="4074" y="2028"/>
                  </a:lnTo>
                  <a:lnTo>
                    <a:pt x="4079" y="2020"/>
                  </a:lnTo>
                  <a:lnTo>
                    <a:pt x="4084" y="1995"/>
                  </a:lnTo>
                  <a:lnTo>
                    <a:pt x="4089" y="1957"/>
                  </a:lnTo>
                  <a:lnTo>
                    <a:pt x="4093" y="1940"/>
                  </a:lnTo>
                  <a:lnTo>
                    <a:pt x="4098" y="1928"/>
                  </a:lnTo>
                  <a:lnTo>
                    <a:pt x="4103" y="1899"/>
                  </a:lnTo>
                  <a:lnTo>
                    <a:pt x="4108" y="1874"/>
                  </a:lnTo>
                  <a:lnTo>
                    <a:pt x="4113" y="1844"/>
                  </a:lnTo>
                  <a:lnTo>
                    <a:pt x="4118" y="1801"/>
                  </a:lnTo>
                  <a:lnTo>
                    <a:pt x="4122" y="1770"/>
                  </a:lnTo>
                  <a:lnTo>
                    <a:pt x="4127" y="1770"/>
                  </a:lnTo>
                  <a:lnTo>
                    <a:pt x="4132" y="1776"/>
                  </a:lnTo>
                  <a:lnTo>
                    <a:pt x="4137" y="1786"/>
                  </a:lnTo>
                  <a:lnTo>
                    <a:pt x="4142" y="1805"/>
                  </a:lnTo>
                  <a:lnTo>
                    <a:pt x="4146" y="1845"/>
                  </a:lnTo>
                  <a:lnTo>
                    <a:pt x="4151" y="1877"/>
                  </a:lnTo>
                  <a:lnTo>
                    <a:pt x="4156" y="1919"/>
                  </a:lnTo>
                  <a:lnTo>
                    <a:pt x="4161" y="1942"/>
                  </a:lnTo>
                  <a:lnTo>
                    <a:pt x="4165" y="1974"/>
                  </a:lnTo>
                  <a:lnTo>
                    <a:pt x="4170" y="2004"/>
                  </a:lnTo>
                  <a:lnTo>
                    <a:pt x="4175" y="2019"/>
                  </a:lnTo>
                  <a:lnTo>
                    <a:pt x="4180" y="2034"/>
                  </a:lnTo>
                  <a:lnTo>
                    <a:pt x="4185" y="2032"/>
                  </a:lnTo>
                  <a:lnTo>
                    <a:pt x="4189" y="2024"/>
                  </a:lnTo>
                  <a:lnTo>
                    <a:pt x="4194" y="2013"/>
                  </a:lnTo>
                  <a:lnTo>
                    <a:pt x="4199" y="2014"/>
                  </a:lnTo>
                  <a:lnTo>
                    <a:pt x="4204" y="2010"/>
                  </a:lnTo>
                  <a:lnTo>
                    <a:pt x="4209" y="2004"/>
                  </a:lnTo>
                  <a:lnTo>
                    <a:pt x="4213" y="2002"/>
                  </a:lnTo>
                  <a:lnTo>
                    <a:pt x="4218" y="1992"/>
                  </a:lnTo>
                  <a:lnTo>
                    <a:pt x="4223" y="1947"/>
                  </a:lnTo>
                  <a:lnTo>
                    <a:pt x="4228" y="1888"/>
                  </a:lnTo>
                  <a:lnTo>
                    <a:pt x="4233" y="1768"/>
                  </a:lnTo>
                  <a:lnTo>
                    <a:pt x="4237" y="1653"/>
                  </a:lnTo>
                  <a:lnTo>
                    <a:pt x="4242" y="1567"/>
                  </a:lnTo>
                  <a:lnTo>
                    <a:pt x="4247" y="1520"/>
                  </a:lnTo>
                  <a:lnTo>
                    <a:pt x="4252" y="1513"/>
                  </a:lnTo>
                  <a:lnTo>
                    <a:pt x="4257" y="1488"/>
                  </a:lnTo>
                  <a:lnTo>
                    <a:pt x="4262" y="1463"/>
                  </a:lnTo>
                  <a:lnTo>
                    <a:pt x="4266" y="1450"/>
                  </a:lnTo>
                  <a:lnTo>
                    <a:pt x="4271" y="1419"/>
                  </a:lnTo>
                  <a:lnTo>
                    <a:pt x="4276" y="1451"/>
                  </a:lnTo>
                  <a:lnTo>
                    <a:pt x="4281" y="1532"/>
                  </a:lnTo>
                  <a:lnTo>
                    <a:pt x="4286" y="1640"/>
                  </a:lnTo>
                  <a:lnTo>
                    <a:pt x="4290" y="1774"/>
                  </a:lnTo>
                  <a:lnTo>
                    <a:pt x="4295" y="1860"/>
                  </a:lnTo>
                  <a:lnTo>
                    <a:pt x="4300" y="1930"/>
                  </a:lnTo>
                  <a:lnTo>
                    <a:pt x="4305" y="1981"/>
                  </a:lnTo>
                  <a:lnTo>
                    <a:pt x="4310" y="2017"/>
                  </a:lnTo>
                  <a:lnTo>
                    <a:pt x="4315" y="2036"/>
                  </a:lnTo>
                  <a:lnTo>
                    <a:pt x="4319" y="2051"/>
                  </a:lnTo>
                  <a:lnTo>
                    <a:pt x="4324" y="2067"/>
                  </a:lnTo>
                  <a:lnTo>
                    <a:pt x="4329" y="2075"/>
                  </a:lnTo>
                  <a:lnTo>
                    <a:pt x="4334" y="2076"/>
                  </a:lnTo>
                  <a:lnTo>
                    <a:pt x="4339" y="2065"/>
                  </a:lnTo>
                  <a:lnTo>
                    <a:pt x="4343" y="2057"/>
                  </a:lnTo>
                  <a:lnTo>
                    <a:pt x="4348" y="2048"/>
                  </a:lnTo>
                  <a:lnTo>
                    <a:pt x="4353" y="2040"/>
                  </a:lnTo>
                  <a:lnTo>
                    <a:pt x="4358" y="2024"/>
                  </a:lnTo>
                  <a:lnTo>
                    <a:pt x="4362" y="2006"/>
                  </a:lnTo>
                  <a:lnTo>
                    <a:pt x="4367" y="1984"/>
                  </a:lnTo>
                  <a:lnTo>
                    <a:pt x="4372" y="1961"/>
                  </a:lnTo>
                  <a:lnTo>
                    <a:pt x="4377" y="1920"/>
                  </a:lnTo>
                  <a:lnTo>
                    <a:pt x="4381" y="1867"/>
                  </a:lnTo>
                  <a:lnTo>
                    <a:pt x="4386" y="1839"/>
                  </a:lnTo>
                  <a:lnTo>
                    <a:pt x="4391" y="1823"/>
                  </a:lnTo>
                  <a:lnTo>
                    <a:pt x="4396" y="1833"/>
                  </a:lnTo>
                  <a:lnTo>
                    <a:pt x="4401" y="1811"/>
                  </a:lnTo>
                  <a:lnTo>
                    <a:pt x="4406" y="1837"/>
                  </a:lnTo>
                  <a:lnTo>
                    <a:pt x="4410" y="1876"/>
                  </a:lnTo>
                  <a:lnTo>
                    <a:pt x="4415" y="1905"/>
                  </a:lnTo>
                  <a:lnTo>
                    <a:pt x="4420" y="1931"/>
                  </a:lnTo>
                  <a:lnTo>
                    <a:pt x="4425" y="1946"/>
                  </a:lnTo>
                  <a:lnTo>
                    <a:pt x="4430" y="1955"/>
                  </a:lnTo>
                  <a:lnTo>
                    <a:pt x="4434" y="1978"/>
                  </a:lnTo>
                  <a:lnTo>
                    <a:pt x="4439" y="1992"/>
                  </a:lnTo>
                  <a:lnTo>
                    <a:pt x="4444" y="1997"/>
                  </a:lnTo>
                  <a:lnTo>
                    <a:pt x="4449" y="1993"/>
                  </a:lnTo>
                  <a:lnTo>
                    <a:pt x="4454" y="1992"/>
                  </a:lnTo>
                  <a:lnTo>
                    <a:pt x="4459" y="1989"/>
                  </a:lnTo>
                  <a:lnTo>
                    <a:pt x="4463" y="1985"/>
                  </a:lnTo>
                  <a:lnTo>
                    <a:pt x="4468" y="1991"/>
                  </a:lnTo>
                  <a:lnTo>
                    <a:pt x="4473" y="1991"/>
                  </a:lnTo>
                  <a:lnTo>
                    <a:pt x="4478" y="2004"/>
                  </a:lnTo>
                  <a:lnTo>
                    <a:pt x="4483" y="1992"/>
                  </a:lnTo>
                  <a:lnTo>
                    <a:pt x="4487" y="1969"/>
                  </a:lnTo>
                  <a:lnTo>
                    <a:pt x="4492" y="1955"/>
                  </a:lnTo>
                  <a:lnTo>
                    <a:pt x="4497" y="1916"/>
                  </a:lnTo>
                  <a:lnTo>
                    <a:pt x="4502" y="1890"/>
                  </a:lnTo>
                  <a:lnTo>
                    <a:pt x="4507" y="1843"/>
                  </a:lnTo>
                  <a:lnTo>
                    <a:pt x="4511" y="1779"/>
                  </a:lnTo>
                  <a:lnTo>
                    <a:pt x="4516" y="1696"/>
                  </a:lnTo>
                  <a:lnTo>
                    <a:pt x="4521" y="1607"/>
                  </a:lnTo>
                  <a:lnTo>
                    <a:pt x="4526" y="1513"/>
                  </a:lnTo>
                  <a:lnTo>
                    <a:pt x="4531" y="1375"/>
                  </a:lnTo>
                  <a:lnTo>
                    <a:pt x="4536" y="1227"/>
                  </a:lnTo>
                  <a:lnTo>
                    <a:pt x="4540" y="1059"/>
                  </a:lnTo>
                  <a:lnTo>
                    <a:pt x="4545" y="906"/>
                  </a:lnTo>
                  <a:lnTo>
                    <a:pt x="4550" y="728"/>
                  </a:lnTo>
                  <a:lnTo>
                    <a:pt x="4555" y="692"/>
                  </a:lnTo>
                  <a:lnTo>
                    <a:pt x="4559" y="616"/>
                  </a:lnTo>
                  <a:lnTo>
                    <a:pt x="4564" y="719"/>
                  </a:lnTo>
                  <a:lnTo>
                    <a:pt x="4569" y="777"/>
                  </a:lnTo>
                  <a:lnTo>
                    <a:pt x="4574" y="1002"/>
                  </a:lnTo>
                  <a:lnTo>
                    <a:pt x="4578" y="1169"/>
                  </a:lnTo>
                  <a:lnTo>
                    <a:pt x="4583" y="1447"/>
                  </a:lnTo>
                  <a:lnTo>
                    <a:pt x="4588" y="1618"/>
                  </a:lnTo>
                  <a:lnTo>
                    <a:pt x="4593" y="1771"/>
                  </a:lnTo>
                  <a:lnTo>
                    <a:pt x="4598" y="1866"/>
                  </a:lnTo>
                  <a:lnTo>
                    <a:pt x="4602" y="1931"/>
                  </a:lnTo>
                  <a:lnTo>
                    <a:pt x="4607" y="1978"/>
                  </a:lnTo>
                  <a:lnTo>
                    <a:pt x="4612" y="2010"/>
                  </a:lnTo>
                  <a:lnTo>
                    <a:pt x="4617" y="2010"/>
                  </a:lnTo>
                  <a:lnTo>
                    <a:pt x="4622" y="2014"/>
                  </a:lnTo>
                  <a:lnTo>
                    <a:pt x="4627" y="2009"/>
                  </a:lnTo>
                  <a:lnTo>
                    <a:pt x="4631" y="2006"/>
                  </a:lnTo>
                  <a:lnTo>
                    <a:pt x="4636" y="2007"/>
                  </a:lnTo>
                  <a:lnTo>
                    <a:pt x="4641" y="1986"/>
                  </a:lnTo>
                  <a:lnTo>
                    <a:pt x="4646" y="1970"/>
                  </a:lnTo>
                  <a:lnTo>
                    <a:pt x="4651" y="1952"/>
                  </a:lnTo>
                  <a:lnTo>
                    <a:pt x="4655" y="1933"/>
                  </a:lnTo>
                  <a:lnTo>
                    <a:pt x="4660" y="1919"/>
                  </a:lnTo>
                  <a:lnTo>
                    <a:pt x="4665" y="1904"/>
                  </a:lnTo>
                  <a:lnTo>
                    <a:pt x="4670" y="1907"/>
                  </a:lnTo>
                  <a:lnTo>
                    <a:pt x="4675" y="1916"/>
                  </a:lnTo>
                  <a:lnTo>
                    <a:pt x="4680" y="1936"/>
                  </a:lnTo>
                  <a:lnTo>
                    <a:pt x="4684" y="1957"/>
                  </a:lnTo>
                  <a:lnTo>
                    <a:pt x="4689" y="1972"/>
                  </a:lnTo>
                  <a:lnTo>
                    <a:pt x="4694" y="1989"/>
                  </a:lnTo>
                  <a:lnTo>
                    <a:pt x="4699" y="1989"/>
                  </a:lnTo>
                  <a:lnTo>
                    <a:pt x="4704" y="1990"/>
                  </a:lnTo>
                  <a:lnTo>
                    <a:pt x="4708" y="1972"/>
                  </a:lnTo>
                  <a:lnTo>
                    <a:pt x="4713" y="1961"/>
                  </a:lnTo>
                  <a:lnTo>
                    <a:pt x="4718" y="1927"/>
                  </a:lnTo>
                  <a:lnTo>
                    <a:pt x="4723" y="1925"/>
                  </a:lnTo>
                  <a:lnTo>
                    <a:pt x="4728" y="1926"/>
                  </a:lnTo>
                  <a:lnTo>
                    <a:pt x="4733" y="1942"/>
                  </a:lnTo>
                  <a:lnTo>
                    <a:pt x="4737" y="1989"/>
                  </a:lnTo>
                  <a:lnTo>
                    <a:pt x="4742" y="2010"/>
                  </a:lnTo>
                  <a:lnTo>
                    <a:pt x="4747" y="2052"/>
                  </a:lnTo>
                  <a:lnTo>
                    <a:pt x="4752" y="2074"/>
                  </a:lnTo>
                  <a:lnTo>
                    <a:pt x="4756" y="2098"/>
                  </a:lnTo>
                  <a:lnTo>
                    <a:pt x="4761" y="2113"/>
                  </a:lnTo>
                  <a:lnTo>
                    <a:pt x="4766" y="2117"/>
                  </a:lnTo>
                  <a:lnTo>
                    <a:pt x="4771" y="2130"/>
                  </a:lnTo>
                  <a:lnTo>
                    <a:pt x="4775" y="2135"/>
                  </a:lnTo>
                  <a:lnTo>
                    <a:pt x="4780" y="2138"/>
                  </a:lnTo>
                  <a:lnTo>
                    <a:pt x="4785" y="2140"/>
                  </a:lnTo>
                  <a:lnTo>
                    <a:pt x="4790" y="2140"/>
                  </a:lnTo>
                  <a:lnTo>
                    <a:pt x="4795" y="2141"/>
                  </a:lnTo>
                  <a:lnTo>
                    <a:pt x="4799" y="2141"/>
                  </a:lnTo>
                  <a:lnTo>
                    <a:pt x="4804" y="2133"/>
                  </a:lnTo>
                  <a:lnTo>
                    <a:pt x="4809" y="2130"/>
                  </a:lnTo>
                  <a:lnTo>
                    <a:pt x="4814" y="2116"/>
                  </a:lnTo>
                  <a:lnTo>
                    <a:pt x="4819" y="2116"/>
                  </a:lnTo>
                  <a:lnTo>
                    <a:pt x="4824" y="2105"/>
                  </a:lnTo>
                  <a:lnTo>
                    <a:pt x="4828" y="2110"/>
                  </a:lnTo>
                  <a:lnTo>
                    <a:pt x="4833" y="2110"/>
                  </a:lnTo>
                  <a:lnTo>
                    <a:pt x="4838" y="2114"/>
                  </a:lnTo>
                  <a:lnTo>
                    <a:pt x="4843" y="2116"/>
                  </a:lnTo>
                  <a:lnTo>
                    <a:pt x="4848" y="2120"/>
                  </a:lnTo>
                  <a:lnTo>
                    <a:pt x="4852" y="2124"/>
                  </a:lnTo>
                  <a:lnTo>
                    <a:pt x="4857" y="2125"/>
                  </a:lnTo>
                  <a:lnTo>
                    <a:pt x="4862" y="2132"/>
                  </a:lnTo>
                  <a:lnTo>
                    <a:pt x="4867" y="2135"/>
                  </a:lnTo>
                  <a:lnTo>
                    <a:pt x="4872" y="2142"/>
                  </a:lnTo>
                  <a:lnTo>
                    <a:pt x="4876" y="2143"/>
                  </a:lnTo>
                  <a:lnTo>
                    <a:pt x="4881" y="2147"/>
                  </a:lnTo>
                  <a:lnTo>
                    <a:pt x="4886" y="2152"/>
                  </a:lnTo>
                  <a:lnTo>
                    <a:pt x="4891" y="2155"/>
                  </a:lnTo>
                  <a:lnTo>
                    <a:pt x="4896" y="2157"/>
                  </a:lnTo>
                  <a:lnTo>
                    <a:pt x="4901" y="2157"/>
                  </a:lnTo>
                  <a:lnTo>
                    <a:pt x="4905" y="2161"/>
                  </a:lnTo>
                  <a:lnTo>
                    <a:pt x="4910" y="2160"/>
                  </a:lnTo>
                  <a:lnTo>
                    <a:pt x="4915" y="2162"/>
                  </a:lnTo>
                </a:path>
              </a:pathLst>
            </a:custGeom>
            <a:noFill/>
            <a:ln w="0" cap="flat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186" name="Freeform 386"/>
            <p:cNvSpPr>
              <a:spLocks/>
            </p:cNvSpPr>
            <p:nvPr/>
          </p:nvSpPr>
          <p:spPr bwMode="auto">
            <a:xfrm>
              <a:off x="7666629" y="3453193"/>
              <a:ext cx="2024593" cy="137341"/>
            </a:xfrm>
            <a:custGeom>
              <a:avLst/>
              <a:gdLst>
                <a:gd name="T0" fmla="*/ 34 w 2213"/>
                <a:gd name="T1" fmla="*/ 82 h 151"/>
                <a:gd name="T2" fmla="*/ 72 w 2213"/>
                <a:gd name="T3" fmla="*/ 97 h 151"/>
                <a:gd name="T4" fmla="*/ 110 w 2213"/>
                <a:gd name="T5" fmla="*/ 102 h 151"/>
                <a:gd name="T6" fmla="*/ 149 w 2213"/>
                <a:gd name="T7" fmla="*/ 91 h 151"/>
                <a:gd name="T8" fmla="*/ 187 w 2213"/>
                <a:gd name="T9" fmla="*/ 97 h 151"/>
                <a:gd name="T10" fmla="*/ 226 w 2213"/>
                <a:gd name="T11" fmla="*/ 100 h 151"/>
                <a:gd name="T12" fmla="*/ 264 w 2213"/>
                <a:gd name="T13" fmla="*/ 102 h 151"/>
                <a:gd name="T14" fmla="*/ 302 w 2213"/>
                <a:gd name="T15" fmla="*/ 109 h 151"/>
                <a:gd name="T16" fmla="*/ 341 w 2213"/>
                <a:gd name="T17" fmla="*/ 111 h 151"/>
                <a:gd name="T18" fmla="*/ 379 w 2213"/>
                <a:gd name="T19" fmla="*/ 104 h 151"/>
                <a:gd name="T20" fmla="*/ 418 w 2213"/>
                <a:gd name="T21" fmla="*/ 108 h 151"/>
                <a:gd name="T22" fmla="*/ 456 w 2213"/>
                <a:gd name="T23" fmla="*/ 73 h 151"/>
                <a:gd name="T24" fmla="*/ 495 w 2213"/>
                <a:gd name="T25" fmla="*/ 102 h 151"/>
                <a:gd name="T26" fmla="*/ 533 w 2213"/>
                <a:gd name="T27" fmla="*/ 96 h 151"/>
                <a:gd name="T28" fmla="*/ 572 w 2213"/>
                <a:gd name="T29" fmla="*/ 97 h 151"/>
                <a:gd name="T30" fmla="*/ 610 w 2213"/>
                <a:gd name="T31" fmla="*/ 98 h 151"/>
                <a:gd name="T32" fmla="*/ 648 w 2213"/>
                <a:gd name="T33" fmla="*/ 63 h 151"/>
                <a:gd name="T34" fmla="*/ 687 w 2213"/>
                <a:gd name="T35" fmla="*/ 18 h 151"/>
                <a:gd name="T36" fmla="*/ 725 w 2213"/>
                <a:gd name="T37" fmla="*/ 75 h 151"/>
                <a:gd name="T38" fmla="*/ 764 w 2213"/>
                <a:gd name="T39" fmla="*/ 96 h 151"/>
                <a:gd name="T40" fmla="*/ 802 w 2213"/>
                <a:gd name="T41" fmla="*/ 89 h 151"/>
                <a:gd name="T42" fmla="*/ 841 w 2213"/>
                <a:gd name="T43" fmla="*/ 99 h 151"/>
                <a:gd name="T44" fmla="*/ 879 w 2213"/>
                <a:gd name="T45" fmla="*/ 86 h 151"/>
                <a:gd name="T46" fmla="*/ 917 w 2213"/>
                <a:gd name="T47" fmla="*/ 95 h 151"/>
                <a:gd name="T48" fmla="*/ 956 w 2213"/>
                <a:gd name="T49" fmla="*/ 111 h 151"/>
                <a:gd name="T50" fmla="*/ 994 w 2213"/>
                <a:gd name="T51" fmla="*/ 121 h 151"/>
                <a:gd name="T52" fmla="*/ 1033 w 2213"/>
                <a:gd name="T53" fmla="*/ 125 h 151"/>
                <a:gd name="T54" fmla="*/ 1071 w 2213"/>
                <a:gd name="T55" fmla="*/ 130 h 151"/>
                <a:gd name="T56" fmla="*/ 1110 w 2213"/>
                <a:gd name="T57" fmla="*/ 130 h 151"/>
                <a:gd name="T58" fmla="*/ 1148 w 2213"/>
                <a:gd name="T59" fmla="*/ 130 h 151"/>
                <a:gd name="T60" fmla="*/ 1187 w 2213"/>
                <a:gd name="T61" fmla="*/ 128 h 151"/>
                <a:gd name="T62" fmla="*/ 1225 w 2213"/>
                <a:gd name="T63" fmla="*/ 119 h 151"/>
                <a:gd name="T64" fmla="*/ 1263 w 2213"/>
                <a:gd name="T65" fmla="*/ 130 h 151"/>
                <a:gd name="T66" fmla="*/ 1302 w 2213"/>
                <a:gd name="T67" fmla="*/ 134 h 151"/>
                <a:gd name="T68" fmla="*/ 1340 w 2213"/>
                <a:gd name="T69" fmla="*/ 136 h 151"/>
                <a:gd name="T70" fmla="*/ 1379 w 2213"/>
                <a:gd name="T71" fmla="*/ 133 h 151"/>
                <a:gd name="T72" fmla="*/ 1417 w 2213"/>
                <a:gd name="T73" fmla="*/ 135 h 151"/>
                <a:gd name="T74" fmla="*/ 1456 w 2213"/>
                <a:gd name="T75" fmla="*/ 135 h 151"/>
                <a:gd name="T76" fmla="*/ 1494 w 2213"/>
                <a:gd name="T77" fmla="*/ 139 h 151"/>
                <a:gd name="T78" fmla="*/ 1532 w 2213"/>
                <a:gd name="T79" fmla="*/ 139 h 151"/>
                <a:gd name="T80" fmla="*/ 1571 w 2213"/>
                <a:gd name="T81" fmla="*/ 141 h 151"/>
                <a:gd name="T82" fmla="*/ 1609 w 2213"/>
                <a:gd name="T83" fmla="*/ 140 h 151"/>
                <a:gd name="T84" fmla="*/ 1648 w 2213"/>
                <a:gd name="T85" fmla="*/ 139 h 151"/>
                <a:gd name="T86" fmla="*/ 1686 w 2213"/>
                <a:gd name="T87" fmla="*/ 142 h 151"/>
                <a:gd name="T88" fmla="*/ 1724 w 2213"/>
                <a:gd name="T89" fmla="*/ 143 h 151"/>
                <a:gd name="T90" fmla="*/ 1763 w 2213"/>
                <a:gd name="T91" fmla="*/ 143 h 151"/>
                <a:gd name="T92" fmla="*/ 1802 w 2213"/>
                <a:gd name="T93" fmla="*/ 143 h 151"/>
                <a:gd name="T94" fmla="*/ 1840 w 2213"/>
                <a:gd name="T95" fmla="*/ 145 h 151"/>
                <a:gd name="T96" fmla="*/ 1878 w 2213"/>
                <a:gd name="T97" fmla="*/ 145 h 151"/>
                <a:gd name="T98" fmla="*/ 1917 w 2213"/>
                <a:gd name="T99" fmla="*/ 146 h 151"/>
                <a:gd name="T100" fmla="*/ 1955 w 2213"/>
                <a:gd name="T101" fmla="*/ 146 h 151"/>
                <a:gd name="T102" fmla="*/ 1994 w 2213"/>
                <a:gd name="T103" fmla="*/ 146 h 151"/>
                <a:gd name="T104" fmla="*/ 2032 w 2213"/>
                <a:gd name="T105" fmla="*/ 147 h 151"/>
                <a:gd name="T106" fmla="*/ 2070 w 2213"/>
                <a:gd name="T107" fmla="*/ 147 h 151"/>
                <a:gd name="T108" fmla="*/ 2109 w 2213"/>
                <a:gd name="T109" fmla="*/ 148 h 151"/>
                <a:gd name="T110" fmla="*/ 2147 w 2213"/>
                <a:gd name="T111" fmla="*/ 149 h 151"/>
                <a:gd name="T112" fmla="*/ 2186 w 2213"/>
                <a:gd name="T113" fmla="*/ 150 h 1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2213" h="151">
                  <a:moveTo>
                    <a:pt x="0" y="80"/>
                  </a:moveTo>
                  <a:lnTo>
                    <a:pt x="5" y="75"/>
                  </a:lnTo>
                  <a:lnTo>
                    <a:pt x="10" y="75"/>
                  </a:lnTo>
                  <a:lnTo>
                    <a:pt x="14" y="77"/>
                  </a:lnTo>
                  <a:lnTo>
                    <a:pt x="19" y="77"/>
                  </a:lnTo>
                  <a:lnTo>
                    <a:pt x="24" y="79"/>
                  </a:lnTo>
                  <a:lnTo>
                    <a:pt x="29" y="79"/>
                  </a:lnTo>
                  <a:lnTo>
                    <a:pt x="34" y="82"/>
                  </a:lnTo>
                  <a:lnTo>
                    <a:pt x="38" y="82"/>
                  </a:lnTo>
                  <a:lnTo>
                    <a:pt x="43" y="90"/>
                  </a:lnTo>
                  <a:lnTo>
                    <a:pt x="48" y="91"/>
                  </a:lnTo>
                  <a:lnTo>
                    <a:pt x="53" y="97"/>
                  </a:lnTo>
                  <a:lnTo>
                    <a:pt x="57" y="97"/>
                  </a:lnTo>
                  <a:lnTo>
                    <a:pt x="62" y="95"/>
                  </a:lnTo>
                  <a:lnTo>
                    <a:pt x="67" y="100"/>
                  </a:lnTo>
                  <a:lnTo>
                    <a:pt x="72" y="97"/>
                  </a:lnTo>
                  <a:lnTo>
                    <a:pt x="77" y="102"/>
                  </a:lnTo>
                  <a:lnTo>
                    <a:pt x="81" y="99"/>
                  </a:lnTo>
                  <a:lnTo>
                    <a:pt x="86" y="100"/>
                  </a:lnTo>
                  <a:lnTo>
                    <a:pt x="91" y="101"/>
                  </a:lnTo>
                  <a:lnTo>
                    <a:pt x="96" y="99"/>
                  </a:lnTo>
                  <a:lnTo>
                    <a:pt x="101" y="107"/>
                  </a:lnTo>
                  <a:lnTo>
                    <a:pt x="105" y="102"/>
                  </a:lnTo>
                  <a:lnTo>
                    <a:pt x="110" y="102"/>
                  </a:lnTo>
                  <a:lnTo>
                    <a:pt x="115" y="102"/>
                  </a:lnTo>
                  <a:lnTo>
                    <a:pt x="120" y="99"/>
                  </a:lnTo>
                  <a:lnTo>
                    <a:pt x="125" y="100"/>
                  </a:lnTo>
                  <a:lnTo>
                    <a:pt x="130" y="100"/>
                  </a:lnTo>
                  <a:lnTo>
                    <a:pt x="134" y="100"/>
                  </a:lnTo>
                  <a:lnTo>
                    <a:pt x="139" y="95"/>
                  </a:lnTo>
                  <a:lnTo>
                    <a:pt x="144" y="99"/>
                  </a:lnTo>
                  <a:lnTo>
                    <a:pt x="149" y="91"/>
                  </a:lnTo>
                  <a:lnTo>
                    <a:pt x="154" y="96"/>
                  </a:lnTo>
                  <a:lnTo>
                    <a:pt x="158" y="96"/>
                  </a:lnTo>
                  <a:lnTo>
                    <a:pt x="163" y="99"/>
                  </a:lnTo>
                  <a:lnTo>
                    <a:pt x="168" y="95"/>
                  </a:lnTo>
                  <a:lnTo>
                    <a:pt x="173" y="93"/>
                  </a:lnTo>
                  <a:lnTo>
                    <a:pt x="178" y="99"/>
                  </a:lnTo>
                  <a:lnTo>
                    <a:pt x="183" y="99"/>
                  </a:lnTo>
                  <a:lnTo>
                    <a:pt x="187" y="97"/>
                  </a:lnTo>
                  <a:lnTo>
                    <a:pt x="192" y="97"/>
                  </a:lnTo>
                  <a:lnTo>
                    <a:pt x="197" y="99"/>
                  </a:lnTo>
                  <a:lnTo>
                    <a:pt x="202" y="96"/>
                  </a:lnTo>
                  <a:lnTo>
                    <a:pt x="207" y="97"/>
                  </a:lnTo>
                  <a:lnTo>
                    <a:pt x="211" y="104"/>
                  </a:lnTo>
                  <a:lnTo>
                    <a:pt x="216" y="103"/>
                  </a:lnTo>
                  <a:lnTo>
                    <a:pt x="221" y="99"/>
                  </a:lnTo>
                  <a:lnTo>
                    <a:pt x="226" y="100"/>
                  </a:lnTo>
                  <a:lnTo>
                    <a:pt x="231" y="98"/>
                  </a:lnTo>
                  <a:lnTo>
                    <a:pt x="235" y="99"/>
                  </a:lnTo>
                  <a:lnTo>
                    <a:pt x="240" y="95"/>
                  </a:lnTo>
                  <a:lnTo>
                    <a:pt x="245" y="99"/>
                  </a:lnTo>
                  <a:lnTo>
                    <a:pt x="250" y="95"/>
                  </a:lnTo>
                  <a:lnTo>
                    <a:pt x="254" y="98"/>
                  </a:lnTo>
                  <a:lnTo>
                    <a:pt x="259" y="99"/>
                  </a:lnTo>
                  <a:lnTo>
                    <a:pt x="264" y="102"/>
                  </a:lnTo>
                  <a:lnTo>
                    <a:pt x="269" y="104"/>
                  </a:lnTo>
                  <a:lnTo>
                    <a:pt x="274" y="107"/>
                  </a:lnTo>
                  <a:lnTo>
                    <a:pt x="278" y="107"/>
                  </a:lnTo>
                  <a:lnTo>
                    <a:pt x="283" y="106"/>
                  </a:lnTo>
                  <a:lnTo>
                    <a:pt x="288" y="108"/>
                  </a:lnTo>
                  <a:lnTo>
                    <a:pt x="293" y="110"/>
                  </a:lnTo>
                  <a:lnTo>
                    <a:pt x="298" y="113"/>
                  </a:lnTo>
                  <a:lnTo>
                    <a:pt x="302" y="109"/>
                  </a:lnTo>
                  <a:lnTo>
                    <a:pt x="307" y="110"/>
                  </a:lnTo>
                  <a:lnTo>
                    <a:pt x="312" y="110"/>
                  </a:lnTo>
                  <a:lnTo>
                    <a:pt x="317" y="111"/>
                  </a:lnTo>
                  <a:lnTo>
                    <a:pt x="322" y="109"/>
                  </a:lnTo>
                  <a:lnTo>
                    <a:pt x="327" y="108"/>
                  </a:lnTo>
                  <a:lnTo>
                    <a:pt x="331" y="114"/>
                  </a:lnTo>
                  <a:lnTo>
                    <a:pt x="336" y="110"/>
                  </a:lnTo>
                  <a:lnTo>
                    <a:pt x="341" y="111"/>
                  </a:lnTo>
                  <a:lnTo>
                    <a:pt x="346" y="108"/>
                  </a:lnTo>
                  <a:lnTo>
                    <a:pt x="351" y="107"/>
                  </a:lnTo>
                  <a:lnTo>
                    <a:pt x="355" y="100"/>
                  </a:lnTo>
                  <a:lnTo>
                    <a:pt x="360" y="105"/>
                  </a:lnTo>
                  <a:lnTo>
                    <a:pt x="365" y="104"/>
                  </a:lnTo>
                  <a:lnTo>
                    <a:pt x="370" y="99"/>
                  </a:lnTo>
                  <a:lnTo>
                    <a:pt x="375" y="104"/>
                  </a:lnTo>
                  <a:lnTo>
                    <a:pt x="379" y="104"/>
                  </a:lnTo>
                  <a:lnTo>
                    <a:pt x="384" y="103"/>
                  </a:lnTo>
                  <a:lnTo>
                    <a:pt x="389" y="106"/>
                  </a:lnTo>
                  <a:lnTo>
                    <a:pt x="394" y="109"/>
                  </a:lnTo>
                  <a:lnTo>
                    <a:pt x="399" y="107"/>
                  </a:lnTo>
                  <a:lnTo>
                    <a:pt x="404" y="109"/>
                  </a:lnTo>
                  <a:lnTo>
                    <a:pt x="408" y="110"/>
                  </a:lnTo>
                  <a:lnTo>
                    <a:pt x="413" y="109"/>
                  </a:lnTo>
                  <a:lnTo>
                    <a:pt x="418" y="108"/>
                  </a:lnTo>
                  <a:lnTo>
                    <a:pt x="423" y="106"/>
                  </a:lnTo>
                  <a:lnTo>
                    <a:pt x="428" y="99"/>
                  </a:lnTo>
                  <a:lnTo>
                    <a:pt x="432" y="98"/>
                  </a:lnTo>
                  <a:lnTo>
                    <a:pt x="437" y="91"/>
                  </a:lnTo>
                  <a:lnTo>
                    <a:pt x="442" y="83"/>
                  </a:lnTo>
                  <a:lnTo>
                    <a:pt x="447" y="79"/>
                  </a:lnTo>
                  <a:lnTo>
                    <a:pt x="451" y="70"/>
                  </a:lnTo>
                  <a:lnTo>
                    <a:pt x="456" y="73"/>
                  </a:lnTo>
                  <a:lnTo>
                    <a:pt x="461" y="71"/>
                  </a:lnTo>
                  <a:lnTo>
                    <a:pt x="466" y="73"/>
                  </a:lnTo>
                  <a:lnTo>
                    <a:pt x="471" y="81"/>
                  </a:lnTo>
                  <a:lnTo>
                    <a:pt x="475" y="85"/>
                  </a:lnTo>
                  <a:lnTo>
                    <a:pt x="480" y="87"/>
                  </a:lnTo>
                  <a:lnTo>
                    <a:pt x="485" y="93"/>
                  </a:lnTo>
                  <a:lnTo>
                    <a:pt x="490" y="95"/>
                  </a:lnTo>
                  <a:lnTo>
                    <a:pt x="495" y="102"/>
                  </a:lnTo>
                  <a:lnTo>
                    <a:pt x="499" y="102"/>
                  </a:lnTo>
                  <a:lnTo>
                    <a:pt x="504" y="103"/>
                  </a:lnTo>
                  <a:lnTo>
                    <a:pt x="509" y="99"/>
                  </a:lnTo>
                  <a:lnTo>
                    <a:pt x="514" y="103"/>
                  </a:lnTo>
                  <a:lnTo>
                    <a:pt x="519" y="100"/>
                  </a:lnTo>
                  <a:lnTo>
                    <a:pt x="523" y="95"/>
                  </a:lnTo>
                  <a:lnTo>
                    <a:pt x="528" y="95"/>
                  </a:lnTo>
                  <a:lnTo>
                    <a:pt x="533" y="96"/>
                  </a:lnTo>
                  <a:lnTo>
                    <a:pt x="538" y="90"/>
                  </a:lnTo>
                  <a:lnTo>
                    <a:pt x="543" y="90"/>
                  </a:lnTo>
                  <a:lnTo>
                    <a:pt x="548" y="85"/>
                  </a:lnTo>
                  <a:lnTo>
                    <a:pt x="552" y="82"/>
                  </a:lnTo>
                  <a:lnTo>
                    <a:pt x="557" y="90"/>
                  </a:lnTo>
                  <a:lnTo>
                    <a:pt x="562" y="89"/>
                  </a:lnTo>
                  <a:lnTo>
                    <a:pt x="567" y="90"/>
                  </a:lnTo>
                  <a:lnTo>
                    <a:pt x="572" y="97"/>
                  </a:lnTo>
                  <a:lnTo>
                    <a:pt x="576" y="96"/>
                  </a:lnTo>
                  <a:lnTo>
                    <a:pt x="581" y="97"/>
                  </a:lnTo>
                  <a:lnTo>
                    <a:pt x="586" y="96"/>
                  </a:lnTo>
                  <a:lnTo>
                    <a:pt x="591" y="96"/>
                  </a:lnTo>
                  <a:lnTo>
                    <a:pt x="596" y="94"/>
                  </a:lnTo>
                  <a:lnTo>
                    <a:pt x="601" y="95"/>
                  </a:lnTo>
                  <a:lnTo>
                    <a:pt x="605" y="98"/>
                  </a:lnTo>
                  <a:lnTo>
                    <a:pt x="610" y="98"/>
                  </a:lnTo>
                  <a:lnTo>
                    <a:pt x="615" y="96"/>
                  </a:lnTo>
                  <a:lnTo>
                    <a:pt x="620" y="98"/>
                  </a:lnTo>
                  <a:lnTo>
                    <a:pt x="625" y="98"/>
                  </a:lnTo>
                  <a:lnTo>
                    <a:pt x="629" y="95"/>
                  </a:lnTo>
                  <a:lnTo>
                    <a:pt x="634" y="92"/>
                  </a:lnTo>
                  <a:lnTo>
                    <a:pt x="639" y="83"/>
                  </a:lnTo>
                  <a:lnTo>
                    <a:pt x="644" y="77"/>
                  </a:lnTo>
                  <a:lnTo>
                    <a:pt x="648" y="63"/>
                  </a:lnTo>
                  <a:lnTo>
                    <a:pt x="653" y="49"/>
                  </a:lnTo>
                  <a:lnTo>
                    <a:pt x="658" y="37"/>
                  </a:lnTo>
                  <a:lnTo>
                    <a:pt x="663" y="19"/>
                  </a:lnTo>
                  <a:lnTo>
                    <a:pt x="668" y="7"/>
                  </a:lnTo>
                  <a:lnTo>
                    <a:pt x="672" y="0"/>
                  </a:lnTo>
                  <a:lnTo>
                    <a:pt x="677" y="0"/>
                  </a:lnTo>
                  <a:lnTo>
                    <a:pt x="682" y="4"/>
                  </a:lnTo>
                  <a:lnTo>
                    <a:pt x="687" y="18"/>
                  </a:lnTo>
                  <a:lnTo>
                    <a:pt x="692" y="22"/>
                  </a:lnTo>
                  <a:lnTo>
                    <a:pt x="696" y="29"/>
                  </a:lnTo>
                  <a:lnTo>
                    <a:pt x="701" y="35"/>
                  </a:lnTo>
                  <a:lnTo>
                    <a:pt x="706" y="47"/>
                  </a:lnTo>
                  <a:lnTo>
                    <a:pt x="711" y="51"/>
                  </a:lnTo>
                  <a:lnTo>
                    <a:pt x="716" y="66"/>
                  </a:lnTo>
                  <a:lnTo>
                    <a:pt x="720" y="70"/>
                  </a:lnTo>
                  <a:lnTo>
                    <a:pt x="725" y="75"/>
                  </a:lnTo>
                  <a:lnTo>
                    <a:pt x="730" y="79"/>
                  </a:lnTo>
                  <a:lnTo>
                    <a:pt x="735" y="81"/>
                  </a:lnTo>
                  <a:lnTo>
                    <a:pt x="740" y="89"/>
                  </a:lnTo>
                  <a:lnTo>
                    <a:pt x="745" y="91"/>
                  </a:lnTo>
                  <a:lnTo>
                    <a:pt x="749" y="92"/>
                  </a:lnTo>
                  <a:lnTo>
                    <a:pt x="754" y="94"/>
                  </a:lnTo>
                  <a:lnTo>
                    <a:pt x="759" y="96"/>
                  </a:lnTo>
                  <a:lnTo>
                    <a:pt x="764" y="96"/>
                  </a:lnTo>
                  <a:lnTo>
                    <a:pt x="769" y="95"/>
                  </a:lnTo>
                  <a:lnTo>
                    <a:pt x="773" y="97"/>
                  </a:lnTo>
                  <a:lnTo>
                    <a:pt x="778" y="97"/>
                  </a:lnTo>
                  <a:lnTo>
                    <a:pt x="783" y="93"/>
                  </a:lnTo>
                  <a:lnTo>
                    <a:pt x="788" y="93"/>
                  </a:lnTo>
                  <a:lnTo>
                    <a:pt x="793" y="93"/>
                  </a:lnTo>
                  <a:lnTo>
                    <a:pt x="797" y="91"/>
                  </a:lnTo>
                  <a:lnTo>
                    <a:pt x="802" y="89"/>
                  </a:lnTo>
                  <a:lnTo>
                    <a:pt x="807" y="88"/>
                  </a:lnTo>
                  <a:lnTo>
                    <a:pt x="812" y="92"/>
                  </a:lnTo>
                  <a:lnTo>
                    <a:pt x="817" y="95"/>
                  </a:lnTo>
                  <a:lnTo>
                    <a:pt x="822" y="95"/>
                  </a:lnTo>
                  <a:lnTo>
                    <a:pt x="826" y="97"/>
                  </a:lnTo>
                  <a:lnTo>
                    <a:pt x="831" y="98"/>
                  </a:lnTo>
                  <a:lnTo>
                    <a:pt x="836" y="99"/>
                  </a:lnTo>
                  <a:lnTo>
                    <a:pt x="841" y="99"/>
                  </a:lnTo>
                  <a:lnTo>
                    <a:pt x="845" y="96"/>
                  </a:lnTo>
                  <a:lnTo>
                    <a:pt x="850" y="97"/>
                  </a:lnTo>
                  <a:lnTo>
                    <a:pt x="855" y="96"/>
                  </a:lnTo>
                  <a:lnTo>
                    <a:pt x="860" y="93"/>
                  </a:lnTo>
                  <a:lnTo>
                    <a:pt x="865" y="91"/>
                  </a:lnTo>
                  <a:lnTo>
                    <a:pt x="869" y="87"/>
                  </a:lnTo>
                  <a:lnTo>
                    <a:pt x="874" y="86"/>
                  </a:lnTo>
                  <a:lnTo>
                    <a:pt x="879" y="86"/>
                  </a:lnTo>
                  <a:lnTo>
                    <a:pt x="884" y="80"/>
                  </a:lnTo>
                  <a:lnTo>
                    <a:pt x="888" y="84"/>
                  </a:lnTo>
                  <a:lnTo>
                    <a:pt x="893" y="84"/>
                  </a:lnTo>
                  <a:lnTo>
                    <a:pt x="898" y="84"/>
                  </a:lnTo>
                  <a:lnTo>
                    <a:pt x="903" y="85"/>
                  </a:lnTo>
                  <a:lnTo>
                    <a:pt x="908" y="91"/>
                  </a:lnTo>
                  <a:lnTo>
                    <a:pt x="913" y="92"/>
                  </a:lnTo>
                  <a:lnTo>
                    <a:pt x="917" y="95"/>
                  </a:lnTo>
                  <a:lnTo>
                    <a:pt x="922" y="98"/>
                  </a:lnTo>
                  <a:lnTo>
                    <a:pt x="927" y="99"/>
                  </a:lnTo>
                  <a:lnTo>
                    <a:pt x="932" y="102"/>
                  </a:lnTo>
                  <a:lnTo>
                    <a:pt x="937" y="107"/>
                  </a:lnTo>
                  <a:lnTo>
                    <a:pt x="941" y="109"/>
                  </a:lnTo>
                  <a:lnTo>
                    <a:pt x="946" y="107"/>
                  </a:lnTo>
                  <a:lnTo>
                    <a:pt x="951" y="108"/>
                  </a:lnTo>
                  <a:lnTo>
                    <a:pt x="956" y="111"/>
                  </a:lnTo>
                  <a:lnTo>
                    <a:pt x="961" y="115"/>
                  </a:lnTo>
                  <a:lnTo>
                    <a:pt x="966" y="116"/>
                  </a:lnTo>
                  <a:lnTo>
                    <a:pt x="970" y="116"/>
                  </a:lnTo>
                  <a:lnTo>
                    <a:pt x="975" y="121"/>
                  </a:lnTo>
                  <a:lnTo>
                    <a:pt x="980" y="120"/>
                  </a:lnTo>
                  <a:lnTo>
                    <a:pt x="985" y="119"/>
                  </a:lnTo>
                  <a:lnTo>
                    <a:pt x="990" y="120"/>
                  </a:lnTo>
                  <a:lnTo>
                    <a:pt x="994" y="121"/>
                  </a:lnTo>
                  <a:lnTo>
                    <a:pt x="999" y="122"/>
                  </a:lnTo>
                  <a:lnTo>
                    <a:pt x="1004" y="123"/>
                  </a:lnTo>
                  <a:lnTo>
                    <a:pt x="1009" y="123"/>
                  </a:lnTo>
                  <a:lnTo>
                    <a:pt x="1014" y="124"/>
                  </a:lnTo>
                  <a:lnTo>
                    <a:pt x="1019" y="125"/>
                  </a:lnTo>
                  <a:lnTo>
                    <a:pt x="1023" y="123"/>
                  </a:lnTo>
                  <a:lnTo>
                    <a:pt x="1028" y="128"/>
                  </a:lnTo>
                  <a:lnTo>
                    <a:pt x="1033" y="125"/>
                  </a:lnTo>
                  <a:lnTo>
                    <a:pt x="1038" y="128"/>
                  </a:lnTo>
                  <a:lnTo>
                    <a:pt x="1042" y="128"/>
                  </a:lnTo>
                  <a:lnTo>
                    <a:pt x="1047" y="127"/>
                  </a:lnTo>
                  <a:lnTo>
                    <a:pt x="1052" y="129"/>
                  </a:lnTo>
                  <a:lnTo>
                    <a:pt x="1057" y="127"/>
                  </a:lnTo>
                  <a:lnTo>
                    <a:pt x="1062" y="128"/>
                  </a:lnTo>
                  <a:lnTo>
                    <a:pt x="1066" y="130"/>
                  </a:lnTo>
                  <a:lnTo>
                    <a:pt x="1071" y="130"/>
                  </a:lnTo>
                  <a:lnTo>
                    <a:pt x="1076" y="130"/>
                  </a:lnTo>
                  <a:lnTo>
                    <a:pt x="1081" y="129"/>
                  </a:lnTo>
                  <a:lnTo>
                    <a:pt x="1085" y="128"/>
                  </a:lnTo>
                  <a:lnTo>
                    <a:pt x="1090" y="129"/>
                  </a:lnTo>
                  <a:lnTo>
                    <a:pt x="1095" y="132"/>
                  </a:lnTo>
                  <a:lnTo>
                    <a:pt x="1100" y="128"/>
                  </a:lnTo>
                  <a:lnTo>
                    <a:pt x="1105" y="132"/>
                  </a:lnTo>
                  <a:lnTo>
                    <a:pt x="1110" y="130"/>
                  </a:lnTo>
                  <a:lnTo>
                    <a:pt x="1114" y="132"/>
                  </a:lnTo>
                  <a:lnTo>
                    <a:pt x="1119" y="130"/>
                  </a:lnTo>
                  <a:lnTo>
                    <a:pt x="1124" y="131"/>
                  </a:lnTo>
                  <a:lnTo>
                    <a:pt x="1129" y="131"/>
                  </a:lnTo>
                  <a:lnTo>
                    <a:pt x="1134" y="131"/>
                  </a:lnTo>
                  <a:lnTo>
                    <a:pt x="1138" y="131"/>
                  </a:lnTo>
                  <a:lnTo>
                    <a:pt x="1143" y="131"/>
                  </a:lnTo>
                  <a:lnTo>
                    <a:pt x="1148" y="130"/>
                  </a:lnTo>
                  <a:lnTo>
                    <a:pt x="1153" y="131"/>
                  </a:lnTo>
                  <a:lnTo>
                    <a:pt x="1158" y="131"/>
                  </a:lnTo>
                  <a:lnTo>
                    <a:pt x="1163" y="132"/>
                  </a:lnTo>
                  <a:lnTo>
                    <a:pt x="1167" y="130"/>
                  </a:lnTo>
                  <a:lnTo>
                    <a:pt x="1172" y="131"/>
                  </a:lnTo>
                  <a:lnTo>
                    <a:pt x="1177" y="129"/>
                  </a:lnTo>
                  <a:lnTo>
                    <a:pt x="1182" y="133"/>
                  </a:lnTo>
                  <a:lnTo>
                    <a:pt x="1187" y="128"/>
                  </a:lnTo>
                  <a:lnTo>
                    <a:pt x="1191" y="127"/>
                  </a:lnTo>
                  <a:lnTo>
                    <a:pt x="1196" y="129"/>
                  </a:lnTo>
                  <a:lnTo>
                    <a:pt x="1201" y="128"/>
                  </a:lnTo>
                  <a:lnTo>
                    <a:pt x="1206" y="127"/>
                  </a:lnTo>
                  <a:lnTo>
                    <a:pt x="1211" y="126"/>
                  </a:lnTo>
                  <a:lnTo>
                    <a:pt x="1216" y="120"/>
                  </a:lnTo>
                  <a:lnTo>
                    <a:pt x="1220" y="121"/>
                  </a:lnTo>
                  <a:lnTo>
                    <a:pt x="1225" y="119"/>
                  </a:lnTo>
                  <a:lnTo>
                    <a:pt x="1230" y="121"/>
                  </a:lnTo>
                  <a:lnTo>
                    <a:pt x="1235" y="124"/>
                  </a:lnTo>
                  <a:lnTo>
                    <a:pt x="1239" y="128"/>
                  </a:lnTo>
                  <a:lnTo>
                    <a:pt x="1244" y="130"/>
                  </a:lnTo>
                  <a:lnTo>
                    <a:pt x="1249" y="130"/>
                  </a:lnTo>
                  <a:lnTo>
                    <a:pt x="1254" y="131"/>
                  </a:lnTo>
                  <a:lnTo>
                    <a:pt x="1259" y="134"/>
                  </a:lnTo>
                  <a:lnTo>
                    <a:pt x="1263" y="130"/>
                  </a:lnTo>
                  <a:lnTo>
                    <a:pt x="1268" y="130"/>
                  </a:lnTo>
                  <a:lnTo>
                    <a:pt x="1273" y="134"/>
                  </a:lnTo>
                  <a:lnTo>
                    <a:pt x="1278" y="135"/>
                  </a:lnTo>
                  <a:lnTo>
                    <a:pt x="1282" y="130"/>
                  </a:lnTo>
                  <a:lnTo>
                    <a:pt x="1287" y="136"/>
                  </a:lnTo>
                  <a:lnTo>
                    <a:pt x="1292" y="134"/>
                  </a:lnTo>
                  <a:lnTo>
                    <a:pt x="1297" y="134"/>
                  </a:lnTo>
                  <a:lnTo>
                    <a:pt x="1302" y="134"/>
                  </a:lnTo>
                  <a:lnTo>
                    <a:pt x="1307" y="136"/>
                  </a:lnTo>
                  <a:lnTo>
                    <a:pt x="1311" y="135"/>
                  </a:lnTo>
                  <a:lnTo>
                    <a:pt x="1316" y="135"/>
                  </a:lnTo>
                  <a:lnTo>
                    <a:pt x="1321" y="135"/>
                  </a:lnTo>
                  <a:lnTo>
                    <a:pt x="1326" y="135"/>
                  </a:lnTo>
                  <a:lnTo>
                    <a:pt x="1331" y="138"/>
                  </a:lnTo>
                  <a:lnTo>
                    <a:pt x="1335" y="137"/>
                  </a:lnTo>
                  <a:lnTo>
                    <a:pt x="1340" y="136"/>
                  </a:lnTo>
                  <a:lnTo>
                    <a:pt x="1345" y="133"/>
                  </a:lnTo>
                  <a:lnTo>
                    <a:pt x="1350" y="138"/>
                  </a:lnTo>
                  <a:lnTo>
                    <a:pt x="1355" y="135"/>
                  </a:lnTo>
                  <a:lnTo>
                    <a:pt x="1359" y="137"/>
                  </a:lnTo>
                  <a:lnTo>
                    <a:pt x="1364" y="135"/>
                  </a:lnTo>
                  <a:lnTo>
                    <a:pt x="1369" y="135"/>
                  </a:lnTo>
                  <a:lnTo>
                    <a:pt x="1374" y="137"/>
                  </a:lnTo>
                  <a:lnTo>
                    <a:pt x="1379" y="133"/>
                  </a:lnTo>
                  <a:lnTo>
                    <a:pt x="1384" y="133"/>
                  </a:lnTo>
                  <a:lnTo>
                    <a:pt x="1388" y="132"/>
                  </a:lnTo>
                  <a:lnTo>
                    <a:pt x="1393" y="134"/>
                  </a:lnTo>
                  <a:lnTo>
                    <a:pt x="1398" y="133"/>
                  </a:lnTo>
                  <a:lnTo>
                    <a:pt x="1403" y="135"/>
                  </a:lnTo>
                  <a:lnTo>
                    <a:pt x="1408" y="136"/>
                  </a:lnTo>
                  <a:lnTo>
                    <a:pt x="1412" y="136"/>
                  </a:lnTo>
                  <a:lnTo>
                    <a:pt x="1417" y="135"/>
                  </a:lnTo>
                  <a:lnTo>
                    <a:pt x="1422" y="137"/>
                  </a:lnTo>
                  <a:lnTo>
                    <a:pt x="1427" y="137"/>
                  </a:lnTo>
                  <a:lnTo>
                    <a:pt x="1432" y="137"/>
                  </a:lnTo>
                  <a:lnTo>
                    <a:pt x="1436" y="138"/>
                  </a:lnTo>
                  <a:lnTo>
                    <a:pt x="1441" y="138"/>
                  </a:lnTo>
                  <a:lnTo>
                    <a:pt x="1446" y="135"/>
                  </a:lnTo>
                  <a:lnTo>
                    <a:pt x="1451" y="137"/>
                  </a:lnTo>
                  <a:lnTo>
                    <a:pt x="1456" y="135"/>
                  </a:lnTo>
                  <a:lnTo>
                    <a:pt x="1460" y="139"/>
                  </a:lnTo>
                  <a:lnTo>
                    <a:pt x="1465" y="139"/>
                  </a:lnTo>
                  <a:lnTo>
                    <a:pt x="1470" y="137"/>
                  </a:lnTo>
                  <a:lnTo>
                    <a:pt x="1475" y="137"/>
                  </a:lnTo>
                  <a:lnTo>
                    <a:pt x="1479" y="136"/>
                  </a:lnTo>
                  <a:lnTo>
                    <a:pt x="1484" y="140"/>
                  </a:lnTo>
                  <a:lnTo>
                    <a:pt x="1489" y="137"/>
                  </a:lnTo>
                  <a:lnTo>
                    <a:pt x="1494" y="139"/>
                  </a:lnTo>
                  <a:lnTo>
                    <a:pt x="1499" y="139"/>
                  </a:lnTo>
                  <a:lnTo>
                    <a:pt x="1503" y="139"/>
                  </a:lnTo>
                  <a:lnTo>
                    <a:pt x="1508" y="139"/>
                  </a:lnTo>
                  <a:lnTo>
                    <a:pt x="1513" y="140"/>
                  </a:lnTo>
                  <a:lnTo>
                    <a:pt x="1518" y="140"/>
                  </a:lnTo>
                  <a:lnTo>
                    <a:pt x="1523" y="139"/>
                  </a:lnTo>
                  <a:lnTo>
                    <a:pt x="1528" y="139"/>
                  </a:lnTo>
                  <a:lnTo>
                    <a:pt x="1532" y="139"/>
                  </a:lnTo>
                  <a:lnTo>
                    <a:pt x="1537" y="140"/>
                  </a:lnTo>
                  <a:lnTo>
                    <a:pt x="1542" y="137"/>
                  </a:lnTo>
                  <a:lnTo>
                    <a:pt x="1547" y="138"/>
                  </a:lnTo>
                  <a:lnTo>
                    <a:pt x="1552" y="137"/>
                  </a:lnTo>
                  <a:lnTo>
                    <a:pt x="1556" y="139"/>
                  </a:lnTo>
                  <a:lnTo>
                    <a:pt x="1561" y="138"/>
                  </a:lnTo>
                  <a:lnTo>
                    <a:pt x="1566" y="142"/>
                  </a:lnTo>
                  <a:lnTo>
                    <a:pt x="1571" y="141"/>
                  </a:lnTo>
                  <a:lnTo>
                    <a:pt x="1576" y="137"/>
                  </a:lnTo>
                  <a:lnTo>
                    <a:pt x="1581" y="138"/>
                  </a:lnTo>
                  <a:lnTo>
                    <a:pt x="1585" y="139"/>
                  </a:lnTo>
                  <a:lnTo>
                    <a:pt x="1590" y="140"/>
                  </a:lnTo>
                  <a:lnTo>
                    <a:pt x="1595" y="140"/>
                  </a:lnTo>
                  <a:lnTo>
                    <a:pt x="1600" y="138"/>
                  </a:lnTo>
                  <a:lnTo>
                    <a:pt x="1605" y="139"/>
                  </a:lnTo>
                  <a:lnTo>
                    <a:pt x="1609" y="140"/>
                  </a:lnTo>
                  <a:lnTo>
                    <a:pt x="1614" y="141"/>
                  </a:lnTo>
                  <a:lnTo>
                    <a:pt x="1619" y="139"/>
                  </a:lnTo>
                  <a:lnTo>
                    <a:pt x="1624" y="141"/>
                  </a:lnTo>
                  <a:lnTo>
                    <a:pt x="1629" y="138"/>
                  </a:lnTo>
                  <a:lnTo>
                    <a:pt x="1633" y="142"/>
                  </a:lnTo>
                  <a:lnTo>
                    <a:pt x="1638" y="142"/>
                  </a:lnTo>
                  <a:lnTo>
                    <a:pt x="1643" y="142"/>
                  </a:lnTo>
                  <a:lnTo>
                    <a:pt x="1648" y="139"/>
                  </a:lnTo>
                  <a:lnTo>
                    <a:pt x="1653" y="139"/>
                  </a:lnTo>
                  <a:lnTo>
                    <a:pt x="1657" y="141"/>
                  </a:lnTo>
                  <a:lnTo>
                    <a:pt x="1662" y="141"/>
                  </a:lnTo>
                  <a:lnTo>
                    <a:pt x="1667" y="142"/>
                  </a:lnTo>
                  <a:lnTo>
                    <a:pt x="1672" y="144"/>
                  </a:lnTo>
                  <a:lnTo>
                    <a:pt x="1676" y="142"/>
                  </a:lnTo>
                  <a:lnTo>
                    <a:pt x="1681" y="140"/>
                  </a:lnTo>
                  <a:lnTo>
                    <a:pt x="1686" y="142"/>
                  </a:lnTo>
                  <a:lnTo>
                    <a:pt x="1691" y="143"/>
                  </a:lnTo>
                  <a:lnTo>
                    <a:pt x="1696" y="141"/>
                  </a:lnTo>
                  <a:lnTo>
                    <a:pt x="1700" y="141"/>
                  </a:lnTo>
                  <a:lnTo>
                    <a:pt x="1705" y="143"/>
                  </a:lnTo>
                  <a:lnTo>
                    <a:pt x="1710" y="142"/>
                  </a:lnTo>
                  <a:lnTo>
                    <a:pt x="1715" y="142"/>
                  </a:lnTo>
                  <a:lnTo>
                    <a:pt x="1720" y="143"/>
                  </a:lnTo>
                  <a:lnTo>
                    <a:pt x="1724" y="143"/>
                  </a:lnTo>
                  <a:lnTo>
                    <a:pt x="1729" y="142"/>
                  </a:lnTo>
                  <a:lnTo>
                    <a:pt x="1734" y="140"/>
                  </a:lnTo>
                  <a:lnTo>
                    <a:pt x="1739" y="143"/>
                  </a:lnTo>
                  <a:lnTo>
                    <a:pt x="1744" y="145"/>
                  </a:lnTo>
                  <a:lnTo>
                    <a:pt x="1749" y="145"/>
                  </a:lnTo>
                  <a:lnTo>
                    <a:pt x="1753" y="142"/>
                  </a:lnTo>
                  <a:lnTo>
                    <a:pt x="1758" y="144"/>
                  </a:lnTo>
                  <a:lnTo>
                    <a:pt x="1763" y="143"/>
                  </a:lnTo>
                  <a:lnTo>
                    <a:pt x="1768" y="142"/>
                  </a:lnTo>
                  <a:lnTo>
                    <a:pt x="1773" y="145"/>
                  </a:lnTo>
                  <a:lnTo>
                    <a:pt x="1777" y="145"/>
                  </a:lnTo>
                  <a:lnTo>
                    <a:pt x="1782" y="146"/>
                  </a:lnTo>
                  <a:lnTo>
                    <a:pt x="1787" y="144"/>
                  </a:lnTo>
                  <a:lnTo>
                    <a:pt x="1792" y="144"/>
                  </a:lnTo>
                  <a:lnTo>
                    <a:pt x="1797" y="145"/>
                  </a:lnTo>
                  <a:lnTo>
                    <a:pt x="1802" y="143"/>
                  </a:lnTo>
                  <a:lnTo>
                    <a:pt x="1806" y="142"/>
                  </a:lnTo>
                  <a:lnTo>
                    <a:pt x="1811" y="143"/>
                  </a:lnTo>
                  <a:lnTo>
                    <a:pt x="1816" y="144"/>
                  </a:lnTo>
                  <a:lnTo>
                    <a:pt x="1821" y="146"/>
                  </a:lnTo>
                  <a:lnTo>
                    <a:pt x="1826" y="147"/>
                  </a:lnTo>
                  <a:lnTo>
                    <a:pt x="1830" y="145"/>
                  </a:lnTo>
                  <a:lnTo>
                    <a:pt x="1835" y="143"/>
                  </a:lnTo>
                  <a:lnTo>
                    <a:pt x="1840" y="145"/>
                  </a:lnTo>
                  <a:lnTo>
                    <a:pt x="1845" y="143"/>
                  </a:lnTo>
                  <a:lnTo>
                    <a:pt x="1850" y="145"/>
                  </a:lnTo>
                  <a:lnTo>
                    <a:pt x="1854" y="144"/>
                  </a:lnTo>
                  <a:lnTo>
                    <a:pt x="1859" y="144"/>
                  </a:lnTo>
                  <a:lnTo>
                    <a:pt x="1864" y="144"/>
                  </a:lnTo>
                  <a:lnTo>
                    <a:pt x="1869" y="146"/>
                  </a:lnTo>
                  <a:lnTo>
                    <a:pt x="1873" y="147"/>
                  </a:lnTo>
                  <a:lnTo>
                    <a:pt x="1878" y="145"/>
                  </a:lnTo>
                  <a:lnTo>
                    <a:pt x="1883" y="146"/>
                  </a:lnTo>
                  <a:lnTo>
                    <a:pt x="1888" y="146"/>
                  </a:lnTo>
                  <a:lnTo>
                    <a:pt x="1893" y="146"/>
                  </a:lnTo>
                  <a:lnTo>
                    <a:pt x="1897" y="146"/>
                  </a:lnTo>
                  <a:lnTo>
                    <a:pt x="1902" y="146"/>
                  </a:lnTo>
                  <a:lnTo>
                    <a:pt x="1907" y="146"/>
                  </a:lnTo>
                  <a:lnTo>
                    <a:pt x="1912" y="147"/>
                  </a:lnTo>
                  <a:lnTo>
                    <a:pt x="1917" y="146"/>
                  </a:lnTo>
                  <a:lnTo>
                    <a:pt x="1921" y="146"/>
                  </a:lnTo>
                  <a:lnTo>
                    <a:pt x="1926" y="146"/>
                  </a:lnTo>
                  <a:lnTo>
                    <a:pt x="1931" y="145"/>
                  </a:lnTo>
                  <a:lnTo>
                    <a:pt x="1936" y="145"/>
                  </a:lnTo>
                  <a:lnTo>
                    <a:pt x="1941" y="147"/>
                  </a:lnTo>
                  <a:lnTo>
                    <a:pt x="1946" y="148"/>
                  </a:lnTo>
                  <a:lnTo>
                    <a:pt x="1950" y="148"/>
                  </a:lnTo>
                  <a:lnTo>
                    <a:pt x="1955" y="146"/>
                  </a:lnTo>
                  <a:lnTo>
                    <a:pt x="1960" y="146"/>
                  </a:lnTo>
                  <a:lnTo>
                    <a:pt x="1965" y="147"/>
                  </a:lnTo>
                  <a:lnTo>
                    <a:pt x="1970" y="148"/>
                  </a:lnTo>
                  <a:lnTo>
                    <a:pt x="1974" y="146"/>
                  </a:lnTo>
                  <a:lnTo>
                    <a:pt x="1979" y="147"/>
                  </a:lnTo>
                  <a:lnTo>
                    <a:pt x="1984" y="147"/>
                  </a:lnTo>
                  <a:lnTo>
                    <a:pt x="1989" y="147"/>
                  </a:lnTo>
                  <a:lnTo>
                    <a:pt x="1994" y="146"/>
                  </a:lnTo>
                  <a:lnTo>
                    <a:pt x="1999" y="149"/>
                  </a:lnTo>
                  <a:lnTo>
                    <a:pt x="2003" y="148"/>
                  </a:lnTo>
                  <a:lnTo>
                    <a:pt x="2008" y="147"/>
                  </a:lnTo>
                  <a:lnTo>
                    <a:pt x="2013" y="147"/>
                  </a:lnTo>
                  <a:lnTo>
                    <a:pt x="2018" y="148"/>
                  </a:lnTo>
                  <a:lnTo>
                    <a:pt x="2023" y="148"/>
                  </a:lnTo>
                  <a:lnTo>
                    <a:pt x="2027" y="146"/>
                  </a:lnTo>
                  <a:lnTo>
                    <a:pt x="2032" y="147"/>
                  </a:lnTo>
                  <a:lnTo>
                    <a:pt x="2037" y="147"/>
                  </a:lnTo>
                  <a:lnTo>
                    <a:pt x="2042" y="147"/>
                  </a:lnTo>
                  <a:lnTo>
                    <a:pt x="2047" y="147"/>
                  </a:lnTo>
                  <a:lnTo>
                    <a:pt x="2051" y="151"/>
                  </a:lnTo>
                  <a:lnTo>
                    <a:pt x="2056" y="150"/>
                  </a:lnTo>
                  <a:lnTo>
                    <a:pt x="2061" y="148"/>
                  </a:lnTo>
                  <a:lnTo>
                    <a:pt x="2066" y="147"/>
                  </a:lnTo>
                  <a:lnTo>
                    <a:pt x="2070" y="147"/>
                  </a:lnTo>
                  <a:lnTo>
                    <a:pt x="2075" y="150"/>
                  </a:lnTo>
                  <a:lnTo>
                    <a:pt x="2080" y="150"/>
                  </a:lnTo>
                  <a:lnTo>
                    <a:pt x="2085" y="150"/>
                  </a:lnTo>
                  <a:lnTo>
                    <a:pt x="2090" y="150"/>
                  </a:lnTo>
                  <a:lnTo>
                    <a:pt x="2094" y="149"/>
                  </a:lnTo>
                  <a:lnTo>
                    <a:pt x="2099" y="148"/>
                  </a:lnTo>
                  <a:lnTo>
                    <a:pt x="2104" y="148"/>
                  </a:lnTo>
                  <a:lnTo>
                    <a:pt x="2109" y="148"/>
                  </a:lnTo>
                  <a:lnTo>
                    <a:pt x="2114" y="151"/>
                  </a:lnTo>
                  <a:lnTo>
                    <a:pt x="2118" y="147"/>
                  </a:lnTo>
                  <a:lnTo>
                    <a:pt x="2123" y="151"/>
                  </a:lnTo>
                  <a:lnTo>
                    <a:pt x="2128" y="149"/>
                  </a:lnTo>
                  <a:lnTo>
                    <a:pt x="2133" y="149"/>
                  </a:lnTo>
                  <a:lnTo>
                    <a:pt x="2138" y="149"/>
                  </a:lnTo>
                  <a:lnTo>
                    <a:pt x="2142" y="147"/>
                  </a:lnTo>
                  <a:lnTo>
                    <a:pt x="2147" y="149"/>
                  </a:lnTo>
                  <a:lnTo>
                    <a:pt x="2152" y="149"/>
                  </a:lnTo>
                  <a:lnTo>
                    <a:pt x="2157" y="150"/>
                  </a:lnTo>
                  <a:lnTo>
                    <a:pt x="2162" y="150"/>
                  </a:lnTo>
                  <a:lnTo>
                    <a:pt x="2167" y="150"/>
                  </a:lnTo>
                  <a:lnTo>
                    <a:pt x="2171" y="149"/>
                  </a:lnTo>
                  <a:lnTo>
                    <a:pt x="2176" y="149"/>
                  </a:lnTo>
                  <a:lnTo>
                    <a:pt x="2181" y="150"/>
                  </a:lnTo>
                  <a:lnTo>
                    <a:pt x="2186" y="150"/>
                  </a:lnTo>
                  <a:lnTo>
                    <a:pt x="2191" y="148"/>
                  </a:lnTo>
                  <a:lnTo>
                    <a:pt x="2195" y="149"/>
                  </a:lnTo>
                  <a:lnTo>
                    <a:pt x="2200" y="149"/>
                  </a:lnTo>
                  <a:lnTo>
                    <a:pt x="2205" y="150"/>
                  </a:lnTo>
                  <a:lnTo>
                    <a:pt x="2210" y="151"/>
                  </a:lnTo>
                  <a:lnTo>
                    <a:pt x="2213" y="151"/>
                  </a:lnTo>
                </a:path>
              </a:pathLst>
            </a:custGeom>
            <a:noFill/>
            <a:ln w="0" cap="flat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187" name="Freeform 387"/>
            <p:cNvSpPr>
              <a:spLocks/>
            </p:cNvSpPr>
            <p:nvPr/>
          </p:nvSpPr>
          <p:spPr bwMode="auto">
            <a:xfrm>
              <a:off x="3171903" y="3444098"/>
              <a:ext cx="4496555" cy="221929"/>
            </a:xfrm>
            <a:custGeom>
              <a:avLst/>
              <a:gdLst>
                <a:gd name="T0" fmla="*/ 77 w 4915"/>
                <a:gd name="T1" fmla="*/ 165 h 244"/>
                <a:gd name="T2" fmla="*/ 159 w 4915"/>
                <a:gd name="T3" fmla="*/ 164 h 244"/>
                <a:gd name="T4" fmla="*/ 240 w 4915"/>
                <a:gd name="T5" fmla="*/ 165 h 244"/>
                <a:gd name="T6" fmla="*/ 322 w 4915"/>
                <a:gd name="T7" fmla="*/ 163 h 244"/>
                <a:gd name="T8" fmla="*/ 404 w 4915"/>
                <a:gd name="T9" fmla="*/ 164 h 244"/>
                <a:gd name="T10" fmla="*/ 486 w 4915"/>
                <a:gd name="T11" fmla="*/ 164 h 244"/>
                <a:gd name="T12" fmla="*/ 567 w 4915"/>
                <a:gd name="T13" fmla="*/ 163 h 244"/>
                <a:gd name="T14" fmla="*/ 649 w 4915"/>
                <a:gd name="T15" fmla="*/ 163 h 244"/>
                <a:gd name="T16" fmla="*/ 731 w 4915"/>
                <a:gd name="T17" fmla="*/ 161 h 244"/>
                <a:gd name="T18" fmla="*/ 812 w 4915"/>
                <a:gd name="T19" fmla="*/ 161 h 244"/>
                <a:gd name="T20" fmla="*/ 894 w 4915"/>
                <a:gd name="T21" fmla="*/ 160 h 244"/>
                <a:gd name="T22" fmla="*/ 976 w 4915"/>
                <a:gd name="T23" fmla="*/ 158 h 244"/>
                <a:gd name="T24" fmla="*/ 1057 w 4915"/>
                <a:gd name="T25" fmla="*/ 158 h 244"/>
                <a:gd name="T26" fmla="*/ 1139 w 4915"/>
                <a:gd name="T27" fmla="*/ 157 h 244"/>
                <a:gd name="T28" fmla="*/ 1220 w 4915"/>
                <a:gd name="T29" fmla="*/ 157 h 244"/>
                <a:gd name="T30" fmla="*/ 1302 w 4915"/>
                <a:gd name="T31" fmla="*/ 156 h 244"/>
                <a:gd name="T32" fmla="*/ 1384 w 4915"/>
                <a:gd name="T33" fmla="*/ 155 h 244"/>
                <a:gd name="T34" fmla="*/ 1466 w 4915"/>
                <a:gd name="T35" fmla="*/ 155 h 244"/>
                <a:gd name="T36" fmla="*/ 1547 w 4915"/>
                <a:gd name="T37" fmla="*/ 157 h 244"/>
                <a:gd name="T38" fmla="*/ 1629 w 4915"/>
                <a:gd name="T39" fmla="*/ 156 h 244"/>
                <a:gd name="T40" fmla="*/ 1711 w 4915"/>
                <a:gd name="T41" fmla="*/ 156 h 244"/>
                <a:gd name="T42" fmla="*/ 1792 w 4915"/>
                <a:gd name="T43" fmla="*/ 157 h 244"/>
                <a:gd name="T44" fmla="*/ 1874 w 4915"/>
                <a:gd name="T45" fmla="*/ 154 h 244"/>
                <a:gd name="T46" fmla="*/ 1956 w 4915"/>
                <a:gd name="T47" fmla="*/ 155 h 244"/>
                <a:gd name="T48" fmla="*/ 2037 w 4915"/>
                <a:gd name="T49" fmla="*/ 156 h 244"/>
                <a:gd name="T50" fmla="*/ 2119 w 4915"/>
                <a:gd name="T51" fmla="*/ 155 h 244"/>
                <a:gd name="T52" fmla="*/ 2201 w 4915"/>
                <a:gd name="T53" fmla="*/ 152 h 244"/>
                <a:gd name="T54" fmla="*/ 2282 w 4915"/>
                <a:gd name="T55" fmla="*/ 151 h 244"/>
                <a:gd name="T56" fmla="*/ 2364 w 4915"/>
                <a:gd name="T57" fmla="*/ 146 h 244"/>
                <a:gd name="T58" fmla="*/ 2445 w 4915"/>
                <a:gd name="T59" fmla="*/ 85 h 244"/>
                <a:gd name="T60" fmla="*/ 2527 w 4915"/>
                <a:gd name="T61" fmla="*/ 150 h 244"/>
                <a:gd name="T62" fmla="*/ 2609 w 4915"/>
                <a:gd name="T63" fmla="*/ 150 h 244"/>
                <a:gd name="T64" fmla="*/ 2691 w 4915"/>
                <a:gd name="T65" fmla="*/ 151 h 244"/>
                <a:gd name="T66" fmla="*/ 2772 w 4915"/>
                <a:gd name="T67" fmla="*/ 143 h 244"/>
                <a:gd name="T68" fmla="*/ 2854 w 4915"/>
                <a:gd name="T69" fmla="*/ 150 h 244"/>
                <a:gd name="T70" fmla="*/ 2936 w 4915"/>
                <a:gd name="T71" fmla="*/ 132 h 244"/>
                <a:gd name="T72" fmla="*/ 3017 w 4915"/>
                <a:gd name="T73" fmla="*/ 145 h 244"/>
                <a:gd name="T74" fmla="*/ 3099 w 4915"/>
                <a:gd name="T75" fmla="*/ 151 h 244"/>
                <a:gd name="T76" fmla="*/ 3181 w 4915"/>
                <a:gd name="T77" fmla="*/ 143 h 244"/>
                <a:gd name="T78" fmla="*/ 3262 w 4915"/>
                <a:gd name="T79" fmla="*/ 138 h 244"/>
                <a:gd name="T80" fmla="*/ 3344 w 4915"/>
                <a:gd name="T81" fmla="*/ 146 h 244"/>
                <a:gd name="T82" fmla="*/ 3426 w 4915"/>
                <a:gd name="T83" fmla="*/ 147 h 244"/>
                <a:gd name="T84" fmla="*/ 3507 w 4915"/>
                <a:gd name="T85" fmla="*/ 141 h 244"/>
                <a:gd name="T86" fmla="*/ 3589 w 4915"/>
                <a:gd name="T87" fmla="*/ 139 h 244"/>
                <a:gd name="T88" fmla="*/ 3671 w 4915"/>
                <a:gd name="T89" fmla="*/ 143 h 244"/>
                <a:gd name="T90" fmla="*/ 3752 w 4915"/>
                <a:gd name="T91" fmla="*/ 136 h 244"/>
                <a:gd name="T92" fmla="*/ 3834 w 4915"/>
                <a:gd name="T93" fmla="*/ 146 h 244"/>
                <a:gd name="T94" fmla="*/ 3916 w 4915"/>
                <a:gd name="T95" fmla="*/ 137 h 244"/>
                <a:gd name="T96" fmla="*/ 3997 w 4915"/>
                <a:gd name="T97" fmla="*/ 144 h 244"/>
                <a:gd name="T98" fmla="*/ 4079 w 4915"/>
                <a:gd name="T99" fmla="*/ 146 h 244"/>
                <a:gd name="T100" fmla="*/ 4161 w 4915"/>
                <a:gd name="T101" fmla="*/ 143 h 244"/>
                <a:gd name="T102" fmla="*/ 4242 w 4915"/>
                <a:gd name="T103" fmla="*/ 139 h 244"/>
                <a:gd name="T104" fmla="*/ 4324 w 4915"/>
                <a:gd name="T105" fmla="*/ 142 h 244"/>
                <a:gd name="T106" fmla="*/ 4406 w 4915"/>
                <a:gd name="T107" fmla="*/ 130 h 244"/>
                <a:gd name="T108" fmla="*/ 4487 w 4915"/>
                <a:gd name="T109" fmla="*/ 123 h 244"/>
                <a:gd name="T110" fmla="*/ 4569 w 4915"/>
                <a:gd name="T111" fmla="*/ 105 h 244"/>
                <a:gd name="T112" fmla="*/ 4651 w 4915"/>
                <a:gd name="T113" fmla="*/ 104 h 244"/>
                <a:gd name="T114" fmla="*/ 4732 w 4915"/>
                <a:gd name="T115" fmla="*/ 69 h 244"/>
                <a:gd name="T116" fmla="*/ 4814 w 4915"/>
                <a:gd name="T117" fmla="*/ 107 h 244"/>
                <a:gd name="T118" fmla="*/ 4896 w 4915"/>
                <a:gd name="T119" fmla="*/ 0 h 2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4915" h="244">
                  <a:moveTo>
                    <a:pt x="0" y="244"/>
                  </a:moveTo>
                  <a:lnTo>
                    <a:pt x="5" y="181"/>
                  </a:lnTo>
                  <a:lnTo>
                    <a:pt x="10" y="165"/>
                  </a:lnTo>
                  <a:lnTo>
                    <a:pt x="15" y="167"/>
                  </a:lnTo>
                  <a:lnTo>
                    <a:pt x="19" y="167"/>
                  </a:lnTo>
                  <a:lnTo>
                    <a:pt x="24" y="166"/>
                  </a:lnTo>
                  <a:lnTo>
                    <a:pt x="29" y="166"/>
                  </a:lnTo>
                  <a:lnTo>
                    <a:pt x="34" y="165"/>
                  </a:lnTo>
                  <a:lnTo>
                    <a:pt x="39" y="165"/>
                  </a:lnTo>
                  <a:lnTo>
                    <a:pt x="44" y="167"/>
                  </a:lnTo>
                  <a:lnTo>
                    <a:pt x="48" y="166"/>
                  </a:lnTo>
                  <a:lnTo>
                    <a:pt x="53" y="166"/>
                  </a:lnTo>
                  <a:lnTo>
                    <a:pt x="58" y="164"/>
                  </a:lnTo>
                  <a:lnTo>
                    <a:pt x="63" y="166"/>
                  </a:lnTo>
                  <a:lnTo>
                    <a:pt x="68" y="165"/>
                  </a:lnTo>
                  <a:lnTo>
                    <a:pt x="72" y="166"/>
                  </a:lnTo>
                  <a:lnTo>
                    <a:pt x="77" y="165"/>
                  </a:lnTo>
                  <a:lnTo>
                    <a:pt x="82" y="167"/>
                  </a:lnTo>
                  <a:lnTo>
                    <a:pt x="87" y="164"/>
                  </a:lnTo>
                  <a:lnTo>
                    <a:pt x="92" y="166"/>
                  </a:lnTo>
                  <a:lnTo>
                    <a:pt x="96" y="166"/>
                  </a:lnTo>
                  <a:lnTo>
                    <a:pt x="101" y="165"/>
                  </a:lnTo>
                  <a:lnTo>
                    <a:pt x="106" y="165"/>
                  </a:lnTo>
                  <a:lnTo>
                    <a:pt x="111" y="165"/>
                  </a:lnTo>
                  <a:lnTo>
                    <a:pt x="116" y="165"/>
                  </a:lnTo>
                  <a:lnTo>
                    <a:pt x="121" y="165"/>
                  </a:lnTo>
                  <a:lnTo>
                    <a:pt x="125" y="166"/>
                  </a:lnTo>
                  <a:lnTo>
                    <a:pt x="130" y="164"/>
                  </a:lnTo>
                  <a:lnTo>
                    <a:pt x="135" y="163"/>
                  </a:lnTo>
                  <a:lnTo>
                    <a:pt x="140" y="163"/>
                  </a:lnTo>
                  <a:lnTo>
                    <a:pt x="145" y="164"/>
                  </a:lnTo>
                  <a:lnTo>
                    <a:pt x="149" y="162"/>
                  </a:lnTo>
                  <a:lnTo>
                    <a:pt x="154" y="162"/>
                  </a:lnTo>
                  <a:lnTo>
                    <a:pt x="159" y="164"/>
                  </a:lnTo>
                  <a:lnTo>
                    <a:pt x="164" y="164"/>
                  </a:lnTo>
                  <a:lnTo>
                    <a:pt x="169" y="165"/>
                  </a:lnTo>
                  <a:lnTo>
                    <a:pt x="173" y="164"/>
                  </a:lnTo>
                  <a:lnTo>
                    <a:pt x="178" y="163"/>
                  </a:lnTo>
                  <a:lnTo>
                    <a:pt x="183" y="165"/>
                  </a:lnTo>
                  <a:lnTo>
                    <a:pt x="188" y="163"/>
                  </a:lnTo>
                  <a:lnTo>
                    <a:pt x="192" y="164"/>
                  </a:lnTo>
                  <a:lnTo>
                    <a:pt x="197" y="164"/>
                  </a:lnTo>
                  <a:lnTo>
                    <a:pt x="202" y="165"/>
                  </a:lnTo>
                  <a:lnTo>
                    <a:pt x="207" y="165"/>
                  </a:lnTo>
                  <a:lnTo>
                    <a:pt x="212" y="164"/>
                  </a:lnTo>
                  <a:lnTo>
                    <a:pt x="216" y="166"/>
                  </a:lnTo>
                  <a:lnTo>
                    <a:pt x="221" y="165"/>
                  </a:lnTo>
                  <a:lnTo>
                    <a:pt x="226" y="165"/>
                  </a:lnTo>
                  <a:lnTo>
                    <a:pt x="231" y="163"/>
                  </a:lnTo>
                  <a:lnTo>
                    <a:pt x="236" y="166"/>
                  </a:lnTo>
                  <a:lnTo>
                    <a:pt x="240" y="165"/>
                  </a:lnTo>
                  <a:lnTo>
                    <a:pt x="245" y="164"/>
                  </a:lnTo>
                  <a:lnTo>
                    <a:pt x="250" y="166"/>
                  </a:lnTo>
                  <a:lnTo>
                    <a:pt x="255" y="164"/>
                  </a:lnTo>
                  <a:lnTo>
                    <a:pt x="260" y="165"/>
                  </a:lnTo>
                  <a:lnTo>
                    <a:pt x="265" y="165"/>
                  </a:lnTo>
                  <a:lnTo>
                    <a:pt x="269" y="163"/>
                  </a:lnTo>
                  <a:lnTo>
                    <a:pt x="274" y="164"/>
                  </a:lnTo>
                  <a:lnTo>
                    <a:pt x="279" y="162"/>
                  </a:lnTo>
                  <a:lnTo>
                    <a:pt x="284" y="165"/>
                  </a:lnTo>
                  <a:lnTo>
                    <a:pt x="289" y="164"/>
                  </a:lnTo>
                  <a:lnTo>
                    <a:pt x="293" y="164"/>
                  </a:lnTo>
                  <a:lnTo>
                    <a:pt x="298" y="163"/>
                  </a:lnTo>
                  <a:lnTo>
                    <a:pt x="303" y="164"/>
                  </a:lnTo>
                  <a:lnTo>
                    <a:pt x="308" y="163"/>
                  </a:lnTo>
                  <a:lnTo>
                    <a:pt x="313" y="165"/>
                  </a:lnTo>
                  <a:lnTo>
                    <a:pt x="318" y="163"/>
                  </a:lnTo>
                  <a:lnTo>
                    <a:pt x="322" y="163"/>
                  </a:lnTo>
                  <a:lnTo>
                    <a:pt x="327" y="162"/>
                  </a:lnTo>
                  <a:lnTo>
                    <a:pt x="332" y="163"/>
                  </a:lnTo>
                  <a:lnTo>
                    <a:pt x="337" y="162"/>
                  </a:lnTo>
                  <a:lnTo>
                    <a:pt x="342" y="164"/>
                  </a:lnTo>
                  <a:lnTo>
                    <a:pt x="346" y="162"/>
                  </a:lnTo>
                  <a:lnTo>
                    <a:pt x="351" y="163"/>
                  </a:lnTo>
                  <a:lnTo>
                    <a:pt x="356" y="165"/>
                  </a:lnTo>
                  <a:lnTo>
                    <a:pt x="361" y="163"/>
                  </a:lnTo>
                  <a:lnTo>
                    <a:pt x="366" y="163"/>
                  </a:lnTo>
                  <a:lnTo>
                    <a:pt x="370" y="164"/>
                  </a:lnTo>
                  <a:lnTo>
                    <a:pt x="375" y="163"/>
                  </a:lnTo>
                  <a:lnTo>
                    <a:pt x="380" y="165"/>
                  </a:lnTo>
                  <a:lnTo>
                    <a:pt x="385" y="165"/>
                  </a:lnTo>
                  <a:lnTo>
                    <a:pt x="389" y="163"/>
                  </a:lnTo>
                  <a:lnTo>
                    <a:pt x="394" y="164"/>
                  </a:lnTo>
                  <a:lnTo>
                    <a:pt x="399" y="163"/>
                  </a:lnTo>
                  <a:lnTo>
                    <a:pt x="404" y="164"/>
                  </a:lnTo>
                  <a:lnTo>
                    <a:pt x="409" y="164"/>
                  </a:lnTo>
                  <a:lnTo>
                    <a:pt x="413" y="163"/>
                  </a:lnTo>
                  <a:lnTo>
                    <a:pt x="418" y="164"/>
                  </a:lnTo>
                  <a:lnTo>
                    <a:pt x="423" y="163"/>
                  </a:lnTo>
                  <a:lnTo>
                    <a:pt x="428" y="163"/>
                  </a:lnTo>
                  <a:lnTo>
                    <a:pt x="433" y="163"/>
                  </a:lnTo>
                  <a:lnTo>
                    <a:pt x="437" y="165"/>
                  </a:lnTo>
                  <a:lnTo>
                    <a:pt x="442" y="165"/>
                  </a:lnTo>
                  <a:lnTo>
                    <a:pt x="447" y="164"/>
                  </a:lnTo>
                  <a:lnTo>
                    <a:pt x="452" y="164"/>
                  </a:lnTo>
                  <a:lnTo>
                    <a:pt x="457" y="166"/>
                  </a:lnTo>
                  <a:lnTo>
                    <a:pt x="461" y="167"/>
                  </a:lnTo>
                  <a:lnTo>
                    <a:pt x="466" y="166"/>
                  </a:lnTo>
                  <a:lnTo>
                    <a:pt x="471" y="164"/>
                  </a:lnTo>
                  <a:lnTo>
                    <a:pt x="476" y="165"/>
                  </a:lnTo>
                  <a:lnTo>
                    <a:pt x="481" y="165"/>
                  </a:lnTo>
                  <a:lnTo>
                    <a:pt x="486" y="164"/>
                  </a:lnTo>
                  <a:lnTo>
                    <a:pt x="490" y="163"/>
                  </a:lnTo>
                  <a:lnTo>
                    <a:pt x="495" y="163"/>
                  </a:lnTo>
                  <a:lnTo>
                    <a:pt x="500" y="163"/>
                  </a:lnTo>
                  <a:lnTo>
                    <a:pt x="505" y="165"/>
                  </a:lnTo>
                  <a:lnTo>
                    <a:pt x="510" y="163"/>
                  </a:lnTo>
                  <a:lnTo>
                    <a:pt x="514" y="164"/>
                  </a:lnTo>
                  <a:lnTo>
                    <a:pt x="519" y="165"/>
                  </a:lnTo>
                  <a:lnTo>
                    <a:pt x="524" y="163"/>
                  </a:lnTo>
                  <a:lnTo>
                    <a:pt x="529" y="162"/>
                  </a:lnTo>
                  <a:lnTo>
                    <a:pt x="534" y="163"/>
                  </a:lnTo>
                  <a:lnTo>
                    <a:pt x="539" y="161"/>
                  </a:lnTo>
                  <a:lnTo>
                    <a:pt x="543" y="164"/>
                  </a:lnTo>
                  <a:lnTo>
                    <a:pt x="548" y="162"/>
                  </a:lnTo>
                  <a:lnTo>
                    <a:pt x="553" y="163"/>
                  </a:lnTo>
                  <a:lnTo>
                    <a:pt x="558" y="163"/>
                  </a:lnTo>
                  <a:lnTo>
                    <a:pt x="563" y="163"/>
                  </a:lnTo>
                  <a:lnTo>
                    <a:pt x="567" y="163"/>
                  </a:lnTo>
                  <a:lnTo>
                    <a:pt x="572" y="163"/>
                  </a:lnTo>
                  <a:lnTo>
                    <a:pt x="577" y="164"/>
                  </a:lnTo>
                  <a:lnTo>
                    <a:pt x="582" y="162"/>
                  </a:lnTo>
                  <a:lnTo>
                    <a:pt x="586" y="163"/>
                  </a:lnTo>
                  <a:lnTo>
                    <a:pt x="591" y="163"/>
                  </a:lnTo>
                  <a:lnTo>
                    <a:pt x="596" y="162"/>
                  </a:lnTo>
                  <a:lnTo>
                    <a:pt x="601" y="162"/>
                  </a:lnTo>
                  <a:lnTo>
                    <a:pt x="606" y="163"/>
                  </a:lnTo>
                  <a:lnTo>
                    <a:pt x="610" y="163"/>
                  </a:lnTo>
                  <a:lnTo>
                    <a:pt x="615" y="163"/>
                  </a:lnTo>
                  <a:lnTo>
                    <a:pt x="620" y="164"/>
                  </a:lnTo>
                  <a:lnTo>
                    <a:pt x="625" y="162"/>
                  </a:lnTo>
                  <a:lnTo>
                    <a:pt x="630" y="163"/>
                  </a:lnTo>
                  <a:lnTo>
                    <a:pt x="634" y="162"/>
                  </a:lnTo>
                  <a:lnTo>
                    <a:pt x="639" y="161"/>
                  </a:lnTo>
                  <a:lnTo>
                    <a:pt x="644" y="164"/>
                  </a:lnTo>
                  <a:lnTo>
                    <a:pt x="649" y="163"/>
                  </a:lnTo>
                  <a:lnTo>
                    <a:pt x="654" y="164"/>
                  </a:lnTo>
                  <a:lnTo>
                    <a:pt x="658" y="162"/>
                  </a:lnTo>
                  <a:lnTo>
                    <a:pt x="663" y="163"/>
                  </a:lnTo>
                  <a:lnTo>
                    <a:pt x="668" y="164"/>
                  </a:lnTo>
                  <a:lnTo>
                    <a:pt x="673" y="162"/>
                  </a:lnTo>
                  <a:lnTo>
                    <a:pt x="678" y="162"/>
                  </a:lnTo>
                  <a:lnTo>
                    <a:pt x="683" y="162"/>
                  </a:lnTo>
                  <a:lnTo>
                    <a:pt x="687" y="164"/>
                  </a:lnTo>
                  <a:lnTo>
                    <a:pt x="692" y="163"/>
                  </a:lnTo>
                  <a:lnTo>
                    <a:pt x="697" y="163"/>
                  </a:lnTo>
                  <a:lnTo>
                    <a:pt x="702" y="162"/>
                  </a:lnTo>
                  <a:lnTo>
                    <a:pt x="707" y="163"/>
                  </a:lnTo>
                  <a:lnTo>
                    <a:pt x="711" y="163"/>
                  </a:lnTo>
                  <a:lnTo>
                    <a:pt x="716" y="162"/>
                  </a:lnTo>
                  <a:lnTo>
                    <a:pt x="721" y="161"/>
                  </a:lnTo>
                  <a:lnTo>
                    <a:pt x="726" y="162"/>
                  </a:lnTo>
                  <a:lnTo>
                    <a:pt x="731" y="161"/>
                  </a:lnTo>
                  <a:lnTo>
                    <a:pt x="736" y="161"/>
                  </a:lnTo>
                  <a:lnTo>
                    <a:pt x="740" y="161"/>
                  </a:lnTo>
                  <a:lnTo>
                    <a:pt x="745" y="162"/>
                  </a:lnTo>
                  <a:lnTo>
                    <a:pt x="750" y="163"/>
                  </a:lnTo>
                  <a:lnTo>
                    <a:pt x="755" y="160"/>
                  </a:lnTo>
                  <a:lnTo>
                    <a:pt x="760" y="161"/>
                  </a:lnTo>
                  <a:lnTo>
                    <a:pt x="764" y="162"/>
                  </a:lnTo>
                  <a:lnTo>
                    <a:pt x="769" y="161"/>
                  </a:lnTo>
                  <a:lnTo>
                    <a:pt x="774" y="161"/>
                  </a:lnTo>
                  <a:lnTo>
                    <a:pt x="779" y="161"/>
                  </a:lnTo>
                  <a:lnTo>
                    <a:pt x="783" y="162"/>
                  </a:lnTo>
                  <a:lnTo>
                    <a:pt x="788" y="162"/>
                  </a:lnTo>
                  <a:lnTo>
                    <a:pt x="793" y="159"/>
                  </a:lnTo>
                  <a:lnTo>
                    <a:pt x="798" y="161"/>
                  </a:lnTo>
                  <a:lnTo>
                    <a:pt x="803" y="161"/>
                  </a:lnTo>
                  <a:lnTo>
                    <a:pt x="807" y="159"/>
                  </a:lnTo>
                  <a:lnTo>
                    <a:pt x="812" y="161"/>
                  </a:lnTo>
                  <a:lnTo>
                    <a:pt x="817" y="161"/>
                  </a:lnTo>
                  <a:lnTo>
                    <a:pt x="822" y="158"/>
                  </a:lnTo>
                  <a:lnTo>
                    <a:pt x="827" y="161"/>
                  </a:lnTo>
                  <a:lnTo>
                    <a:pt x="831" y="160"/>
                  </a:lnTo>
                  <a:lnTo>
                    <a:pt x="836" y="161"/>
                  </a:lnTo>
                  <a:lnTo>
                    <a:pt x="841" y="162"/>
                  </a:lnTo>
                  <a:lnTo>
                    <a:pt x="846" y="161"/>
                  </a:lnTo>
                  <a:lnTo>
                    <a:pt x="851" y="161"/>
                  </a:lnTo>
                  <a:lnTo>
                    <a:pt x="855" y="159"/>
                  </a:lnTo>
                  <a:lnTo>
                    <a:pt x="860" y="161"/>
                  </a:lnTo>
                  <a:lnTo>
                    <a:pt x="865" y="159"/>
                  </a:lnTo>
                  <a:lnTo>
                    <a:pt x="870" y="159"/>
                  </a:lnTo>
                  <a:lnTo>
                    <a:pt x="875" y="159"/>
                  </a:lnTo>
                  <a:lnTo>
                    <a:pt x="879" y="161"/>
                  </a:lnTo>
                  <a:lnTo>
                    <a:pt x="884" y="159"/>
                  </a:lnTo>
                  <a:lnTo>
                    <a:pt x="889" y="159"/>
                  </a:lnTo>
                  <a:lnTo>
                    <a:pt x="894" y="160"/>
                  </a:lnTo>
                  <a:lnTo>
                    <a:pt x="899" y="159"/>
                  </a:lnTo>
                  <a:lnTo>
                    <a:pt x="904" y="159"/>
                  </a:lnTo>
                  <a:lnTo>
                    <a:pt x="908" y="158"/>
                  </a:lnTo>
                  <a:lnTo>
                    <a:pt x="913" y="159"/>
                  </a:lnTo>
                  <a:lnTo>
                    <a:pt x="918" y="159"/>
                  </a:lnTo>
                  <a:lnTo>
                    <a:pt x="923" y="160"/>
                  </a:lnTo>
                  <a:lnTo>
                    <a:pt x="928" y="159"/>
                  </a:lnTo>
                  <a:lnTo>
                    <a:pt x="932" y="159"/>
                  </a:lnTo>
                  <a:lnTo>
                    <a:pt x="937" y="160"/>
                  </a:lnTo>
                  <a:lnTo>
                    <a:pt x="942" y="159"/>
                  </a:lnTo>
                  <a:lnTo>
                    <a:pt x="947" y="159"/>
                  </a:lnTo>
                  <a:lnTo>
                    <a:pt x="952" y="159"/>
                  </a:lnTo>
                  <a:lnTo>
                    <a:pt x="957" y="159"/>
                  </a:lnTo>
                  <a:lnTo>
                    <a:pt x="961" y="160"/>
                  </a:lnTo>
                  <a:lnTo>
                    <a:pt x="966" y="159"/>
                  </a:lnTo>
                  <a:lnTo>
                    <a:pt x="971" y="160"/>
                  </a:lnTo>
                  <a:lnTo>
                    <a:pt x="976" y="158"/>
                  </a:lnTo>
                  <a:lnTo>
                    <a:pt x="980" y="158"/>
                  </a:lnTo>
                  <a:lnTo>
                    <a:pt x="985" y="159"/>
                  </a:lnTo>
                  <a:lnTo>
                    <a:pt x="990" y="159"/>
                  </a:lnTo>
                  <a:lnTo>
                    <a:pt x="995" y="159"/>
                  </a:lnTo>
                  <a:lnTo>
                    <a:pt x="1000" y="159"/>
                  </a:lnTo>
                  <a:lnTo>
                    <a:pt x="1004" y="159"/>
                  </a:lnTo>
                  <a:lnTo>
                    <a:pt x="1009" y="157"/>
                  </a:lnTo>
                  <a:lnTo>
                    <a:pt x="1014" y="159"/>
                  </a:lnTo>
                  <a:lnTo>
                    <a:pt x="1019" y="159"/>
                  </a:lnTo>
                  <a:lnTo>
                    <a:pt x="1023" y="159"/>
                  </a:lnTo>
                  <a:lnTo>
                    <a:pt x="1028" y="158"/>
                  </a:lnTo>
                  <a:lnTo>
                    <a:pt x="1033" y="159"/>
                  </a:lnTo>
                  <a:lnTo>
                    <a:pt x="1038" y="158"/>
                  </a:lnTo>
                  <a:lnTo>
                    <a:pt x="1043" y="159"/>
                  </a:lnTo>
                  <a:lnTo>
                    <a:pt x="1048" y="161"/>
                  </a:lnTo>
                  <a:lnTo>
                    <a:pt x="1052" y="159"/>
                  </a:lnTo>
                  <a:lnTo>
                    <a:pt x="1057" y="158"/>
                  </a:lnTo>
                  <a:lnTo>
                    <a:pt x="1062" y="157"/>
                  </a:lnTo>
                  <a:lnTo>
                    <a:pt x="1067" y="159"/>
                  </a:lnTo>
                  <a:lnTo>
                    <a:pt x="1072" y="158"/>
                  </a:lnTo>
                  <a:lnTo>
                    <a:pt x="1076" y="158"/>
                  </a:lnTo>
                  <a:lnTo>
                    <a:pt x="1081" y="158"/>
                  </a:lnTo>
                  <a:lnTo>
                    <a:pt x="1086" y="157"/>
                  </a:lnTo>
                  <a:lnTo>
                    <a:pt x="1091" y="158"/>
                  </a:lnTo>
                  <a:lnTo>
                    <a:pt x="1096" y="156"/>
                  </a:lnTo>
                  <a:lnTo>
                    <a:pt x="1101" y="158"/>
                  </a:lnTo>
                  <a:lnTo>
                    <a:pt x="1105" y="159"/>
                  </a:lnTo>
                  <a:lnTo>
                    <a:pt x="1110" y="158"/>
                  </a:lnTo>
                  <a:lnTo>
                    <a:pt x="1115" y="157"/>
                  </a:lnTo>
                  <a:lnTo>
                    <a:pt x="1120" y="156"/>
                  </a:lnTo>
                  <a:lnTo>
                    <a:pt x="1125" y="159"/>
                  </a:lnTo>
                  <a:lnTo>
                    <a:pt x="1129" y="157"/>
                  </a:lnTo>
                  <a:lnTo>
                    <a:pt x="1134" y="156"/>
                  </a:lnTo>
                  <a:lnTo>
                    <a:pt x="1139" y="157"/>
                  </a:lnTo>
                  <a:lnTo>
                    <a:pt x="1144" y="156"/>
                  </a:lnTo>
                  <a:lnTo>
                    <a:pt x="1149" y="157"/>
                  </a:lnTo>
                  <a:lnTo>
                    <a:pt x="1153" y="158"/>
                  </a:lnTo>
                  <a:lnTo>
                    <a:pt x="1158" y="158"/>
                  </a:lnTo>
                  <a:lnTo>
                    <a:pt x="1163" y="158"/>
                  </a:lnTo>
                  <a:lnTo>
                    <a:pt x="1168" y="157"/>
                  </a:lnTo>
                  <a:lnTo>
                    <a:pt x="1173" y="158"/>
                  </a:lnTo>
                  <a:lnTo>
                    <a:pt x="1177" y="157"/>
                  </a:lnTo>
                  <a:lnTo>
                    <a:pt x="1182" y="156"/>
                  </a:lnTo>
                  <a:lnTo>
                    <a:pt x="1187" y="157"/>
                  </a:lnTo>
                  <a:lnTo>
                    <a:pt x="1192" y="157"/>
                  </a:lnTo>
                  <a:lnTo>
                    <a:pt x="1197" y="157"/>
                  </a:lnTo>
                  <a:lnTo>
                    <a:pt x="1201" y="158"/>
                  </a:lnTo>
                  <a:lnTo>
                    <a:pt x="1206" y="156"/>
                  </a:lnTo>
                  <a:lnTo>
                    <a:pt x="1211" y="157"/>
                  </a:lnTo>
                  <a:lnTo>
                    <a:pt x="1216" y="157"/>
                  </a:lnTo>
                  <a:lnTo>
                    <a:pt x="1220" y="157"/>
                  </a:lnTo>
                  <a:lnTo>
                    <a:pt x="1225" y="157"/>
                  </a:lnTo>
                  <a:lnTo>
                    <a:pt x="1230" y="156"/>
                  </a:lnTo>
                  <a:lnTo>
                    <a:pt x="1235" y="156"/>
                  </a:lnTo>
                  <a:lnTo>
                    <a:pt x="1240" y="155"/>
                  </a:lnTo>
                  <a:lnTo>
                    <a:pt x="1244" y="153"/>
                  </a:lnTo>
                  <a:lnTo>
                    <a:pt x="1249" y="155"/>
                  </a:lnTo>
                  <a:lnTo>
                    <a:pt x="1254" y="157"/>
                  </a:lnTo>
                  <a:lnTo>
                    <a:pt x="1259" y="156"/>
                  </a:lnTo>
                  <a:lnTo>
                    <a:pt x="1264" y="156"/>
                  </a:lnTo>
                  <a:lnTo>
                    <a:pt x="1269" y="157"/>
                  </a:lnTo>
                  <a:lnTo>
                    <a:pt x="1273" y="157"/>
                  </a:lnTo>
                  <a:lnTo>
                    <a:pt x="1278" y="157"/>
                  </a:lnTo>
                  <a:lnTo>
                    <a:pt x="1283" y="158"/>
                  </a:lnTo>
                  <a:lnTo>
                    <a:pt x="1288" y="156"/>
                  </a:lnTo>
                  <a:lnTo>
                    <a:pt x="1293" y="157"/>
                  </a:lnTo>
                  <a:lnTo>
                    <a:pt x="1297" y="155"/>
                  </a:lnTo>
                  <a:lnTo>
                    <a:pt x="1302" y="156"/>
                  </a:lnTo>
                  <a:lnTo>
                    <a:pt x="1307" y="155"/>
                  </a:lnTo>
                  <a:lnTo>
                    <a:pt x="1312" y="157"/>
                  </a:lnTo>
                  <a:lnTo>
                    <a:pt x="1317" y="156"/>
                  </a:lnTo>
                  <a:lnTo>
                    <a:pt x="1322" y="156"/>
                  </a:lnTo>
                  <a:lnTo>
                    <a:pt x="1326" y="157"/>
                  </a:lnTo>
                  <a:lnTo>
                    <a:pt x="1331" y="158"/>
                  </a:lnTo>
                  <a:lnTo>
                    <a:pt x="1336" y="156"/>
                  </a:lnTo>
                  <a:lnTo>
                    <a:pt x="1341" y="156"/>
                  </a:lnTo>
                  <a:lnTo>
                    <a:pt x="1346" y="157"/>
                  </a:lnTo>
                  <a:lnTo>
                    <a:pt x="1350" y="157"/>
                  </a:lnTo>
                  <a:lnTo>
                    <a:pt x="1355" y="156"/>
                  </a:lnTo>
                  <a:lnTo>
                    <a:pt x="1360" y="157"/>
                  </a:lnTo>
                  <a:lnTo>
                    <a:pt x="1365" y="156"/>
                  </a:lnTo>
                  <a:lnTo>
                    <a:pt x="1370" y="156"/>
                  </a:lnTo>
                  <a:lnTo>
                    <a:pt x="1374" y="156"/>
                  </a:lnTo>
                  <a:lnTo>
                    <a:pt x="1379" y="157"/>
                  </a:lnTo>
                  <a:lnTo>
                    <a:pt x="1384" y="155"/>
                  </a:lnTo>
                  <a:lnTo>
                    <a:pt x="1389" y="156"/>
                  </a:lnTo>
                  <a:lnTo>
                    <a:pt x="1394" y="157"/>
                  </a:lnTo>
                  <a:lnTo>
                    <a:pt x="1398" y="157"/>
                  </a:lnTo>
                  <a:lnTo>
                    <a:pt x="1403" y="157"/>
                  </a:lnTo>
                  <a:lnTo>
                    <a:pt x="1408" y="155"/>
                  </a:lnTo>
                  <a:lnTo>
                    <a:pt x="1413" y="158"/>
                  </a:lnTo>
                  <a:lnTo>
                    <a:pt x="1417" y="155"/>
                  </a:lnTo>
                  <a:lnTo>
                    <a:pt x="1422" y="156"/>
                  </a:lnTo>
                  <a:lnTo>
                    <a:pt x="1427" y="155"/>
                  </a:lnTo>
                  <a:lnTo>
                    <a:pt x="1432" y="156"/>
                  </a:lnTo>
                  <a:lnTo>
                    <a:pt x="1437" y="155"/>
                  </a:lnTo>
                  <a:lnTo>
                    <a:pt x="1441" y="154"/>
                  </a:lnTo>
                  <a:lnTo>
                    <a:pt x="1446" y="155"/>
                  </a:lnTo>
                  <a:lnTo>
                    <a:pt x="1451" y="155"/>
                  </a:lnTo>
                  <a:lnTo>
                    <a:pt x="1456" y="156"/>
                  </a:lnTo>
                  <a:lnTo>
                    <a:pt x="1461" y="156"/>
                  </a:lnTo>
                  <a:lnTo>
                    <a:pt x="1466" y="155"/>
                  </a:lnTo>
                  <a:lnTo>
                    <a:pt x="1470" y="157"/>
                  </a:lnTo>
                  <a:lnTo>
                    <a:pt x="1475" y="154"/>
                  </a:lnTo>
                  <a:lnTo>
                    <a:pt x="1480" y="155"/>
                  </a:lnTo>
                  <a:lnTo>
                    <a:pt x="1485" y="157"/>
                  </a:lnTo>
                  <a:lnTo>
                    <a:pt x="1490" y="156"/>
                  </a:lnTo>
                  <a:lnTo>
                    <a:pt x="1494" y="156"/>
                  </a:lnTo>
                  <a:lnTo>
                    <a:pt x="1499" y="155"/>
                  </a:lnTo>
                  <a:lnTo>
                    <a:pt x="1504" y="155"/>
                  </a:lnTo>
                  <a:lnTo>
                    <a:pt x="1509" y="156"/>
                  </a:lnTo>
                  <a:lnTo>
                    <a:pt x="1514" y="158"/>
                  </a:lnTo>
                  <a:lnTo>
                    <a:pt x="1519" y="157"/>
                  </a:lnTo>
                  <a:lnTo>
                    <a:pt x="1523" y="157"/>
                  </a:lnTo>
                  <a:lnTo>
                    <a:pt x="1528" y="156"/>
                  </a:lnTo>
                  <a:lnTo>
                    <a:pt x="1533" y="156"/>
                  </a:lnTo>
                  <a:lnTo>
                    <a:pt x="1538" y="156"/>
                  </a:lnTo>
                  <a:lnTo>
                    <a:pt x="1543" y="157"/>
                  </a:lnTo>
                  <a:lnTo>
                    <a:pt x="1547" y="157"/>
                  </a:lnTo>
                  <a:lnTo>
                    <a:pt x="1552" y="158"/>
                  </a:lnTo>
                  <a:lnTo>
                    <a:pt x="1557" y="155"/>
                  </a:lnTo>
                  <a:lnTo>
                    <a:pt x="1562" y="157"/>
                  </a:lnTo>
                  <a:lnTo>
                    <a:pt x="1567" y="156"/>
                  </a:lnTo>
                  <a:lnTo>
                    <a:pt x="1571" y="156"/>
                  </a:lnTo>
                  <a:lnTo>
                    <a:pt x="1576" y="158"/>
                  </a:lnTo>
                  <a:lnTo>
                    <a:pt x="1581" y="157"/>
                  </a:lnTo>
                  <a:lnTo>
                    <a:pt x="1586" y="156"/>
                  </a:lnTo>
                  <a:lnTo>
                    <a:pt x="1590" y="156"/>
                  </a:lnTo>
                  <a:lnTo>
                    <a:pt x="1595" y="155"/>
                  </a:lnTo>
                  <a:lnTo>
                    <a:pt x="1600" y="157"/>
                  </a:lnTo>
                  <a:lnTo>
                    <a:pt x="1605" y="157"/>
                  </a:lnTo>
                  <a:lnTo>
                    <a:pt x="1610" y="156"/>
                  </a:lnTo>
                  <a:lnTo>
                    <a:pt x="1614" y="156"/>
                  </a:lnTo>
                  <a:lnTo>
                    <a:pt x="1619" y="157"/>
                  </a:lnTo>
                  <a:lnTo>
                    <a:pt x="1624" y="156"/>
                  </a:lnTo>
                  <a:lnTo>
                    <a:pt x="1629" y="156"/>
                  </a:lnTo>
                  <a:lnTo>
                    <a:pt x="1634" y="158"/>
                  </a:lnTo>
                  <a:lnTo>
                    <a:pt x="1638" y="157"/>
                  </a:lnTo>
                  <a:lnTo>
                    <a:pt x="1643" y="155"/>
                  </a:lnTo>
                  <a:lnTo>
                    <a:pt x="1648" y="156"/>
                  </a:lnTo>
                  <a:lnTo>
                    <a:pt x="1653" y="156"/>
                  </a:lnTo>
                  <a:lnTo>
                    <a:pt x="1658" y="157"/>
                  </a:lnTo>
                  <a:lnTo>
                    <a:pt x="1662" y="154"/>
                  </a:lnTo>
                  <a:lnTo>
                    <a:pt x="1667" y="157"/>
                  </a:lnTo>
                  <a:lnTo>
                    <a:pt x="1672" y="156"/>
                  </a:lnTo>
                  <a:lnTo>
                    <a:pt x="1677" y="155"/>
                  </a:lnTo>
                  <a:lnTo>
                    <a:pt x="1682" y="155"/>
                  </a:lnTo>
                  <a:lnTo>
                    <a:pt x="1687" y="157"/>
                  </a:lnTo>
                  <a:lnTo>
                    <a:pt x="1691" y="156"/>
                  </a:lnTo>
                  <a:lnTo>
                    <a:pt x="1696" y="157"/>
                  </a:lnTo>
                  <a:lnTo>
                    <a:pt x="1701" y="156"/>
                  </a:lnTo>
                  <a:lnTo>
                    <a:pt x="1706" y="156"/>
                  </a:lnTo>
                  <a:lnTo>
                    <a:pt x="1711" y="156"/>
                  </a:lnTo>
                  <a:lnTo>
                    <a:pt x="1715" y="155"/>
                  </a:lnTo>
                  <a:lnTo>
                    <a:pt x="1720" y="156"/>
                  </a:lnTo>
                  <a:lnTo>
                    <a:pt x="1725" y="156"/>
                  </a:lnTo>
                  <a:lnTo>
                    <a:pt x="1730" y="154"/>
                  </a:lnTo>
                  <a:lnTo>
                    <a:pt x="1735" y="154"/>
                  </a:lnTo>
                  <a:lnTo>
                    <a:pt x="1740" y="151"/>
                  </a:lnTo>
                  <a:lnTo>
                    <a:pt x="1744" y="153"/>
                  </a:lnTo>
                  <a:lnTo>
                    <a:pt x="1749" y="152"/>
                  </a:lnTo>
                  <a:lnTo>
                    <a:pt x="1754" y="154"/>
                  </a:lnTo>
                  <a:lnTo>
                    <a:pt x="1759" y="155"/>
                  </a:lnTo>
                  <a:lnTo>
                    <a:pt x="1764" y="155"/>
                  </a:lnTo>
                  <a:lnTo>
                    <a:pt x="1768" y="155"/>
                  </a:lnTo>
                  <a:lnTo>
                    <a:pt x="1773" y="156"/>
                  </a:lnTo>
                  <a:lnTo>
                    <a:pt x="1778" y="155"/>
                  </a:lnTo>
                  <a:lnTo>
                    <a:pt x="1783" y="157"/>
                  </a:lnTo>
                  <a:lnTo>
                    <a:pt x="1787" y="158"/>
                  </a:lnTo>
                  <a:lnTo>
                    <a:pt x="1792" y="157"/>
                  </a:lnTo>
                  <a:lnTo>
                    <a:pt x="1797" y="155"/>
                  </a:lnTo>
                  <a:lnTo>
                    <a:pt x="1802" y="157"/>
                  </a:lnTo>
                  <a:lnTo>
                    <a:pt x="1807" y="154"/>
                  </a:lnTo>
                  <a:lnTo>
                    <a:pt x="1811" y="155"/>
                  </a:lnTo>
                  <a:lnTo>
                    <a:pt x="1816" y="156"/>
                  </a:lnTo>
                  <a:lnTo>
                    <a:pt x="1821" y="156"/>
                  </a:lnTo>
                  <a:lnTo>
                    <a:pt x="1826" y="155"/>
                  </a:lnTo>
                  <a:lnTo>
                    <a:pt x="1831" y="155"/>
                  </a:lnTo>
                  <a:lnTo>
                    <a:pt x="1835" y="155"/>
                  </a:lnTo>
                  <a:lnTo>
                    <a:pt x="1840" y="156"/>
                  </a:lnTo>
                  <a:lnTo>
                    <a:pt x="1845" y="155"/>
                  </a:lnTo>
                  <a:lnTo>
                    <a:pt x="1850" y="153"/>
                  </a:lnTo>
                  <a:lnTo>
                    <a:pt x="1855" y="153"/>
                  </a:lnTo>
                  <a:lnTo>
                    <a:pt x="1859" y="155"/>
                  </a:lnTo>
                  <a:lnTo>
                    <a:pt x="1864" y="154"/>
                  </a:lnTo>
                  <a:lnTo>
                    <a:pt x="1869" y="155"/>
                  </a:lnTo>
                  <a:lnTo>
                    <a:pt x="1874" y="154"/>
                  </a:lnTo>
                  <a:lnTo>
                    <a:pt x="1879" y="153"/>
                  </a:lnTo>
                  <a:lnTo>
                    <a:pt x="1884" y="154"/>
                  </a:lnTo>
                  <a:lnTo>
                    <a:pt x="1888" y="153"/>
                  </a:lnTo>
                  <a:lnTo>
                    <a:pt x="1893" y="153"/>
                  </a:lnTo>
                  <a:lnTo>
                    <a:pt x="1898" y="154"/>
                  </a:lnTo>
                  <a:lnTo>
                    <a:pt x="1903" y="155"/>
                  </a:lnTo>
                  <a:lnTo>
                    <a:pt x="1908" y="155"/>
                  </a:lnTo>
                  <a:lnTo>
                    <a:pt x="1912" y="155"/>
                  </a:lnTo>
                  <a:lnTo>
                    <a:pt x="1917" y="156"/>
                  </a:lnTo>
                  <a:lnTo>
                    <a:pt x="1922" y="155"/>
                  </a:lnTo>
                  <a:lnTo>
                    <a:pt x="1927" y="154"/>
                  </a:lnTo>
                  <a:lnTo>
                    <a:pt x="1932" y="151"/>
                  </a:lnTo>
                  <a:lnTo>
                    <a:pt x="1936" y="155"/>
                  </a:lnTo>
                  <a:lnTo>
                    <a:pt x="1941" y="154"/>
                  </a:lnTo>
                  <a:lnTo>
                    <a:pt x="1946" y="155"/>
                  </a:lnTo>
                  <a:lnTo>
                    <a:pt x="1951" y="155"/>
                  </a:lnTo>
                  <a:lnTo>
                    <a:pt x="1956" y="155"/>
                  </a:lnTo>
                  <a:lnTo>
                    <a:pt x="1961" y="157"/>
                  </a:lnTo>
                  <a:lnTo>
                    <a:pt x="1965" y="155"/>
                  </a:lnTo>
                  <a:lnTo>
                    <a:pt x="1970" y="154"/>
                  </a:lnTo>
                  <a:lnTo>
                    <a:pt x="1975" y="156"/>
                  </a:lnTo>
                  <a:lnTo>
                    <a:pt x="1980" y="156"/>
                  </a:lnTo>
                  <a:lnTo>
                    <a:pt x="1984" y="155"/>
                  </a:lnTo>
                  <a:lnTo>
                    <a:pt x="1989" y="153"/>
                  </a:lnTo>
                  <a:lnTo>
                    <a:pt x="1994" y="154"/>
                  </a:lnTo>
                  <a:lnTo>
                    <a:pt x="1999" y="153"/>
                  </a:lnTo>
                  <a:lnTo>
                    <a:pt x="2004" y="155"/>
                  </a:lnTo>
                  <a:lnTo>
                    <a:pt x="2008" y="155"/>
                  </a:lnTo>
                  <a:lnTo>
                    <a:pt x="2013" y="154"/>
                  </a:lnTo>
                  <a:lnTo>
                    <a:pt x="2018" y="153"/>
                  </a:lnTo>
                  <a:lnTo>
                    <a:pt x="2023" y="153"/>
                  </a:lnTo>
                  <a:lnTo>
                    <a:pt x="2027" y="154"/>
                  </a:lnTo>
                  <a:lnTo>
                    <a:pt x="2032" y="153"/>
                  </a:lnTo>
                  <a:lnTo>
                    <a:pt x="2037" y="156"/>
                  </a:lnTo>
                  <a:lnTo>
                    <a:pt x="2042" y="153"/>
                  </a:lnTo>
                  <a:lnTo>
                    <a:pt x="2047" y="155"/>
                  </a:lnTo>
                  <a:lnTo>
                    <a:pt x="2052" y="154"/>
                  </a:lnTo>
                  <a:lnTo>
                    <a:pt x="2056" y="156"/>
                  </a:lnTo>
                  <a:lnTo>
                    <a:pt x="2061" y="155"/>
                  </a:lnTo>
                  <a:lnTo>
                    <a:pt x="2066" y="153"/>
                  </a:lnTo>
                  <a:lnTo>
                    <a:pt x="2071" y="155"/>
                  </a:lnTo>
                  <a:lnTo>
                    <a:pt x="2076" y="155"/>
                  </a:lnTo>
                  <a:lnTo>
                    <a:pt x="2080" y="154"/>
                  </a:lnTo>
                  <a:lnTo>
                    <a:pt x="2085" y="154"/>
                  </a:lnTo>
                  <a:lnTo>
                    <a:pt x="2090" y="154"/>
                  </a:lnTo>
                  <a:lnTo>
                    <a:pt x="2095" y="154"/>
                  </a:lnTo>
                  <a:lnTo>
                    <a:pt x="2100" y="154"/>
                  </a:lnTo>
                  <a:lnTo>
                    <a:pt x="2105" y="154"/>
                  </a:lnTo>
                  <a:lnTo>
                    <a:pt x="2109" y="155"/>
                  </a:lnTo>
                  <a:lnTo>
                    <a:pt x="2114" y="152"/>
                  </a:lnTo>
                  <a:lnTo>
                    <a:pt x="2119" y="155"/>
                  </a:lnTo>
                  <a:lnTo>
                    <a:pt x="2124" y="153"/>
                  </a:lnTo>
                  <a:lnTo>
                    <a:pt x="2129" y="153"/>
                  </a:lnTo>
                  <a:lnTo>
                    <a:pt x="2133" y="154"/>
                  </a:lnTo>
                  <a:lnTo>
                    <a:pt x="2138" y="151"/>
                  </a:lnTo>
                  <a:lnTo>
                    <a:pt x="2143" y="153"/>
                  </a:lnTo>
                  <a:lnTo>
                    <a:pt x="2148" y="152"/>
                  </a:lnTo>
                  <a:lnTo>
                    <a:pt x="2153" y="152"/>
                  </a:lnTo>
                  <a:lnTo>
                    <a:pt x="2158" y="154"/>
                  </a:lnTo>
                  <a:lnTo>
                    <a:pt x="2162" y="153"/>
                  </a:lnTo>
                  <a:lnTo>
                    <a:pt x="2167" y="151"/>
                  </a:lnTo>
                  <a:lnTo>
                    <a:pt x="2172" y="152"/>
                  </a:lnTo>
                  <a:lnTo>
                    <a:pt x="2177" y="153"/>
                  </a:lnTo>
                  <a:lnTo>
                    <a:pt x="2181" y="151"/>
                  </a:lnTo>
                  <a:lnTo>
                    <a:pt x="2186" y="153"/>
                  </a:lnTo>
                  <a:lnTo>
                    <a:pt x="2191" y="152"/>
                  </a:lnTo>
                  <a:lnTo>
                    <a:pt x="2196" y="152"/>
                  </a:lnTo>
                  <a:lnTo>
                    <a:pt x="2201" y="152"/>
                  </a:lnTo>
                  <a:lnTo>
                    <a:pt x="2205" y="152"/>
                  </a:lnTo>
                  <a:lnTo>
                    <a:pt x="2210" y="151"/>
                  </a:lnTo>
                  <a:lnTo>
                    <a:pt x="2215" y="153"/>
                  </a:lnTo>
                  <a:lnTo>
                    <a:pt x="2220" y="152"/>
                  </a:lnTo>
                  <a:lnTo>
                    <a:pt x="2224" y="152"/>
                  </a:lnTo>
                  <a:lnTo>
                    <a:pt x="2229" y="153"/>
                  </a:lnTo>
                  <a:lnTo>
                    <a:pt x="2234" y="153"/>
                  </a:lnTo>
                  <a:lnTo>
                    <a:pt x="2239" y="151"/>
                  </a:lnTo>
                  <a:lnTo>
                    <a:pt x="2244" y="150"/>
                  </a:lnTo>
                  <a:lnTo>
                    <a:pt x="2249" y="151"/>
                  </a:lnTo>
                  <a:lnTo>
                    <a:pt x="2253" y="150"/>
                  </a:lnTo>
                  <a:lnTo>
                    <a:pt x="2258" y="151"/>
                  </a:lnTo>
                  <a:lnTo>
                    <a:pt x="2263" y="152"/>
                  </a:lnTo>
                  <a:lnTo>
                    <a:pt x="2268" y="152"/>
                  </a:lnTo>
                  <a:lnTo>
                    <a:pt x="2273" y="153"/>
                  </a:lnTo>
                  <a:lnTo>
                    <a:pt x="2277" y="152"/>
                  </a:lnTo>
                  <a:lnTo>
                    <a:pt x="2282" y="151"/>
                  </a:lnTo>
                  <a:lnTo>
                    <a:pt x="2287" y="152"/>
                  </a:lnTo>
                  <a:lnTo>
                    <a:pt x="2292" y="150"/>
                  </a:lnTo>
                  <a:lnTo>
                    <a:pt x="2297" y="150"/>
                  </a:lnTo>
                  <a:lnTo>
                    <a:pt x="2302" y="150"/>
                  </a:lnTo>
                  <a:lnTo>
                    <a:pt x="2306" y="146"/>
                  </a:lnTo>
                  <a:lnTo>
                    <a:pt x="2311" y="142"/>
                  </a:lnTo>
                  <a:lnTo>
                    <a:pt x="2316" y="137"/>
                  </a:lnTo>
                  <a:lnTo>
                    <a:pt x="2321" y="137"/>
                  </a:lnTo>
                  <a:lnTo>
                    <a:pt x="2326" y="137"/>
                  </a:lnTo>
                  <a:lnTo>
                    <a:pt x="2330" y="139"/>
                  </a:lnTo>
                  <a:lnTo>
                    <a:pt x="2335" y="141"/>
                  </a:lnTo>
                  <a:lnTo>
                    <a:pt x="2340" y="143"/>
                  </a:lnTo>
                  <a:lnTo>
                    <a:pt x="2345" y="140"/>
                  </a:lnTo>
                  <a:lnTo>
                    <a:pt x="2350" y="139"/>
                  </a:lnTo>
                  <a:lnTo>
                    <a:pt x="2354" y="139"/>
                  </a:lnTo>
                  <a:lnTo>
                    <a:pt x="2359" y="140"/>
                  </a:lnTo>
                  <a:lnTo>
                    <a:pt x="2364" y="146"/>
                  </a:lnTo>
                  <a:lnTo>
                    <a:pt x="2369" y="149"/>
                  </a:lnTo>
                  <a:lnTo>
                    <a:pt x="2374" y="151"/>
                  </a:lnTo>
                  <a:lnTo>
                    <a:pt x="2378" y="149"/>
                  </a:lnTo>
                  <a:lnTo>
                    <a:pt x="2383" y="150"/>
                  </a:lnTo>
                  <a:lnTo>
                    <a:pt x="2388" y="146"/>
                  </a:lnTo>
                  <a:lnTo>
                    <a:pt x="2393" y="145"/>
                  </a:lnTo>
                  <a:lnTo>
                    <a:pt x="2398" y="145"/>
                  </a:lnTo>
                  <a:lnTo>
                    <a:pt x="2402" y="141"/>
                  </a:lnTo>
                  <a:lnTo>
                    <a:pt x="2407" y="139"/>
                  </a:lnTo>
                  <a:lnTo>
                    <a:pt x="2412" y="139"/>
                  </a:lnTo>
                  <a:lnTo>
                    <a:pt x="2417" y="139"/>
                  </a:lnTo>
                  <a:lnTo>
                    <a:pt x="2421" y="139"/>
                  </a:lnTo>
                  <a:lnTo>
                    <a:pt x="2426" y="142"/>
                  </a:lnTo>
                  <a:lnTo>
                    <a:pt x="2431" y="138"/>
                  </a:lnTo>
                  <a:lnTo>
                    <a:pt x="2436" y="124"/>
                  </a:lnTo>
                  <a:lnTo>
                    <a:pt x="2441" y="103"/>
                  </a:lnTo>
                  <a:lnTo>
                    <a:pt x="2445" y="85"/>
                  </a:lnTo>
                  <a:lnTo>
                    <a:pt x="2450" y="80"/>
                  </a:lnTo>
                  <a:lnTo>
                    <a:pt x="2455" y="100"/>
                  </a:lnTo>
                  <a:lnTo>
                    <a:pt x="2460" y="117"/>
                  </a:lnTo>
                  <a:lnTo>
                    <a:pt x="2465" y="131"/>
                  </a:lnTo>
                  <a:lnTo>
                    <a:pt x="2470" y="139"/>
                  </a:lnTo>
                  <a:lnTo>
                    <a:pt x="2474" y="141"/>
                  </a:lnTo>
                  <a:lnTo>
                    <a:pt x="2479" y="149"/>
                  </a:lnTo>
                  <a:lnTo>
                    <a:pt x="2484" y="145"/>
                  </a:lnTo>
                  <a:lnTo>
                    <a:pt x="2489" y="146"/>
                  </a:lnTo>
                  <a:lnTo>
                    <a:pt x="2494" y="148"/>
                  </a:lnTo>
                  <a:lnTo>
                    <a:pt x="2498" y="148"/>
                  </a:lnTo>
                  <a:lnTo>
                    <a:pt x="2503" y="148"/>
                  </a:lnTo>
                  <a:lnTo>
                    <a:pt x="2508" y="150"/>
                  </a:lnTo>
                  <a:lnTo>
                    <a:pt x="2513" y="148"/>
                  </a:lnTo>
                  <a:lnTo>
                    <a:pt x="2518" y="147"/>
                  </a:lnTo>
                  <a:lnTo>
                    <a:pt x="2523" y="149"/>
                  </a:lnTo>
                  <a:lnTo>
                    <a:pt x="2527" y="150"/>
                  </a:lnTo>
                  <a:lnTo>
                    <a:pt x="2532" y="149"/>
                  </a:lnTo>
                  <a:lnTo>
                    <a:pt x="2537" y="150"/>
                  </a:lnTo>
                  <a:lnTo>
                    <a:pt x="2542" y="150"/>
                  </a:lnTo>
                  <a:lnTo>
                    <a:pt x="2547" y="150"/>
                  </a:lnTo>
                  <a:lnTo>
                    <a:pt x="2551" y="152"/>
                  </a:lnTo>
                  <a:lnTo>
                    <a:pt x="2556" y="149"/>
                  </a:lnTo>
                  <a:lnTo>
                    <a:pt x="2561" y="151"/>
                  </a:lnTo>
                  <a:lnTo>
                    <a:pt x="2566" y="149"/>
                  </a:lnTo>
                  <a:lnTo>
                    <a:pt x="2571" y="149"/>
                  </a:lnTo>
                  <a:lnTo>
                    <a:pt x="2575" y="149"/>
                  </a:lnTo>
                  <a:lnTo>
                    <a:pt x="2580" y="148"/>
                  </a:lnTo>
                  <a:lnTo>
                    <a:pt x="2585" y="148"/>
                  </a:lnTo>
                  <a:lnTo>
                    <a:pt x="2590" y="148"/>
                  </a:lnTo>
                  <a:lnTo>
                    <a:pt x="2595" y="149"/>
                  </a:lnTo>
                  <a:lnTo>
                    <a:pt x="2599" y="150"/>
                  </a:lnTo>
                  <a:lnTo>
                    <a:pt x="2604" y="149"/>
                  </a:lnTo>
                  <a:lnTo>
                    <a:pt x="2609" y="150"/>
                  </a:lnTo>
                  <a:lnTo>
                    <a:pt x="2614" y="149"/>
                  </a:lnTo>
                  <a:lnTo>
                    <a:pt x="2618" y="148"/>
                  </a:lnTo>
                  <a:lnTo>
                    <a:pt x="2623" y="144"/>
                  </a:lnTo>
                  <a:lnTo>
                    <a:pt x="2628" y="134"/>
                  </a:lnTo>
                  <a:lnTo>
                    <a:pt x="2633" y="117"/>
                  </a:lnTo>
                  <a:lnTo>
                    <a:pt x="2638" y="106"/>
                  </a:lnTo>
                  <a:lnTo>
                    <a:pt x="2642" y="104"/>
                  </a:lnTo>
                  <a:lnTo>
                    <a:pt x="2647" y="113"/>
                  </a:lnTo>
                  <a:lnTo>
                    <a:pt x="2652" y="126"/>
                  </a:lnTo>
                  <a:lnTo>
                    <a:pt x="2657" y="134"/>
                  </a:lnTo>
                  <a:lnTo>
                    <a:pt x="2662" y="142"/>
                  </a:lnTo>
                  <a:lnTo>
                    <a:pt x="2667" y="144"/>
                  </a:lnTo>
                  <a:lnTo>
                    <a:pt x="2671" y="145"/>
                  </a:lnTo>
                  <a:lnTo>
                    <a:pt x="2676" y="147"/>
                  </a:lnTo>
                  <a:lnTo>
                    <a:pt x="2681" y="150"/>
                  </a:lnTo>
                  <a:lnTo>
                    <a:pt x="2686" y="150"/>
                  </a:lnTo>
                  <a:lnTo>
                    <a:pt x="2691" y="151"/>
                  </a:lnTo>
                  <a:lnTo>
                    <a:pt x="2695" y="152"/>
                  </a:lnTo>
                  <a:lnTo>
                    <a:pt x="2700" y="151"/>
                  </a:lnTo>
                  <a:lnTo>
                    <a:pt x="2705" y="152"/>
                  </a:lnTo>
                  <a:lnTo>
                    <a:pt x="2710" y="150"/>
                  </a:lnTo>
                  <a:lnTo>
                    <a:pt x="2715" y="150"/>
                  </a:lnTo>
                  <a:lnTo>
                    <a:pt x="2720" y="148"/>
                  </a:lnTo>
                  <a:lnTo>
                    <a:pt x="2724" y="150"/>
                  </a:lnTo>
                  <a:lnTo>
                    <a:pt x="2729" y="148"/>
                  </a:lnTo>
                  <a:lnTo>
                    <a:pt x="2734" y="149"/>
                  </a:lnTo>
                  <a:lnTo>
                    <a:pt x="2739" y="149"/>
                  </a:lnTo>
                  <a:lnTo>
                    <a:pt x="2744" y="150"/>
                  </a:lnTo>
                  <a:lnTo>
                    <a:pt x="2748" y="148"/>
                  </a:lnTo>
                  <a:lnTo>
                    <a:pt x="2753" y="151"/>
                  </a:lnTo>
                  <a:lnTo>
                    <a:pt x="2758" y="149"/>
                  </a:lnTo>
                  <a:lnTo>
                    <a:pt x="2763" y="146"/>
                  </a:lnTo>
                  <a:lnTo>
                    <a:pt x="2768" y="146"/>
                  </a:lnTo>
                  <a:lnTo>
                    <a:pt x="2772" y="143"/>
                  </a:lnTo>
                  <a:lnTo>
                    <a:pt x="2777" y="137"/>
                  </a:lnTo>
                  <a:lnTo>
                    <a:pt x="2782" y="129"/>
                  </a:lnTo>
                  <a:lnTo>
                    <a:pt x="2787" y="125"/>
                  </a:lnTo>
                  <a:lnTo>
                    <a:pt x="2792" y="124"/>
                  </a:lnTo>
                  <a:lnTo>
                    <a:pt x="2796" y="129"/>
                  </a:lnTo>
                  <a:lnTo>
                    <a:pt x="2801" y="136"/>
                  </a:lnTo>
                  <a:lnTo>
                    <a:pt x="2806" y="143"/>
                  </a:lnTo>
                  <a:lnTo>
                    <a:pt x="2811" y="144"/>
                  </a:lnTo>
                  <a:lnTo>
                    <a:pt x="2815" y="146"/>
                  </a:lnTo>
                  <a:lnTo>
                    <a:pt x="2820" y="149"/>
                  </a:lnTo>
                  <a:lnTo>
                    <a:pt x="2825" y="149"/>
                  </a:lnTo>
                  <a:lnTo>
                    <a:pt x="2830" y="150"/>
                  </a:lnTo>
                  <a:lnTo>
                    <a:pt x="2835" y="150"/>
                  </a:lnTo>
                  <a:lnTo>
                    <a:pt x="2839" y="150"/>
                  </a:lnTo>
                  <a:lnTo>
                    <a:pt x="2844" y="150"/>
                  </a:lnTo>
                  <a:lnTo>
                    <a:pt x="2849" y="149"/>
                  </a:lnTo>
                  <a:lnTo>
                    <a:pt x="2854" y="150"/>
                  </a:lnTo>
                  <a:lnTo>
                    <a:pt x="2859" y="149"/>
                  </a:lnTo>
                  <a:lnTo>
                    <a:pt x="2863" y="149"/>
                  </a:lnTo>
                  <a:lnTo>
                    <a:pt x="2868" y="150"/>
                  </a:lnTo>
                  <a:lnTo>
                    <a:pt x="2873" y="148"/>
                  </a:lnTo>
                  <a:lnTo>
                    <a:pt x="2878" y="147"/>
                  </a:lnTo>
                  <a:lnTo>
                    <a:pt x="2883" y="149"/>
                  </a:lnTo>
                  <a:lnTo>
                    <a:pt x="2888" y="150"/>
                  </a:lnTo>
                  <a:lnTo>
                    <a:pt x="2892" y="151"/>
                  </a:lnTo>
                  <a:lnTo>
                    <a:pt x="2897" y="150"/>
                  </a:lnTo>
                  <a:lnTo>
                    <a:pt x="2902" y="148"/>
                  </a:lnTo>
                  <a:lnTo>
                    <a:pt x="2907" y="148"/>
                  </a:lnTo>
                  <a:lnTo>
                    <a:pt x="2912" y="147"/>
                  </a:lnTo>
                  <a:lnTo>
                    <a:pt x="2916" y="148"/>
                  </a:lnTo>
                  <a:lnTo>
                    <a:pt x="2921" y="148"/>
                  </a:lnTo>
                  <a:lnTo>
                    <a:pt x="2926" y="144"/>
                  </a:lnTo>
                  <a:lnTo>
                    <a:pt x="2931" y="139"/>
                  </a:lnTo>
                  <a:lnTo>
                    <a:pt x="2936" y="132"/>
                  </a:lnTo>
                  <a:lnTo>
                    <a:pt x="2941" y="135"/>
                  </a:lnTo>
                  <a:lnTo>
                    <a:pt x="2945" y="135"/>
                  </a:lnTo>
                  <a:lnTo>
                    <a:pt x="2950" y="141"/>
                  </a:lnTo>
                  <a:lnTo>
                    <a:pt x="2955" y="144"/>
                  </a:lnTo>
                  <a:lnTo>
                    <a:pt x="2960" y="144"/>
                  </a:lnTo>
                  <a:lnTo>
                    <a:pt x="2965" y="146"/>
                  </a:lnTo>
                  <a:lnTo>
                    <a:pt x="2969" y="148"/>
                  </a:lnTo>
                  <a:lnTo>
                    <a:pt x="2974" y="148"/>
                  </a:lnTo>
                  <a:lnTo>
                    <a:pt x="2979" y="149"/>
                  </a:lnTo>
                  <a:lnTo>
                    <a:pt x="2984" y="150"/>
                  </a:lnTo>
                  <a:lnTo>
                    <a:pt x="2989" y="150"/>
                  </a:lnTo>
                  <a:lnTo>
                    <a:pt x="2993" y="148"/>
                  </a:lnTo>
                  <a:lnTo>
                    <a:pt x="2998" y="148"/>
                  </a:lnTo>
                  <a:lnTo>
                    <a:pt x="3003" y="148"/>
                  </a:lnTo>
                  <a:lnTo>
                    <a:pt x="3008" y="146"/>
                  </a:lnTo>
                  <a:lnTo>
                    <a:pt x="3012" y="146"/>
                  </a:lnTo>
                  <a:lnTo>
                    <a:pt x="3017" y="145"/>
                  </a:lnTo>
                  <a:lnTo>
                    <a:pt x="3022" y="144"/>
                  </a:lnTo>
                  <a:lnTo>
                    <a:pt x="3027" y="145"/>
                  </a:lnTo>
                  <a:lnTo>
                    <a:pt x="3032" y="146"/>
                  </a:lnTo>
                  <a:lnTo>
                    <a:pt x="3036" y="148"/>
                  </a:lnTo>
                  <a:lnTo>
                    <a:pt x="3041" y="148"/>
                  </a:lnTo>
                  <a:lnTo>
                    <a:pt x="3046" y="149"/>
                  </a:lnTo>
                  <a:lnTo>
                    <a:pt x="3051" y="148"/>
                  </a:lnTo>
                  <a:lnTo>
                    <a:pt x="3056" y="148"/>
                  </a:lnTo>
                  <a:lnTo>
                    <a:pt x="3060" y="149"/>
                  </a:lnTo>
                  <a:lnTo>
                    <a:pt x="3065" y="149"/>
                  </a:lnTo>
                  <a:lnTo>
                    <a:pt x="3070" y="151"/>
                  </a:lnTo>
                  <a:lnTo>
                    <a:pt x="3075" y="152"/>
                  </a:lnTo>
                  <a:lnTo>
                    <a:pt x="3080" y="150"/>
                  </a:lnTo>
                  <a:lnTo>
                    <a:pt x="3085" y="149"/>
                  </a:lnTo>
                  <a:lnTo>
                    <a:pt x="3089" y="150"/>
                  </a:lnTo>
                  <a:lnTo>
                    <a:pt x="3094" y="149"/>
                  </a:lnTo>
                  <a:lnTo>
                    <a:pt x="3099" y="151"/>
                  </a:lnTo>
                  <a:lnTo>
                    <a:pt x="3104" y="149"/>
                  </a:lnTo>
                  <a:lnTo>
                    <a:pt x="3109" y="151"/>
                  </a:lnTo>
                  <a:lnTo>
                    <a:pt x="3113" y="150"/>
                  </a:lnTo>
                  <a:lnTo>
                    <a:pt x="3118" y="149"/>
                  </a:lnTo>
                  <a:lnTo>
                    <a:pt x="3123" y="148"/>
                  </a:lnTo>
                  <a:lnTo>
                    <a:pt x="3128" y="148"/>
                  </a:lnTo>
                  <a:lnTo>
                    <a:pt x="3133" y="144"/>
                  </a:lnTo>
                  <a:lnTo>
                    <a:pt x="3137" y="141"/>
                  </a:lnTo>
                  <a:lnTo>
                    <a:pt x="3142" y="137"/>
                  </a:lnTo>
                  <a:lnTo>
                    <a:pt x="3147" y="133"/>
                  </a:lnTo>
                  <a:lnTo>
                    <a:pt x="3152" y="130"/>
                  </a:lnTo>
                  <a:lnTo>
                    <a:pt x="3157" y="132"/>
                  </a:lnTo>
                  <a:lnTo>
                    <a:pt x="3162" y="133"/>
                  </a:lnTo>
                  <a:lnTo>
                    <a:pt x="3166" y="134"/>
                  </a:lnTo>
                  <a:lnTo>
                    <a:pt x="3171" y="139"/>
                  </a:lnTo>
                  <a:lnTo>
                    <a:pt x="3176" y="143"/>
                  </a:lnTo>
                  <a:lnTo>
                    <a:pt x="3181" y="143"/>
                  </a:lnTo>
                  <a:lnTo>
                    <a:pt x="3186" y="144"/>
                  </a:lnTo>
                  <a:lnTo>
                    <a:pt x="3190" y="145"/>
                  </a:lnTo>
                  <a:lnTo>
                    <a:pt x="3195" y="145"/>
                  </a:lnTo>
                  <a:lnTo>
                    <a:pt x="3200" y="144"/>
                  </a:lnTo>
                  <a:lnTo>
                    <a:pt x="3205" y="144"/>
                  </a:lnTo>
                  <a:lnTo>
                    <a:pt x="3209" y="147"/>
                  </a:lnTo>
                  <a:lnTo>
                    <a:pt x="3214" y="146"/>
                  </a:lnTo>
                  <a:lnTo>
                    <a:pt x="3219" y="144"/>
                  </a:lnTo>
                  <a:lnTo>
                    <a:pt x="3224" y="142"/>
                  </a:lnTo>
                  <a:lnTo>
                    <a:pt x="3229" y="140"/>
                  </a:lnTo>
                  <a:lnTo>
                    <a:pt x="3233" y="143"/>
                  </a:lnTo>
                  <a:lnTo>
                    <a:pt x="3238" y="141"/>
                  </a:lnTo>
                  <a:lnTo>
                    <a:pt x="3243" y="141"/>
                  </a:lnTo>
                  <a:lnTo>
                    <a:pt x="3248" y="142"/>
                  </a:lnTo>
                  <a:lnTo>
                    <a:pt x="3253" y="143"/>
                  </a:lnTo>
                  <a:lnTo>
                    <a:pt x="3257" y="142"/>
                  </a:lnTo>
                  <a:lnTo>
                    <a:pt x="3262" y="138"/>
                  </a:lnTo>
                  <a:lnTo>
                    <a:pt x="3267" y="142"/>
                  </a:lnTo>
                  <a:lnTo>
                    <a:pt x="3272" y="143"/>
                  </a:lnTo>
                  <a:lnTo>
                    <a:pt x="3277" y="144"/>
                  </a:lnTo>
                  <a:lnTo>
                    <a:pt x="3281" y="145"/>
                  </a:lnTo>
                  <a:lnTo>
                    <a:pt x="3286" y="145"/>
                  </a:lnTo>
                  <a:lnTo>
                    <a:pt x="3291" y="148"/>
                  </a:lnTo>
                  <a:lnTo>
                    <a:pt x="3296" y="148"/>
                  </a:lnTo>
                  <a:lnTo>
                    <a:pt x="3301" y="147"/>
                  </a:lnTo>
                  <a:lnTo>
                    <a:pt x="3306" y="145"/>
                  </a:lnTo>
                  <a:lnTo>
                    <a:pt x="3310" y="146"/>
                  </a:lnTo>
                  <a:lnTo>
                    <a:pt x="3315" y="145"/>
                  </a:lnTo>
                  <a:lnTo>
                    <a:pt x="3320" y="146"/>
                  </a:lnTo>
                  <a:lnTo>
                    <a:pt x="3325" y="145"/>
                  </a:lnTo>
                  <a:lnTo>
                    <a:pt x="3330" y="146"/>
                  </a:lnTo>
                  <a:lnTo>
                    <a:pt x="3334" y="146"/>
                  </a:lnTo>
                  <a:lnTo>
                    <a:pt x="3339" y="147"/>
                  </a:lnTo>
                  <a:lnTo>
                    <a:pt x="3344" y="146"/>
                  </a:lnTo>
                  <a:lnTo>
                    <a:pt x="3349" y="148"/>
                  </a:lnTo>
                  <a:lnTo>
                    <a:pt x="3354" y="147"/>
                  </a:lnTo>
                  <a:lnTo>
                    <a:pt x="3359" y="146"/>
                  </a:lnTo>
                  <a:lnTo>
                    <a:pt x="3363" y="147"/>
                  </a:lnTo>
                  <a:lnTo>
                    <a:pt x="3368" y="149"/>
                  </a:lnTo>
                  <a:lnTo>
                    <a:pt x="3373" y="148"/>
                  </a:lnTo>
                  <a:lnTo>
                    <a:pt x="3378" y="147"/>
                  </a:lnTo>
                  <a:lnTo>
                    <a:pt x="3383" y="149"/>
                  </a:lnTo>
                  <a:lnTo>
                    <a:pt x="3387" y="146"/>
                  </a:lnTo>
                  <a:lnTo>
                    <a:pt x="3392" y="149"/>
                  </a:lnTo>
                  <a:lnTo>
                    <a:pt x="3397" y="149"/>
                  </a:lnTo>
                  <a:lnTo>
                    <a:pt x="3402" y="148"/>
                  </a:lnTo>
                  <a:lnTo>
                    <a:pt x="3406" y="148"/>
                  </a:lnTo>
                  <a:lnTo>
                    <a:pt x="3411" y="151"/>
                  </a:lnTo>
                  <a:lnTo>
                    <a:pt x="3416" y="149"/>
                  </a:lnTo>
                  <a:lnTo>
                    <a:pt x="3421" y="147"/>
                  </a:lnTo>
                  <a:lnTo>
                    <a:pt x="3426" y="147"/>
                  </a:lnTo>
                  <a:lnTo>
                    <a:pt x="3430" y="144"/>
                  </a:lnTo>
                  <a:lnTo>
                    <a:pt x="3435" y="144"/>
                  </a:lnTo>
                  <a:lnTo>
                    <a:pt x="3440" y="143"/>
                  </a:lnTo>
                  <a:lnTo>
                    <a:pt x="3445" y="144"/>
                  </a:lnTo>
                  <a:lnTo>
                    <a:pt x="3450" y="141"/>
                  </a:lnTo>
                  <a:lnTo>
                    <a:pt x="3454" y="137"/>
                  </a:lnTo>
                  <a:lnTo>
                    <a:pt x="3459" y="136"/>
                  </a:lnTo>
                  <a:lnTo>
                    <a:pt x="3464" y="131"/>
                  </a:lnTo>
                  <a:lnTo>
                    <a:pt x="3469" y="126"/>
                  </a:lnTo>
                  <a:lnTo>
                    <a:pt x="3474" y="118"/>
                  </a:lnTo>
                  <a:lnTo>
                    <a:pt x="3478" y="114"/>
                  </a:lnTo>
                  <a:lnTo>
                    <a:pt x="3483" y="114"/>
                  </a:lnTo>
                  <a:lnTo>
                    <a:pt x="3488" y="121"/>
                  </a:lnTo>
                  <a:lnTo>
                    <a:pt x="3493" y="125"/>
                  </a:lnTo>
                  <a:lnTo>
                    <a:pt x="3498" y="134"/>
                  </a:lnTo>
                  <a:lnTo>
                    <a:pt x="3503" y="137"/>
                  </a:lnTo>
                  <a:lnTo>
                    <a:pt x="3507" y="141"/>
                  </a:lnTo>
                  <a:lnTo>
                    <a:pt x="3512" y="139"/>
                  </a:lnTo>
                  <a:lnTo>
                    <a:pt x="3517" y="140"/>
                  </a:lnTo>
                  <a:lnTo>
                    <a:pt x="3522" y="142"/>
                  </a:lnTo>
                  <a:lnTo>
                    <a:pt x="3527" y="140"/>
                  </a:lnTo>
                  <a:lnTo>
                    <a:pt x="3531" y="144"/>
                  </a:lnTo>
                  <a:lnTo>
                    <a:pt x="3536" y="144"/>
                  </a:lnTo>
                  <a:lnTo>
                    <a:pt x="3541" y="143"/>
                  </a:lnTo>
                  <a:lnTo>
                    <a:pt x="3546" y="143"/>
                  </a:lnTo>
                  <a:lnTo>
                    <a:pt x="3551" y="142"/>
                  </a:lnTo>
                  <a:lnTo>
                    <a:pt x="3555" y="140"/>
                  </a:lnTo>
                  <a:lnTo>
                    <a:pt x="3560" y="139"/>
                  </a:lnTo>
                  <a:lnTo>
                    <a:pt x="3565" y="136"/>
                  </a:lnTo>
                  <a:lnTo>
                    <a:pt x="3570" y="134"/>
                  </a:lnTo>
                  <a:lnTo>
                    <a:pt x="3575" y="138"/>
                  </a:lnTo>
                  <a:lnTo>
                    <a:pt x="3580" y="137"/>
                  </a:lnTo>
                  <a:lnTo>
                    <a:pt x="3584" y="139"/>
                  </a:lnTo>
                  <a:lnTo>
                    <a:pt x="3589" y="139"/>
                  </a:lnTo>
                  <a:lnTo>
                    <a:pt x="3594" y="142"/>
                  </a:lnTo>
                  <a:lnTo>
                    <a:pt x="3599" y="142"/>
                  </a:lnTo>
                  <a:lnTo>
                    <a:pt x="3603" y="142"/>
                  </a:lnTo>
                  <a:lnTo>
                    <a:pt x="3608" y="139"/>
                  </a:lnTo>
                  <a:lnTo>
                    <a:pt x="3613" y="142"/>
                  </a:lnTo>
                  <a:lnTo>
                    <a:pt x="3618" y="141"/>
                  </a:lnTo>
                  <a:lnTo>
                    <a:pt x="3623" y="141"/>
                  </a:lnTo>
                  <a:lnTo>
                    <a:pt x="3627" y="143"/>
                  </a:lnTo>
                  <a:lnTo>
                    <a:pt x="3632" y="144"/>
                  </a:lnTo>
                  <a:lnTo>
                    <a:pt x="3637" y="141"/>
                  </a:lnTo>
                  <a:lnTo>
                    <a:pt x="3642" y="143"/>
                  </a:lnTo>
                  <a:lnTo>
                    <a:pt x="3646" y="144"/>
                  </a:lnTo>
                  <a:lnTo>
                    <a:pt x="3651" y="143"/>
                  </a:lnTo>
                  <a:lnTo>
                    <a:pt x="3656" y="141"/>
                  </a:lnTo>
                  <a:lnTo>
                    <a:pt x="3661" y="143"/>
                  </a:lnTo>
                  <a:lnTo>
                    <a:pt x="3666" y="143"/>
                  </a:lnTo>
                  <a:lnTo>
                    <a:pt x="3671" y="143"/>
                  </a:lnTo>
                  <a:lnTo>
                    <a:pt x="3675" y="143"/>
                  </a:lnTo>
                  <a:lnTo>
                    <a:pt x="3680" y="144"/>
                  </a:lnTo>
                  <a:lnTo>
                    <a:pt x="3685" y="144"/>
                  </a:lnTo>
                  <a:lnTo>
                    <a:pt x="3690" y="143"/>
                  </a:lnTo>
                  <a:lnTo>
                    <a:pt x="3695" y="145"/>
                  </a:lnTo>
                  <a:lnTo>
                    <a:pt x="3699" y="143"/>
                  </a:lnTo>
                  <a:lnTo>
                    <a:pt x="3704" y="143"/>
                  </a:lnTo>
                  <a:lnTo>
                    <a:pt x="3709" y="140"/>
                  </a:lnTo>
                  <a:lnTo>
                    <a:pt x="3714" y="136"/>
                  </a:lnTo>
                  <a:lnTo>
                    <a:pt x="3719" y="131"/>
                  </a:lnTo>
                  <a:lnTo>
                    <a:pt x="3724" y="128"/>
                  </a:lnTo>
                  <a:lnTo>
                    <a:pt x="3728" y="130"/>
                  </a:lnTo>
                  <a:lnTo>
                    <a:pt x="3733" y="134"/>
                  </a:lnTo>
                  <a:lnTo>
                    <a:pt x="3738" y="138"/>
                  </a:lnTo>
                  <a:lnTo>
                    <a:pt x="3743" y="137"/>
                  </a:lnTo>
                  <a:lnTo>
                    <a:pt x="3748" y="137"/>
                  </a:lnTo>
                  <a:lnTo>
                    <a:pt x="3752" y="136"/>
                  </a:lnTo>
                  <a:lnTo>
                    <a:pt x="3757" y="133"/>
                  </a:lnTo>
                  <a:lnTo>
                    <a:pt x="3762" y="137"/>
                  </a:lnTo>
                  <a:lnTo>
                    <a:pt x="3767" y="137"/>
                  </a:lnTo>
                  <a:lnTo>
                    <a:pt x="3772" y="141"/>
                  </a:lnTo>
                  <a:lnTo>
                    <a:pt x="3777" y="144"/>
                  </a:lnTo>
                  <a:lnTo>
                    <a:pt x="3781" y="144"/>
                  </a:lnTo>
                  <a:lnTo>
                    <a:pt x="3786" y="145"/>
                  </a:lnTo>
                  <a:lnTo>
                    <a:pt x="3791" y="146"/>
                  </a:lnTo>
                  <a:lnTo>
                    <a:pt x="3796" y="146"/>
                  </a:lnTo>
                  <a:lnTo>
                    <a:pt x="3800" y="146"/>
                  </a:lnTo>
                  <a:lnTo>
                    <a:pt x="3805" y="144"/>
                  </a:lnTo>
                  <a:lnTo>
                    <a:pt x="3810" y="145"/>
                  </a:lnTo>
                  <a:lnTo>
                    <a:pt x="3815" y="147"/>
                  </a:lnTo>
                  <a:lnTo>
                    <a:pt x="3820" y="146"/>
                  </a:lnTo>
                  <a:lnTo>
                    <a:pt x="3824" y="145"/>
                  </a:lnTo>
                  <a:lnTo>
                    <a:pt x="3829" y="146"/>
                  </a:lnTo>
                  <a:lnTo>
                    <a:pt x="3834" y="146"/>
                  </a:lnTo>
                  <a:lnTo>
                    <a:pt x="3839" y="148"/>
                  </a:lnTo>
                  <a:lnTo>
                    <a:pt x="3843" y="147"/>
                  </a:lnTo>
                  <a:lnTo>
                    <a:pt x="3848" y="148"/>
                  </a:lnTo>
                  <a:lnTo>
                    <a:pt x="3853" y="145"/>
                  </a:lnTo>
                  <a:lnTo>
                    <a:pt x="3858" y="145"/>
                  </a:lnTo>
                  <a:lnTo>
                    <a:pt x="3863" y="148"/>
                  </a:lnTo>
                  <a:lnTo>
                    <a:pt x="3868" y="146"/>
                  </a:lnTo>
                  <a:lnTo>
                    <a:pt x="3872" y="144"/>
                  </a:lnTo>
                  <a:lnTo>
                    <a:pt x="3877" y="148"/>
                  </a:lnTo>
                  <a:lnTo>
                    <a:pt x="3882" y="143"/>
                  </a:lnTo>
                  <a:lnTo>
                    <a:pt x="3887" y="140"/>
                  </a:lnTo>
                  <a:lnTo>
                    <a:pt x="3892" y="136"/>
                  </a:lnTo>
                  <a:lnTo>
                    <a:pt x="3896" y="138"/>
                  </a:lnTo>
                  <a:lnTo>
                    <a:pt x="3901" y="135"/>
                  </a:lnTo>
                  <a:lnTo>
                    <a:pt x="3906" y="135"/>
                  </a:lnTo>
                  <a:lnTo>
                    <a:pt x="3911" y="135"/>
                  </a:lnTo>
                  <a:lnTo>
                    <a:pt x="3916" y="137"/>
                  </a:lnTo>
                  <a:lnTo>
                    <a:pt x="3920" y="138"/>
                  </a:lnTo>
                  <a:lnTo>
                    <a:pt x="3925" y="139"/>
                  </a:lnTo>
                  <a:lnTo>
                    <a:pt x="3930" y="138"/>
                  </a:lnTo>
                  <a:lnTo>
                    <a:pt x="3935" y="137"/>
                  </a:lnTo>
                  <a:lnTo>
                    <a:pt x="3940" y="130"/>
                  </a:lnTo>
                  <a:lnTo>
                    <a:pt x="3945" y="128"/>
                  </a:lnTo>
                  <a:lnTo>
                    <a:pt x="3949" y="127"/>
                  </a:lnTo>
                  <a:lnTo>
                    <a:pt x="3954" y="129"/>
                  </a:lnTo>
                  <a:lnTo>
                    <a:pt x="3959" y="133"/>
                  </a:lnTo>
                  <a:lnTo>
                    <a:pt x="3964" y="139"/>
                  </a:lnTo>
                  <a:lnTo>
                    <a:pt x="3969" y="143"/>
                  </a:lnTo>
                  <a:lnTo>
                    <a:pt x="3973" y="142"/>
                  </a:lnTo>
                  <a:lnTo>
                    <a:pt x="3978" y="146"/>
                  </a:lnTo>
                  <a:lnTo>
                    <a:pt x="3983" y="146"/>
                  </a:lnTo>
                  <a:lnTo>
                    <a:pt x="3988" y="145"/>
                  </a:lnTo>
                  <a:lnTo>
                    <a:pt x="3993" y="145"/>
                  </a:lnTo>
                  <a:lnTo>
                    <a:pt x="3997" y="144"/>
                  </a:lnTo>
                  <a:lnTo>
                    <a:pt x="4002" y="146"/>
                  </a:lnTo>
                  <a:lnTo>
                    <a:pt x="4007" y="145"/>
                  </a:lnTo>
                  <a:lnTo>
                    <a:pt x="4012" y="146"/>
                  </a:lnTo>
                  <a:lnTo>
                    <a:pt x="4017" y="147"/>
                  </a:lnTo>
                  <a:lnTo>
                    <a:pt x="4021" y="146"/>
                  </a:lnTo>
                  <a:lnTo>
                    <a:pt x="4026" y="146"/>
                  </a:lnTo>
                  <a:lnTo>
                    <a:pt x="4031" y="147"/>
                  </a:lnTo>
                  <a:lnTo>
                    <a:pt x="4036" y="149"/>
                  </a:lnTo>
                  <a:lnTo>
                    <a:pt x="4040" y="149"/>
                  </a:lnTo>
                  <a:lnTo>
                    <a:pt x="4045" y="146"/>
                  </a:lnTo>
                  <a:lnTo>
                    <a:pt x="4050" y="146"/>
                  </a:lnTo>
                  <a:lnTo>
                    <a:pt x="4055" y="146"/>
                  </a:lnTo>
                  <a:lnTo>
                    <a:pt x="4060" y="146"/>
                  </a:lnTo>
                  <a:lnTo>
                    <a:pt x="4064" y="147"/>
                  </a:lnTo>
                  <a:lnTo>
                    <a:pt x="4069" y="145"/>
                  </a:lnTo>
                  <a:lnTo>
                    <a:pt x="4074" y="144"/>
                  </a:lnTo>
                  <a:lnTo>
                    <a:pt x="4079" y="146"/>
                  </a:lnTo>
                  <a:lnTo>
                    <a:pt x="4084" y="145"/>
                  </a:lnTo>
                  <a:lnTo>
                    <a:pt x="4089" y="148"/>
                  </a:lnTo>
                  <a:lnTo>
                    <a:pt x="4093" y="147"/>
                  </a:lnTo>
                  <a:lnTo>
                    <a:pt x="4098" y="146"/>
                  </a:lnTo>
                  <a:lnTo>
                    <a:pt x="4103" y="144"/>
                  </a:lnTo>
                  <a:lnTo>
                    <a:pt x="4108" y="146"/>
                  </a:lnTo>
                  <a:lnTo>
                    <a:pt x="4113" y="145"/>
                  </a:lnTo>
                  <a:lnTo>
                    <a:pt x="4117" y="146"/>
                  </a:lnTo>
                  <a:lnTo>
                    <a:pt x="4122" y="145"/>
                  </a:lnTo>
                  <a:lnTo>
                    <a:pt x="4127" y="145"/>
                  </a:lnTo>
                  <a:lnTo>
                    <a:pt x="4132" y="143"/>
                  </a:lnTo>
                  <a:lnTo>
                    <a:pt x="4137" y="143"/>
                  </a:lnTo>
                  <a:lnTo>
                    <a:pt x="4142" y="145"/>
                  </a:lnTo>
                  <a:lnTo>
                    <a:pt x="4146" y="145"/>
                  </a:lnTo>
                  <a:lnTo>
                    <a:pt x="4151" y="141"/>
                  </a:lnTo>
                  <a:lnTo>
                    <a:pt x="4156" y="142"/>
                  </a:lnTo>
                  <a:lnTo>
                    <a:pt x="4161" y="143"/>
                  </a:lnTo>
                  <a:lnTo>
                    <a:pt x="4166" y="140"/>
                  </a:lnTo>
                  <a:lnTo>
                    <a:pt x="4170" y="142"/>
                  </a:lnTo>
                  <a:lnTo>
                    <a:pt x="4175" y="144"/>
                  </a:lnTo>
                  <a:lnTo>
                    <a:pt x="4180" y="144"/>
                  </a:lnTo>
                  <a:lnTo>
                    <a:pt x="4185" y="145"/>
                  </a:lnTo>
                  <a:lnTo>
                    <a:pt x="4190" y="144"/>
                  </a:lnTo>
                  <a:lnTo>
                    <a:pt x="4194" y="142"/>
                  </a:lnTo>
                  <a:lnTo>
                    <a:pt x="4199" y="145"/>
                  </a:lnTo>
                  <a:lnTo>
                    <a:pt x="4204" y="145"/>
                  </a:lnTo>
                  <a:lnTo>
                    <a:pt x="4209" y="142"/>
                  </a:lnTo>
                  <a:lnTo>
                    <a:pt x="4214" y="145"/>
                  </a:lnTo>
                  <a:lnTo>
                    <a:pt x="4218" y="143"/>
                  </a:lnTo>
                  <a:lnTo>
                    <a:pt x="4223" y="143"/>
                  </a:lnTo>
                  <a:lnTo>
                    <a:pt x="4228" y="142"/>
                  </a:lnTo>
                  <a:lnTo>
                    <a:pt x="4233" y="141"/>
                  </a:lnTo>
                  <a:lnTo>
                    <a:pt x="4237" y="142"/>
                  </a:lnTo>
                  <a:lnTo>
                    <a:pt x="4242" y="139"/>
                  </a:lnTo>
                  <a:lnTo>
                    <a:pt x="4247" y="141"/>
                  </a:lnTo>
                  <a:lnTo>
                    <a:pt x="4252" y="142"/>
                  </a:lnTo>
                  <a:lnTo>
                    <a:pt x="4257" y="138"/>
                  </a:lnTo>
                  <a:lnTo>
                    <a:pt x="4261" y="142"/>
                  </a:lnTo>
                  <a:lnTo>
                    <a:pt x="4266" y="139"/>
                  </a:lnTo>
                  <a:lnTo>
                    <a:pt x="4271" y="139"/>
                  </a:lnTo>
                  <a:lnTo>
                    <a:pt x="4276" y="140"/>
                  </a:lnTo>
                  <a:lnTo>
                    <a:pt x="4281" y="139"/>
                  </a:lnTo>
                  <a:lnTo>
                    <a:pt x="4286" y="140"/>
                  </a:lnTo>
                  <a:lnTo>
                    <a:pt x="4290" y="141"/>
                  </a:lnTo>
                  <a:lnTo>
                    <a:pt x="4295" y="140"/>
                  </a:lnTo>
                  <a:lnTo>
                    <a:pt x="4300" y="141"/>
                  </a:lnTo>
                  <a:lnTo>
                    <a:pt x="4305" y="141"/>
                  </a:lnTo>
                  <a:lnTo>
                    <a:pt x="4310" y="143"/>
                  </a:lnTo>
                  <a:lnTo>
                    <a:pt x="4314" y="138"/>
                  </a:lnTo>
                  <a:lnTo>
                    <a:pt x="4319" y="140"/>
                  </a:lnTo>
                  <a:lnTo>
                    <a:pt x="4324" y="142"/>
                  </a:lnTo>
                  <a:lnTo>
                    <a:pt x="4329" y="142"/>
                  </a:lnTo>
                  <a:lnTo>
                    <a:pt x="4334" y="140"/>
                  </a:lnTo>
                  <a:lnTo>
                    <a:pt x="4338" y="141"/>
                  </a:lnTo>
                  <a:lnTo>
                    <a:pt x="4343" y="141"/>
                  </a:lnTo>
                  <a:lnTo>
                    <a:pt x="4348" y="143"/>
                  </a:lnTo>
                  <a:lnTo>
                    <a:pt x="4353" y="141"/>
                  </a:lnTo>
                  <a:lnTo>
                    <a:pt x="4358" y="140"/>
                  </a:lnTo>
                  <a:lnTo>
                    <a:pt x="4363" y="141"/>
                  </a:lnTo>
                  <a:lnTo>
                    <a:pt x="4367" y="140"/>
                  </a:lnTo>
                  <a:lnTo>
                    <a:pt x="4372" y="141"/>
                  </a:lnTo>
                  <a:lnTo>
                    <a:pt x="4377" y="142"/>
                  </a:lnTo>
                  <a:lnTo>
                    <a:pt x="4382" y="139"/>
                  </a:lnTo>
                  <a:lnTo>
                    <a:pt x="4387" y="139"/>
                  </a:lnTo>
                  <a:lnTo>
                    <a:pt x="4391" y="134"/>
                  </a:lnTo>
                  <a:lnTo>
                    <a:pt x="4396" y="134"/>
                  </a:lnTo>
                  <a:lnTo>
                    <a:pt x="4401" y="130"/>
                  </a:lnTo>
                  <a:lnTo>
                    <a:pt x="4406" y="130"/>
                  </a:lnTo>
                  <a:lnTo>
                    <a:pt x="4411" y="128"/>
                  </a:lnTo>
                  <a:lnTo>
                    <a:pt x="4415" y="127"/>
                  </a:lnTo>
                  <a:lnTo>
                    <a:pt x="4420" y="128"/>
                  </a:lnTo>
                  <a:lnTo>
                    <a:pt x="4425" y="124"/>
                  </a:lnTo>
                  <a:lnTo>
                    <a:pt x="4430" y="121"/>
                  </a:lnTo>
                  <a:lnTo>
                    <a:pt x="4434" y="123"/>
                  </a:lnTo>
                  <a:lnTo>
                    <a:pt x="4439" y="120"/>
                  </a:lnTo>
                  <a:lnTo>
                    <a:pt x="4444" y="121"/>
                  </a:lnTo>
                  <a:lnTo>
                    <a:pt x="4449" y="118"/>
                  </a:lnTo>
                  <a:lnTo>
                    <a:pt x="4454" y="120"/>
                  </a:lnTo>
                  <a:lnTo>
                    <a:pt x="4458" y="119"/>
                  </a:lnTo>
                  <a:lnTo>
                    <a:pt x="4463" y="117"/>
                  </a:lnTo>
                  <a:lnTo>
                    <a:pt x="4468" y="118"/>
                  </a:lnTo>
                  <a:lnTo>
                    <a:pt x="4473" y="119"/>
                  </a:lnTo>
                  <a:lnTo>
                    <a:pt x="4478" y="121"/>
                  </a:lnTo>
                  <a:lnTo>
                    <a:pt x="4482" y="120"/>
                  </a:lnTo>
                  <a:lnTo>
                    <a:pt x="4487" y="123"/>
                  </a:lnTo>
                  <a:lnTo>
                    <a:pt x="4492" y="122"/>
                  </a:lnTo>
                  <a:lnTo>
                    <a:pt x="4497" y="123"/>
                  </a:lnTo>
                  <a:lnTo>
                    <a:pt x="4502" y="126"/>
                  </a:lnTo>
                  <a:lnTo>
                    <a:pt x="4507" y="125"/>
                  </a:lnTo>
                  <a:lnTo>
                    <a:pt x="4511" y="128"/>
                  </a:lnTo>
                  <a:lnTo>
                    <a:pt x="4516" y="124"/>
                  </a:lnTo>
                  <a:lnTo>
                    <a:pt x="4521" y="124"/>
                  </a:lnTo>
                  <a:lnTo>
                    <a:pt x="4526" y="124"/>
                  </a:lnTo>
                  <a:lnTo>
                    <a:pt x="4531" y="126"/>
                  </a:lnTo>
                  <a:lnTo>
                    <a:pt x="4535" y="127"/>
                  </a:lnTo>
                  <a:lnTo>
                    <a:pt x="4540" y="127"/>
                  </a:lnTo>
                  <a:lnTo>
                    <a:pt x="4545" y="124"/>
                  </a:lnTo>
                  <a:lnTo>
                    <a:pt x="4550" y="121"/>
                  </a:lnTo>
                  <a:lnTo>
                    <a:pt x="4555" y="120"/>
                  </a:lnTo>
                  <a:lnTo>
                    <a:pt x="4560" y="115"/>
                  </a:lnTo>
                  <a:lnTo>
                    <a:pt x="4564" y="108"/>
                  </a:lnTo>
                  <a:lnTo>
                    <a:pt x="4569" y="105"/>
                  </a:lnTo>
                  <a:lnTo>
                    <a:pt x="4574" y="96"/>
                  </a:lnTo>
                  <a:lnTo>
                    <a:pt x="4579" y="91"/>
                  </a:lnTo>
                  <a:lnTo>
                    <a:pt x="4584" y="84"/>
                  </a:lnTo>
                  <a:lnTo>
                    <a:pt x="4588" y="80"/>
                  </a:lnTo>
                  <a:lnTo>
                    <a:pt x="4593" y="79"/>
                  </a:lnTo>
                  <a:lnTo>
                    <a:pt x="4598" y="74"/>
                  </a:lnTo>
                  <a:lnTo>
                    <a:pt x="4603" y="74"/>
                  </a:lnTo>
                  <a:lnTo>
                    <a:pt x="4608" y="78"/>
                  </a:lnTo>
                  <a:lnTo>
                    <a:pt x="4612" y="81"/>
                  </a:lnTo>
                  <a:lnTo>
                    <a:pt x="4617" y="87"/>
                  </a:lnTo>
                  <a:lnTo>
                    <a:pt x="4622" y="90"/>
                  </a:lnTo>
                  <a:lnTo>
                    <a:pt x="4627" y="94"/>
                  </a:lnTo>
                  <a:lnTo>
                    <a:pt x="4631" y="101"/>
                  </a:lnTo>
                  <a:lnTo>
                    <a:pt x="4636" y="104"/>
                  </a:lnTo>
                  <a:lnTo>
                    <a:pt x="4641" y="106"/>
                  </a:lnTo>
                  <a:lnTo>
                    <a:pt x="4646" y="107"/>
                  </a:lnTo>
                  <a:lnTo>
                    <a:pt x="4651" y="104"/>
                  </a:lnTo>
                  <a:lnTo>
                    <a:pt x="4655" y="104"/>
                  </a:lnTo>
                  <a:lnTo>
                    <a:pt x="4660" y="96"/>
                  </a:lnTo>
                  <a:lnTo>
                    <a:pt x="4665" y="89"/>
                  </a:lnTo>
                  <a:lnTo>
                    <a:pt x="4670" y="84"/>
                  </a:lnTo>
                  <a:lnTo>
                    <a:pt x="4675" y="81"/>
                  </a:lnTo>
                  <a:lnTo>
                    <a:pt x="4679" y="74"/>
                  </a:lnTo>
                  <a:lnTo>
                    <a:pt x="4684" y="70"/>
                  </a:lnTo>
                  <a:lnTo>
                    <a:pt x="4689" y="64"/>
                  </a:lnTo>
                  <a:lnTo>
                    <a:pt x="4694" y="60"/>
                  </a:lnTo>
                  <a:lnTo>
                    <a:pt x="4699" y="56"/>
                  </a:lnTo>
                  <a:lnTo>
                    <a:pt x="4704" y="55"/>
                  </a:lnTo>
                  <a:lnTo>
                    <a:pt x="4708" y="58"/>
                  </a:lnTo>
                  <a:lnTo>
                    <a:pt x="4713" y="56"/>
                  </a:lnTo>
                  <a:lnTo>
                    <a:pt x="4718" y="58"/>
                  </a:lnTo>
                  <a:lnTo>
                    <a:pt x="4723" y="60"/>
                  </a:lnTo>
                  <a:lnTo>
                    <a:pt x="4728" y="67"/>
                  </a:lnTo>
                  <a:lnTo>
                    <a:pt x="4732" y="69"/>
                  </a:lnTo>
                  <a:lnTo>
                    <a:pt x="4737" y="72"/>
                  </a:lnTo>
                  <a:lnTo>
                    <a:pt x="4742" y="80"/>
                  </a:lnTo>
                  <a:lnTo>
                    <a:pt x="4747" y="81"/>
                  </a:lnTo>
                  <a:lnTo>
                    <a:pt x="4752" y="88"/>
                  </a:lnTo>
                  <a:lnTo>
                    <a:pt x="4756" y="92"/>
                  </a:lnTo>
                  <a:lnTo>
                    <a:pt x="4761" y="96"/>
                  </a:lnTo>
                  <a:lnTo>
                    <a:pt x="4766" y="99"/>
                  </a:lnTo>
                  <a:lnTo>
                    <a:pt x="4771" y="101"/>
                  </a:lnTo>
                  <a:lnTo>
                    <a:pt x="4776" y="103"/>
                  </a:lnTo>
                  <a:lnTo>
                    <a:pt x="4781" y="106"/>
                  </a:lnTo>
                  <a:lnTo>
                    <a:pt x="4785" y="109"/>
                  </a:lnTo>
                  <a:lnTo>
                    <a:pt x="4790" y="108"/>
                  </a:lnTo>
                  <a:lnTo>
                    <a:pt x="4795" y="110"/>
                  </a:lnTo>
                  <a:lnTo>
                    <a:pt x="4800" y="109"/>
                  </a:lnTo>
                  <a:lnTo>
                    <a:pt x="4805" y="111"/>
                  </a:lnTo>
                  <a:lnTo>
                    <a:pt x="4809" y="107"/>
                  </a:lnTo>
                  <a:lnTo>
                    <a:pt x="4814" y="107"/>
                  </a:lnTo>
                  <a:lnTo>
                    <a:pt x="4819" y="105"/>
                  </a:lnTo>
                  <a:lnTo>
                    <a:pt x="4824" y="102"/>
                  </a:lnTo>
                  <a:lnTo>
                    <a:pt x="4828" y="103"/>
                  </a:lnTo>
                  <a:lnTo>
                    <a:pt x="4833" y="98"/>
                  </a:lnTo>
                  <a:lnTo>
                    <a:pt x="4838" y="94"/>
                  </a:lnTo>
                  <a:lnTo>
                    <a:pt x="4843" y="88"/>
                  </a:lnTo>
                  <a:lnTo>
                    <a:pt x="4848" y="82"/>
                  </a:lnTo>
                  <a:lnTo>
                    <a:pt x="4852" y="76"/>
                  </a:lnTo>
                  <a:lnTo>
                    <a:pt x="4857" y="66"/>
                  </a:lnTo>
                  <a:lnTo>
                    <a:pt x="4862" y="59"/>
                  </a:lnTo>
                  <a:lnTo>
                    <a:pt x="4867" y="48"/>
                  </a:lnTo>
                  <a:lnTo>
                    <a:pt x="4872" y="34"/>
                  </a:lnTo>
                  <a:lnTo>
                    <a:pt x="4876" y="24"/>
                  </a:lnTo>
                  <a:lnTo>
                    <a:pt x="4881" y="15"/>
                  </a:lnTo>
                  <a:lnTo>
                    <a:pt x="4886" y="4"/>
                  </a:lnTo>
                  <a:lnTo>
                    <a:pt x="4891" y="0"/>
                  </a:lnTo>
                  <a:lnTo>
                    <a:pt x="4896" y="0"/>
                  </a:lnTo>
                  <a:lnTo>
                    <a:pt x="4900" y="2"/>
                  </a:lnTo>
                  <a:lnTo>
                    <a:pt x="4905" y="10"/>
                  </a:lnTo>
                  <a:lnTo>
                    <a:pt x="4910" y="21"/>
                  </a:lnTo>
                  <a:lnTo>
                    <a:pt x="4915" y="31"/>
                  </a:lnTo>
                </a:path>
              </a:pathLst>
            </a:cu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188" name="Freeform 388"/>
            <p:cNvSpPr>
              <a:spLocks/>
            </p:cNvSpPr>
            <p:nvPr/>
          </p:nvSpPr>
          <p:spPr bwMode="auto">
            <a:xfrm>
              <a:off x="7668458" y="3472294"/>
              <a:ext cx="2022764" cy="93683"/>
            </a:xfrm>
            <a:custGeom>
              <a:avLst/>
              <a:gdLst>
                <a:gd name="T0" fmla="*/ 34 w 2211"/>
                <a:gd name="T1" fmla="*/ 55 h 103"/>
                <a:gd name="T2" fmla="*/ 72 w 2211"/>
                <a:gd name="T3" fmla="*/ 70 h 103"/>
                <a:gd name="T4" fmla="*/ 110 w 2211"/>
                <a:gd name="T5" fmla="*/ 61 h 103"/>
                <a:gd name="T6" fmla="*/ 149 w 2211"/>
                <a:gd name="T7" fmla="*/ 26 h 103"/>
                <a:gd name="T8" fmla="*/ 187 w 2211"/>
                <a:gd name="T9" fmla="*/ 58 h 103"/>
                <a:gd name="T10" fmla="*/ 226 w 2211"/>
                <a:gd name="T11" fmla="*/ 69 h 103"/>
                <a:gd name="T12" fmla="*/ 264 w 2211"/>
                <a:gd name="T13" fmla="*/ 81 h 103"/>
                <a:gd name="T14" fmla="*/ 303 w 2211"/>
                <a:gd name="T15" fmla="*/ 91 h 103"/>
                <a:gd name="T16" fmla="*/ 341 w 2211"/>
                <a:gd name="T17" fmla="*/ 95 h 103"/>
                <a:gd name="T18" fmla="*/ 379 w 2211"/>
                <a:gd name="T19" fmla="*/ 96 h 103"/>
                <a:gd name="T20" fmla="*/ 418 w 2211"/>
                <a:gd name="T21" fmla="*/ 100 h 103"/>
                <a:gd name="T22" fmla="*/ 456 w 2211"/>
                <a:gd name="T23" fmla="*/ 100 h 103"/>
                <a:gd name="T24" fmla="*/ 495 w 2211"/>
                <a:gd name="T25" fmla="*/ 88 h 103"/>
                <a:gd name="T26" fmla="*/ 533 w 2211"/>
                <a:gd name="T27" fmla="*/ 84 h 103"/>
                <a:gd name="T28" fmla="*/ 572 w 2211"/>
                <a:gd name="T29" fmla="*/ 91 h 103"/>
                <a:gd name="T30" fmla="*/ 610 w 2211"/>
                <a:gd name="T31" fmla="*/ 97 h 103"/>
                <a:gd name="T32" fmla="*/ 649 w 2211"/>
                <a:gd name="T33" fmla="*/ 99 h 103"/>
                <a:gd name="T34" fmla="*/ 687 w 2211"/>
                <a:gd name="T35" fmla="*/ 96 h 103"/>
                <a:gd name="T36" fmla="*/ 725 w 2211"/>
                <a:gd name="T37" fmla="*/ 101 h 103"/>
                <a:gd name="T38" fmla="*/ 764 w 2211"/>
                <a:gd name="T39" fmla="*/ 99 h 103"/>
                <a:gd name="T40" fmla="*/ 802 w 2211"/>
                <a:gd name="T41" fmla="*/ 95 h 103"/>
                <a:gd name="T42" fmla="*/ 841 w 2211"/>
                <a:gd name="T43" fmla="*/ 92 h 103"/>
                <a:gd name="T44" fmla="*/ 879 w 2211"/>
                <a:gd name="T45" fmla="*/ 91 h 103"/>
                <a:gd name="T46" fmla="*/ 917 w 2211"/>
                <a:gd name="T47" fmla="*/ 94 h 103"/>
                <a:gd name="T48" fmla="*/ 956 w 2211"/>
                <a:gd name="T49" fmla="*/ 94 h 103"/>
                <a:gd name="T50" fmla="*/ 994 w 2211"/>
                <a:gd name="T51" fmla="*/ 89 h 103"/>
                <a:gd name="T52" fmla="*/ 1033 w 2211"/>
                <a:gd name="T53" fmla="*/ 84 h 103"/>
                <a:gd name="T54" fmla="*/ 1071 w 2211"/>
                <a:gd name="T55" fmla="*/ 89 h 103"/>
                <a:gd name="T56" fmla="*/ 1110 w 2211"/>
                <a:gd name="T57" fmla="*/ 94 h 103"/>
                <a:gd name="T58" fmla="*/ 1148 w 2211"/>
                <a:gd name="T59" fmla="*/ 93 h 103"/>
                <a:gd name="T60" fmla="*/ 1186 w 2211"/>
                <a:gd name="T61" fmla="*/ 91 h 103"/>
                <a:gd name="T62" fmla="*/ 1225 w 2211"/>
                <a:gd name="T63" fmla="*/ 95 h 103"/>
                <a:gd name="T64" fmla="*/ 1264 w 2211"/>
                <a:gd name="T65" fmla="*/ 94 h 103"/>
                <a:gd name="T66" fmla="*/ 1302 w 2211"/>
                <a:gd name="T67" fmla="*/ 92 h 103"/>
                <a:gd name="T68" fmla="*/ 1340 w 2211"/>
                <a:gd name="T69" fmla="*/ 99 h 103"/>
                <a:gd name="T70" fmla="*/ 1379 w 2211"/>
                <a:gd name="T71" fmla="*/ 100 h 103"/>
                <a:gd name="T72" fmla="*/ 1417 w 2211"/>
                <a:gd name="T73" fmla="*/ 100 h 103"/>
                <a:gd name="T74" fmla="*/ 1456 w 2211"/>
                <a:gd name="T75" fmla="*/ 101 h 103"/>
                <a:gd name="T76" fmla="*/ 1494 w 2211"/>
                <a:gd name="T77" fmla="*/ 102 h 103"/>
                <a:gd name="T78" fmla="*/ 1532 w 2211"/>
                <a:gd name="T79" fmla="*/ 99 h 103"/>
                <a:gd name="T80" fmla="*/ 1571 w 2211"/>
                <a:gd name="T81" fmla="*/ 99 h 103"/>
                <a:gd name="T82" fmla="*/ 1609 w 2211"/>
                <a:gd name="T83" fmla="*/ 101 h 103"/>
                <a:gd name="T84" fmla="*/ 1648 w 2211"/>
                <a:gd name="T85" fmla="*/ 95 h 103"/>
                <a:gd name="T86" fmla="*/ 1686 w 2211"/>
                <a:gd name="T87" fmla="*/ 98 h 103"/>
                <a:gd name="T88" fmla="*/ 1725 w 2211"/>
                <a:gd name="T89" fmla="*/ 99 h 103"/>
                <a:gd name="T90" fmla="*/ 1763 w 2211"/>
                <a:gd name="T91" fmla="*/ 95 h 103"/>
                <a:gd name="T92" fmla="*/ 1801 w 2211"/>
                <a:gd name="T93" fmla="*/ 96 h 103"/>
                <a:gd name="T94" fmla="*/ 1840 w 2211"/>
                <a:gd name="T95" fmla="*/ 97 h 103"/>
                <a:gd name="T96" fmla="*/ 1878 w 2211"/>
                <a:gd name="T97" fmla="*/ 99 h 103"/>
                <a:gd name="T98" fmla="*/ 1917 w 2211"/>
                <a:gd name="T99" fmla="*/ 97 h 103"/>
                <a:gd name="T100" fmla="*/ 1955 w 2211"/>
                <a:gd name="T101" fmla="*/ 98 h 103"/>
                <a:gd name="T102" fmla="*/ 1994 w 2211"/>
                <a:gd name="T103" fmla="*/ 98 h 103"/>
                <a:gd name="T104" fmla="*/ 2032 w 2211"/>
                <a:gd name="T105" fmla="*/ 98 h 103"/>
                <a:gd name="T106" fmla="*/ 2071 w 2211"/>
                <a:gd name="T107" fmla="*/ 98 h 103"/>
                <a:gd name="T108" fmla="*/ 2109 w 2211"/>
                <a:gd name="T109" fmla="*/ 98 h 103"/>
                <a:gd name="T110" fmla="*/ 2147 w 2211"/>
                <a:gd name="T111" fmla="*/ 98 h 103"/>
                <a:gd name="T112" fmla="*/ 2186 w 2211"/>
                <a:gd name="T113" fmla="*/ 97 h 1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2211" h="103">
                  <a:moveTo>
                    <a:pt x="0" y="0"/>
                  </a:moveTo>
                  <a:lnTo>
                    <a:pt x="5" y="11"/>
                  </a:lnTo>
                  <a:lnTo>
                    <a:pt x="10" y="22"/>
                  </a:lnTo>
                  <a:lnTo>
                    <a:pt x="14" y="30"/>
                  </a:lnTo>
                  <a:lnTo>
                    <a:pt x="19" y="40"/>
                  </a:lnTo>
                  <a:lnTo>
                    <a:pt x="24" y="45"/>
                  </a:lnTo>
                  <a:lnTo>
                    <a:pt x="29" y="56"/>
                  </a:lnTo>
                  <a:lnTo>
                    <a:pt x="34" y="55"/>
                  </a:lnTo>
                  <a:lnTo>
                    <a:pt x="38" y="62"/>
                  </a:lnTo>
                  <a:lnTo>
                    <a:pt x="43" y="65"/>
                  </a:lnTo>
                  <a:lnTo>
                    <a:pt x="48" y="68"/>
                  </a:lnTo>
                  <a:lnTo>
                    <a:pt x="53" y="68"/>
                  </a:lnTo>
                  <a:lnTo>
                    <a:pt x="58" y="69"/>
                  </a:lnTo>
                  <a:lnTo>
                    <a:pt x="63" y="70"/>
                  </a:lnTo>
                  <a:lnTo>
                    <a:pt x="67" y="70"/>
                  </a:lnTo>
                  <a:lnTo>
                    <a:pt x="72" y="70"/>
                  </a:lnTo>
                  <a:lnTo>
                    <a:pt x="77" y="70"/>
                  </a:lnTo>
                  <a:lnTo>
                    <a:pt x="82" y="72"/>
                  </a:lnTo>
                  <a:lnTo>
                    <a:pt x="87" y="70"/>
                  </a:lnTo>
                  <a:lnTo>
                    <a:pt x="91" y="69"/>
                  </a:lnTo>
                  <a:lnTo>
                    <a:pt x="96" y="67"/>
                  </a:lnTo>
                  <a:lnTo>
                    <a:pt x="101" y="66"/>
                  </a:lnTo>
                  <a:lnTo>
                    <a:pt x="106" y="64"/>
                  </a:lnTo>
                  <a:lnTo>
                    <a:pt x="110" y="61"/>
                  </a:lnTo>
                  <a:lnTo>
                    <a:pt x="115" y="57"/>
                  </a:lnTo>
                  <a:lnTo>
                    <a:pt x="120" y="54"/>
                  </a:lnTo>
                  <a:lnTo>
                    <a:pt x="125" y="47"/>
                  </a:lnTo>
                  <a:lnTo>
                    <a:pt x="130" y="41"/>
                  </a:lnTo>
                  <a:lnTo>
                    <a:pt x="134" y="34"/>
                  </a:lnTo>
                  <a:lnTo>
                    <a:pt x="139" y="33"/>
                  </a:lnTo>
                  <a:lnTo>
                    <a:pt x="144" y="30"/>
                  </a:lnTo>
                  <a:lnTo>
                    <a:pt x="149" y="26"/>
                  </a:lnTo>
                  <a:lnTo>
                    <a:pt x="154" y="28"/>
                  </a:lnTo>
                  <a:lnTo>
                    <a:pt x="158" y="28"/>
                  </a:lnTo>
                  <a:lnTo>
                    <a:pt x="163" y="34"/>
                  </a:lnTo>
                  <a:lnTo>
                    <a:pt x="168" y="41"/>
                  </a:lnTo>
                  <a:lnTo>
                    <a:pt x="173" y="45"/>
                  </a:lnTo>
                  <a:lnTo>
                    <a:pt x="178" y="48"/>
                  </a:lnTo>
                  <a:lnTo>
                    <a:pt x="182" y="52"/>
                  </a:lnTo>
                  <a:lnTo>
                    <a:pt x="187" y="58"/>
                  </a:lnTo>
                  <a:lnTo>
                    <a:pt x="192" y="60"/>
                  </a:lnTo>
                  <a:lnTo>
                    <a:pt x="197" y="67"/>
                  </a:lnTo>
                  <a:lnTo>
                    <a:pt x="202" y="70"/>
                  </a:lnTo>
                  <a:lnTo>
                    <a:pt x="206" y="71"/>
                  </a:lnTo>
                  <a:lnTo>
                    <a:pt x="211" y="72"/>
                  </a:lnTo>
                  <a:lnTo>
                    <a:pt x="216" y="72"/>
                  </a:lnTo>
                  <a:lnTo>
                    <a:pt x="221" y="69"/>
                  </a:lnTo>
                  <a:lnTo>
                    <a:pt x="226" y="69"/>
                  </a:lnTo>
                  <a:lnTo>
                    <a:pt x="231" y="70"/>
                  </a:lnTo>
                  <a:lnTo>
                    <a:pt x="235" y="71"/>
                  </a:lnTo>
                  <a:lnTo>
                    <a:pt x="240" y="72"/>
                  </a:lnTo>
                  <a:lnTo>
                    <a:pt x="245" y="77"/>
                  </a:lnTo>
                  <a:lnTo>
                    <a:pt x="250" y="76"/>
                  </a:lnTo>
                  <a:lnTo>
                    <a:pt x="255" y="79"/>
                  </a:lnTo>
                  <a:lnTo>
                    <a:pt x="259" y="78"/>
                  </a:lnTo>
                  <a:lnTo>
                    <a:pt x="264" y="81"/>
                  </a:lnTo>
                  <a:lnTo>
                    <a:pt x="269" y="82"/>
                  </a:lnTo>
                  <a:lnTo>
                    <a:pt x="274" y="84"/>
                  </a:lnTo>
                  <a:lnTo>
                    <a:pt x="279" y="87"/>
                  </a:lnTo>
                  <a:lnTo>
                    <a:pt x="284" y="89"/>
                  </a:lnTo>
                  <a:lnTo>
                    <a:pt x="288" y="90"/>
                  </a:lnTo>
                  <a:lnTo>
                    <a:pt x="293" y="88"/>
                  </a:lnTo>
                  <a:lnTo>
                    <a:pt x="298" y="92"/>
                  </a:lnTo>
                  <a:lnTo>
                    <a:pt x="303" y="91"/>
                  </a:lnTo>
                  <a:lnTo>
                    <a:pt x="307" y="90"/>
                  </a:lnTo>
                  <a:lnTo>
                    <a:pt x="312" y="94"/>
                  </a:lnTo>
                  <a:lnTo>
                    <a:pt x="317" y="91"/>
                  </a:lnTo>
                  <a:lnTo>
                    <a:pt x="322" y="96"/>
                  </a:lnTo>
                  <a:lnTo>
                    <a:pt x="327" y="95"/>
                  </a:lnTo>
                  <a:lnTo>
                    <a:pt x="331" y="94"/>
                  </a:lnTo>
                  <a:lnTo>
                    <a:pt x="336" y="95"/>
                  </a:lnTo>
                  <a:lnTo>
                    <a:pt x="341" y="95"/>
                  </a:lnTo>
                  <a:lnTo>
                    <a:pt x="346" y="96"/>
                  </a:lnTo>
                  <a:lnTo>
                    <a:pt x="350" y="96"/>
                  </a:lnTo>
                  <a:lnTo>
                    <a:pt x="355" y="94"/>
                  </a:lnTo>
                  <a:lnTo>
                    <a:pt x="360" y="95"/>
                  </a:lnTo>
                  <a:lnTo>
                    <a:pt x="365" y="97"/>
                  </a:lnTo>
                  <a:lnTo>
                    <a:pt x="370" y="97"/>
                  </a:lnTo>
                  <a:lnTo>
                    <a:pt x="375" y="96"/>
                  </a:lnTo>
                  <a:lnTo>
                    <a:pt x="379" y="96"/>
                  </a:lnTo>
                  <a:lnTo>
                    <a:pt x="384" y="99"/>
                  </a:lnTo>
                  <a:lnTo>
                    <a:pt x="389" y="99"/>
                  </a:lnTo>
                  <a:lnTo>
                    <a:pt x="394" y="99"/>
                  </a:lnTo>
                  <a:lnTo>
                    <a:pt x="399" y="100"/>
                  </a:lnTo>
                  <a:lnTo>
                    <a:pt x="403" y="99"/>
                  </a:lnTo>
                  <a:lnTo>
                    <a:pt x="408" y="99"/>
                  </a:lnTo>
                  <a:lnTo>
                    <a:pt x="413" y="99"/>
                  </a:lnTo>
                  <a:lnTo>
                    <a:pt x="418" y="100"/>
                  </a:lnTo>
                  <a:lnTo>
                    <a:pt x="423" y="100"/>
                  </a:lnTo>
                  <a:lnTo>
                    <a:pt x="428" y="99"/>
                  </a:lnTo>
                  <a:lnTo>
                    <a:pt x="432" y="101"/>
                  </a:lnTo>
                  <a:lnTo>
                    <a:pt x="437" y="100"/>
                  </a:lnTo>
                  <a:lnTo>
                    <a:pt x="442" y="101"/>
                  </a:lnTo>
                  <a:lnTo>
                    <a:pt x="447" y="102"/>
                  </a:lnTo>
                  <a:lnTo>
                    <a:pt x="452" y="99"/>
                  </a:lnTo>
                  <a:lnTo>
                    <a:pt x="456" y="100"/>
                  </a:lnTo>
                  <a:lnTo>
                    <a:pt x="461" y="99"/>
                  </a:lnTo>
                  <a:lnTo>
                    <a:pt x="466" y="100"/>
                  </a:lnTo>
                  <a:lnTo>
                    <a:pt x="471" y="95"/>
                  </a:lnTo>
                  <a:lnTo>
                    <a:pt x="476" y="96"/>
                  </a:lnTo>
                  <a:lnTo>
                    <a:pt x="481" y="92"/>
                  </a:lnTo>
                  <a:lnTo>
                    <a:pt x="485" y="93"/>
                  </a:lnTo>
                  <a:lnTo>
                    <a:pt x="490" y="88"/>
                  </a:lnTo>
                  <a:lnTo>
                    <a:pt x="495" y="88"/>
                  </a:lnTo>
                  <a:lnTo>
                    <a:pt x="500" y="87"/>
                  </a:lnTo>
                  <a:lnTo>
                    <a:pt x="504" y="87"/>
                  </a:lnTo>
                  <a:lnTo>
                    <a:pt x="509" y="80"/>
                  </a:lnTo>
                  <a:lnTo>
                    <a:pt x="514" y="83"/>
                  </a:lnTo>
                  <a:lnTo>
                    <a:pt x="519" y="82"/>
                  </a:lnTo>
                  <a:lnTo>
                    <a:pt x="524" y="82"/>
                  </a:lnTo>
                  <a:lnTo>
                    <a:pt x="528" y="83"/>
                  </a:lnTo>
                  <a:lnTo>
                    <a:pt x="533" y="84"/>
                  </a:lnTo>
                  <a:lnTo>
                    <a:pt x="538" y="84"/>
                  </a:lnTo>
                  <a:lnTo>
                    <a:pt x="543" y="86"/>
                  </a:lnTo>
                  <a:lnTo>
                    <a:pt x="547" y="88"/>
                  </a:lnTo>
                  <a:lnTo>
                    <a:pt x="552" y="86"/>
                  </a:lnTo>
                  <a:lnTo>
                    <a:pt x="557" y="87"/>
                  </a:lnTo>
                  <a:lnTo>
                    <a:pt x="562" y="87"/>
                  </a:lnTo>
                  <a:lnTo>
                    <a:pt x="567" y="89"/>
                  </a:lnTo>
                  <a:lnTo>
                    <a:pt x="572" y="91"/>
                  </a:lnTo>
                  <a:lnTo>
                    <a:pt x="576" y="90"/>
                  </a:lnTo>
                  <a:lnTo>
                    <a:pt x="581" y="91"/>
                  </a:lnTo>
                  <a:lnTo>
                    <a:pt x="586" y="93"/>
                  </a:lnTo>
                  <a:lnTo>
                    <a:pt x="591" y="95"/>
                  </a:lnTo>
                  <a:lnTo>
                    <a:pt x="596" y="94"/>
                  </a:lnTo>
                  <a:lnTo>
                    <a:pt x="600" y="95"/>
                  </a:lnTo>
                  <a:lnTo>
                    <a:pt x="605" y="96"/>
                  </a:lnTo>
                  <a:lnTo>
                    <a:pt x="610" y="97"/>
                  </a:lnTo>
                  <a:lnTo>
                    <a:pt x="615" y="96"/>
                  </a:lnTo>
                  <a:lnTo>
                    <a:pt x="620" y="96"/>
                  </a:lnTo>
                  <a:lnTo>
                    <a:pt x="624" y="97"/>
                  </a:lnTo>
                  <a:lnTo>
                    <a:pt x="629" y="96"/>
                  </a:lnTo>
                  <a:lnTo>
                    <a:pt x="634" y="97"/>
                  </a:lnTo>
                  <a:lnTo>
                    <a:pt x="639" y="99"/>
                  </a:lnTo>
                  <a:lnTo>
                    <a:pt x="644" y="97"/>
                  </a:lnTo>
                  <a:lnTo>
                    <a:pt x="649" y="99"/>
                  </a:lnTo>
                  <a:lnTo>
                    <a:pt x="653" y="100"/>
                  </a:lnTo>
                  <a:lnTo>
                    <a:pt x="658" y="98"/>
                  </a:lnTo>
                  <a:lnTo>
                    <a:pt x="663" y="98"/>
                  </a:lnTo>
                  <a:lnTo>
                    <a:pt x="668" y="97"/>
                  </a:lnTo>
                  <a:lnTo>
                    <a:pt x="673" y="100"/>
                  </a:lnTo>
                  <a:lnTo>
                    <a:pt x="677" y="96"/>
                  </a:lnTo>
                  <a:lnTo>
                    <a:pt x="682" y="98"/>
                  </a:lnTo>
                  <a:lnTo>
                    <a:pt x="687" y="96"/>
                  </a:lnTo>
                  <a:lnTo>
                    <a:pt x="692" y="94"/>
                  </a:lnTo>
                  <a:lnTo>
                    <a:pt x="697" y="97"/>
                  </a:lnTo>
                  <a:lnTo>
                    <a:pt x="701" y="98"/>
                  </a:lnTo>
                  <a:lnTo>
                    <a:pt x="706" y="96"/>
                  </a:lnTo>
                  <a:lnTo>
                    <a:pt x="711" y="98"/>
                  </a:lnTo>
                  <a:lnTo>
                    <a:pt x="716" y="97"/>
                  </a:lnTo>
                  <a:lnTo>
                    <a:pt x="720" y="98"/>
                  </a:lnTo>
                  <a:lnTo>
                    <a:pt x="725" y="101"/>
                  </a:lnTo>
                  <a:lnTo>
                    <a:pt x="730" y="100"/>
                  </a:lnTo>
                  <a:lnTo>
                    <a:pt x="735" y="99"/>
                  </a:lnTo>
                  <a:lnTo>
                    <a:pt x="740" y="98"/>
                  </a:lnTo>
                  <a:lnTo>
                    <a:pt x="744" y="98"/>
                  </a:lnTo>
                  <a:lnTo>
                    <a:pt x="749" y="98"/>
                  </a:lnTo>
                  <a:lnTo>
                    <a:pt x="754" y="96"/>
                  </a:lnTo>
                  <a:lnTo>
                    <a:pt x="759" y="99"/>
                  </a:lnTo>
                  <a:lnTo>
                    <a:pt x="764" y="99"/>
                  </a:lnTo>
                  <a:lnTo>
                    <a:pt x="768" y="99"/>
                  </a:lnTo>
                  <a:lnTo>
                    <a:pt x="773" y="96"/>
                  </a:lnTo>
                  <a:lnTo>
                    <a:pt x="778" y="95"/>
                  </a:lnTo>
                  <a:lnTo>
                    <a:pt x="783" y="96"/>
                  </a:lnTo>
                  <a:lnTo>
                    <a:pt x="788" y="94"/>
                  </a:lnTo>
                  <a:lnTo>
                    <a:pt x="793" y="92"/>
                  </a:lnTo>
                  <a:lnTo>
                    <a:pt x="797" y="94"/>
                  </a:lnTo>
                  <a:lnTo>
                    <a:pt x="802" y="95"/>
                  </a:lnTo>
                  <a:lnTo>
                    <a:pt x="807" y="94"/>
                  </a:lnTo>
                  <a:lnTo>
                    <a:pt x="812" y="92"/>
                  </a:lnTo>
                  <a:lnTo>
                    <a:pt x="817" y="94"/>
                  </a:lnTo>
                  <a:lnTo>
                    <a:pt x="821" y="95"/>
                  </a:lnTo>
                  <a:lnTo>
                    <a:pt x="826" y="89"/>
                  </a:lnTo>
                  <a:lnTo>
                    <a:pt x="831" y="91"/>
                  </a:lnTo>
                  <a:lnTo>
                    <a:pt x="836" y="93"/>
                  </a:lnTo>
                  <a:lnTo>
                    <a:pt x="841" y="92"/>
                  </a:lnTo>
                  <a:lnTo>
                    <a:pt x="846" y="94"/>
                  </a:lnTo>
                  <a:lnTo>
                    <a:pt x="850" y="92"/>
                  </a:lnTo>
                  <a:lnTo>
                    <a:pt x="855" y="90"/>
                  </a:lnTo>
                  <a:lnTo>
                    <a:pt x="860" y="90"/>
                  </a:lnTo>
                  <a:lnTo>
                    <a:pt x="865" y="91"/>
                  </a:lnTo>
                  <a:lnTo>
                    <a:pt x="870" y="94"/>
                  </a:lnTo>
                  <a:lnTo>
                    <a:pt x="874" y="91"/>
                  </a:lnTo>
                  <a:lnTo>
                    <a:pt x="879" y="91"/>
                  </a:lnTo>
                  <a:lnTo>
                    <a:pt x="884" y="93"/>
                  </a:lnTo>
                  <a:lnTo>
                    <a:pt x="889" y="92"/>
                  </a:lnTo>
                  <a:lnTo>
                    <a:pt x="894" y="91"/>
                  </a:lnTo>
                  <a:lnTo>
                    <a:pt x="898" y="93"/>
                  </a:lnTo>
                  <a:lnTo>
                    <a:pt x="903" y="93"/>
                  </a:lnTo>
                  <a:lnTo>
                    <a:pt x="908" y="93"/>
                  </a:lnTo>
                  <a:lnTo>
                    <a:pt x="913" y="94"/>
                  </a:lnTo>
                  <a:lnTo>
                    <a:pt x="917" y="94"/>
                  </a:lnTo>
                  <a:lnTo>
                    <a:pt x="922" y="92"/>
                  </a:lnTo>
                  <a:lnTo>
                    <a:pt x="927" y="94"/>
                  </a:lnTo>
                  <a:lnTo>
                    <a:pt x="932" y="94"/>
                  </a:lnTo>
                  <a:lnTo>
                    <a:pt x="937" y="94"/>
                  </a:lnTo>
                  <a:lnTo>
                    <a:pt x="941" y="93"/>
                  </a:lnTo>
                  <a:lnTo>
                    <a:pt x="946" y="94"/>
                  </a:lnTo>
                  <a:lnTo>
                    <a:pt x="951" y="95"/>
                  </a:lnTo>
                  <a:lnTo>
                    <a:pt x="956" y="94"/>
                  </a:lnTo>
                  <a:lnTo>
                    <a:pt x="961" y="95"/>
                  </a:lnTo>
                  <a:lnTo>
                    <a:pt x="965" y="94"/>
                  </a:lnTo>
                  <a:lnTo>
                    <a:pt x="970" y="95"/>
                  </a:lnTo>
                  <a:lnTo>
                    <a:pt x="975" y="94"/>
                  </a:lnTo>
                  <a:lnTo>
                    <a:pt x="980" y="93"/>
                  </a:lnTo>
                  <a:lnTo>
                    <a:pt x="985" y="92"/>
                  </a:lnTo>
                  <a:lnTo>
                    <a:pt x="989" y="90"/>
                  </a:lnTo>
                  <a:lnTo>
                    <a:pt x="994" y="89"/>
                  </a:lnTo>
                  <a:lnTo>
                    <a:pt x="999" y="88"/>
                  </a:lnTo>
                  <a:lnTo>
                    <a:pt x="1004" y="86"/>
                  </a:lnTo>
                  <a:lnTo>
                    <a:pt x="1009" y="85"/>
                  </a:lnTo>
                  <a:lnTo>
                    <a:pt x="1014" y="84"/>
                  </a:lnTo>
                  <a:lnTo>
                    <a:pt x="1018" y="84"/>
                  </a:lnTo>
                  <a:lnTo>
                    <a:pt x="1023" y="84"/>
                  </a:lnTo>
                  <a:lnTo>
                    <a:pt x="1028" y="85"/>
                  </a:lnTo>
                  <a:lnTo>
                    <a:pt x="1033" y="84"/>
                  </a:lnTo>
                  <a:lnTo>
                    <a:pt x="1038" y="83"/>
                  </a:lnTo>
                  <a:lnTo>
                    <a:pt x="1042" y="85"/>
                  </a:lnTo>
                  <a:lnTo>
                    <a:pt x="1047" y="85"/>
                  </a:lnTo>
                  <a:lnTo>
                    <a:pt x="1052" y="85"/>
                  </a:lnTo>
                  <a:lnTo>
                    <a:pt x="1057" y="85"/>
                  </a:lnTo>
                  <a:lnTo>
                    <a:pt x="1062" y="87"/>
                  </a:lnTo>
                  <a:lnTo>
                    <a:pt x="1067" y="89"/>
                  </a:lnTo>
                  <a:lnTo>
                    <a:pt x="1071" y="89"/>
                  </a:lnTo>
                  <a:lnTo>
                    <a:pt x="1076" y="89"/>
                  </a:lnTo>
                  <a:lnTo>
                    <a:pt x="1081" y="90"/>
                  </a:lnTo>
                  <a:lnTo>
                    <a:pt x="1086" y="88"/>
                  </a:lnTo>
                  <a:lnTo>
                    <a:pt x="1091" y="91"/>
                  </a:lnTo>
                  <a:lnTo>
                    <a:pt x="1095" y="91"/>
                  </a:lnTo>
                  <a:lnTo>
                    <a:pt x="1100" y="93"/>
                  </a:lnTo>
                  <a:lnTo>
                    <a:pt x="1105" y="91"/>
                  </a:lnTo>
                  <a:lnTo>
                    <a:pt x="1110" y="94"/>
                  </a:lnTo>
                  <a:lnTo>
                    <a:pt x="1114" y="93"/>
                  </a:lnTo>
                  <a:lnTo>
                    <a:pt x="1119" y="93"/>
                  </a:lnTo>
                  <a:lnTo>
                    <a:pt x="1124" y="93"/>
                  </a:lnTo>
                  <a:lnTo>
                    <a:pt x="1129" y="94"/>
                  </a:lnTo>
                  <a:lnTo>
                    <a:pt x="1134" y="94"/>
                  </a:lnTo>
                  <a:lnTo>
                    <a:pt x="1138" y="93"/>
                  </a:lnTo>
                  <a:lnTo>
                    <a:pt x="1143" y="93"/>
                  </a:lnTo>
                  <a:lnTo>
                    <a:pt x="1148" y="93"/>
                  </a:lnTo>
                  <a:lnTo>
                    <a:pt x="1153" y="95"/>
                  </a:lnTo>
                  <a:lnTo>
                    <a:pt x="1158" y="95"/>
                  </a:lnTo>
                  <a:lnTo>
                    <a:pt x="1162" y="93"/>
                  </a:lnTo>
                  <a:lnTo>
                    <a:pt x="1167" y="94"/>
                  </a:lnTo>
                  <a:lnTo>
                    <a:pt x="1172" y="94"/>
                  </a:lnTo>
                  <a:lnTo>
                    <a:pt x="1177" y="91"/>
                  </a:lnTo>
                  <a:lnTo>
                    <a:pt x="1182" y="93"/>
                  </a:lnTo>
                  <a:lnTo>
                    <a:pt x="1186" y="91"/>
                  </a:lnTo>
                  <a:lnTo>
                    <a:pt x="1191" y="95"/>
                  </a:lnTo>
                  <a:lnTo>
                    <a:pt x="1196" y="94"/>
                  </a:lnTo>
                  <a:lnTo>
                    <a:pt x="1201" y="94"/>
                  </a:lnTo>
                  <a:lnTo>
                    <a:pt x="1206" y="93"/>
                  </a:lnTo>
                  <a:lnTo>
                    <a:pt x="1211" y="93"/>
                  </a:lnTo>
                  <a:lnTo>
                    <a:pt x="1215" y="94"/>
                  </a:lnTo>
                  <a:lnTo>
                    <a:pt x="1220" y="95"/>
                  </a:lnTo>
                  <a:lnTo>
                    <a:pt x="1225" y="95"/>
                  </a:lnTo>
                  <a:lnTo>
                    <a:pt x="1230" y="93"/>
                  </a:lnTo>
                  <a:lnTo>
                    <a:pt x="1235" y="95"/>
                  </a:lnTo>
                  <a:lnTo>
                    <a:pt x="1239" y="93"/>
                  </a:lnTo>
                  <a:lnTo>
                    <a:pt x="1244" y="94"/>
                  </a:lnTo>
                  <a:lnTo>
                    <a:pt x="1249" y="94"/>
                  </a:lnTo>
                  <a:lnTo>
                    <a:pt x="1254" y="94"/>
                  </a:lnTo>
                  <a:lnTo>
                    <a:pt x="1259" y="95"/>
                  </a:lnTo>
                  <a:lnTo>
                    <a:pt x="1264" y="94"/>
                  </a:lnTo>
                  <a:lnTo>
                    <a:pt x="1268" y="92"/>
                  </a:lnTo>
                  <a:lnTo>
                    <a:pt x="1273" y="94"/>
                  </a:lnTo>
                  <a:lnTo>
                    <a:pt x="1278" y="93"/>
                  </a:lnTo>
                  <a:lnTo>
                    <a:pt x="1283" y="94"/>
                  </a:lnTo>
                  <a:lnTo>
                    <a:pt x="1288" y="94"/>
                  </a:lnTo>
                  <a:lnTo>
                    <a:pt x="1292" y="93"/>
                  </a:lnTo>
                  <a:lnTo>
                    <a:pt x="1297" y="95"/>
                  </a:lnTo>
                  <a:lnTo>
                    <a:pt x="1302" y="92"/>
                  </a:lnTo>
                  <a:lnTo>
                    <a:pt x="1307" y="94"/>
                  </a:lnTo>
                  <a:lnTo>
                    <a:pt x="1311" y="96"/>
                  </a:lnTo>
                  <a:lnTo>
                    <a:pt x="1316" y="96"/>
                  </a:lnTo>
                  <a:lnTo>
                    <a:pt x="1321" y="96"/>
                  </a:lnTo>
                  <a:lnTo>
                    <a:pt x="1326" y="95"/>
                  </a:lnTo>
                  <a:lnTo>
                    <a:pt x="1331" y="97"/>
                  </a:lnTo>
                  <a:lnTo>
                    <a:pt x="1335" y="100"/>
                  </a:lnTo>
                  <a:lnTo>
                    <a:pt x="1340" y="99"/>
                  </a:lnTo>
                  <a:lnTo>
                    <a:pt x="1345" y="99"/>
                  </a:lnTo>
                  <a:lnTo>
                    <a:pt x="1350" y="99"/>
                  </a:lnTo>
                  <a:lnTo>
                    <a:pt x="1355" y="99"/>
                  </a:lnTo>
                  <a:lnTo>
                    <a:pt x="1359" y="100"/>
                  </a:lnTo>
                  <a:lnTo>
                    <a:pt x="1364" y="101"/>
                  </a:lnTo>
                  <a:lnTo>
                    <a:pt x="1369" y="100"/>
                  </a:lnTo>
                  <a:lnTo>
                    <a:pt x="1374" y="99"/>
                  </a:lnTo>
                  <a:lnTo>
                    <a:pt x="1379" y="100"/>
                  </a:lnTo>
                  <a:lnTo>
                    <a:pt x="1383" y="101"/>
                  </a:lnTo>
                  <a:lnTo>
                    <a:pt x="1388" y="101"/>
                  </a:lnTo>
                  <a:lnTo>
                    <a:pt x="1393" y="103"/>
                  </a:lnTo>
                  <a:lnTo>
                    <a:pt x="1398" y="99"/>
                  </a:lnTo>
                  <a:lnTo>
                    <a:pt x="1403" y="100"/>
                  </a:lnTo>
                  <a:lnTo>
                    <a:pt x="1407" y="100"/>
                  </a:lnTo>
                  <a:lnTo>
                    <a:pt x="1412" y="101"/>
                  </a:lnTo>
                  <a:lnTo>
                    <a:pt x="1417" y="100"/>
                  </a:lnTo>
                  <a:lnTo>
                    <a:pt x="1422" y="99"/>
                  </a:lnTo>
                  <a:lnTo>
                    <a:pt x="1427" y="98"/>
                  </a:lnTo>
                  <a:lnTo>
                    <a:pt x="1432" y="100"/>
                  </a:lnTo>
                  <a:lnTo>
                    <a:pt x="1436" y="102"/>
                  </a:lnTo>
                  <a:lnTo>
                    <a:pt x="1441" y="101"/>
                  </a:lnTo>
                  <a:lnTo>
                    <a:pt x="1446" y="99"/>
                  </a:lnTo>
                  <a:lnTo>
                    <a:pt x="1451" y="101"/>
                  </a:lnTo>
                  <a:lnTo>
                    <a:pt x="1456" y="101"/>
                  </a:lnTo>
                  <a:lnTo>
                    <a:pt x="1460" y="100"/>
                  </a:lnTo>
                  <a:lnTo>
                    <a:pt x="1465" y="102"/>
                  </a:lnTo>
                  <a:lnTo>
                    <a:pt x="1470" y="99"/>
                  </a:lnTo>
                  <a:lnTo>
                    <a:pt x="1475" y="100"/>
                  </a:lnTo>
                  <a:lnTo>
                    <a:pt x="1480" y="99"/>
                  </a:lnTo>
                  <a:lnTo>
                    <a:pt x="1485" y="100"/>
                  </a:lnTo>
                  <a:lnTo>
                    <a:pt x="1489" y="101"/>
                  </a:lnTo>
                  <a:lnTo>
                    <a:pt x="1494" y="102"/>
                  </a:lnTo>
                  <a:lnTo>
                    <a:pt x="1499" y="100"/>
                  </a:lnTo>
                  <a:lnTo>
                    <a:pt x="1504" y="100"/>
                  </a:lnTo>
                  <a:lnTo>
                    <a:pt x="1508" y="101"/>
                  </a:lnTo>
                  <a:lnTo>
                    <a:pt x="1513" y="102"/>
                  </a:lnTo>
                  <a:lnTo>
                    <a:pt x="1518" y="100"/>
                  </a:lnTo>
                  <a:lnTo>
                    <a:pt x="1523" y="98"/>
                  </a:lnTo>
                  <a:lnTo>
                    <a:pt x="1528" y="101"/>
                  </a:lnTo>
                  <a:lnTo>
                    <a:pt x="1532" y="99"/>
                  </a:lnTo>
                  <a:lnTo>
                    <a:pt x="1537" y="101"/>
                  </a:lnTo>
                  <a:lnTo>
                    <a:pt x="1542" y="100"/>
                  </a:lnTo>
                  <a:lnTo>
                    <a:pt x="1547" y="100"/>
                  </a:lnTo>
                  <a:lnTo>
                    <a:pt x="1551" y="100"/>
                  </a:lnTo>
                  <a:lnTo>
                    <a:pt x="1556" y="100"/>
                  </a:lnTo>
                  <a:lnTo>
                    <a:pt x="1561" y="103"/>
                  </a:lnTo>
                  <a:lnTo>
                    <a:pt x="1566" y="100"/>
                  </a:lnTo>
                  <a:lnTo>
                    <a:pt x="1571" y="99"/>
                  </a:lnTo>
                  <a:lnTo>
                    <a:pt x="1576" y="101"/>
                  </a:lnTo>
                  <a:lnTo>
                    <a:pt x="1580" y="99"/>
                  </a:lnTo>
                  <a:lnTo>
                    <a:pt x="1585" y="101"/>
                  </a:lnTo>
                  <a:lnTo>
                    <a:pt x="1590" y="100"/>
                  </a:lnTo>
                  <a:lnTo>
                    <a:pt x="1595" y="101"/>
                  </a:lnTo>
                  <a:lnTo>
                    <a:pt x="1600" y="98"/>
                  </a:lnTo>
                  <a:lnTo>
                    <a:pt x="1604" y="98"/>
                  </a:lnTo>
                  <a:lnTo>
                    <a:pt x="1609" y="101"/>
                  </a:lnTo>
                  <a:lnTo>
                    <a:pt x="1614" y="99"/>
                  </a:lnTo>
                  <a:lnTo>
                    <a:pt x="1619" y="101"/>
                  </a:lnTo>
                  <a:lnTo>
                    <a:pt x="1624" y="100"/>
                  </a:lnTo>
                  <a:lnTo>
                    <a:pt x="1629" y="98"/>
                  </a:lnTo>
                  <a:lnTo>
                    <a:pt x="1633" y="98"/>
                  </a:lnTo>
                  <a:lnTo>
                    <a:pt x="1638" y="97"/>
                  </a:lnTo>
                  <a:lnTo>
                    <a:pt x="1643" y="97"/>
                  </a:lnTo>
                  <a:lnTo>
                    <a:pt x="1648" y="95"/>
                  </a:lnTo>
                  <a:lnTo>
                    <a:pt x="1653" y="91"/>
                  </a:lnTo>
                  <a:lnTo>
                    <a:pt x="1657" y="88"/>
                  </a:lnTo>
                  <a:lnTo>
                    <a:pt x="1662" y="87"/>
                  </a:lnTo>
                  <a:lnTo>
                    <a:pt x="1667" y="90"/>
                  </a:lnTo>
                  <a:lnTo>
                    <a:pt x="1672" y="92"/>
                  </a:lnTo>
                  <a:lnTo>
                    <a:pt x="1677" y="94"/>
                  </a:lnTo>
                  <a:lnTo>
                    <a:pt x="1682" y="93"/>
                  </a:lnTo>
                  <a:lnTo>
                    <a:pt x="1686" y="98"/>
                  </a:lnTo>
                  <a:lnTo>
                    <a:pt x="1691" y="96"/>
                  </a:lnTo>
                  <a:lnTo>
                    <a:pt x="1696" y="97"/>
                  </a:lnTo>
                  <a:lnTo>
                    <a:pt x="1701" y="100"/>
                  </a:lnTo>
                  <a:lnTo>
                    <a:pt x="1705" y="99"/>
                  </a:lnTo>
                  <a:lnTo>
                    <a:pt x="1710" y="99"/>
                  </a:lnTo>
                  <a:lnTo>
                    <a:pt x="1715" y="98"/>
                  </a:lnTo>
                  <a:lnTo>
                    <a:pt x="1720" y="97"/>
                  </a:lnTo>
                  <a:lnTo>
                    <a:pt x="1725" y="99"/>
                  </a:lnTo>
                  <a:lnTo>
                    <a:pt x="1729" y="97"/>
                  </a:lnTo>
                  <a:lnTo>
                    <a:pt x="1734" y="100"/>
                  </a:lnTo>
                  <a:lnTo>
                    <a:pt x="1739" y="98"/>
                  </a:lnTo>
                  <a:lnTo>
                    <a:pt x="1744" y="100"/>
                  </a:lnTo>
                  <a:lnTo>
                    <a:pt x="1748" y="99"/>
                  </a:lnTo>
                  <a:lnTo>
                    <a:pt x="1753" y="99"/>
                  </a:lnTo>
                  <a:lnTo>
                    <a:pt x="1758" y="98"/>
                  </a:lnTo>
                  <a:lnTo>
                    <a:pt x="1763" y="95"/>
                  </a:lnTo>
                  <a:lnTo>
                    <a:pt x="1768" y="99"/>
                  </a:lnTo>
                  <a:lnTo>
                    <a:pt x="1773" y="99"/>
                  </a:lnTo>
                  <a:lnTo>
                    <a:pt x="1777" y="97"/>
                  </a:lnTo>
                  <a:lnTo>
                    <a:pt x="1782" y="100"/>
                  </a:lnTo>
                  <a:lnTo>
                    <a:pt x="1787" y="99"/>
                  </a:lnTo>
                  <a:lnTo>
                    <a:pt x="1792" y="99"/>
                  </a:lnTo>
                  <a:lnTo>
                    <a:pt x="1797" y="98"/>
                  </a:lnTo>
                  <a:lnTo>
                    <a:pt x="1801" y="96"/>
                  </a:lnTo>
                  <a:lnTo>
                    <a:pt x="1806" y="99"/>
                  </a:lnTo>
                  <a:lnTo>
                    <a:pt x="1811" y="97"/>
                  </a:lnTo>
                  <a:lnTo>
                    <a:pt x="1816" y="96"/>
                  </a:lnTo>
                  <a:lnTo>
                    <a:pt x="1821" y="100"/>
                  </a:lnTo>
                  <a:lnTo>
                    <a:pt x="1826" y="99"/>
                  </a:lnTo>
                  <a:lnTo>
                    <a:pt x="1830" y="99"/>
                  </a:lnTo>
                  <a:lnTo>
                    <a:pt x="1835" y="99"/>
                  </a:lnTo>
                  <a:lnTo>
                    <a:pt x="1840" y="97"/>
                  </a:lnTo>
                  <a:lnTo>
                    <a:pt x="1845" y="100"/>
                  </a:lnTo>
                  <a:lnTo>
                    <a:pt x="1850" y="97"/>
                  </a:lnTo>
                  <a:lnTo>
                    <a:pt x="1854" y="97"/>
                  </a:lnTo>
                  <a:lnTo>
                    <a:pt x="1859" y="100"/>
                  </a:lnTo>
                  <a:lnTo>
                    <a:pt x="1864" y="97"/>
                  </a:lnTo>
                  <a:lnTo>
                    <a:pt x="1869" y="97"/>
                  </a:lnTo>
                  <a:lnTo>
                    <a:pt x="1874" y="99"/>
                  </a:lnTo>
                  <a:lnTo>
                    <a:pt x="1878" y="99"/>
                  </a:lnTo>
                  <a:lnTo>
                    <a:pt x="1883" y="97"/>
                  </a:lnTo>
                  <a:lnTo>
                    <a:pt x="1888" y="97"/>
                  </a:lnTo>
                  <a:lnTo>
                    <a:pt x="1893" y="96"/>
                  </a:lnTo>
                  <a:lnTo>
                    <a:pt x="1898" y="99"/>
                  </a:lnTo>
                  <a:lnTo>
                    <a:pt x="1902" y="99"/>
                  </a:lnTo>
                  <a:lnTo>
                    <a:pt x="1907" y="98"/>
                  </a:lnTo>
                  <a:lnTo>
                    <a:pt x="1912" y="97"/>
                  </a:lnTo>
                  <a:lnTo>
                    <a:pt x="1917" y="97"/>
                  </a:lnTo>
                  <a:lnTo>
                    <a:pt x="1922" y="99"/>
                  </a:lnTo>
                  <a:lnTo>
                    <a:pt x="1926" y="98"/>
                  </a:lnTo>
                  <a:lnTo>
                    <a:pt x="1931" y="97"/>
                  </a:lnTo>
                  <a:lnTo>
                    <a:pt x="1936" y="98"/>
                  </a:lnTo>
                  <a:lnTo>
                    <a:pt x="1941" y="98"/>
                  </a:lnTo>
                  <a:lnTo>
                    <a:pt x="1945" y="98"/>
                  </a:lnTo>
                  <a:lnTo>
                    <a:pt x="1950" y="96"/>
                  </a:lnTo>
                  <a:lnTo>
                    <a:pt x="1955" y="98"/>
                  </a:lnTo>
                  <a:lnTo>
                    <a:pt x="1960" y="97"/>
                  </a:lnTo>
                  <a:lnTo>
                    <a:pt x="1965" y="98"/>
                  </a:lnTo>
                  <a:lnTo>
                    <a:pt x="1969" y="98"/>
                  </a:lnTo>
                  <a:lnTo>
                    <a:pt x="1974" y="99"/>
                  </a:lnTo>
                  <a:lnTo>
                    <a:pt x="1979" y="97"/>
                  </a:lnTo>
                  <a:lnTo>
                    <a:pt x="1984" y="98"/>
                  </a:lnTo>
                  <a:lnTo>
                    <a:pt x="1989" y="95"/>
                  </a:lnTo>
                  <a:lnTo>
                    <a:pt x="1994" y="98"/>
                  </a:lnTo>
                  <a:lnTo>
                    <a:pt x="1998" y="95"/>
                  </a:lnTo>
                  <a:lnTo>
                    <a:pt x="2003" y="99"/>
                  </a:lnTo>
                  <a:lnTo>
                    <a:pt x="2008" y="97"/>
                  </a:lnTo>
                  <a:lnTo>
                    <a:pt x="2013" y="96"/>
                  </a:lnTo>
                  <a:lnTo>
                    <a:pt x="2018" y="97"/>
                  </a:lnTo>
                  <a:lnTo>
                    <a:pt x="2022" y="95"/>
                  </a:lnTo>
                  <a:lnTo>
                    <a:pt x="2027" y="97"/>
                  </a:lnTo>
                  <a:lnTo>
                    <a:pt x="2032" y="98"/>
                  </a:lnTo>
                  <a:lnTo>
                    <a:pt x="2037" y="97"/>
                  </a:lnTo>
                  <a:lnTo>
                    <a:pt x="2042" y="98"/>
                  </a:lnTo>
                  <a:lnTo>
                    <a:pt x="2047" y="99"/>
                  </a:lnTo>
                  <a:lnTo>
                    <a:pt x="2051" y="97"/>
                  </a:lnTo>
                  <a:lnTo>
                    <a:pt x="2056" y="100"/>
                  </a:lnTo>
                  <a:lnTo>
                    <a:pt x="2061" y="97"/>
                  </a:lnTo>
                  <a:lnTo>
                    <a:pt x="2066" y="97"/>
                  </a:lnTo>
                  <a:lnTo>
                    <a:pt x="2071" y="98"/>
                  </a:lnTo>
                  <a:lnTo>
                    <a:pt x="2075" y="98"/>
                  </a:lnTo>
                  <a:lnTo>
                    <a:pt x="2080" y="97"/>
                  </a:lnTo>
                  <a:lnTo>
                    <a:pt x="2085" y="97"/>
                  </a:lnTo>
                  <a:lnTo>
                    <a:pt x="2090" y="96"/>
                  </a:lnTo>
                  <a:lnTo>
                    <a:pt x="2095" y="97"/>
                  </a:lnTo>
                  <a:lnTo>
                    <a:pt x="2099" y="99"/>
                  </a:lnTo>
                  <a:lnTo>
                    <a:pt x="2104" y="97"/>
                  </a:lnTo>
                  <a:lnTo>
                    <a:pt x="2109" y="98"/>
                  </a:lnTo>
                  <a:lnTo>
                    <a:pt x="2114" y="97"/>
                  </a:lnTo>
                  <a:lnTo>
                    <a:pt x="2119" y="96"/>
                  </a:lnTo>
                  <a:lnTo>
                    <a:pt x="2123" y="99"/>
                  </a:lnTo>
                  <a:lnTo>
                    <a:pt x="2128" y="97"/>
                  </a:lnTo>
                  <a:lnTo>
                    <a:pt x="2133" y="97"/>
                  </a:lnTo>
                  <a:lnTo>
                    <a:pt x="2138" y="99"/>
                  </a:lnTo>
                  <a:lnTo>
                    <a:pt x="2142" y="99"/>
                  </a:lnTo>
                  <a:lnTo>
                    <a:pt x="2147" y="98"/>
                  </a:lnTo>
                  <a:lnTo>
                    <a:pt x="2152" y="99"/>
                  </a:lnTo>
                  <a:lnTo>
                    <a:pt x="2157" y="97"/>
                  </a:lnTo>
                  <a:lnTo>
                    <a:pt x="2162" y="98"/>
                  </a:lnTo>
                  <a:lnTo>
                    <a:pt x="2166" y="96"/>
                  </a:lnTo>
                  <a:lnTo>
                    <a:pt x="2171" y="97"/>
                  </a:lnTo>
                  <a:lnTo>
                    <a:pt x="2176" y="97"/>
                  </a:lnTo>
                  <a:lnTo>
                    <a:pt x="2181" y="99"/>
                  </a:lnTo>
                  <a:lnTo>
                    <a:pt x="2186" y="97"/>
                  </a:lnTo>
                  <a:lnTo>
                    <a:pt x="2191" y="102"/>
                  </a:lnTo>
                  <a:lnTo>
                    <a:pt x="2195" y="98"/>
                  </a:lnTo>
                  <a:lnTo>
                    <a:pt x="2200" y="97"/>
                  </a:lnTo>
                  <a:lnTo>
                    <a:pt x="2205" y="98"/>
                  </a:lnTo>
                  <a:lnTo>
                    <a:pt x="2210" y="98"/>
                  </a:lnTo>
                  <a:lnTo>
                    <a:pt x="2211" y="97"/>
                  </a:lnTo>
                </a:path>
              </a:pathLst>
            </a:cu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189" name="Rectangle 389"/>
            <p:cNvSpPr>
              <a:spLocks noChangeArrowheads="1"/>
            </p:cNvSpPr>
            <p:nvPr/>
          </p:nvSpPr>
          <p:spPr bwMode="auto">
            <a:xfrm>
              <a:off x="2778512" y="1221171"/>
              <a:ext cx="6922774" cy="2702257"/>
            </a:xfrm>
            <a:prstGeom prst="rect">
              <a:avLst/>
            </a:prstGeom>
            <a:noFill/>
            <a:ln w="17463" cap="flat">
              <a:noFill/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190" name="Rectangle 390"/>
            <p:cNvSpPr>
              <a:spLocks noChangeArrowheads="1"/>
            </p:cNvSpPr>
            <p:nvPr/>
          </p:nvSpPr>
          <p:spPr bwMode="auto">
            <a:xfrm>
              <a:off x="3124330" y="1349417"/>
              <a:ext cx="29276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808080"/>
                  </a:solidFill>
                  <a:effectLst/>
                  <a:latin typeface="Microsoft Sans Serif" panose="020B0604020202020204" pitchFamily="34" charset="0"/>
                </a:rPr>
                <a:t>1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1" name="Line 391"/>
            <p:cNvSpPr>
              <a:spLocks noChangeShapeType="1"/>
            </p:cNvSpPr>
            <p:nvPr/>
          </p:nvSpPr>
          <p:spPr bwMode="auto">
            <a:xfrm flipV="1">
              <a:off x="3170074" y="1349417"/>
              <a:ext cx="0" cy="2578559"/>
            </a:xfrm>
            <a:prstGeom prst="line">
              <a:avLst/>
            </a:prstGeom>
            <a:noFill/>
            <a:ln w="9525" cap="flat">
              <a:solidFill>
                <a:srgbClr val="80808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192" name="Rectangle 392"/>
            <p:cNvSpPr>
              <a:spLocks noChangeArrowheads="1"/>
            </p:cNvSpPr>
            <p:nvPr/>
          </p:nvSpPr>
          <p:spPr bwMode="auto">
            <a:xfrm>
              <a:off x="3181052" y="1349417"/>
              <a:ext cx="29276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808080"/>
                  </a:solidFill>
                  <a:effectLst/>
                  <a:latin typeface="Microsoft Sans Serif" panose="020B0604020202020204" pitchFamily="34" charset="0"/>
                </a:rPr>
                <a:t>2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3" name="Rectangle 393"/>
            <p:cNvSpPr>
              <a:spLocks noChangeArrowheads="1"/>
            </p:cNvSpPr>
            <p:nvPr/>
          </p:nvSpPr>
          <p:spPr bwMode="auto">
            <a:xfrm>
              <a:off x="5749989" y="4026206"/>
              <a:ext cx="1719944" cy="122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Counts (%) vs. Acquisition Time (min)</a:t>
              </a:r>
              <a:endPara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4" name="Line 394"/>
            <p:cNvSpPr>
              <a:spLocks noChangeShapeType="1"/>
            </p:cNvSpPr>
            <p:nvPr/>
          </p:nvSpPr>
          <p:spPr bwMode="auto">
            <a:xfrm>
              <a:off x="2783086" y="3933433"/>
              <a:ext cx="6908136" cy="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195" name="Line 395"/>
            <p:cNvSpPr>
              <a:spLocks noChangeShapeType="1"/>
            </p:cNvSpPr>
            <p:nvPr/>
          </p:nvSpPr>
          <p:spPr bwMode="auto">
            <a:xfrm>
              <a:off x="2881891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196" name="Rectangle 396"/>
            <p:cNvSpPr>
              <a:spLocks noChangeArrowheads="1"/>
            </p:cNvSpPr>
            <p:nvPr/>
          </p:nvSpPr>
          <p:spPr bwMode="auto">
            <a:xfrm>
              <a:off x="2866339" y="3954352"/>
              <a:ext cx="29276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7" name="Line 397"/>
            <p:cNvSpPr>
              <a:spLocks noChangeShapeType="1"/>
            </p:cNvSpPr>
            <p:nvPr/>
          </p:nvSpPr>
          <p:spPr bwMode="auto">
            <a:xfrm>
              <a:off x="3020951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198" name="Rectangle 398"/>
            <p:cNvSpPr>
              <a:spLocks noChangeArrowheads="1"/>
            </p:cNvSpPr>
            <p:nvPr/>
          </p:nvSpPr>
          <p:spPr bwMode="auto">
            <a:xfrm>
              <a:off x="2979782" y="3954352"/>
              <a:ext cx="72274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9" name="Line 399"/>
            <p:cNvSpPr>
              <a:spLocks noChangeShapeType="1"/>
            </p:cNvSpPr>
            <p:nvPr/>
          </p:nvSpPr>
          <p:spPr bwMode="auto">
            <a:xfrm>
              <a:off x="3154521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00" name="Rectangle 400"/>
            <p:cNvSpPr>
              <a:spLocks noChangeArrowheads="1"/>
            </p:cNvSpPr>
            <p:nvPr/>
          </p:nvSpPr>
          <p:spPr bwMode="auto">
            <a:xfrm>
              <a:off x="3138968" y="3954352"/>
              <a:ext cx="29276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1" name="Line 401"/>
            <p:cNvSpPr>
              <a:spLocks noChangeShapeType="1"/>
            </p:cNvSpPr>
            <p:nvPr/>
          </p:nvSpPr>
          <p:spPr bwMode="auto">
            <a:xfrm>
              <a:off x="3294495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02" name="Rectangle 402"/>
            <p:cNvSpPr>
              <a:spLocks noChangeArrowheads="1"/>
            </p:cNvSpPr>
            <p:nvPr/>
          </p:nvSpPr>
          <p:spPr bwMode="auto">
            <a:xfrm>
              <a:off x="3253326" y="3954352"/>
              <a:ext cx="72274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3" name="Line 403"/>
            <p:cNvSpPr>
              <a:spLocks noChangeShapeType="1"/>
            </p:cNvSpPr>
            <p:nvPr/>
          </p:nvSpPr>
          <p:spPr bwMode="auto">
            <a:xfrm>
              <a:off x="3428065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04" name="Rectangle 404"/>
            <p:cNvSpPr>
              <a:spLocks noChangeArrowheads="1"/>
            </p:cNvSpPr>
            <p:nvPr/>
          </p:nvSpPr>
          <p:spPr bwMode="auto">
            <a:xfrm>
              <a:off x="3412512" y="3954352"/>
              <a:ext cx="29276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3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5" name="Line 405"/>
            <p:cNvSpPr>
              <a:spLocks noChangeShapeType="1"/>
            </p:cNvSpPr>
            <p:nvPr/>
          </p:nvSpPr>
          <p:spPr bwMode="auto">
            <a:xfrm>
              <a:off x="3567124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06" name="Rectangle 406"/>
            <p:cNvSpPr>
              <a:spLocks noChangeArrowheads="1"/>
            </p:cNvSpPr>
            <p:nvPr/>
          </p:nvSpPr>
          <p:spPr bwMode="auto">
            <a:xfrm>
              <a:off x="3525956" y="3954352"/>
              <a:ext cx="72274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3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7" name="Line 407"/>
            <p:cNvSpPr>
              <a:spLocks noChangeShapeType="1"/>
            </p:cNvSpPr>
            <p:nvPr/>
          </p:nvSpPr>
          <p:spPr bwMode="auto">
            <a:xfrm>
              <a:off x="3701609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08" name="Rectangle 408"/>
            <p:cNvSpPr>
              <a:spLocks noChangeArrowheads="1"/>
            </p:cNvSpPr>
            <p:nvPr/>
          </p:nvSpPr>
          <p:spPr bwMode="auto">
            <a:xfrm>
              <a:off x="3686057" y="3954352"/>
              <a:ext cx="29276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4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9" name="Line 409"/>
            <p:cNvSpPr>
              <a:spLocks noChangeShapeType="1"/>
            </p:cNvSpPr>
            <p:nvPr/>
          </p:nvSpPr>
          <p:spPr bwMode="auto">
            <a:xfrm>
              <a:off x="3836094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10" name="Rectangle 410"/>
            <p:cNvSpPr>
              <a:spLocks noChangeArrowheads="1"/>
            </p:cNvSpPr>
            <p:nvPr/>
          </p:nvSpPr>
          <p:spPr bwMode="auto">
            <a:xfrm>
              <a:off x="3794925" y="3954352"/>
              <a:ext cx="72274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4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1" name="Line 411"/>
            <p:cNvSpPr>
              <a:spLocks noChangeShapeType="1"/>
            </p:cNvSpPr>
            <p:nvPr/>
          </p:nvSpPr>
          <p:spPr bwMode="auto">
            <a:xfrm>
              <a:off x="3975154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12" name="Rectangle 412"/>
            <p:cNvSpPr>
              <a:spLocks noChangeArrowheads="1"/>
            </p:cNvSpPr>
            <p:nvPr/>
          </p:nvSpPr>
          <p:spPr bwMode="auto">
            <a:xfrm>
              <a:off x="3959601" y="3954352"/>
              <a:ext cx="29276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3" name="Line 413"/>
            <p:cNvSpPr>
              <a:spLocks noChangeShapeType="1"/>
            </p:cNvSpPr>
            <p:nvPr/>
          </p:nvSpPr>
          <p:spPr bwMode="auto">
            <a:xfrm>
              <a:off x="4109639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14" name="Rectangle 414"/>
            <p:cNvSpPr>
              <a:spLocks noChangeArrowheads="1"/>
            </p:cNvSpPr>
            <p:nvPr/>
          </p:nvSpPr>
          <p:spPr bwMode="auto">
            <a:xfrm>
              <a:off x="4067555" y="3954352"/>
              <a:ext cx="72274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5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5" name="Line 415"/>
            <p:cNvSpPr>
              <a:spLocks noChangeShapeType="1"/>
            </p:cNvSpPr>
            <p:nvPr/>
          </p:nvSpPr>
          <p:spPr bwMode="auto">
            <a:xfrm>
              <a:off x="4248698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16" name="Rectangle 416"/>
            <p:cNvSpPr>
              <a:spLocks noChangeArrowheads="1"/>
            </p:cNvSpPr>
            <p:nvPr/>
          </p:nvSpPr>
          <p:spPr bwMode="auto">
            <a:xfrm>
              <a:off x="4233145" y="3954352"/>
              <a:ext cx="29276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6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7" name="Line 417"/>
            <p:cNvSpPr>
              <a:spLocks noChangeShapeType="1"/>
            </p:cNvSpPr>
            <p:nvPr/>
          </p:nvSpPr>
          <p:spPr bwMode="auto">
            <a:xfrm>
              <a:off x="4382268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18" name="Rectangle 418"/>
            <p:cNvSpPr>
              <a:spLocks noChangeArrowheads="1"/>
            </p:cNvSpPr>
            <p:nvPr/>
          </p:nvSpPr>
          <p:spPr bwMode="auto">
            <a:xfrm>
              <a:off x="4341099" y="3954352"/>
              <a:ext cx="72274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6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9" name="Line 419"/>
            <p:cNvSpPr>
              <a:spLocks noChangeShapeType="1"/>
            </p:cNvSpPr>
            <p:nvPr/>
          </p:nvSpPr>
          <p:spPr bwMode="auto">
            <a:xfrm>
              <a:off x="4522242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20" name="Rectangle 420"/>
            <p:cNvSpPr>
              <a:spLocks noChangeArrowheads="1"/>
            </p:cNvSpPr>
            <p:nvPr/>
          </p:nvSpPr>
          <p:spPr bwMode="auto">
            <a:xfrm>
              <a:off x="4506689" y="3954352"/>
              <a:ext cx="29276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7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1" name="Line 421"/>
            <p:cNvSpPr>
              <a:spLocks noChangeShapeType="1"/>
            </p:cNvSpPr>
            <p:nvPr/>
          </p:nvSpPr>
          <p:spPr bwMode="auto">
            <a:xfrm>
              <a:off x="4655812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22" name="Rectangle 422"/>
            <p:cNvSpPr>
              <a:spLocks noChangeArrowheads="1"/>
            </p:cNvSpPr>
            <p:nvPr/>
          </p:nvSpPr>
          <p:spPr bwMode="auto">
            <a:xfrm>
              <a:off x="4614643" y="3954352"/>
              <a:ext cx="72274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7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3" name="Line 423"/>
            <p:cNvSpPr>
              <a:spLocks noChangeShapeType="1"/>
            </p:cNvSpPr>
            <p:nvPr/>
          </p:nvSpPr>
          <p:spPr bwMode="auto">
            <a:xfrm>
              <a:off x="4794871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24" name="Rectangle 424"/>
            <p:cNvSpPr>
              <a:spLocks noChangeArrowheads="1"/>
            </p:cNvSpPr>
            <p:nvPr/>
          </p:nvSpPr>
          <p:spPr bwMode="auto">
            <a:xfrm>
              <a:off x="4780234" y="3954352"/>
              <a:ext cx="29276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8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5" name="Line 425"/>
            <p:cNvSpPr>
              <a:spLocks noChangeShapeType="1"/>
            </p:cNvSpPr>
            <p:nvPr/>
          </p:nvSpPr>
          <p:spPr bwMode="auto">
            <a:xfrm>
              <a:off x="4929356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26" name="Rectangle 426"/>
            <p:cNvSpPr>
              <a:spLocks noChangeArrowheads="1"/>
            </p:cNvSpPr>
            <p:nvPr/>
          </p:nvSpPr>
          <p:spPr bwMode="auto">
            <a:xfrm>
              <a:off x="4888188" y="3954352"/>
              <a:ext cx="72274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8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7" name="Line 427"/>
            <p:cNvSpPr>
              <a:spLocks noChangeShapeType="1"/>
            </p:cNvSpPr>
            <p:nvPr/>
          </p:nvSpPr>
          <p:spPr bwMode="auto">
            <a:xfrm>
              <a:off x="5068416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28" name="Rectangle 428"/>
            <p:cNvSpPr>
              <a:spLocks noChangeArrowheads="1"/>
            </p:cNvSpPr>
            <p:nvPr/>
          </p:nvSpPr>
          <p:spPr bwMode="auto">
            <a:xfrm>
              <a:off x="5052863" y="3954352"/>
              <a:ext cx="29276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9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9" name="Line 429"/>
            <p:cNvSpPr>
              <a:spLocks noChangeShapeType="1"/>
            </p:cNvSpPr>
            <p:nvPr/>
          </p:nvSpPr>
          <p:spPr bwMode="auto">
            <a:xfrm>
              <a:off x="5202901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30" name="Rectangle 430"/>
            <p:cNvSpPr>
              <a:spLocks noChangeArrowheads="1"/>
            </p:cNvSpPr>
            <p:nvPr/>
          </p:nvSpPr>
          <p:spPr bwMode="auto">
            <a:xfrm>
              <a:off x="5161732" y="3954352"/>
              <a:ext cx="72274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9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1" name="Line 431"/>
            <p:cNvSpPr>
              <a:spLocks noChangeShapeType="1"/>
            </p:cNvSpPr>
            <p:nvPr/>
          </p:nvSpPr>
          <p:spPr bwMode="auto">
            <a:xfrm>
              <a:off x="5341960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32" name="Rectangle 432"/>
            <p:cNvSpPr>
              <a:spLocks noChangeArrowheads="1"/>
            </p:cNvSpPr>
            <p:nvPr/>
          </p:nvSpPr>
          <p:spPr bwMode="auto">
            <a:xfrm>
              <a:off x="5310855" y="3954352"/>
              <a:ext cx="57636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0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3" name="Line 433"/>
            <p:cNvSpPr>
              <a:spLocks noChangeShapeType="1"/>
            </p:cNvSpPr>
            <p:nvPr/>
          </p:nvSpPr>
          <p:spPr bwMode="auto">
            <a:xfrm>
              <a:off x="5476445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34" name="Rectangle 434"/>
            <p:cNvSpPr>
              <a:spLocks noChangeArrowheads="1"/>
            </p:cNvSpPr>
            <p:nvPr/>
          </p:nvSpPr>
          <p:spPr bwMode="auto">
            <a:xfrm>
              <a:off x="5419723" y="3954352"/>
              <a:ext cx="100635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0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5" name="Line 435"/>
            <p:cNvSpPr>
              <a:spLocks noChangeShapeType="1"/>
            </p:cNvSpPr>
            <p:nvPr/>
          </p:nvSpPr>
          <p:spPr bwMode="auto">
            <a:xfrm>
              <a:off x="5615504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36" name="Rectangle 436"/>
            <p:cNvSpPr>
              <a:spLocks noChangeArrowheads="1"/>
            </p:cNvSpPr>
            <p:nvPr/>
          </p:nvSpPr>
          <p:spPr bwMode="auto">
            <a:xfrm>
              <a:off x="5584399" y="3954352"/>
              <a:ext cx="57636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1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7" name="Line 437"/>
            <p:cNvSpPr>
              <a:spLocks noChangeShapeType="1"/>
            </p:cNvSpPr>
            <p:nvPr/>
          </p:nvSpPr>
          <p:spPr bwMode="auto">
            <a:xfrm>
              <a:off x="5749989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38" name="Rectangle 438"/>
            <p:cNvSpPr>
              <a:spLocks noChangeArrowheads="1"/>
            </p:cNvSpPr>
            <p:nvPr/>
          </p:nvSpPr>
          <p:spPr bwMode="auto">
            <a:xfrm>
              <a:off x="5693268" y="3954352"/>
              <a:ext cx="100635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1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9" name="Line 439"/>
            <p:cNvSpPr>
              <a:spLocks noChangeShapeType="1"/>
            </p:cNvSpPr>
            <p:nvPr/>
          </p:nvSpPr>
          <p:spPr bwMode="auto">
            <a:xfrm>
              <a:off x="5889049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40" name="Rectangle 440"/>
            <p:cNvSpPr>
              <a:spLocks noChangeArrowheads="1"/>
            </p:cNvSpPr>
            <p:nvPr/>
          </p:nvSpPr>
          <p:spPr bwMode="auto">
            <a:xfrm>
              <a:off x="5857943" y="3954352"/>
              <a:ext cx="57636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2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1" name="Line 441"/>
            <p:cNvSpPr>
              <a:spLocks noChangeShapeType="1"/>
            </p:cNvSpPr>
            <p:nvPr/>
          </p:nvSpPr>
          <p:spPr bwMode="auto">
            <a:xfrm>
              <a:off x="6022619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42" name="Rectangle 442"/>
            <p:cNvSpPr>
              <a:spLocks noChangeArrowheads="1"/>
            </p:cNvSpPr>
            <p:nvPr/>
          </p:nvSpPr>
          <p:spPr bwMode="auto">
            <a:xfrm>
              <a:off x="5965897" y="3954352"/>
              <a:ext cx="100635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2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3" name="Line 443"/>
            <p:cNvSpPr>
              <a:spLocks noChangeShapeType="1"/>
            </p:cNvSpPr>
            <p:nvPr/>
          </p:nvSpPr>
          <p:spPr bwMode="auto">
            <a:xfrm>
              <a:off x="6162593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44" name="Rectangle 444"/>
            <p:cNvSpPr>
              <a:spLocks noChangeArrowheads="1"/>
            </p:cNvSpPr>
            <p:nvPr/>
          </p:nvSpPr>
          <p:spPr bwMode="auto">
            <a:xfrm>
              <a:off x="6131487" y="3954352"/>
              <a:ext cx="57636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3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5" name="Line 445"/>
            <p:cNvSpPr>
              <a:spLocks noChangeShapeType="1"/>
            </p:cNvSpPr>
            <p:nvPr/>
          </p:nvSpPr>
          <p:spPr bwMode="auto">
            <a:xfrm>
              <a:off x="6296163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46" name="Rectangle 446"/>
            <p:cNvSpPr>
              <a:spLocks noChangeArrowheads="1"/>
            </p:cNvSpPr>
            <p:nvPr/>
          </p:nvSpPr>
          <p:spPr bwMode="auto">
            <a:xfrm>
              <a:off x="6239441" y="3954352"/>
              <a:ext cx="100635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3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7" name="Line 447"/>
            <p:cNvSpPr>
              <a:spLocks noChangeShapeType="1"/>
            </p:cNvSpPr>
            <p:nvPr/>
          </p:nvSpPr>
          <p:spPr bwMode="auto">
            <a:xfrm>
              <a:off x="6436137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48" name="Rectangle 448"/>
            <p:cNvSpPr>
              <a:spLocks noChangeArrowheads="1"/>
            </p:cNvSpPr>
            <p:nvPr/>
          </p:nvSpPr>
          <p:spPr bwMode="auto">
            <a:xfrm>
              <a:off x="6405032" y="3954352"/>
              <a:ext cx="57636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4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9" name="Line 449"/>
            <p:cNvSpPr>
              <a:spLocks noChangeShapeType="1"/>
            </p:cNvSpPr>
            <p:nvPr/>
          </p:nvSpPr>
          <p:spPr bwMode="auto">
            <a:xfrm>
              <a:off x="6569707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50" name="Rectangle 450"/>
            <p:cNvSpPr>
              <a:spLocks noChangeArrowheads="1"/>
            </p:cNvSpPr>
            <p:nvPr/>
          </p:nvSpPr>
          <p:spPr bwMode="auto">
            <a:xfrm>
              <a:off x="6512986" y="3954352"/>
              <a:ext cx="100635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4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1" name="Line 451"/>
            <p:cNvSpPr>
              <a:spLocks noChangeShapeType="1"/>
            </p:cNvSpPr>
            <p:nvPr/>
          </p:nvSpPr>
          <p:spPr bwMode="auto">
            <a:xfrm>
              <a:off x="6708766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52" name="Rectangle 452"/>
            <p:cNvSpPr>
              <a:spLocks noChangeArrowheads="1"/>
            </p:cNvSpPr>
            <p:nvPr/>
          </p:nvSpPr>
          <p:spPr bwMode="auto">
            <a:xfrm>
              <a:off x="6678576" y="3954352"/>
              <a:ext cx="57636" cy="6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3" name="Line 453"/>
            <p:cNvSpPr>
              <a:spLocks noChangeShapeType="1"/>
            </p:cNvSpPr>
            <p:nvPr/>
          </p:nvSpPr>
          <p:spPr bwMode="auto">
            <a:xfrm>
              <a:off x="6843251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14" name="Rectangle 455"/>
            <p:cNvSpPr>
              <a:spLocks noChangeArrowheads="1"/>
            </p:cNvSpPr>
            <p:nvPr/>
          </p:nvSpPr>
          <p:spPr bwMode="auto">
            <a:xfrm>
              <a:off x="6786530" y="3954352"/>
              <a:ext cx="100990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5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Line 456"/>
            <p:cNvSpPr>
              <a:spLocks noChangeShapeType="1"/>
            </p:cNvSpPr>
            <p:nvPr/>
          </p:nvSpPr>
          <p:spPr bwMode="auto">
            <a:xfrm>
              <a:off x="6977736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16" name="Rectangle 457"/>
            <p:cNvSpPr>
              <a:spLocks noChangeArrowheads="1"/>
            </p:cNvSpPr>
            <p:nvPr/>
          </p:nvSpPr>
          <p:spPr bwMode="auto">
            <a:xfrm>
              <a:off x="6946631" y="3954352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6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Line 458"/>
            <p:cNvSpPr>
              <a:spLocks noChangeShapeType="1"/>
            </p:cNvSpPr>
            <p:nvPr/>
          </p:nvSpPr>
          <p:spPr bwMode="auto">
            <a:xfrm>
              <a:off x="7116796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18" name="Rectangle 459"/>
            <p:cNvSpPr>
              <a:spLocks noChangeArrowheads="1"/>
            </p:cNvSpPr>
            <p:nvPr/>
          </p:nvSpPr>
          <p:spPr bwMode="auto">
            <a:xfrm>
              <a:off x="7060074" y="3954352"/>
              <a:ext cx="100990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6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Line 460"/>
            <p:cNvSpPr>
              <a:spLocks noChangeShapeType="1"/>
            </p:cNvSpPr>
            <p:nvPr/>
          </p:nvSpPr>
          <p:spPr bwMode="auto">
            <a:xfrm>
              <a:off x="7250366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0" name="Rectangle 461"/>
            <p:cNvSpPr>
              <a:spLocks noChangeArrowheads="1"/>
            </p:cNvSpPr>
            <p:nvPr/>
          </p:nvSpPr>
          <p:spPr bwMode="auto">
            <a:xfrm>
              <a:off x="7220175" y="3954352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7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Line 462"/>
            <p:cNvSpPr>
              <a:spLocks noChangeShapeType="1"/>
            </p:cNvSpPr>
            <p:nvPr/>
          </p:nvSpPr>
          <p:spPr bwMode="auto">
            <a:xfrm>
              <a:off x="7390340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2" name="Rectangle 463"/>
            <p:cNvSpPr>
              <a:spLocks noChangeArrowheads="1"/>
            </p:cNvSpPr>
            <p:nvPr/>
          </p:nvSpPr>
          <p:spPr bwMode="auto">
            <a:xfrm>
              <a:off x="7333619" y="3954352"/>
              <a:ext cx="100990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7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Line 464"/>
            <p:cNvSpPr>
              <a:spLocks noChangeShapeType="1"/>
            </p:cNvSpPr>
            <p:nvPr/>
          </p:nvSpPr>
          <p:spPr bwMode="auto">
            <a:xfrm>
              <a:off x="7523910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4" name="Rectangle 465"/>
            <p:cNvSpPr>
              <a:spLocks noChangeArrowheads="1"/>
            </p:cNvSpPr>
            <p:nvPr/>
          </p:nvSpPr>
          <p:spPr bwMode="auto">
            <a:xfrm>
              <a:off x="7492805" y="3954352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8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Line 466"/>
            <p:cNvSpPr>
              <a:spLocks noChangeShapeType="1"/>
            </p:cNvSpPr>
            <p:nvPr/>
          </p:nvSpPr>
          <p:spPr bwMode="auto">
            <a:xfrm>
              <a:off x="7663884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6" name="Rectangle 467"/>
            <p:cNvSpPr>
              <a:spLocks noChangeArrowheads="1"/>
            </p:cNvSpPr>
            <p:nvPr/>
          </p:nvSpPr>
          <p:spPr bwMode="auto">
            <a:xfrm>
              <a:off x="7607163" y="3954352"/>
              <a:ext cx="100990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8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Line 468"/>
            <p:cNvSpPr>
              <a:spLocks noChangeShapeType="1"/>
            </p:cNvSpPr>
            <p:nvPr/>
          </p:nvSpPr>
          <p:spPr bwMode="auto">
            <a:xfrm>
              <a:off x="7797454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28" name="Rectangle 469"/>
            <p:cNvSpPr>
              <a:spLocks noChangeArrowheads="1"/>
            </p:cNvSpPr>
            <p:nvPr/>
          </p:nvSpPr>
          <p:spPr bwMode="auto">
            <a:xfrm>
              <a:off x="7766349" y="3954352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9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Line 470"/>
            <p:cNvSpPr>
              <a:spLocks noChangeShapeType="1"/>
            </p:cNvSpPr>
            <p:nvPr/>
          </p:nvSpPr>
          <p:spPr bwMode="auto">
            <a:xfrm>
              <a:off x="7936513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30" name="Rectangle 471"/>
            <p:cNvSpPr>
              <a:spLocks noChangeArrowheads="1"/>
            </p:cNvSpPr>
            <p:nvPr/>
          </p:nvSpPr>
          <p:spPr bwMode="auto">
            <a:xfrm>
              <a:off x="7879792" y="3954352"/>
              <a:ext cx="100990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19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Line 472"/>
            <p:cNvSpPr>
              <a:spLocks noChangeShapeType="1"/>
            </p:cNvSpPr>
            <p:nvPr/>
          </p:nvSpPr>
          <p:spPr bwMode="auto">
            <a:xfrm>
              <a:off x="8070999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32" name="Rectangle 473"/>
            <p:cNvSpPr>
              <a:spLocks noChangeArrowheads="1"/>
            </p:cNvSpPr>
            <p:nvPr/>
          </p:nvSpPr>
          <p:spPr bwMode="auto">
            <a:xfrm>
              <a:off x="8039893" y="3954352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0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Line 474"/>
            <p:cNvSpPr>
              <a:spLocks noChangeShapeType="1"/>
            </p:cNvSpPr>
            <p:nvPr/>
          </p:nvSpPr>
          <p:spPr bwMode="auto">
            <a:xfrm>
              <a:off x="8210058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34" name="Rectangle 475"/>
            <p:cNvSpPr>
              <a:spLocks noChangeArrowheads="1"/>
            </p:cNvSpPr>
            <p:nvPr/>
          </p:nvSpPr>
          <p:spPr bwMode="auto">
            <a:xfrm>
              <a:off x="8153336" y="3954352"/>
              <a:ext cx="100990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0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Line 476"/>
            <p:cNvSpPr>
              <a:spLocks noChangeShapeType="1"/>
            </p:cNvSpPr>
            <p:nvPr/>
          </p:nvSpPr>
          <p:spPr bwMode="auto">
            <a:xfrm>
              <a:off x="8344543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36" name="Rectangle 477"/>
            <p:cNvSpPr>
              <a:spLocks noChangeArrowheads="1"/>
            </p:cNvSpPr>
            <p:nvPr/>
          </p:nvSpPr>
          <p:spPr bwMode="auto">
            <a:xfrm>
              <a:off x="8313438" y="3954352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1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Line 478"/>
            <p:cNvSpPr>
              <a:spLocks noChangeShapeType="1"/>
            </p:cNvSpPr>
            <p:nvPr/>
          </p:nvSpPr>
          <p:spPr bwMode="auto">
            <a:xfrm>
              <a:off x="8483602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38" name="Rectangle 479"/>
            <p:cNvSpPr>
              <a:spLocks noChangeArrowheads="1"/>
            </p:cNvSpPr>
            <p:nvPr/>
          </p:nvSpPr>
          <p:spPr bwMode="auto">
            <a:xfrm>
              <a:off x="8426880" y="3954352"/>
              <a:ext cx="100990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1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Line 480"/>
            <p:cNvSpPr>
              <a:spLocks noChangeShapeType="1"/>
            </p:cNvSpPr>
            <p:nvPr/>
          </p:nvSpPr>
          <p:spPr bwMode="auto">
            <a:xfrm>
              <a:off x="8618087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40" name="Rectangle 481"/>
            <p:cNvSpPr>
              <a:spLocks noChangeArrowheads="1"/>
            </p:cNvSpPr>
            <p:nvPr/>
          </p:nvSpPr>
          <p:spPr bwMode="auto">
            <a:xfrm>
              <a:off x="8586982" y="3954352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2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Line 482"/>
            <p:cNvSpPr>
              <a:spLocks noChangeShapeType="1"/>
            </p:cNvSpPr>
            <p:nvPr/>
          </p:nvSpPr>
          <p:spPr bwMode="auto">
            <a:xfrm>
              <a:off x="8757146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42" name="Rectangle 483"/>
            <p:cNvSpPr>
              <a:spLocks noChangeArrowheads="1"/>
            </p:cNvSpPr>
            <p:nvPr/>
          </p:nvSpPr>
          <p:spPr bwMode="auto">
            <a:xfrm>
              <a:off x="8700425" y="3954352"/>
              <a:ext cx="100990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2.5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Line 484"/>
            <p:cNvSpPr>
              <a:spLocks noChangeShapeType="1"/>
            </p:cNvSpPr>
            <p:nvPr/>
          </p:nvSpPr>
          <p:spPr bwMode="auto">
            <a:xfrm>
              <a:off x="8891631" y="3933433"/>
              <a:ext cx="0" cy="20010"/>
            </a:xfrm>
            <a:prstGeom prst="line">
              <a:avLst/>
            </a:prstGeom>
            <a:noFill/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/>
            </a:p>
          </p:txBody>
        </p:sp>
        <p:sp>
          <p:nvSpPr>
            <p:cNvPr id="44" name="Rectangle 485"/>
            <p:cNvSpPr>
              <a:spLocks noChangeArrowheads="1"/>
            </p:cNvSpPr>
            <p:nvPr/>
          </p:nvSpPr>
          <p:spPr bwMode="auto">
            <a:xfrm>
              <a:off x="8860526" y="3954352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icrosoft Sans Serif" panose="020B0604020202020204" pitchFamily="34" charset="0"/>
                </a:rPr>
                <a:t>23</a:t>
              </a:r>
              <a:endPara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202095" y="3133943"/>
              <a:ext cx="209506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u="sng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 wash</a:t>
              </a:r>
              <a:endParaRPr lang="en-US" sz="1600" b="1" u="sng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200248" y="3562508"/>
              <a:ext cx="209506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fter wash</a:t>
              </a:r>
            </a:p>
          </p:txBody>
        </p:sp>
        <p:sp>
          <p:nvSpPr>
            <p:cNvPr id="254" name="TextBox 253"/>
            <p:cNvSpPr txBox="1"/>
            <p:nvPr/>
          </p:nvSpPr>
          <p:spPr>
            <a:xfrm>
              <a:off x="2708095" y="1188606"/>
              <a:ext cx="20950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TIC scan</a:t>
              </a:r>
            </a:p>
          </p:txBody>
        </p:sp>
        <p:sp>
          <p:nvSpPr>
            <p:cNvPr id="4" name="Rectangle 3"/>
            <p:cNvSpPr/>
            <p:nvPr/>
          </p:nvSpPr>
          <p:spPr>
            <a:xfrm>
              <a:off x="8916795" y="3031164"/>
              <a:ext cx="914400" cy="9144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8188799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945</TotalTime>
  <Words>692</Words>
  <Application>Microsoft Office PowerPoint</Application>
  <PresentationFormat>Widescreen</PresentationFormat>
  <Paragraphs>146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3" baseType="lpstr">
      <vt:lpstr>Gene Sans</vt:lpstr>
      <vt:lpstr>Arial</vt:lpstr>
      <vt:lpstr>Calibri</vt:lpstr>
      <vt:lpstr>Calibri Light</vt:lpstr>
      <vt:lpstr>Microsoft Sans Serif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F. Hoffmann-La Roche, Ltd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mperi, Julien {MMCD~South San Francisco}</dc:creator>
  <cp:lastModifiedBy>MDPI</cp:lastModifiedBy>
  <cp:revision>109</cp:revision>
  <dcterms:created xsi:type="dcterms:W3CDTF">2023-05-01T04:19:59Z</dcterms:created>
  <dcterms:modified xsi:type="dcterms:W3CDTF">2023-08-17T04:44:20Z</dcterms:modified>
</cp:coreProperties>
</file>